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 showGuides="1">
      <p:cViewPr varScale="1">
        <p:scale>
          <a:sx n="60" d="100"/>
          <a:sy n="60" d="100"/>
        </p:scale>
        <p:origin x="2558" y="8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Διαφάνεια τίτλου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l-GR" smtClean="0"/>
              <a:t>Κάντε κλικ για να επεξεργαστείτε τον υπότιτλο του υποδείγματος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29BAB-11DC-46E0-A513-3F51A82882A0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BC191E-211B-4D5B-AE46-0E7CAD4DA1F2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42433583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Τίτλος και Κατακόρυφο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29BAB-11DC-46E0-A513-3F51A82882A0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BC191E-211B-4D5B-AE46-0E7CAD4DA1F2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0332102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Κατακόρυφος τίτλος και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29BAB-11DC-46E0-A513-3F51A82882A0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BC191E-211B-4D5B-AE46-0E7CAD4DA1F2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0021346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Τίτλος και περιεχό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29BAB-11DC-46E0-A513-3F51A82882A0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BC191E-211B-4D5B-AE46-0E7CAD4DA1F2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4570712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Κεφαλίδα ενότητα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l-GR" smtClean="0"/>
              <a:t>Επεξεργασία στυλ υποδείγματος κειμένου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29BAB-11DC-46E0-A513-3F51A82882A0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BC191E-211B-4D5B-AE46-0E7CAD4DA1F2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42233681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Δύο περιεχόμεν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29BAB-11DC-46E0-A513-3F51A82882A0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BC191E-211B-4D5B-AE46-0E7CAD4DA1F2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0538442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Σύγκριση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l-GR" smtClean="0"/>
              <a:t>Επεξεργασία στυλ υποδείγματος κειμένου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l-GR" smtClean="0"/>
              <a:t>Επεξεργασία στυλ υποδείγματος κειμένου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29BAB-11DC-46E0-A513-3F51A82882A0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BC191E-211B-4D5B-AE46-0E7CAD4DA1F2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972426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Μόνο τίτλο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29BAB-11DC-46E0-A513-3F51A82882A0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BC191E-211B-4D5B-AE46-0E7CAD4DA1F2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4600949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Κεν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29BAB-11DC-46E0-A513-3F51A82882A0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BC191E-211B-4D5B-AE46-0E7CAD4DA1F2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6824713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Περιεχόμενο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l-GR" smtClean="0"/>
              <a:t>Επεξεργασία στυλ υποδείγματος κειμένου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29BAB-11DC-46E0-A513-3F51A82882A0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BC191E-211B-4D5B-AE46-0E7CAD4DA1F2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8370417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Εικόνα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l-GR" smtClean="0"/>
              <a:t>Κάντε κλικ στο εικονίδιο για να προσθέσετε εικόνα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l-GR" smtClean="0"/>
              <a:t>Επεξεργασία στυλ υποδείγματος κειμένου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29BAB-11DC-46E0-A513-3F51A82882A0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BC191E-211B-4D5B-AE46-0E7CAD4DA1F2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0594344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D29BAB-11DC-46E0-A513-3F51A82882A0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BC191E-211B-4D5B-AE46-0E7CAD4DA1F2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0043323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Ομάδα 2"/>
          <p:cNvGrpSpPr/>
          <p:nvPr/>
        </p:nvGrpSpPr>
        <p:grpSpPr>
          <a:xfrm>
            <a:off x="0" y="-24844"/>
            <a:ext cx="6856413" cy="7511494"/>
            <a:chOff x="0" y="-24844"/>
            <a:chExt cx="6856413" cy="7511494"/>
          </a:xfrm>
        </p:grpSpPr>
        <p:sp>
          <p:nvSpPr>
            <p:cNvPr id="4" name="60 - TextBox"/>
            <p:cNvSpPr txBox="1"/>
            <p:nvPr/>
          </p:nvSpPr>
          <p:spPr>
            <a:xfrm>
              <a:off x="0" y="-24844"/>
              <a:ext cx="281359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upplementary Figure 7</a:t>
              </a:r>
              <a:endParaRPr lang="el-GR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AutoShape 3"/>
            <p:cNvSpPr>
              <a:spLocks noChangeAspect="1" noChangeArrowheads="1" noTextEdit="1"/>
            </p:cNvSpPr>
            <p:nvPr/>
          </p:nvSpPr>
          <p:spPr bwMode="auto">
            <a:xfrm>
              <a:off x="57150" y="657225"/>
              <a:ext cx="2700338" cy="1900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16" name="Rectangle 5"/>
            <p:cNvSpPr>
              <a:spLocks noChangeArrowheads="1"/>
            </p:cNvSpPr>
            <p:nvPr/>
          </p:nvSpPr>
          <p:spPr bwMode="auto">
            <a:xfrm>
              <a:off x="504825" y="2187575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el-GR" altLang="el-GR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" name="Rectangle 6"/>
            <p:cNvSpPr>
              <a:spLocks noChangeArrowheads="1"/>
            </p:cNvSpPr>
            <p:nvPr/>
          </p:nvSpPr>
          <p:spPr bwMode="auto">
            <a:xfrm>
              <a:off x="785813" y="2187575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</a:t>
              </a:r>
              <a:endParaRPr kumimoji="0" lang="el-GR" altLang="el-G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" name="Rectangle 7"/>
            <p:cNvSpPr>
              <a:spLocks noChangeArrowheads="1"/>
            </p:cNvSpPr>
            <p:nvPr/>
          </p:nvSpPr>
          <p:spPr bwMode="auto">
            <a:xfrm>
              <a:off x="1033463" y="2187575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</a:t>
              </a:r>
              <a:endParaRPr kumimoji="0" lang="el-GR" altLang="el-G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" name="Rectangle 8"/>
            <p:cNvSpPr>
              <a:spLocks noChangeArrowheads="1"/>
            </p:cNvSpPr>
            <p:nvPr/>
          </p:nvSpPr>
          <p:spPr bwMode="auto">
            <a:xfrm>
              <a:off x="1308100" y="2187575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5</a:t>
              </a:r>
              <a:endParaRPr kumimoji="0" lang="el-GR" altLang="el-GR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" name="Rectangle 9"/>
            <p:cNvSpPr>
              <a:spLocks noChangeArrowheads="1"/>
            </p:cNvSpPr>
            <p:nvPr/>
          </p:nvSpPr>
          <p:spPr bwMode="auto">
            <a:xfrm>
              <a:off x="1581150" y="2187575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</a:t>
              </a:r>
              <a:endParaRPr kumimoji="0" lang="el-GR" altLang="el-G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" name="Rectangle 10"/>
            <p:cNvSpPr>
              <a:spLocks noChangeArrowheads="1"/>
            </p:cNvSpPr>
            <p:nvPr/>
          </p:nvSpPr>
          <p:spPr bwMode="auto">
            <a:xfrm>
              <a:off x="1855788" y="2187575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5</a:t>
              </a:r>
              <a:endParaRPr kumimoji="0" lang="el-GR" altLang="el-G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" name="Rectangle 11"/>
            <p:cNvSpPr>
              <a:spLocks noChangeArrowheads="1"/>
            </p:cNvSpPr>
            <p:nvPr/>
          </p:nvSpPr>
          <p:spPr bwMode="auto">
            <a:xfrm>
              <a:off x="2130425" y="2187575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0</a:t>
              </a:r>
              <a:endParaRPr kumimoji="0" lang="el-GR" altLang="el-G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" name="Rectangle 12"/>
            <p:cNvSpPr>
              <a:spLocks noChangeArrowheads="1"/>
            </p:cNvSpPr>
            <p:nvPr/>
          </p:nvSpPr>
          <p:spPr bwMode="auto">
            <a:xfrm>
              <a:off x="2403475" y="2187575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5</a:t>
              </a:r>
              <a:endParaRPr kumimoji="0" lang="el-GR" altLang="el-GR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" name="Freeform 13"/>
            <p:cNvSpPr>
              <a:spLocks noEditPoints="1"/>
            </p:cNvSpPr>
            <p:nvPr/>
          </p:nvSpPr>
          <p:spPr bwMode="auto">
            <a:xfrm>
              <a:off x="528638" y="2120900"/>
              <a:ext cx="1938338" cy="53975"/>
            </a:xfrm>
            <a:custGeom>
              <a:avLst/>
              <a:gdLst>
                <a:gd name="T0" fmla="*/ 0 w 1221"/>
                <a:gd name="T1" fmla="*/ 0 h 34"/>
                <a:gd name="T2" fmla="*/ 1221 w 1221"/>
                <a:gd name="T3" fmla="*/ 0 h 34"/>
                <a:gd name="T4" fmla="*/ 4 w 1221"/>
                <a:gd name="T5" fmla="*/ 0 h 34"/>
                <a:gd name="T6" fmla="*/ 4 w 1221"/>
                <a:gd name="T7" fmla="*/ 34 h 34"/>
                <a:gd name="T8" fmla="*/ 178 w 1221"/>
                <a:gd name="T9" fmla="*/ 0 h 34"/>
                <a:gd name="T10" fmla="*/ 178 w 1221"/>
                <a:gd name="T11" fmla="*/ 34 h 34"/>
                <a:gd name="T12" fmla="*/ 351 w 1221"/>
                <a:gd name="T13" fmla="*/ 0 h 34"/>
                <a:gd name="T14" fmla="*/ 351 w 1221"/>
                <a:gd name="T15" fmla="*/ 34 h 34"/>
                <a:gd name="T16" fmla="*/ 524 w 1221"/>
                <a:gd name="T17" fmla="*/ 0 h 34"/>
                <a:gd name="T18" fmla="*/ 524 w 1221"/>
                <a:gd name="T19" fmla="*/ 34 h 34"/>
                <a:gd name="T20" fmla="*/ 697 w 1221"/>
                <a:gd name="T21" fmla="*/ 0 h 34"/>
                <a:gd name="T22" fmla="*/ 697 w 1221"/>
                <a:gd name="T23" fmla="*/ 34 h 34"/>
                <a:gd name="T24" fmla="*/ 870 w 1221"/>
                <a:gd name="T25" fmla="*/ 0 h 34"/>
                <a:gd name="T26" fmla="*/ 870 w 1221"/>
                <a:gd name="T27" fmla="*/ 34 h 34"/>
                <a:gd name="T28" fmla="*/ 1044 w 1221"/>
                <a:gd name="T29" fmla="*/ 0 h 34"/>
                <a:gd name="T30" fmla="*/ 1044 w 1221"/>
                <a:gd name="T31" fmla="*/ 34 h 34"/>
                <a:gd name="T32" fmla="*/ 1218 w 1221"/>
                <a:gd name="T33" fmla="*/ 0 h 34"/>
                <a:gd name="T34" fmla="*/ 1218 w 1221"/>
                <a:gd name="T35" fmla="*/ 34 h 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221" h="34">
                  <a:moveTo>
                    <a:pt x="0" y="0"/>
                  </a:moveTo>
                  <a:lnTo>
                    <a:pt x="1221" y="0"/>
                  </a:lnTo>
                  <a:moveTo>
                    <a:pt x="4" y="0"/>
                  </a:moveTo>
                  <a:lnTo>
                    <a:pt x="4" y="34"/>
                  </a:lnTo>
                  <a:moveTo>
                    <a:pt x="178" y="0"/>
                  </a:moveTo>
                  <a:lnTo>
                    <a:pt x="178" y="34"/>
                  </a:lnTo>
                  <a:moveTo>
                    <a:pt x="351" y="0"/>
                  </a:moveTo>
                  <a:lnTo>
                    <a:pt x="351" y="34"/>
                  </a:lnTo>
                  <a:moveTo>
                    <a:pt x="524" y="0"/>
                  </a:moveTo>
                  <a:lnTo>
                    <a:pt x="524" y="34"/>
                  </a:lnTo>
                  <a:moveTo>
                    <a:pt x="697" y="0"/>
                  </a:moveTo>
                  <a:lnTo>
                    <a:pt x="697" y="34"/>
                  </a:lnTo>
                  <a:moveTo>
                    <a:pt x="870" y="0"/>
                  </a:moveTo>
                  <a:lnTo>
                    <a:pt x="870" y="34"/>
                  </a:lnTo>
                  <a:moveTo>
                    <a:pt x="1044" y="0"/>
                  </a:moveTo>
                  <a:lnTo>
                    <a:pt x="1044" y="34"/>
                  </a:lnTo>
                  <a:moveTo>
                    <a:pt x="1218" y="0"/>
                  </a:moveTo>
                  <a:lnTo>
                    <a:pt x="1218" y="34"/>
                  </a:lnTo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25" name="Rectangle 14"/>
            <p:cNvSpPr>
              <a:spLocks noChangeArrowheads="1"/>
            </p:cNvSpPr>
            <p:nvPr/>
          </p:nvSpPr>
          <p:spPr bwMode="auto">
            <a:xfrm>
              <a:off x="411163" y="2060575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el-GR" altLang="el-G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" name="Rectangle 15"/>
            <p:cNvSpPr>
              <a:spLocks noChangeArrowheads="1"/>
            </p:cNvSpPr>
            <p:nvPr/>
          </p:nvSpPr>
          <p:spPr bwMode="auto">
            <a:xfrm>
              <a:off x="358775" y="1806575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</a:t>
              </a:r>
              <a:endParaRPr kumimoji="0" lang="el-GR" altLang="el-G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" name="Rectangle 16"/>
            <p:cNvSpPr>
              <a:spLocks noChangeArrowheads="1"/>
            </p:cNvSpPr>
            <p:nvPr/>
          </p:nvSpPr>
          <p:spPr bwMode="auto">
            <a:xfrm>
              <a:off x="358775" y="1546225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0</a:t>
              </a:r>
              <a:endParaRPr kumimoji="0" lang="el-GR" altLang="el-G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" name="Rectangle 17"/>
            <p:cNvSpPr>
              <a:spLocks noChangeArrowheads="1"/>
            </p:cNvSpPr>
            <p:nvPr/>
          </p:nvSpPr>
          <p:spPr bwMode="auto">
            <a:xfrm>
              <a:off x="358775" y="1292225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0</a:t>
              </a:r>
              <a:endParaRPr kumimoji="0" lang="el-GR" altLang="el-G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" name="Rectangle 18"/>
            <p:cNvSpPr>
              <a:spLocks noChangeArrowheads="1"/>
            </p:cNvSpPr>
            <p:nvPr/>
          </p:nvSpPr>
          <p:spPr bwMode="auto">
            <a:xfrm>
              <a:off x="358775" y="1038225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0</a:t>
              </a:r>
              <a:endParaRPr kumimoji="0" lang="el-GR" altLang="el-G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" name="Rectangle 19"/>
            <p:cNvSpPr>
              <a:spLocks noChangeArrowheads="1"/>
            </p:cNvSpPr>
            <p:nvPr/>
          </p:nvSpPr>
          <p:spPr bwMode="auto">
            <a:xfrm>
              <a:off x="304800" y="777875"/>
              <a:ext cx="17312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</a:t>
              </a:r>
              <a:endParaRPr kumimoji="0" lang="el-GR" altLang="el-GR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" name="Freeform 20"/>
            <p:cNvSpPr>
              <a:spLocks noEditPoints="1"/>
            </p:cNvSpPr>
            <p:nvPr/>
          </p:nvSpPr>
          <p:spPr bwMode="auto">
            <a:xfrm>
              <a:off x="481013" y="830263"/>
              <a:ext cx="53975" cy="1296988"/>
            </a:xfrm>
            <a:custGeom>
              <a:avLst/>
              <a:gdLst>
                <a:gd name="T0" fmla="*/ 34 w 34"/>
                <a:gd name="T1" fmla="*/ 817 h 817"/>
                <a:gd name="T2" fmla="*/ 34 w 34"/>
                <a:gd name="T3" fmla="*/ 0 h 817"/>
                <a:gd name="T4" fmla="*/ 34 w 34"/>
                <a:gd name="T5" fmla="*/ 813 h 817"/>
                <a:gd name="T6" fmla="*/ 0 w 34"/>
                <a:gd name="T7" fmla="*/ 813 h 817"/>
                <a:gd name="T8" fmla="*/ 34 w 34"/>
                <a:gd name="T9" fmla="*/ 651 h 817"/>
                <a:gd name="T10" fmla="*/ 0 w 34"/>
                <a:gd name="T11" fmla="*/ 651 h 817"/>
                <a:gd name="T12" fmla="*/ 34 w 34"/>
                <a:gd name="T13" fmla="*/ 489 h 817"/>
                <a:gd name="T14" fmla="*/ 0 w 34"/>
                <a:gd name="T15" fmla="*/ 489 h 817"/>
                <a:gd name="T16" fmla="*/ 34 w 34"/>
                <a:gd name="T17" fmla="*/ 328 h 817"/>
                <a:gd name="T18" fmla="*/ 0 w 34"/>
                <a:gd name="T19" fmla="*/ 328 h 817"/>
                <a:gd name="T20" fmla="*/ 34 w 34"/>
                <a:gd name="T21" fmla="*/ 166 h 817"/>
                <a:gd name="T22" fmla="*/ 0 w 34"/>
                <a:gd name="T23" fmla="*/ 166 h 817"/>
                <a:gd name="T24" fmla="*/ 34 w 34"/>
                <a:gd name="T25" fmla="*/ 4 h 817"/>
                <a:gd name="T26" fmla="*/ 0 w 34"/>
                <a:gd name="T27" fmla="*/ 4 h 8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34" h="817">
                  <a:moveTo>
                    <a:pt x="34" y="817"/>
                  </a:moveTo>
                  <a:lnTo>
                    <a:pt x="34" y="0"/>
                  </a:lnTo>
                  <a:moveTo>
                    <a:pt x="34" y="813"/>
                  </a:moveTo>
                  <a:lnTo>
                    <a:pt x="0" y="813"/>
                  </a:lnTo>
                  <a:moveTo>
                    <a:pt x="34" y="651"/>
                  </a:moveTo>
                  <a:lnTo>
                    <a:pt x="0" y="651"/>
                  </a:lnTo>
                  <a:moveTo>
                    <a:pt x="34" y="489"/>
                  </a:moveTo>
                  <a:lnTo>
                    <a:pt x="0" y="489"/>
                  </a:lnTo>
                  <a:moveTo>
                    <a:pt x="34" y="328"/>
                  </a:moveTo>
                  <a:lnTo>
                    <a:pt x="0" y="328"/>
                  </a:lnTo>
                  <a:moveTo>
                    <a:pt x="34" y="166"/>
                  </a:moveTo>
                  <a:lnTo>
                    <a:pt x="0" y="166"/>
                  </a:lnTo>
                  <a:moveTo>
                    <a:pt x="34" y="4"/>
                  </a:moveTo>
                  <a:lnTo>
                    <a:pt x="0" y="4"/>
                  </a:lnTo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32" name="Freeform 21"/>
            <p:cNvSpPr>
              <a:spLocks noEditPoints="1"/>
            </p:cNvSpPr>
            <p:nvPr/>
          </p:nvSpPr>
          <p:spPr bwMode="auto">
            <a:xfrm>
              <a:off x="534988" y="827088"/>
              <a:ext cx="1487488" cy="1303338"/>
            </a:xfrm>
            <a:custGeom>
              <a:avLst/>
              <a:gdLst>
                <a:gd name="T0" fmla="*/ 92 w 3558"/>
                <a:gd name="T1" fmla="*/ 49 h 3120"/>
                <a:gd name="T2" fmla="*/ 322 w 3558"/>
                <a:gd name="T3" fmla="*/ 3 h 3120"/>
                <a:gd name="T4" fmla="*/ 207 w 3558"/>
                <a:gd name="T5" fmla="*/ 26 h 3120"/>
                <a:gd name="T6" fmla="*/ 548 w 3558"/>
                <a:gd name="T7" fmla="*/ 26 h 3120"/>
                <a:gd name="T8" fmla="*/ 461 w 3558"/>
                <a:gd name="T9" fmla="*/ 3 h 3120"/>
                <a:gd name="T10" fmla="*/ 544 w 3558"/>
                <a:gd name="T11" fmla="*/ 56 h 3120"/>
                <a:gd name="T12" fmla="*/ 689 w 3558"/>
                <a:gd name="T13" fmla="*/ 58 h 3120"/>
                <a:gd name="T14" fmla="*/ 675 w 3558"/>
                <a:gd name="T15" fmla="*/ 101 h 3120"/>
                <a:gd name="T16" fmla="*/ 929 w 3558"/>
                <a:gd name="T17" fmla="*/ 139 h 3120"/>
                <a:gd name="T18" fmla="*/ 878 w 3558"/>
                <a:gd name="T19" fmla="*/ 146 h 3120"/>
                <a:gd name="T20" fmla="*/ 1000 w 3558"/>
                <a:gd name="T21" fmla="*/ 210 h 3120"/>
                <a:gd name="T22" fmla="*/ 933 w 3558"/>
                <a:gd name="T23" fmla="*/ 142 h 3120"/>
                <a:gd name="T24" fmla="*/ 1165 w 3558"/>
                <a:gd name="T25" fmla="*/ 338 h 3120"/>
                <a:gd name="T26" fmla="*/ 1275 w 3558"/>
                <a:gd name="T27" fmla="*/ 418 h 3120"/>
                <a:gd name="T28" fmla="*/ 1237 w 3558"/>
                <a:gd name="T29" fmla="*/ 444 h 3120"/>
                <a:gd name="T30" fmla="*/ 1444 w 3558"/>
                <a:gd name="T31" fmla="*/ 695 h 3120"/>
                <a:gd name="T32" fmla="*/ 1366 w 3558"/>
                <a:gd name="T33" fmla="*/ 607 h 3120"/>
                <a:gd name="T34" fmla="*/ 1553 w 3558"/>
                <a:gd name="T35" fmla="*/ 924 h 3120"/>
                <a:gd name="T36" fmla="*/ 1514 w 3558"/>
                <a:gd name="T37" fmla="*/ 814 h 3120"/>
                <a:gd name="T38" fmla="*/ 1624 w 3558"/>
                <a:gd name="T39" fmla="*/ 1120 h 3120"/>
                <a:gd name="T40" fmla="*/ 1724 w 3558"/>
                <a:gd name="T41" fmla="*/ 1226 h 3120"/>
                <a:gd name="T42" fmla="*/ 1683 w 3558"/>
                <a:gd name="T43" fmla="*/ 1245 h 3120"/>
                <a:gd name="T44" fmla="*/ 1783 w 3558"/>
                <a:gd name="T45" fmla="*/ 1283 h 3120"/>
                <a:gd name="T46" fmla="*/ 1693 w 3558"/>
                <a:gd name="T47" fmla="*/ 1234 h 3120"/>
                <a:gd name="T48" fmla="*/ 1924 w 3558"/>
                <a:gd name="T49" fmla="*/ 1497 h 3120"/>
                <a:gd name="T50" fmla="*/ 1882 w 3558"/>
                <a:gd name="T51" fmla="*/ 1387 h 3120"/>
                <a:gd name="T52" fmla="*/ 2014 w 3558"/>
                <a:gd name="T53" fmla="*/ 1685 h 3120"/>
                <a:gd name="T54" fmla="*/ 2127 w 3558"/>
                <a:gd name="T55" fmla="*/ 1780 h 3120"/>
                <a:gd name="T56" fmla="*/ 2085 w 3558"/>
                <a:gd name="T57" fmla="*/ 1800 h 3120"/>
                <a:gd name="T58" fmla="*/ 2258 w 3558"/>
                <a:gd name="T59" fmla="*/ 2059 h 3120"/>
                <a:gd name="T60" fmla="*/ 2194 w 3558"/>
                <a:gd name="T61" fmla="*/ 1978 h 3120"/>
                <a:gd name="T62" fmla="*/ 2252 w 3558"/>
                <a:gd name="T63" fmla="*/ 2104 h 3120"/>
                <a:gd name="T64" fmla="*/ 2259 w 3558"/>
                <a:gd name="T65" fmla="*/ 2060 h 3120"/>
                <a:gd name="T66" fmla="*/ 2309 w 3558"/>
                <a:gd name="T67" fmla="*/ 2304 h 3120"/>
                <a:gd name="T68" fmla="*/ 2408 w 3558"/>
                <a:gd name="T69" fmla="*/ 2407 h 3120"/>
                <a:gd name="T70" fmla="*/ 2370 w 3558"/>
                <a:gd name="T71" fmla="*/ 2433 h 3120"/>
                <a:gd name="T72" fmla="*/ 2615 w 3558"/>
                <a:gd name="T73" fmla="*/ 2639 h 3120"/>
                <a:gd name="T74" fmla="*/ 2509 w 3558"/>
                <a:gd name="T75" fmla="*/ 2589 h 3120"/>
                <a:gd name="T76" fmla="*/ 2781 w 3558"/>
                <a:gd name="T77" fmla="*/ 2824 h 3120"/>
                <a:gd name="T78" fmla="*/ 2720 w 3558"/>
                <a:gd name="T79" fmla="*/ 2733 h 3120"/>
                <a:gd name="T80" fmla="*/ 2767 w 3558"/>
                <a:gd name="T81" fmla="*/ 2832 h 3120"/>
                <a:gd name="T82" fmla="*/ 2912 w 3558"/>
                <a:gd name="T83" fmla="*/ 2821 h 3120"/>
                <a:gd name="T84" fmla="*/ 2901 w 3558"/>
                <a:gd name="T85" fmla="*/ 2865 h 3120"/>
                <a:gd name="T86" fmla="*/ 3169 w 3558"/>
                <a:gd name="T87" fmla="*/ 2918 h 3120"/>
                <a:gd name="T88" fmla="*/ 3101 w 3558"/>
                <a:gd name="T89" fmla="*/ 2910 h 3120"/>
                <a:gd name="T90" fmla="*/ 3225 w 3558"/>
                <a:gd name="T91" fmla="*/ 2971 h 3120"/>
                <a:gd name="T92" fmla="*/ 3169 w 3558"/>
                <a:gd name="T93" fmla="*/ 2918 h 3120"/>
                <a:gd name="T94" fmla="*/ 3402 w 3558"/>
                <a:gd name="T95" fmla="*/ 3082 h 3120"/>
                <a:gd name="T96" fmla="*/ 3551 w 3558"/>
                <a:gd name="T97" fmla="*/ 3073 h 3120"/>
                <a:gd name="T98" fmla="*/ 3523 w 3558"/>
                <a:gd name="T99" fmla="*/ 3090 h 31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</a:cxnLst>
              <a:rect l="0" t="0" r="r" b="b"/>
              <a:pathLst>
                <a:path w="3558" h="3120">
                  <a:moveTo>
                    <a:pt x="0" y="3"/>
                  </a:moveTo>
                  <a:lnTo>
                    <a:pt x="92" y="3"/>
                  </a:lnTo>
                  <a:cubicBezTo>
                    <a:pt x="105" y="3"/>
                    <a:pt x="115" y="13"/>
                    <a:pt x="115" y="26"/>
                  </a:cubicBezTo>
                  <a:cubicBezTo>
                    <a:pt x="115" y="38"/>
                    <a:pt x="105" y="49"/>
                    <a:pt x="92" y="49"/>
                  </a:cubicBezTo>
                  <a:lnTo>
                    <a:pt x="0" y="49"/>
                  </a:lnTo>
                  <a:lnTo>
                    <a:pt x="0" y="3"/>
                  </a:lnTo>
                  <a:close/>
                  <a:moveTo>
                    <a:pt x="230" y="3"/>
                  </a:moveTo>
                  <a:lnTo>
                    <a:pt x="322" y="3"/>
                  </a:lnTo>
                  <a:cubicBezTo>
                    <a:pt x="335" y="3"/>
                    <a:pt x="345" y="13"/>
                    <a:pt x="345" y="26"/>
                  </a:cubicBezTo>
                  <a:cubicBezTo>
                    <a:pt x="345" y="38"/>
                    <a:pt x="335" y="49"/>
                    <a:pt x="322" y="49"/>
                  </a:cubicBezTo>
                  <a:lnTo>
                    <a:pt x="230" y="49"/>
                  </a:lnTo>
                  <a:cubicBezTo>
                    <a:pt x="217" y="49"/>
                    <a:pt x="207" y="38"/>
                    <a:pt x="207" y="26"/>
                  </a:cubicBezTo>
                  <a:cubicBezTo>
                    <a:pt x="207" y="13"/>
                    <a:pt x="217" y="3"/>
                    <a:pt x="230" y="3"/>
                  </a:cubicBezTo>
                  <a:close/>
                  <a:moveTo>
                    <a:pt x="461" y="3"/>
                  </a:moveTo>
                  <a:lnTo>
                    <a:pt x="525" y="3"/>
                  </a:lnTo>
                  <a:cubicBezTo>
                    <a:pt x="537" y="3"/>
                    <a:pt x="548" y="13"/>
                    <a:pt x="548" y="26"/>
                  </a:cubicBezTo>
                  <a:cubicBezTo>
                    <a:pt x="548" y="38"/>
                    <a:pt x="537" y="49"/>
                    <a:pt x="525" y="49"/>
                  </a:cubicBezTo>
                  <a:lnTo>
                    <a:pt x="461" y="49"/>
                  </a:lnTo>
                  <a:cubicBezTo>
                    <a:pt x="448" y="49"/>
                    <a:pt x="438" y="38"/>
                    <a:pt x="438" y="26"/>
                  </a:cubicBezTo>
                  <a:cubicBezTo>
                    <a:pt x="438" y="13"/>
                    <a:pt x="448" y="3"/>
                    <a:pt x="461" y="3"/>
                  </a:cubicBezTo>
                  <a:close/>
                  <a:moveTo>
                    <a:pt x="532" y="4"/>
                  </a:moveTo>
                  <a:lnTo>
                    <a:pt x="559" y="13"/>
                  </a:lnTo>
                  <a:cubicBezTo>
                    <a:pt x="571" y="17"/>
                    <a:pt x="577" y="30"/>
                    <a:pt x="573" y="42"/>
                  </a:cubicBezTo>
                  <a:cubicBezTo>
                    <a:pt x="569" y="54"/>
                    <a:pt x="556" y="61"/>
                    <a:pt x="544" y="56"/>
                  </a:cubicBezTo>
                  <a:lnTo>
                    <a:pt x="517" y="47"/>
                  </a:lnTo>
                  <a:cubicBezTo>
                    <a:pt x="505" y="43"/>
                    <a:pt x="499" y="30"/>
                    <a:pt x="503" y="18"/>
                  </a:cubicBezTo>
                  <a:cubicBezTo>
                    <a:pt x="507" y="6"/>
                    <a:pt x="520" y="0"/>
                    <a:pt x="532" y="4"/>
                  </a:cubicBezTo>
                  <a:close/>
                  <a:moveTo>
                    <a:pt x="689" y="58"/>
                  </a:moveTo>
                  <a:lnTo>
                    <a:pt x="777" y="87"/>
                  </a:lnTo>
                  <a:cubicBezTo>
                    <a:pt x="789" y="92"/>
                    <a:pt x="795" y="105"/>
                    <a:pt x="791" y="117"/>
                  </a:cubicBezTo>
                  <a:cubicBezTo>
                    <a:pt x="787" y="129"/>
                    <a:pt x="774" y="135"/>
                    <a:pt x="762" y="131"/>
                  </a:cubicBezTo>
                  <a:lnTo>
                    <a:pt x="675" y="101"/>
                  </a:lnTo>
                  <a:cubicBezTo>
                    <a:pt x="663" y="97"/>
                    <a:pt x="656" y="84"/>
                    <a:pt x="660" y="72"/>
                  </a:cubicBezTo>
                  <a:cubicBezTo>
                    <a:pt x="664" y="60"/>
                    <a:pt x="677" y="53"/>
                    <a:pt x="689" y="58"/>
                  </a:cubicBezTo>
                  <a:close/>
                  <a:moveTo>
                    <a:pt x="907" y="132"/>
                  </a:moveTo>
                  <a:lnTo>
                    <a:pt x="929" y="139"/>
                  </a:lnTo>
                  <a:cubicBezTo>
                    <a:pt x="941" y="144"/>
                    <a:pt x="947" y="157"/>
                    <a:pt x="943" y="169"/>
                  </a:cubicBezTo>
                  <a:cubicBezTo>
                    <a:pt x="939" y="181"/>
                    <a:pt x="926" y="187"/>
                    <a:pt x="914" y="183"/>
                  </a:cubicBezTo>
                  <a:lnTo>
                    <a:pt x="893" y="176"/>
                  </a:lnTo>
                  <a:cubicBezTo>
                    <a:pt x="881" y="172"/>
                    <a:pt x="874" y="159"/>
                    <a:pt x="878" y="146"/>
                  </a:cubicBezTo>
                  <a:cubicBezTo>
                    <a:pt x="882" y="134"/>
                    <a:pt x="895" y="128"/>
                    <a:pt x="907" y="132"/>
                  </a:cubicBezTo>
                  <a:close/>
                  <a:moveTo>
                    <a:pt x="933" y="142"/>
                  </a:moveTo>
                  <a:lnTo>
                    <a:pt x="993" y="178"/>
                  </a:lnTo>
                  <a:cubicBezTo>
                    <a:pt x="1004" y="185"/>
                    <a:pt x="1007" y="199"/>
                    <a:pt x="1000" y="210"/>
                  </a:cubicBezTo>
                  <a:cubicBezTo>
                    <a:pt x="994" y="221"/>
                    <a:pt x="979" y="224"/>
                    <a:pt x="968" y="217"/>
                  </a:cubicBezTo>
                  <a:lnTo>
                    <a:pt x="909" y="181"/>
                  </a:lnTo>
                  <a:cubicBezTo>
                    <a:pt x="898" y="174"/>
                    <a:pt x="895" y="160"/>
                    <a:pt x="902" y="149"/>
                  </a:cubicBezTo>
                  <a:cubicBezTo>
                    <a:pt x="908" y="138"/>
                    <a:pt x="923" y="135"/>
                    <a:pt x="933" y="142"/>
                  </a:cubicBezTo>
                  <a:close/>
                  <a:moveTo>
                    <a:pt x="1110" y="251"/>
                  </a:moveTo>
                  <a:lnTo>
                    <a:pt x="1189" y="299"/>
                  </a:lnTo>
                  <a:cubicBezTo>
                    <a:pt x="1200" y="306"/>
                    <a:pt x="1203" y="320"/>
                    <a:pt x="1196" y="331"/>
                  </a:cubicBezTo>
                  <a:cubicBezTo>
                    <a:pt x="1190" y="342"/>
                    <a:pt x="1175" y="345"/>
                    <a:pt x="1165" y="338"/>
                  </a:cubicBezTo>
                  <a:lnTo>
                    <a:pt x="1086" y="290"/>
                  </a:lnTo>
                  <a:cubicBezTo>
                    <a:pt x="1075" y="283"/>
                    <a:pt x="1072" y="269"/>
                    <a:pt x="1079" y="258"/>
                  </a:cubicBezTo>
                  <a:cubicBezTo>
                    <a:pt x="1085" y="248"/>
                    <a:pt x="1100" y="244"/>
                    <a:pt x="1110" y="251"/>
                  </a:cubicBezTo>
                  <a:close/>
                  <a:moveTo>
                    <a:pt x="1275" y="418"/>
                  </a:moveTo>
                  <a:lnTo>
                    <a:pt x="1327" y="495"/>
                  </a:lnTo>
                  <a:cubicBezTo>
                    <a:pt x="1334" y="505"/>
                    <a:pt x="1331" y="520"/>
                    <a:pt x="1320" y="527"/>
                  </a:cubicBezTo>
                  <a:cubicBezTo>
                    <a:pt x="1310" y="534"/>
                    <a:pt x="1296" y="531"/>
                    <a:pt x="1288" y="521"/>
                  </a:cubicBezTo>
                  <a:lnTo>
                    <a:pt x="1237" y="444"/>
                  </a:lnTo>
                  <a:cubicBezTo>
                    <a:pt x="1230" y="434"/>
                    <a:pt x="1233" y="419"/>
                    <a:pt x="1243" y="412"/>
                  </a:cubicBezTo>
                  <a:cubicBezTo>
                    <a:pt x="1254" y="405"/>
                    <a:pt x="1268" y="408"/>
                    <a:pt x="1275" y="418"/>
                  </a:cubicBezTo>
                  <a:close/>
                  <a:moveTo>
                    <a:pt x="1398" y="615"/>
                  </a:moveTo>
                  <a:lnTo>
                    <a:pt x="1444" y="695"/>
                  </a:lnTo>
                  <a:cubicBezTo>
                    <a:pt x="1450" y="706"/>
                    <a:pt x="1447" y="720"/>
                    <a:pt x="1436" y="726"/>
                  </a:cubicBezTo>
                  <a:cubicBezTo>
                    <a:pt x="1424" y="733"/>
                    <a:pt x="1410" y="729"/>
                    <a:pt x="1404" y="718"/>
                  </a:cubicBezTo>
                  <a:lnTo>
                    <a:pt x="1358" y="638"/>
                  </a:lnTo>
                  <a:cubicBezTo>
                    <a:pt x="1351" y="627"/>
                    <a:pt x="1355" y="613"/>
                    <a:pt x="1366" y="607"/>
                  </a:cubicBezTo>
                  <a:cubicBezTo>
                    <a:pt x="1377" y="600"/>
                    <a:pt x="1391" y="604"/>
                    <a:pt x="1398" y="615"/>
                  </a:cubicBezTo>
                  <a:close/>
                  <a:moveTo>
                    <a:pt x="1514" y="814"/>
                  </a:moveTo>
                  <a:lnTo>
                    <a:pt x="1561" y="893"/>
                  </a:lnTo>
                  <a:cubicBezTo>
                    <a:pt x="1568" y="904"/>
                    <a:pt x="1564" y="918"/>
                    <a:pt x="1553" y="924"/>
                  </a:cubicBezTo>
                  <a:cubicBezTo>
                    <a:pt x="1543" y="931"/>
                    <a:pt x="1528" y="927"/>
                    <a:pt x="1522" y="916"/>
                  </a:cubicBezTo>
                  <a:lnTo>
                    <a:pt x="1475" y="837"/>
                  </a:lnTo>
                  <a:cubicBezTo>
                    <a:pt x="1468" y="826"/>
                    <a:pt x="1472" y="812"/>
                    <a:pt x="1483" y="806"/>
                  </a:cubicBezTo>
                  <a:cubicBezTo>
                    <a:pt x="1493" y="799"/>
                    <a:pt x="1508" y="803"/>
                    <a:pt x="1514" y="814"/>
                  </a:cubicBezTo>
                  <a:close/>
                  <a:moveTo>
                    <a:pt x="1627" y="1017"/>
                  </a:moveTo>
                  <a:lnTo>
                    <a:pt x="1666" y="1100"/>
                  </a:lnTo>
                  <a:cubicBezTo>
                    <a:pt x="1672" y="1112"/>
                    <a:pt x="1667" y="1126"/>
                    <a:pt x="1655" y="1131"/>
                  </a:cubicBezTo>
                  <a:cubicBezTo>
                    <a:pt x="1643" y="1136"/>
                    <a:pt x="1630" y="1131"/>
                    <a:pt x="1624" y="1120"/>
                  </a:cubicBezTo>
                  <a:lnTo>
                    <a:pt x="1586" y="1036"/>
                  </a:lnTo>
                  <a:cubicBezTo>
                    <a:pt x="1580" y="1025"/>
                    <a:pt x="1585" y="1011"/>
                    <a:pt x="1597" y="1006"/>
                  </a:cubicBezTo>
                  <a:cubicBezTo>
                    <a:pt x="1608" y="1000"/>
                    <a:pt x="1622" y="1005"/>
                    <a:pt x="1627" y="1017"/>
                  </a:cubicBezTo>
                  <a:close/>
                  <a:moveTo>
                    <a:pt x="1724" y="1226"/>
                  </a:moveTo>
                  <a:lnTo>
                    <a:pt x="1731" y="1240"/>
                  </a:lnTo>
                  <a:cubicBezTo>
                    <a:pt x="1736" y="1251"/>
                    <a:pt x="1731" y="1265"/>
                    <a:pt x="1720" y="1270"/>
                  </a:cubicBezTo>
                  <a:cubicBezTo>
                    <a:pt x="1708" y="1275"/>
                    <a:pt x="1694" y="1270"/>
                    <a:pt x="1689" y="1259"/>
                  </a:cubicBezTo>
                  <a:lnTo>
                    <a:pt x="1683" y="1245"/>
                  </a:lnTo>
                  <a:cubicBezTo>
                    <a:pt x="1677" y="1234"/>
                    <a:pt x="1682" y="1220"/>
                    <a:pt x="1694" y="1215"/>
                  </a:cubicBezTo>
                  <a:cubicBezTo>
                    <a:pt x="1705" y="1209"/>
                    <a:pt x="1719" y="1214"/>
                    <a:pt x="1724" y="1226"/>
                  </a:cubicBezTo>
                  <a:close/>
                  <a:moveTo>
                    <a:pt x="1725" y="1232"/>
                  </a:moveTo>
                  <a:lnTo>
                    <a:pt x="1783" y="1283"/>
                  </a:lnTo>
                  <a:cubicBezTo>
                    <a:pt x="1792" y="1291"/>
                    <a:pt x="1793" y="1306"/>
                    <a:pt x="1785" y="1316"/>
                  </a:cubicBezTo>
                  <a:cubicBezTo>
                    <a:pt x="1776" y="1325"/>
                    <a:pt x="1762" y="1326"/>
                    <a:pt x="1752" y="1317"/>
                  </a:cubicBezTo>
                  <a:lnTo>
                    <a:pt x="1695" y="1266"/>
                  </a:lnTo>
                  <a:cubicBezTo>
                    <a:pt x="1685" y="1258"/>
                    <a:pt x="1684" y="1243"/>
                    <a:pt x="1693" y="1234"/>
                  </a:cubicBezTo>
                  <a:cubicBezTo>
                    <a:pt x="1701" y="1224"/>
                    <a:pt x="1716" y="1224"/>
                    <a:pt x="1725" y="1232"/>
                  </a:cubicBezTo>
                  <a:close/>
                  <a:moveTo>
                    <a:pt x="1882" y="1387"/>
                  </a:moveTo>
                  <a:lnTo>
                    <a:pt x="1931" y="1465"/>
                  </a:lnTo>
                  <a:cubicBezTo>
                    <a:pt x="1938" y="1476"/>
                    <a:pt x="1934" y="1490"/>
                    <a:pt x="1924" y="1497"/>
                  </a:cubicBezTo>
                  <a:cubicBezTo>
                    <a:pt x="1913" y="1503"/>
                    <a:pt x="1899" y="1500"/>
                    <a:pt x="1892" y="1489"/>
                  </a:cubicBezTo>
                  <a:lnTo>
                    <a:pt x="1843" y="1411"/>
                  </a:lnTo>
                  <a:cubicBezTo>
                    <a:pt x="1837" y="1400"/>
                    <a:pt x="1840" y="1386"/>
                    <a:pt x="1851" y="1379"/>
                  </a:cubicBezTo>
                  <a:cubicBezTo>
                    <a:pt x="1861" y="1373"/>
                    <a:pt x="1876" y="1376"/>
                    <a:pt x="1882" y="1387"/>
                  </a:cubicBezTo>
                  <a:close/>
                  <a:moveTo>
                    <a:pt x="2004" y="1582"/>
                  </a:moveTo>
                  <a:lnTo>
                    <a:pt x="2053" y="1661"/>
                  </a:lnTo>
                  <a:cubicBezTo>
                    <a:pt x="2059" y="1671"/>
                    <a:pt x="2056" y="1686"/>
                    <a:pt x="2045" y="1692"/>
                  </a:cubicBezTo>
                  <a:cubicBezTo>
                    <a:pt x="2035" y="1699"/>
                    <a:pt x="2020" y="1696"/>
                    <a:pt x="2014" y="1685"/>
                  </a:cubicBezTo>
                  <a:lnTo>
                    <a:pt x="1965" y="1607"/>
                  </a:lnTo>
                  <a:cubicBezTo>
                    <a:pt x="1958" y="1596"/>
                    <a:pt x="1961" y="1582"/>
                    <a:pt x="1972" y="1575"/>
                  </a:cubicBezTo>
                  <a:cubicBezTo>
                    <a:pt x="1983" y="1568"/>
                    <a:pt x="1997" y="1572"/>
                    <a:pt x="2004" y="1582"/>
                  </a:cubicBezTo>
                  <a:close/>
                  <a:moveTo>
                    <a:pt x="2127" y="1780"/>
                  </a:moveTo>
                  <a:lnTo>
                    <a:pt x="2166" y="1864"/>
                  </a:lnTo>
                  <a:cubicBezTo>
                    <a:pt x="2171" y="1875"/>
                    <a:pt x="2167" y="1889"/>
                    <a:pt x="2155" y="1894"/>
                  </a:cubicBezTo>
                  <a:cubicBezTo>
                    <a:pt x="2143" y="1900"/>
                    <a:pt x="2130" y="1895"/>
                    <a:pt x="2124" y="1883"/>
                  </a:cubicBezTo>
                  <a:lnTo>
                    <a:pt x="2085" y="1800"/>
                  </a:lnTo>
                  <a:cubicBezTo>
                    <a:pt x="2079" y="1789"/>
                    <a:pt x="2084" y="1775"/>
                    <a:pt x="2096" y="1770"/>
                  </a:cubicBezTo>
                  <a:cubicBezTo>
                    <a:pt x="2107" y="1764"/>
                    <a:pt x="2121" y="1769"/>
                    <a:pt x="2127" y="1780"/>
                  </a:cubicBezTo>
                  <a:close/>
                  <a:moveTo>
                    <a:pt x="2225" y="1989"/>
                  </a:moveTo>
                  <a:lnTo>
                    <a:pt x="2258" y="2059"/>
                  </a:lnTo>
                  <a:cubicBezTo>
                    <a:pt x="2263" y="2070"/>
                    <a:pt x="2259" y="2084"/>
                    <a:pt x="2247" y="2089"/>
                  </a:cubicBezTo>
                  <a:cubicBezTo>
                    <a:pt x="2236" y="2095"/>
                    <a:pt x="2222" y="2090"/>
                    <a:pt x="2216" y="2078"/>
                  </a:cubicBezTo>
                  <a:lnTo>
                    <a:pt x="2183" y="2008"/>
                  </a:lnTo>
                  <a:cubicBezTo>
                    <a:pt x="2178" y="1997"/>
                    <a:pt x="2183" y="1983"/>
                    <a:pt x="2194" y="1978"/>
                  </a:cubicBezTo>
                  <a:cubicBezTo>
                    <a:pt x="2206" y="1972"/>
                    <a:pt x="2220" y="1977"/>
                    <a:pt x="2225" y="1989"/>
                  </a:cubicBezTo>
                  <a:close/>
                  <a:moveTo>
                    <a:pt x="2259" y="2060"/>
                  </a:moveTo>
                  <a:lnTo>
                    <a:pt x="2264" y="2074"/>
                  </a:lnTo>
                  <a:cubicBezTo>
                    <a:pt x="2269" y="2085"/>
                    <a:pt x="2263" y="2099"/>
                    <a:pt x="2252" y="2104"/>
                  </a:cubicBezTo>
                  <a:cubicBezTo>
                    <a:pt x="2240" y="2108"/>
                    <a:pt x="2226" y="2103"/>
                    <a:pt x="2222" y="2091"/>
                  </a:cubicBezTo>
                  <a:lnTo>
                    <a:pt x="2216" y="2077"/>
                  </a:lnTo>
                  <a:cubicBezTo>
                    <a:pt x="2211" y="2065"/>
                    <a:pt x="2217" y="2052"/>
                    <a:pt x="2229" y="2047"/>
                  </a:cubicBezTo>
                  <a:cubicBezTo>
                    <a:pt x="2240" y="2042"/>
                    <a:pt x="2254" y="2048"/>
                    <a:pt x="2259" y="2060"/>
                  </a:cubicBezTo>
                  <a:close/>
                  <a:moveTo>
                    <a:pt x="2316" y="2202"/>
                  </a:moveTo>
                  <a:lnTo>
                    <a:pt x="2351" y="2287"/>
                  </a:lnTo>
                  <a:cubicBezTo>
                    <a:pt x="2356" y="2299"/>
                    <a:pt x="2350" y="2312"/>
                    <a:pt x="2339" y="2317"/>
                  </a:cubicBezTo>
                  <a:cubicBezTo>
                    <a:pt x="2327" y="2322"/>
                    <a:pt x="2313" y="2316"/>
                    <a:pt x="2309" y="2304"/>
                  </a:cubicBezTo>
                  <a:lnTo>
                    <a:pt x="2274" y="2219"/>
                  </a:lnTo>
                  <a:cubicBezTo>
                    <a:pt x="2269" y="2207"/>
                    <a:pt x="2275" y="2194"/>
                    <a:pt x="2286" y="2189"/>
                  </a:cubicBezTo>
                  <a:cubicBezTo>
                    <a:pt x="2298" y="2184"/>
                    <a:pt x="2312" y="2190"/>
                    <a:pt x="2316" y="2202"/>
                  </a:cubicBezTo>
                  <a:close/>
                  <a:moveTo>
                    <a:pt x="2408" y="2407"/>
                  </a:moveTo>
                  <a:lnTo>
                    <a:pt x="2460" y="2483"/>
                  </a:lnTo>
                  <a:cubicBezTo>
                    <a:pt x="2467" y="2493"/>
                    <a:pt x="2465" y="2508"/>
                    <a:pt x="2454" y="2515"/>
                  </a:cubicBezTo>
                  <a:cubicBezTo>
                    <a:pt x="2444" y="2522"/>
                    <a:pt x="2429" y="2519"/>
                    <a:pt x="2422" y="2509"/>
                  </a:cubicBezTo>
                  <a:lnTo>
                    <a:pt x="2370" y="2433"/>
                  </a:lnTo>
                  <a:cubicBezTo>
                    <a:pt x="2363" y="2422"/>
                    <a:pt x="2366" y="2408"/>
                    <a:pt x="2376" y="2401"/>
                  </a:cubicBezTo>
                  <a:cubicBezTo>
                    <a:pt x="2387" y="2394"/>
                    <a:pt x="2401" y="2396"/>
                    <a:pt x="2408" y="2407"/>
                  </a:cubicBezTo>
                  <a:close/>
                  <a:moveTo>
                    <a:pt x="2541" y="2584"/>
                  </a:moveTo>
                  <a:lnTo>
                    <a:pt x="2615" y="2639"/>
                  </a:lnTo>
                  <a:cubicBezTo>
                    <a:pt x="2625" y="2647"/>
                    <a:pt x="2627" y="2661"/>
                    <a:pt x="2619" y="2671"/>
                  </a:cubicBezTo>
                  <a:cubicBezTo>
                    <a:pt x="2612" y="2682"/>
                    <a:pt x="2597" y="2684"/>
                    <a:pt x="2587" y="2676"/>
                  </a:cubicBezTo>
                  <a:lnTo>
                    <a:pt x="2513" y="2621"/>
                  </a:lnTo>
                  <a:cubicBezTo>
                    <a:pt x="2503" y="2613"/>
                    <a:pt x="2501" y="2599"/>
                    <a:pt x="2509" y="2589"/>
                  </a:cubicBezTo>
                  <a:cubicBezTo>
                    <a:pt x="2516" y="2579"/>
                    <a:pt x="2531" y="2576"/>
                    <a:pt x="2541" y="2584"/>
                  </a:cubicBezTo>
                  <a:close/>
                  <a:moveTo>
                    <a:pt x="2720" y="2733"/>
                  </a:moveTo>
                  <a:lnTo>
                    <a:pt x="2781" y="2792"/>
                  </a:lnTo>
                  <a:cubicBezTo>
                    <a:pt x="2790" y="2800"/>
                    <a:pt x="2790" y="2815"/>
                    <a:pt x="2781" y="2824"/>
                  </a:cubicBezTo>
                  <a:cubicBezTo>
                    <a:pt x="2772" y="2833"/>
                    <a:pt x="2758" y="2834"/>
                    <a:pt x="2749" y="2825"/>
                  </a:cubicBezTo>
                  <a:lnTo>
                    <a:pt x="2688" y="2766"/>
                  </a:lnTo>
                  <a:cubicBezTo>
                    <a:pt x="2679" y="2758"/>
                    <a:pt x="2678" y="2743"/>
                    <a:pt x="2687" y="2734"/>
                  </a:cubicBezTo>
                  <a:cubicBezTo>
                    <a:pt x="2696" y="2725"/>
                    <a:pt x="2711" y="2724"/>
                    <a:pt x="2720" y="2733"/>
                  </a:cubicBezTo>
                  <a:close/>
                  <a:moveTo>
                    <a:pt x="2770" y="2786"/>
                  </a:moveTo>
                  <a:lnTo>
                    <a:pt x="2778" y="2788"/>
                  </a:lnTo>
                  <a:cubicBezTo>
                    <a:pt x="2790" y="2791"/>
                    <a:pt x="2797" y="2803"/>
                    <a:pt x="2794" y="2816"/>
                  </a:cubicBezTo>
                  <a:cubicBezTo>
                    <a:pt x="2791" y="2828"/>
                    <a:pt x="2779" y="2836"/>
                    <a:pt x="2767" y="2832"/>
                  </a:cubicBezTo>
                  <a:lnTo>
                    <a:pt x="2759" y="2831"/>
                  </a:lnTo>
                  <a:cubicBezTo>
                    <a:pt x="2747" y="2828"/>
                    <a:pt x="2739" y="2815"/>
                    <a:pt x="2742" y="2803"/>
                  </a:cubicBezTo>
                  <a:cubicBezTo>
                    <a:pt x="2745" y="2790"/>
                    <a:pt x="2758" y="2783"/>
                    <a:pt x="2770" y="2786"/>
                  </a:cubicBezTo>
                  <a:close/>
                  <a:moveTo>
                    <a:pt x="2912" y="2821"/>
                  </a:moveTo>
                  <a:lnTo>
                    <a:pt x="3001" y="2843"/>
                  </a:lnTo>
                  <a:cubicBezTo>
                    <a:pt x="3014" y="2846"/>
                    <a:pt x="3021" y="2858"/>
                    <a:pt x="3018" y="2870"/>
                  </a:cubicBezTo>
                  <a:cubicBezTo>
                    <a:pt x="3015" y="2883"/>
                    <a:pt x="3003" y="2890"/>
                    <a:pt x="2990" y="2887"/>
                  </a:cubicBezTo>
                  <a:lnTo>
                    <a:pt x="2901" y="2865"/>
                  </a:lnTo>
                  <a:cubicBezTo>
                    <a:pt x="2889" y="2862"/>
                    <a:pt x="2881" y="2850"/>
                    <a:pt x="2884" y="2838"/>
                  </a:cubicBezTo>
                  <a:cubicBezTo>
                    <a:pt x="2887" y="2825"/>
                    <a:pt x="2899" y="2818"/>
                    <a:pt x="2912" y="2821"/>
                  </a:cubicBezTo>
                  <a:close/>
                  <a:moveTo>
                    <a:pt x="3132" y="2900"/>
                  </a:moveTo>
                  <a:lnTo>
                    <a:pt x="3169" y="2918"/>
                  </a:lnTo>
                  <a:cubicBezTo>
                    <a:pt x="3181" y="2924"/>
                    <a:pt x="3185" y="2938"/>
                    <a:pt x="3179" y="2949"/>
                  </a:cubicBezTo>
                  <a:cubicBezTo>
                    <a:pt x="3174" y="2961"/>
                    <a:pt x="3160" y="2965"/>
                    <a:pt x="3149" y="2959"/>
                  </a:cubicBezTo>
                  <a:lnTo>
                    <a:pt x="3112" y="2941"/>
                  </a:lnTo>
                  <a:cubicBezTo>
                    <a:pt x="3100" y="2935"/>
                    <a:pt x="3096" y="2921"/>
                    <a:pt x="3101" y="2910"/>
                  </a:cubicBezTo>
                  <a:cubicBezTo>
                    <a:pt x="3107" y="2899"/>
                    <a:pt x="3121" y="2894"/>
                    <a:pt x="3132" y="2900"/>
                  </a:cubicBezTo>
                  <a:close/>
                  <a:moveTo>
                    <a:pt x="3169" y="2918"/>
                  </a:moveTo>
                  <a:lnTo>
                    <a:pt x="3215" y="2941"/>
                  </a:lnTo>
                  <a:cubicBezTo>
                    <a:pt x="3226" y="2946"/>
                    <a:pt x="3231" y="2960"/>
                    <a:pt x="3225" y="2971"/>
                  </a:cubicBezTo>
                  <a:cubicBezTo>
                    <a:pt x="3220" y="2983"/>
                    <a:pt x="3206" y="2987"/>
                    <a:pt x="3194" y="2982"/>
                  </a:cubicBezTo>
                  <a:lnTo>
                    <a:pt x="3149" y="2960"/>
                  </a:lnTo>
                  <a:cubicBezTo>
                    <a:pt x="3137" y="2954"/>
                    <a:pt x="3133" y="2940"/>
                    <a:pt x="3138" y="2929"/>
                  </a:cubicBezTo>
                  <a:cubicBezTo>
                    <a:pt x="3144" y="2917"/>
                    <a:pt x="3158" y="2913"/>
                    <a:pt x="3169" y="2918"/>
                  </a:cubicBezTo>
                  <a:close/>
                  <a:moveTo>
                    <a:pt x="3339" y="3001"/>
                  </a:moveTo>
                  <a:lnTo>
                    <a:pt x="3422" y="3041"/>
                  </a:lnTo>
                  <a:cubicBezTo>
                    <a:pt x="3433" y="3046"/>
                    <a:pt x="3438" y="3060"/>
                    <a:pt x="3433" y="3072"/>
                  </a:cubicBezTo>
                  <a:cubicBezTo>
                    <a:pt x="3427" y="3083"/>
                    <a:pt x="3413" y="3088"/>
                    <a:pt x="3402" y="3082"/>
                  </a:cubicBezTo>
                  <a:lnTo>
                    <a:pt x="3319" y="3043"/>
                  </a:lnTo>
                  <a:cubicBezTo>
                    <a:pt x="3307" y="3037"/>
                    <a:pt x="3302" y="3023"/>
                    <a:pt x="3308" y="3012"/>
                  </a:cubicBezTo>
                  <a:cubicBezTo>
                    <a:pt x="3313" y="3000"/>
                    <a:pt x="3327" y="2995"/>
                    <a:pt x="3339" y="3001"/>
                  </a:cubicBezTo>
                  <a:close/>
                  <a:moveTo>
                    <a:pt x="3551" y="3073"/>
                  </a:moveTo>
                  <a:lnTo>
                    <a:pt x="3558" y="3075"/>
                  </a:lnTo>
                  <a:lnTo>
                    <a:pt x="3548" y="3120"/>
                  </a:lnTo>
                  <a:lnTo>
                    <a:pt x="3540" y="3118"/>
                  </a:lnTo>
                  <a:cubicBezTo>
                    <a:pt x="3528" y="3115"/>
                    <a:pt x="3520" y="3103"/>
                    <a:pt x="3523" y="3090"/>
                  </a:cubicBezTo>
                  <a:cubicBezTo>
                    <a:pt x="3526" y="3078"/>
                    <a:pt x="3538" y="3070"/>
                    <a:pt x="3551" y="3073"/>
                  </a:cubicBez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33" name="Freeform 22"/>
            <p:cNvSpPr>
              <a:spLocks/>
            </p:cNvSpPr>
            <p:nvPr/>
          </p:nvSpPr>
          <p:spPr bwMode="auto">
            <a:xfrm>
              <a:off x="534988" y="836613"/>
              <a:ext cx="1541463" cy="1284288"/>
            </a:xfrm>
            <a:custGeom>
              <a:avLst/>
              <a:gdLst>
                <a:gd name="T0" fmla="*/ 0 w 971"/>
                <a:gd name="T1" fmla="*/ 0 h 809"/>
                <a:gd name="T2" fmla="*/ 0 w 971"/>
                <a:gd name="T3" fmla="*/ 0 h 809"/>
                <a:gd name="T4" fmla="*/ 0 w 971"/>
                <a:gd name="T5" fmla="*/ 0 h 809"/>
                <a:gd name="T6" fmla="*/ 174 w 971"/>
                <a:gd name="T7" fmla="*/ 0 h 809"/>
                <a:gd name="T8" fmla="*/ 174 w 971"/>
                <a:gd name="T9" fmla="*/ 0 h 809"/>
                <a:gd name="T10" fmla="*/ 243 w 971"/>
                <a:gd name="T11" fmla="*/ 14 h 809"/>
                <a:gd name="T12" fmla="*/ 243 w 971"/>
                <a:gd name="T13" fmla="*/ 14 h 809"/>
                <a:gd name="T14" fmla="*/ 312 w 971"/>
                <a:gd name="T15" fmla="*/ 48 h 809"/>
                <a:gd name="T16" fmla="*/ 312 w 971"/>
                <a:gd name="T17" fmla="*/ 48 h 809"/>
                <a:gd name="T18" fmla="*/ 347 w 971"/>
                <a:gd name="T19" fmla="*/ 69 h 809"/>
                <a:gd name="T20" fmla="*/ 347 w 971"/>
                <a:gd name="T21" fmla="*/ 69 h 809"/>
                <a:gd name="T22" fmla="*/ 381 w 971"/>
                <a:gd name="T23" fmla="*/ 98 h 809"/>
                <a:gd name="T24" fmla="*/ 381 w 971"/>
                <a:gd name="T25" fmla="*/ 98 h 809"/>
                <a:gd name="T26" fmla="*/ 416 w 971"/>
                <a:gd name="T27" fmla="*/ 112 h 809"/>
                <a:gd name="T28" fmla="*/ 416 w 971"/>
                <a:gd name="T29" fmla="*/ 112 h 809"/>
                <a:gd name="T30" fmla="*/ 451 w 971"/>
                <a:gd name="T31" fmla="*/ 183 h 809"/>
                <a:gd name="T32" fmla="*/ 451 w 971"/>
                <a:gd name="T33" fmla="*/ 183 h 809"/>
                <a:gd name="T34" fmla="*/ 486 w 971"/>
                <a:gd name="T35" fmla="*/ 296 h 809"/>
                <a:gd name="T36" fmla="*/ 486 w 971"/>
                <a:gd name="T37" fmla="*/ 296 h 809"/>
                <a:gd name="T38" fmla="*/ 554 w 971"/>
                <a:gd name="T39" fmla="*/ 341 h 809"/>
                <a:gd name="T40" fmla="*/ 554 w 971"/>
                <a:gd name="T41" fmla="*/ 341 h 809"/>
                <a:gd name="T42" fmla="*/ 589 w 971"/>
                <a:gd name="T43" fmla="*/ 418 h 809"/>
                <a:gd name="T44" fmla="*/ 589 w 971"/>
                <a:gd name="T45" fmla="*/ 418 h 809"/>
                <a:gd name="T46" fmla="*/ 624 w 971"/>
                <a:gd name="T47" fmla="*/ 457 h 809"/>
                <a:gd name="T48" fmla="*/ 624 w 971"/>
                <a:gd name="T49" fmla="*/ 457 h 809"/>
                <a:gd name="T50" fmla="*/ 659 w 971"/>
                <a:gd name="T51" fmla="*/ 549 h 809"/>
                <a:gd name="T52" fmla="*/ 659 w 971"/>
                <a:gd name="T53" fmla="*/ 549 h 809"/>
                <a:gd name="T54" fmla="*/ 693 w 971"/>
                <a:gd name="T55" fmla="*/ 579 h 809"/>
                <a:gd name="T56" fmla="*/ 693 w 971"/>
                <a:gd name="T57" fmla="*/ 579 h 809"/>
                <a:gd name="T58" fmla="*/ 728 w 971"/>
                <a:gd name="T59" fmla="*/ 641 h 809"/>
                <a:gd name="T60" fmla="*/ 728 w 971"/>
                <a:gd name="T61" fmla="*/ 641 h 809"/>
                <a:gd name="T62" fmla="*/ 763 w 971"/>
                <a:gd name="T63" fmla="*/ 648 h 809"/>
                <a:gd name="T64" fmla="*/ 763 w 971"/>
                <a:gd name="T65" fmla="*/ 648 h 809"/>
                <a:gd name="T66" fmla="*/ 797 w 971"/>
                <a:gd name="T67" fmla="*/ 689 h 809"/>
                <a:gd name="T68" fmla="*/ 797 w 971"/>
                <a:gd name="T69" fmla="*/ 689 h 809"/>
                <a:gd name="T70" fmla="*/ 832 w 971"/>
                <a:gd name="T71" fmla="*/ 721 h 809"/>
                <a:gd name="T72" fmla="*/ 832 w 971"/>
                <a:gd name="T73" fmla="*/ 721 h 809"/>
                <a:gd name="T74" fmla="*/ 866 w 971"/>
                <a:gd name="T75" fmla="*/ 753 h 809"/>
                <a:gd name="T76" fmla="*/ 866 w 971"/>
                <a:gd name="T77" fmla="*/ 753 h 809"/>
                <a:gd name="T78" fmla="*/ 902 w 971"/>
                <a:gd name="T79" fmla="*/ 785 h 809"/>
                <a:gd name="T80" fmla="*/ 902 w 971"/>
                <a:gd name="T81" fmla="*/ 785 h 809"/>
                <a:gd name="T82" fmla="*/ 936 w 971"/>
                <a:gd name="T83" fmla="*/ 801 h 809"/>
                <a:gd name="T84" fmla="*/ 936 w 971"/>
                <a:gd name="T85" fmla="*/ 801 h 809"/>
                <a:gd name="T86" fmla="*/ 971 w 971"/>
                <a:gd name="T87" fmla="*/ 809 h 8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</a:cxnLst>
              <a:rect l="0" t="0" r="r" b="b"/>
              <a:pathLst>
                <a:path w="971" h="809">
                  <a:moveTo>
                    <a:pt x="0" y="0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174" y="0"/>
                  </a:lnTo>
                  <a:lnTo>
                    <a:pt x="174" y="0"/>
                  </a:lnTo>
                  <a:lnTo>
                    <a:pt x="243" y="14"/>
                  </a:lnTo>
                  <a:lnTo>
                    <a:pt x="243" y="14"/>
                  </a:lnTo>
                  <a:lnTo>
                    <a:pt x="312" y="48"/>
                  </a:lnTo>
                  <a:lnTo>
                    <a:pt x="312" y="48"/>
                  </a:lnTo>
                  <a:lnTo>
                    <a:pt x="347" y="69"/>
                  </a:lnTo>
                  <a:lnTo>
                    <a:pt x="347" y="69"/>
                  </a:lnTo>
                  <a:lnTo>
                    <a:pt x="381" y="98"/>
                  </a:lnTo>
                  <a:lnTo>
                    <a:pt x="381" y="98"/>
                  </a:lnTo>
                  <a:lnTo>
                    <a:pt x="416" y="112"/>
                  </a:lnTo>
                  <a:lnTo>
                    <a:pt x="416" y="112"/>
                  </a:lnTo>
                  <a:lnTo>
                    <a:pt x="451" y="183"/>
                  </a:lnTo>
                  <a:lnTo>
                    <a:pt x="451" y="183"/>
                  </a:lnTo>
                  <a:lnTo>
                    <a:pt x="486" y="296"/>
                  </a:lnTo>
                  <a:lnTo>
                    <a:pt x="486" y="296"/>
                  </a:lnTo>
                  <a:lnTo>
                    <a:pt x="554" y="341"/>
                  </a:lnTo>
                  <a:lnTo>
                    <a:pt x="554" y="341"/>
                  </a:lnTo>
                  <a:lnTo>
                    <a:pt x="589" y="418"/>
                  </a:lnTo>
                  <a:lnTo>
                    <a:pt x="589" y="418"/>
                  </a:lnTo>
                  <a:lnTo>
                    <a:pt x="624" y="457"/>
                  </a:lnTo>
                  <a:lnTo>
                    <a:pt x="624" y="457"/>
                  </a:lnTo>
                  <a:lnTo>
                    <a:pt x="659" y="549"/>
                  </a:lnTo>
                  <a:lnTo>
                    <a:pt x="659" y="549"/>
                  </a:lnTo>
                  <a:lnTo>
                    <a:pt x="693" y="579"/>
                  </a:lnTo>
                  <a:lnTo>
                    <a:pt x="693" y="579"/>
                  </a:lnTo>
                  <a:lnTo>
                    <a:pt x="728" y="641"/>
                  </a:lnTo>
                  <a:lnTo>
                    <a:pt x="728" y="641"/>
                  </a:lnTo>
                  <a:lnTo>
                    <a:pt x="763" y="648"/>
                  </a:lnTo>
                  <a:lnTo>
                    <a:pt x="763" y="648"/>
                  </a:lnTo>
                  <a:lnTo>
                    <a:pt x="797" y="689"/>
                  </a:lnTo>
                  <a:lnTo>
                    <a:pt x="797" y="689"/>
                  </a:lnTo>
                  <a:lnTo>
                    <a:pt x="832" y="721"/>
                  </a:lnTo>
                  <a:lnTo>
                    <a:pt x="832" y="721"/>
                  </a:lnTo>
                  <a:lnTo>
                    <a:pt x="866" y="753"/>
                  </a:lnTo>
                  <a:lnTo>
                    <a:pt x="866" y="753"/>
                  </a:lnTo>
                  <a:lnTo>
                    <a:pt x="902" y="785"/>
                  </a:lnTo>
                  <a:lnTo>
                    <a:pt x="902" y="785"/>
                  </a:lnTo>
                  <a:lnTo>
                    <a:pt x="936" y="801"/>
                  </a:lnTo>
                  <a:lnTo>
                    <a:pt x="936" y="801"/>
                  </a:lnTo>
                  <a:lnTo>
                    <a:pt x="971" y="809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34" name="Rectangle 23"/>
            <p:cNvSpPr>
              <a:spLocks noChangeArrowheads="1"/>
            </p:cNvSpPr>
            <p:nvPr/>
          </p:nvSpPr>
          <p:spPr bwMode="auto">
            <a:xfrm>
              <a:off x="915487" y="2341563"/>
              <a:ext cx="1136530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11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Days</a:t>
              </a:r>
              <a:r>
                <a:rPr kumimoji="0" lang="el-GR" altLang="el-GR" sz="11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of </a:t>
              </a:r>
              <a:r>
                <a:rPr kumimoji="0" lang="el-GR" altLang="el-GR" sz="11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adulthood</a:t>
              </a:r>
              <a:endParaRPr kumimoji="0" lang="el-GR" altLang="el-GR" sz="32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1" name="Rectangle 40"/>
            <p:cNvSpPr>
              <a:spLocks noChangeArrowheads="1"/>
            </p:cNvSpPr>
            <p:nvPr/>
          </p:nvSpPr>
          <p:spPr bwMode="auto">
            <a:xfrm>
              <a:off x="1828800" y="984250"/>
              <a:ext cx="147476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N2</a:t>
              </a:r>
              <a:endParaRPr kumimoji="0" lang="el-GR" altLang="el-GR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2" name="Line 41"/>
            <p:cNvSpPr>
              <a:spLocks noChangeShapeType="1"/>
            </p:cNvSpPr>
            <p:nvPr/>
          </p:nvSpPr>
          <p:spPr bwMode="auto">
            <a:xfrm>
              <a:off x="1619250" y="1053499"/>
              <a:ext cx="136525" cy="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53" name="Rectangle 42"/>
            <p:cNvSpPr>
              <a:spLocks noChangeArrowheads="1"/>
            </p:cNvSpPr>
            <p:nvPr/>
          </p:nvSpPr>
          <p:spPr bwMode="auto">
            <a:xfrm>
              <a:off x="1828800" y="1177925"/>
              <a:ext cx="833562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N2;</a:t>
              </a:r>
              <a:r>
                <a:rPr kumimoji="0" lang="en-US" altLang="el-GR" sz="9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isd-1(RNAi)</a:t>
              </a:r>
              <a:endParaRPr kumimoji="0" lang="el-GR" altLang="el-GR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5" name="Freeform 44"/>
            <p:cNvSpPr>
              <a:spLocks noEditPoints="1"/>
            </p:cNvSpPr>
            <p:nvPr/>
          </p:nvSpPr>
          <p:spPr bwMode="auto">
            <a:xfrm>
              <a:off x="1619250" y="1237649"/>
              <a:ext cx="133350" cy="19050"/>
            </a:xfrm>
            <a:custGeom>
              <a:avLst/>
              <a:gdLst>
                <a:gd name="T0" fmla="*/ 0 w 322"/>
                <a:gd name="T1" fmla="*/ 0 h 46"/>
                <a:gd name="T2" fmla="*/ 92 w 322"/>
                <a:gd name="T3" fmla="*/ 0 h 46"/>
                <a:gd name="T4" fmla="*/ 115 w 322"/>
                <a:gd name="T5" fmla="*/ 23 h 46"/>
                <a:gd name="T6" fmla="*/ 92 w 322"/>
                <a:gd name="T7" fmla="*/ 46 h 46"/>
                <a:gd name="T8" fmla="*/ 0 w 322"/>
                <a:gd name="T9" fmla="*/ 46 h 46"/>
                <a:gd name="T10" fmla="*/ 0 w 322"/>
                <a:gd name="T11" fmla="*/ 0 h 46"/>
                <a:gd name="T12" fmla="*/ 230 w 322"/>
                <a:gd name="T13" fmla="*/ 0 h 46"/>
                <a:gd name="T14" fmla="*/ 322 w 322"/>
                <a:gd name="T15" fmla="*/ 0 h 46"/>
                <a:gd name="T16" fmla="*/ 322 w 322"/>
                <a:gd name="T17" fmla="*/ 46 h 46"/>
                <a:gd name="T18" fmla="*/ 230 w 322"/>
                <a:gd name="T19" fmla="*/ 46 h 46"/>
                <a:gd name="T20" fmla="*/ 207 w 322"/>
                <a:gd name="T21" fmla="*/ 23 h 46"/>
                <a:gd name="T22" fmla="*/ 230 w 322"/>
                <a:gd name="T23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322" h="46">
                  <a:moveTo>
                    <a:pt x="0" y="0"/>
                  </a:moveTo>
                  <a:lnTo>
                    <a:pt x="92" y="0"/>
                  </a:lnTo>
                  <a:cubicBezTo>
                    <a:pt x="104" y="0"/>
                    <a:pt x="115" y="10"/>
                    <a:pt x="115" y="23"/>
                  </a:cubicBezTo>
                  <a:cubicBezTo>
                    <a:pt x="115" y="36"/>
                    <a:pt x="104" y="46"/>
                    <a:pt x="92" y="46"/>
                  </a:cubicBezTo>
                  <a:lnTo>
                    <a:pt x="0" y="46"/>
                  </a:lnTo>
                  <a:lnTo>
                    <a:pt x="0" y="0"/>
                  </a:lnTo>
                  <a:close/>
                  <a:moveTo>
                    <a:pt x="230" y="0"/>
                  </a:moveTo>
                  <a:lnTo>
                    <a:pt x="322" y="0"/>
                  </a:lnTo>
                  <a:lnTo>
                    <a:pt x="322" y="46"/>
                  </a:lnTo>
                  <a:lnTo>
                    <a:pt x="230" y="46"/>
                  </a:lnTo>
                  <a:cubicBezTo>
                    <a:pt x="217" y="46"/>
                    <a:pt x="207" y="36"/>
                    <a:pt x="207" y="23"/>
                  </a:cubicBezTo>
                  <a:cubicBezTo>
                    <a:pt x="207" y="10"/>
                    <a:pt x="217" y="0"/>
                    <a:pt x="230" y="0"/>
                  </a:cubicBez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56" name="TextBox 55"/>
            <p:cNvSpPr txBox="1"/>
            <p:nvPr/>
          </p:nvSpPr>
          <p:spPr>
            <a:xfrm rot="16200000">
              <a:off x="-405790" y="1334748"/>
              <a:ext cx="118814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ercent survival</a:t>
              </a:r>
              <a:endParaRPr lang="el-GR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AutoShape 46"/>
            <p:cNvSpPr>
              <a:spLocks noChangeAspect="1" noChangeArrowheads="1" noTextEdit="1"/>
            </p:cNvSpPr>
            <p:nvPr/>
          </p:nvSpPr>
          <p:spPr bwMode="auto">
            <a:xfrm>
              <a:off x="57150" y="2868613"/>
              <a:ext cx="2806700" cy="20939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59" name="Rectangle 48"/>
            <p:cNvSpPr>
              <a:spLocks noChangeArrowheads="1"/>
            </p:cNvSpPr>
            <p:nvPr/>
          </p:nvSpPr>
          <p:spPr bwMode="auto">
            <a:xfrm>
              <a:off x="504825" y="4594225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el-GR" altLang="el-GR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0" name="Rectangle 49"/>
            <p:cNvSpPr>
              <a:spLocks noChangeArrowheads="1"/>
            </p:cNvSpPr>
            <p:nvPr/>
          </p:nvSpPr>
          <p:spPr bwMode="auto">
            <a:xfrm>
              <a:off x="785813" y="4594225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</a:t>
              </a:r>
              <a:endParaRPr kumimoji="0" lang="el-GR" altLang="el-G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1" name="Rectangle 50"/>
            <p:cNvSpPr>
              <a:spLocks noChangeArrowheads="1"/>
            </p:cNvSpPr>
            <p:nvPr/>
          </p:nvSpPr>
          <p:spPr bwMode="auto">
            <a:xfrm>
              <a:off x="1031875" y="4594225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</a:t>
              </a:r>
              <a:endParaRPr kumimoji="0" lang="el-GR" altLang="el-G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2" name="Rectangle 51"/>
            <p:cNvSpPr>
              <a:spLocks noChangeArrowheads="1"/>
            </p:cNvSpPr>
            <p:nvPr/>
          </p:nvSpPr>
          <p:spPr bwMode="auto">
            <a:xfrm>
              <a:off x="1306513" y="4594225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5</a:t>
              </a:r>
              <a:endParaRPr kumimoji="0" lang="el-GR" altLang="el-G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3" name="Rectangle 52"/>
            <p:cNvSpPr>
              <a:spLocks noChangeArrowheads="1"/>
            </p:cNvSpPr>
            <p:nvPr/>
          </p:nvSpPr>
          <p:spPr bwMode="auto">
            <a:xfrm>
              <a:off x="1579563" y="4594225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</a:t>
              </a:r>
              <a:endParaRPr kumimoji="0" lang="el-GR" altLang="el-G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4" name="Rectangle 53"/>
            <p:cNvSpPr>
              <a:spLocks noChangeArrowheads="1"/>
            </p:cNvSpPr>
            <p:nvPr/>
          </p:nvSpPr>
          <p:spPr bwMode="auto">
            <a:xfrm>
              <a:off x="1854200" y="4594225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5</a:t>
              </a:r>
              <a:endParaRPr kumimoji="0" lang="el-GR" altLang="el-G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5" name="Rectangle 54"/>
            <p:cNvSpPr>
              <a:spLocks noChangeArrowheads="1"/>
            </p:cNvSpPr>
            <p:nvPr/>
          </p:nvSpPr>
          <p:spPr bwMode="auto">
            <a:xfrm>
              <a:off x="2127250" y="4594225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0</a:t>
              </a:r>
              <a:endParaRPr kumimoji="0" lang="el-GR" altLang="el-G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6" name="Rectangle 55"/>
            <p:cNvSpPr>
              <a:spLocks noChangeArrowheads="1"/>
            </p:cNvSpPr>
            <p:nvPr/>
          </p:nvSpPr>
          <p:spPr bwMode="auto">
            <a:xfrm>
              <a:off x="2401888" y="4594225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5</a:t>
              </a:r>
              <a:endParaRPr kumimoji="0" lang="el-GR" altLang="el-G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7" name="Freeform 56"/>
            <p:cNvSpPr>
              <a:spLocks noEditPoints="1"/>
            </p:cNvSpPr>
            <p:nvPr/>
          </p:nvSpPr>
          <p:spPr bwMode="auto">
            <a:xfrm>
              <a:off x="528638" y="4525963"/>
              <a:ext cx="1936750" cy="53975"/>
            </a:xfrm>
            <a:custGeom>
              <a:avLst/>
              <a:gdLst>
                <a:gd name="T0" fmla="*/ 0 w 1220"/>
                <a:gd name="T1" fmla="*/ 0 h 34"/>
                <a:gd name="T2" fmla="*/ 1220 w 1220"/>
                <a:gd name="T3" fmla="*/ 0 h 34"/>
                <a:gd name="T4" fmla="*/ 4 w 1220"/>
                <a:gd name="T5" fmla="*/ 0 h 34"/>
                <a:gd name="T6" fmla="*/ 4 w 1220"/>
                <a:gd name="T7" fmla="*/ 34 h 34"/>
                <a:gd name="T8" fmla="*/ 177 w 1220"/>
                <a:gd name="T9" fmla="*/ 0 h 34"/>
                <a:gd name="T10" fmla="*/ 177 w 1220"/>
                <a:gd name="T11" fmla="*/ 34 h 34"/>
                <a:gd name="T12" fmla="*/ 350 w 1220"/>
                <a:gd name="T13" fmla="*/ 0 h 34"/>
                <a:gd name="T14" fmla="*/ 350 w 1220"/>
                <a:gd name="T15" fmla="*/ 34 h 34"/>
                <a:gd name="T16" fmla="*/ 523 w 1220"/>
                <a:gd name="T17" fmla="*/ 0 h 34"/>
                <a:gd name="T18" fmla="*/ 523 w 1220"/>
                <a:gd name="T19" fmla="*/ 34 h 34"/>
                <a:gd name="T20" fmla="*/ 696 w 1220"/>
                <a:gd name="T21" fmla="*/ 0 h 34"/>
                <a:gd name="T22" fmla="*/ 696 w 1220"/>
                <a:gd name="T23" fmla="*/ 34 h 34"/>
                <a:gd name="T24" fmla="*/ 869 w 1220"/>
                <a:gd name="T25" fmla="*/ 0 h 34"/>
                <a:gd name="T26" fmla="*/ 869 w 1220"/>
                <a:gd name="T27" fmla="*/ 34 h 34"/>
                <a:gd name="T28" fmla="*/ 1042 w 1220"/>
                <a:gd name="T29" fmla="*/ 0 h 34"/>
                <a:gd name="T30" fmla="*/ 1042 w 1220"/>
                <a:gd name="T31" fmla="*/ 34 h 34"/>
                <a:gd name="T32" fmla="*/ 1216 w 1220"/>
                <a:gd name="T33" fmla="*/ 0 h 34"/>
                <a:gd name="T34" fmla="*/ 1216 w 1220"/>
                <a:gd name="T35" fmla="*/ 34 h 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220" h="34">
                  <a:moveTo>
                    <a:pt x="0" y="0"/>
                  </a:moveTo>
                  <a:lnTo>
                    <a:pt x="1220" y="0"/>
                  </a:lnTo>
                  <a:moveTo>
                    <a:pt x="4" y="0"/>
                  </a:moveTo>
                  <a:lnTo>
                    <a:pt x="4" y="34"/>
                  </a:lnTo>
                  <a:moveTo>
                    <a:pt x="177" y="0"/>
                  </a:moveTo>
                  <a:lnTo>
                    <a:pt x="177" y="34"/>
                  </a:lnTo>
                  <a:moveTo>
                    <a:pt x="350" y="0"/>
                  </a:moveTo>
                  <a:lnTo>
                    <a:pt x="350" y="34"/>
                  </a:lnTo>
                  <a:moveTo>
                    <a:pt x="523" y="0"/>
                  </a:moveTo>
                  <a:lnTo>
                    <a:pt x="523" y="34"/>
                  </a:lnTo>
                  <a:moveTo>
                    <a:pt x="696" y="0"/>
                  </a:moveTo>
                  <a:lnTo>
                    <a:pt x="696" y="34"/>
                  </a:lnTo>
                  <a:moveTo>
                    <a:pt x="869" y="0"/>
                  </a:moveTo>
                  <a:lnTo>
                    <a:pt x="869" y="34"/>
                  </a:lnTo>
                  <a:moveTo>
                    <a:pt x="1042" y="0"/>
                  </a:moveTo>
                  <a:lnTo>
                    <a:pt x="1042" y="34"/>
                  </a:lnTo>
                  <a:moveTo>
                    <a:pt x="1216" y="0"/>
                  </a:moveTo>
                  <a:lnTo>
                    <a:pt x="1216" y="34"/>
                  </a:lnTo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68" name="Rectangle 57"/>
            <p:cNvSpPr>
              <a:spLocks noChangeArrowheads="1"/>
            </p:cNvSpPr>
            <p:nvPr/>
          </p:nvSpPr>
          <p:spPr bwMode="auto">
            <a:xfrm>
              <a:off x="411163" y="4467225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el-GR" altLang="el-GR" sz="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9" name="Rectangle 58"/>
            <p:cNvSpPr>
              <a:spLocks noChangeArrowheads="1"/>
            </p:cNvSpPr>
            <p:nvPr/>
          </p:nvSpPr>
          <p:spPr bwMode="auto">
            <a:xfrm>
              <a:off x="357188" y="4213225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</a:t>
              </a:r>
              <a:endParaRPr kumimoji="0" lang="el-GR" altLang="el-GR" sz="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0" name="Rectangle 59"/>
            <p:cNvSpPr>
              <a:spLocks noChangeArrowheads="1"/>
            </p:cNvSpPr>
            <p:nvPr/>
          </p:nvSpPr>
          <p:spPr bwMode="auto">
            <a:xfrm>
              <a:off x="357188" y="3952875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0</a:t>
              </a:r>
              <a:endParaRPr kumimoji="0" lang="el-GR" altLang="el-GR" sz="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1" name="Rectangle 60"/>
            <p:cNvSpPr>
              <a:spLocks noChangeArrowheads="1"/>
            </p:cNvSpPr>
            <p:nvPr/>
          </p:nvSpPr>
          <p:spPr bwMode="auto">
            <a:xfrm>
              <a:off x="357188" y="3697288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0</a:t>
              </a:r>
              <a:endParaRPr kumimoji="0" lang="el-GR" altLang="el-GR" sz="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2" name="Rectangle 61"/>
            <p:cNvSpPr>
              <a:spLocks noChangeArrowheads="1"/>
            </p:cNvSpPr>
            <p:nvPr/>
          </p:nvSpPr>
          <p:spPr bwMode="auto">
            <a:xfrm>
              <a:off x="357188" y="3436938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0</a:t>
              </a:r>
              <a:endParaRPr kumimoji="0" lang="el-GR" altLang="el-GR" sz="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3" name="Rectangle 62"/>
            <p:cNvSpPr>
              <a:spLocks noChangeArrowheads="1"/>
            </p:cNvSpPr>
            <p:nvPr/>
          </p:nvSpPr>
          <p:spPr bwMode="auto">
            <a:xfrm>
              <a:off x="304800" y="3182938"/>
              <a:ext cx="17312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</a:t>
              </a:r>
              <a:endParaRPr kumimoji="0" lang="el-GR" altLang="el-GR" sz="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4" name="Freeform 63"/>
            <p:cNvSpPr>
              <a:spLocks noEditPoints="1"/>
            </p:cNvSpPr>
            <p:nvPr/>
          </p:nvSpPr>
          <p:spPr bwMode="auto">
            <a:xfrm>
              <a:off x="481013" y="3235325"/>
              <a:ext cx="53975" cy="1296987"/>
            </a:xfrm>
            <a:custGeom>
              <a:avLst/>
              <a:gdLst>
                <a:gd name="T0" fmla="*/ 34 w 34"/>
                <a:gd name="T1" fmla="*/ 817 h 817"/>
                <a:gd name="T2" fmla="*/ 34 w 34"/>
                <a:gd name="T3" fmla="*/ 0 h 817"/>
                <a:gd name="T4" fmla="*/ 34 w 34"/>
                <a:gd name="T5" fmla="*/ 813 h 817"/>
                <a:gd name="T6" fmla="*/ 0 w 34"/>
                <a:gd name="T7" fmla="*/ 813 h 817"/>
                <a:gd name="T8" fmla="*/ 34 w 34"/>
                <a:gd name="T9" fmla="*/ 651 h 817"/>
                <a:gd name="T10" fmla="*/ 0 w 34"/>
                <a:gd name="T11" fmla="*/ 651 h 817"/>
                <a:gd name="T12" fmla="*/ 34 w 34"/>
                <a:gd name="T13" fmla="*/ 489 h 817"/>
                <a:gd name="T14" fmla="*/ 0 w 34"/>
                <a:gd name="T15" fmla="*/ 489 h 817"/>
                <a:gd name="T16" fmla="*/ 34 w 34"/>
                <a:gd name="T17" fmla="*/ 327 h 817"/>
                <a:gd name="T18" fmla="*/ 0 w 34"/>
                <a:gd name="T19" fmla="*/ 327 h 817"/>
                <a:gd name="T20" fmla="*/ 34 w 34"/>
                <a:gd name="T21" fmla="*/ 166 h 817"/>
                <a:gd name="T22" fmla="*/ 0 w 34"/>
                <a:gd name="T23" fmla="*/ 166 h 817"/>
                <a:gd name="T24" fmla="*/ 34 w 34"/>
                <a:gd name="T25" fmla="*/ 4 h 817"/>
                <a:gd name="T26" fmla="*/ 0 w 34"/>
                <a:gd name="T27" fmla="*/ 4 h 8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34" h="817">
                  <a:moveTo>
                    <a:pt x="34" y="817"/>
                  </a:moveTo>
                  <a:lnTo>
                    <a:pt x="34" y="0"/>
                  </a:lnTo>
                  <a:moveTo>
                    <a:pt x="34" y="813"/>
                  </a:moveTo>
                  <a:lnTo>
                    <a:pt x="0" y="813"/>
                  </a:lnTo>
                  <a:moveTo>
                    <a:pt x="34" y="651"/>
                  </a:moveTo>
                  <a:lnTo>
                    <a:pt x="0" y="651"/>
                  </a:lnTo>
                  <a:moveTo>
                    <a:pt x="34" y="489"/>
                  </a:moveTo>
                  <a:lnTo>
                    <a:pt x="0" y="489"/>
                  </a:lnTo>
                  <a:moveTo>
                    <a:pt x="34" y="327"/>
                  </a:moveTo>
                  <a:lnTo>
                    <a:pt x="0" y="327"/>
                  </a:lnTo>
                  <a:moveTo>
                    <a:pt x="34" y="166"/>
                  </a:moveTo>
                  <a:lnTo>
                    <a:pt x="0" y="166"/>
                  </a:lnTo>
                  <a:moveTo>
                    <a:pt x="34" y="4"/>
                  </a:moveTo>
                  <a:lnTo>
                    <a:pt x="0" y="4"/>
                  </a:lnTo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 sz="800"/>
            </a:p>
          </p:txBody>
        </p:sp>
        <p:sp>
          <p:nvSpPr>
            <p:cNvPr id="75" name="Freeform 64"/>
            <p:cNvSpPr>
              <a:spLocks noEditPoints="1"/>
            </p:cNvSpPr>
            <p:nvPr/>
          </p:nvSpPr>
          <p:spPr bwMode="auto">
            <a:xfrm>
              <a:off x="534988" y="3232150"/>
              <a:ext cx="1662113" cy="1296987"/>
            </a:xfrm>
            <a:custGeom>
              <a:avLst/>
              <a:gdLst>
                <a:gd name="T0" fmla="*/ 92 w 3981"/>
                <a:gd name="T1" fmla="*/ 46 h 3103"/>
                <a:gd name="T2" fmla="*/ 322 w 3981"/>
                <a:gd name="T3" fmla="*/ 0 h 3103"/>
                <a:gd name="T4" fmla="*/ 207 w 3981"/>
                <a:gd name="T5" fmla="*/ 23 h 3103"/>
                <a:gd name="T6" fmla="*/ 576 w 3981"/>
                <a:gd name="T7" fmla="*/ 23 h 3103"/>
                <a:gd name="T8" fmla="*/ 461 w 3981"/>
                <a:gd name="T9" fmla="*/ 0 h 3103"/>
                <a:gd name="T10" fmla="*/ 783 w 3981"/>
                <a:gd name="T11" fmla="*/ 46 h 3103"/>
                <a:gd name="T12" fmla="*/ 919 w 3981"/>
                <a:gd name="T13" fmla="*/ 56 h 3103"/>
                <a:gd name="T14" fmla="*/ 901 w 3981"/>
                <a:gd name="T15" fmla="*/ 98 h 3103"/>
                <a:gd name="T16" fmla="*/ 1004 w 3981"/>
                <a:gd name="T17" fmla="*/ 88 h 3103"/>
                <a:gd name="T18" fmla="*/ 900 w 3981"/>
                <a:gd name="T19" fmla="*/ 74 h 3103"/>
                <a:gd name="T20" fmla="*/ 1234 w 3981"/>
                <a:gd name="T21" fmla="*/ 196 h 3103"/>
                <a:gd name="T22" fmla="*/ 1134 w 3981"/>
                <a:gd name="T23" fmla="*/ 135 h 3103"/>
                <a:gd name="T24" fmla="*/ 1371 w 3981"/>
                <a:gd name="T25" fmla="*/ 336 h 3103"/>
                <a:gd name="T26" fmla="*/ 1491 w 3981"/>
                <a:gd name="T27" fmla="*/ 418 h 3103"/>
                <a:gd name="T28" fmla="*/ 1455 w 3981"/>
                <a:gd name="T29" fmla="*/ 446 h 3103"/>
                <a:gd name="T30" fmla="*/ 1669 w 3981"/>
                <a:gd name="T31" fmla="*/ 690 h 3103"/>
                <a:gd name="T32" fmla="*/ 1595 w 3981"/>
                <a:gd name="T33" fmla="*/ 599 h 3103"/>
                <a:gd name="T34" fmla="*/ 1774 w 3981"/>
                <a:gd name="T35" fmla="*/ 921 h 3103"/>
                <a:gd name="T36" fmla="*/ 1733 w 3981"/>
                <a:gd name="T37" fmla="*/ 811 h 3103"/>
                <a:gd name="T38" fmla="*/ 1823 w 3981"/>
                <a:gd name="T39" fmla="*/ 1044 h 3103"/>
                <a:gd name="T40" fmla="*/ 1858 w 3981"/>
                <a:gd name="T41" fmla="*/ 1014 h 3103"/>
                <a:gd name="T42" fmla="*/ 1828 w 3981"/>
                <a:gd name="T43" fmla="*/ 1050 h 3103"/>
                <a:gd name="T44" fmla="*/ 2095 w 3981"/>
                <a:gd name="T45" fmla="*/ 1209 h 3103"/>
                <a:gd name="T46" fmla="*/ 1991 w 3981"/>
                <a:gd name="T47" fmla="*/ 1154 h 3103"/>
                <a:gd name="T48" fmla="*/ 2218 w 3981"/>
                <a:gd name="T49" fmla="*/ 1438 h 3103"/>
                <a:gd name="T50" fmla="*/ 2179 w 3981"/>
                <a:gd name="T51" fmla="*/ 1327 h 3103"/>
                <a:gd name="T52" fmla="*/ 2287 w 3981"/>
                <a:gd name="T53" fmla="*/ 1634 h 3103"/>
                <a:gd name="T54" fmla="*/ 2386 w 3981"/>
                <a:gd name="T55" fmla="*/ 1741 h 3103"/>
                <a:gd name="T56" fmla="*/ 2344 w 3981"/>
                <a:gd name="T57" fmla="*/ 1760 h 3103"/>
                <a:gd name="T58" fmla="*/ 2428 w 3981"/>
                <a:gd name="T59" fmla="*/ 1822 h 3103"/>
                <a:gd name="T60" fmla="*/ 2357 w 3981"/>
                <a:gd name="T61" fmla="*/ 1736 h 3103"/>
                <a:gd name="T62" fmla="*/ 2512 w 3981"/>
                <a:gd name="T63" fmla="*/ 2033 h 3103"/>
                <a:gd name="T64" fmla="*/ 2491 w 3981"/>
                <a:gd name="T65" fmla="*/ 1944 h 3103"/>
                <a:gd name="T66" fmla="*/ 2509 w 3981"/>
                <a:gd name="T67" fmla="*/ 2047 h 3103"/>
                <a:gd name="T68" fmla="*/ 2650 w 3981"/>
                <a:gd name="T69" fmla="*/ 2093 h 3103"/>
                <a:gd name="T70" fmla="*/ 2618 w 3981"/>
                <a:gd name="T71" fmla="*/ 2127 h 3103"/>
                <a:gd name="T72" fmla="*/ 2887 w 3981"/>
                <a:gd name="T73" fmla="*/ 2310 h 3103"/>
                <a:gd name="T74" fmla="*/ 2785 w 3981"/>
                <a:gd name="T75" fmla="*/ 2253 h 3103"/>
                <a:gd name="T76" fmla="*/ 3007 w 3981"/>
                <a:gd name="T77" fmla="*/ 2541 h 3103"/>
                <a:gd name="T78" fmla="*/ 2969 w 3981"/>
                <a:gd name="T79" fmla="*/ 2430 h 3103"/>
                <a:gd name="T80" fmla="*/ 3148 w 3981"/>
                <a:gd name="T81" fmla="*/ 2667 h 3103"/>
                <a:gd name="T82" fmla="*/ 3176 w 3981"/>
                <a:gd name="T83" fmla="*/ 2632 h 3103"/>
                <a:gd name="T84" fmla="*/ 3141 w 3981"/>
                <a:gd name="T85" fmla="*/ 2662 h 3103"/>
                <a:gd name="T86" fmla="*/ 3307 w 3981"/>
                <a:gd name="T87" fmla="*/ 2783 h 3103"/>
                <a:gd name="T88" fmla="*/ 3246 w 3981"/>
                <a:gd name="T89" fmla="*/ 2748 h 3103"/>
                <a:gd name="T90" fmla="*/ 3352 w 3981"/>
                <a:gd name="T91" fmla="*/ 2833 h 3103"/>
                <a:gd name="T92" fmla="*/ 3301 w 3981"/>
                <a:gd name="T93" fmla="*/ 2778 h 3103"/>
                <a:gd name="T94" fmla="*/ 3503 w 3981"/>
                <a:gd name="T95" fmla="*/ 2973 h 3103"/>
                <a:gd name="T96" fmla="*/ 3648 w 3981"/>
                <a:gd name="T97" fmla="*/ 2987 h 3103"/>
                <a:gd name="T98" fmla="*/ 3636 w 3981"/>
                <a:gd name="T99" fmla="*/ 3031 h 3103"/>
                <a:gd name="T100" fmla="*/ 3737 w 3981"/>
                <a:gd name="T101" fmla="*/ 3012 h 3103"/>
                <a:gd name="T102" fmla="*/ 3664 w 3981"/>
                <a:gd name="T103" fmla="*/ 3015 h 3103"/>
                <a:gd name="T104" fmla="*/ 3979 w 3981"/>
                <a:gd name="T105" fmla="*/ 3082 h 3103"/>
                <a:gd name="T106" fmla="*/ 3868 w 3981"/>
                <a:gd name="T107" fmla="*/ 3043 h 310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</a:cxnLst>
              <a:rect l="0" t="0" r="r" b="b"/>
              <a:pathLst>
                <a:path w="3981" h="3103">
                  <a:moveTo>
                    <a:pt x="0" y="0"/>
                  </a:moveTo>
                  <a:lnTo>
                    <a:pt x="92" y="0"/>
                  </a:lnTo>
                  <a:cubicBezTo>
                    <a:pt x="105" y="0"/>
                    <a:pt x="115" y="11"/>
                    <a:pt x="115" y="23"/>
                  </a:cubicBezTo>
                  <a:cubicBezTo>
                    <a:pt x="115" y="36"/>
                    <a:pt x="105" y="46"/>
                    <a:pt x="92" y="46"/>
                  </a:cubicBezTo>
                  <a:lnTo>
                    <a:pt x="0" y="46"/>
                  </a:lnTo>
                  <a:lnTo>
                    <a:pt x="0" y="0"/>
                  </a:lnTo>
                  <a:close/>
                  <a:moveTo>
                    <a:pt x="230" y="0"/>
                  </a:moveTo>
                  <a:lnTo>
                    <a:pt x="322" y="0"/>
                  </a:lnTo>
                  <a:cubicBezTo>
                    <a:pt x="335" y="0"/>
                    <a:pt x="345" y="11"/>
                    <a:pt x="345" y="23"/>
                  </a:cubicBezTo>
                  <a:cubicBezTo>
                    <a:pt x="345" y="36"/>
                    <a:pt x="335" y="46"/>
                    <a:pt x="322" y="46"/>
                  </a:cubicBezTo>
                  <a:lnTo>
                    <a:pt x="230" y="46"/>
                  </a:lnTo>
                  <a:cubicBezTo>
                    <a:pt x="217" y="46"/>
                    <a:pt x="207" y="36"/>
                    <a:pt x="207" y="23"/>
                  </a:cubicBezTo>
                  <a:cubicBezTo>
                    <a:pt x="207" y="11"/>
                    <a:pt x="217" y="0"/>
                    <a:pt x="230" y="0"/>
                  </a:cubicBezTo>
                  <a:close/>
                  <a:moveTo>
                    <a:pt x="461" y="0"/>
                  </a:moveTo>
                  <a:lnTo>
                    <a:pt x="553" y="0"/>
                  </a:lnTo>
                  <a:cubicBezTo>
                    <a:pt x="565" y="0"/>
                    <a:pt x="576" y="11"/>
                    <a:pt x="576" y="23"/>
                  </a:cubicBezTo>
                  <a:cubicBezTo>
                    <a:pt x="576" y="36"/>
                    <a:pt x="565" y="46"/>
                    <a:pt x="553" y="46"/>
                  </a:cubicBezTo>
                  <a:lnTo>
                    <a:pt x="461" y="46"/>
                  </a:lnTo>
                  <a:cubicBezTo>
                    <a:pt x="448" y="46"/>
                    <a:pt x="438" y="36"/>
                    <a:pt x="438" y="23"/>
                  </a:cubicBezTo>
                  <a:cubicBezTo>
                    <a:pt x="438" y="11"/>
                    <a:pt x="448" y="0"/>
                    <a:pt x="461" y="0"/>
                  </a:cubicBezTo>
                  <a:close/>
                  <a:moveTo>
                    <a:pt x="691" y="0"/>
                  </a:moveTo>
                  <a:lnTo>
                    <a:pt x="783" y="0"/>
                  </a:lnTo>
                  <a:cubicBezTo>
                    <a:pt x="796" y="0"/>
                    <a:pt x="806" y="11"/>
                    <a:pt x="806" y="23"/>
                  </a:cubicBezTo>
                  <a:cubicBezTo>
                    <a:pt x="806" y="36"/>
                    <a:pt x="796" y="46"/>
                    <a:pt x="783" y="46"/>
                  </a:cubicBezTo>
                  <a:lnTo>
                    <a:pt x="691" y="46"/>
                  </a:lnTo>
                  <a:cubicBezTo>
                    <a:pt x="678" y="46"/>
                    <a:pt x="668" y="36"/>
                    <a:pt x="668" y="23"/>
                  </a:cubicBezTo>
                  <a:cubicBezTo>
                    <a:pt x="668" y="11"/>
                    <a:pt x="678" y="0"/>
                    <a:pt x="691" y="0"/>
                  </a:cubicBezTo>
                  <a:close/>
                  <a:moveTo>
                    <a:pt x="919" y="56"/>
                  </a:moveTo>
                  <a:lnTo>
                    <a:pt x="931" y="61"/>
                  </a:lnTo>
                  <a:cubicBezTo>
                    <a:pt x="942" y="66"/>
                    <a:pt x="948" y="80"/>
                    <a:pt x="942" y="92"/>
                  </a:cubicBezTo>
                  <a:cubicBezTo>
                    <a:pt x="937" y="103"/>
                    <a:pt x="924" y="108"/>
                    <a:pt x="912" y="103"/>
                  </a:cubicBezTo>
                  <a:lnTo>
                    <a:pt x="901" y="98"/>
                  </a:lnTo>
                  <a:cubicBezTo>
                    <a:pt x="889" y="93"/>
                    <a:pt x="884" y="80"/>
                    <a:pt x="889" y="68"/>
                  </a:cubicBezTo>
                  <a:cubicBezTo>
                    <a:pt x="894" y="56"/>
                    <a:pt x="908" y="51"/>
                    <a:pt x="919" y="56"/>
                  </a:cubicBezTo>
                  <a:close/>
                  <a:moveTo>
                    <a:pt x="929" y="61"/>
                  </a:moveTo>
                  <a:lnTo>
                    <a:pt x="1004" y="88"/>
                  </a:lnTo>
                  <a:cubicBezTo>
                    <a:pt x="1016" y="92"/>
                    <a:pt x="1022" y="105"/>
                    <a:pt x="1018" y="117"/>
                  </a:cubicBezTo>
                  <a:cubicBezTo>
                    <a:pt x="1014" y="129"/>
                    <a:pt x="1000" y="135"/>
                    <a:pt x="988" y="131"/>
                  </a:cubicBezTo>
                  <a:lnTo>
                    <a:pt x="914" y="104"/>
                  </a:lnTo>
                  <a:cubicBezTo>
                    <a:pt x="902" y="100"/>
                    <a:pt x="895" y="86"/>
                    <a:pt x="900" y="74"/>
                  </a:cubicBezTo>
                  <a:cubicBezTo>
                    <a:pt x="904" y="62"/>
                    <a:pt x="917" y="56"/>
                    <a:pt x="929" y="61"/>
                  </a:cubicBezTo>
                  <a:close/>
                  <a:moveTo>
                    <a:pt x="1134" y="135"/>
                  </a:moveTo>
                  <a:lnTo>
                    <a:pt x="1221" y="167"/>
                  </a:lnTo>
                  <a:cubicBezTo>
                    <a:pt x="1233" y="171"/>
                    <a:pt x="1239" y="184"/>
                    <a:pt x="1234" y="196"/>
                  </a:cubicBezTo>
                  <a:cubicBezTo>
                    <a:pt x="1230" y="208"/>
                    <a:pt x="1217" y="214"/>
                    <a:pt x="1205" y="210"/>
                  </a:cubicBezTo>
                  <a:lnTo>
                    <a:pt x="1118" y="178"/>
                  </a:lnTo>
                  <a:cubicBezTo>
                    <a:pt x="1106" y="174"/>
                    <a:pt x="1100" y="161"/>
                    <a:pt x="1105" y="149"/>
                  </a:cubicBezTo>
                  <a:cubicBezTo>
                    <a:pt x="1109" y="137"/>
                    <a:pt x="1122" y="131"/>
                    <a:pt x="1134" y="135"/>
                  </a:cubicBezTo>
                  <a:close/>
                  <a:moveTo>
                    <a:pt x="1351" y="235"/>
                  </a:moveTo>
                  <a:lnTo>
                    <a:pt x="1407" y="308"/>
                  </a:lnTo>
                  <a:cubicBezTo>
                    <a:pt x="1415" y="318"/>
                    <a:pt x="1413" y="333"/>
                    <a:pt x="1403" y="340"/>
                  </a:cubicBezTo>
                  <a:cubicBezTo>
                    <a:pt x="1393" y="348"/>
                    <a:pt x="1378" y="346"/>
                    <a:pt x="1371" y="336"/>
                  </a:cubicBezTo>
                  <a:lnTo>
                    <a:pt x="1315" y="263"/>
                  </a:lnTo>
                  <a:cubicBezTo>
                    <a:pt x="1307" y="252"/>
                    <a:pt x="1309" y="238"/>
                    <a:pt x="1319" y="230"/>
                  </a:cubicBezTo>
                  <a:cubicBezTo>
                    <a:pt x="1329" y="223"/>
                    <a:pt x="1344" y="224"/>
                    <a:pt x="1351" y="235"/>
                  </a:cubicBezTo>
                  <a:close/>
                  <a:moveTo>
                    <a:pt x="1491" y="418"/>
                  </a:moveTo>
                  <a:lnTo>
                    <a:pt x="1548" y="490"/>
                  </a:lnTo>
                  <a:cubicBezTo>
                    <a:pt x="1555" y="500"/>
                    <a:pt x="1554" y="515"/>
                    <a:pt x="1544" y="523"/>
                  </a:cubicBezTo>
                  <a:cubicBezTo>
                    <a:pt x="1534" y="530"/>
                    <a:pt x="1519" y="529"/>
                    <a:pt x="1511" y="519"/>
                  </a:cubicBezTo>
                  <a:lnTo>
                    <a:pt x="1455" y="446"/>
                  </a:lnTo>
                  <a:cubicBezTo>
                    <a:pt x="1447" y="436"/>
                    <a:pt x="1449" y="421"/>
                    <a:pt x="1459" y="413"/>
                  </a:cubicBezTo>
                  <a:cubicBezTo>
                    <a:pt x="1469" y="406"/>
                    <a:pt x="1483" y="407"/>
                    <a:pt x="1491" y="418"/>
                  </a:cubicBezTo>
                  <a:close/>
                  <a:moveTo>
                    <a:pt x="1626" y="608"/>
                  </a:moveTo>
                  <a:lnTo>
                    <a:pt x="1669" y="690"/>
                  </a:lnTo>
                  <a:cubicBezTo>
                    <a:pt x="1675" y="701"/>
                    <a:pt x="1671" y="715"/>
                    <a:pt x="1659" y="721"/>
                  </a:cubicBezTo>
                  <a:cubicBezTo>
                    <a:pt x="1648" y="727"/>
                    <a:pt x="1634" y="723"/>
                    <a:pt x="1628" y="711"/>
                  </a:cubicBezTo>
                  <a:lnTo>
                    <a:pt x="1585" y="630"/>
                  </a:lnTo>
                  <a:cubicBezTo>
                    <a:pt x="1580" y="619"/>
                    <a:pt x="1584" y="605"/>
                    <a:pt x="1595" y="599"/>
                  </a:cubicBezTo>
                  <a:cubicBezTo>
                    <a:pt x="1606" y="593"/>
                    <a:pt x="1620" y="597"/>
                    <a:pt x="1626" y="608"/>
                  </a:cubicBezTo>
                  <a:close/>
                  <a:moveTo>
                    <a:pt x="1733" y="811"/>
                  </a:moveTo>
                  <a:lnTo>
                    <a:pt x="1782" y="889"/>
                  </a:lnTo>
                  <a:cubicBezTo>
                    <a:pt x="1788" y="900"/>
                    <a:pt x="1785" y="914"/>
                    <a:pt x="1774" y="921"/>
                  </a:cubicBezTo>
                  <a:cubicBezTo>
                    <a:pt x="1763" y="927"/>
                    <a:pt x="1749" y="924"/>
                    <a:pt x="1742" y="913"/>
                  </a:cubicBezTo>
                  <a:lnTo>
                    <a:pt x="1694" y="835"/>
                  </a:lnTo>
                  <a:cubicBezTo>
                    <a:pt x="1687" y="824"/>
                    <a:pt x="1691" y="810"/>
                    <a:pt x="1701" y="803"/>
                  </a:cubicBezTo>
                  <a:cubicBezTo>
                    <a:pt x="1712" y="796"/>
                    <a:pt x="1726" y="800"/>
                    <a:pt x="1733" y="811"/>
                  </a:cubicBezTo>
                  <a:close/>
                  <a:moveTo>
                    <a:pt x="1854" y="1007"/>
                  </a:moveTo>
                  <a:lnTo>
                    <a:pt x="1863" y="1020"/>
                  </a:lnTo>
                  <a:cubicBezTo>
                    <a:pt x="1869" y="1031"/>
                    <a:pt x="1866" y="1045"/>
                    <a:pt x="1855" y="1052"/>
                  </a:cubicBezTo>
                  <a:cubicBezTo>
                    <a:pt x="1844" y="1058"/>
                    <a:pt x="1830" y="1055"/>
                    <a:pt x="1823" y="1044"/>
                  </a:cubicBezTo>
                  <a:lnTo>
                    <a:pt x="1815" y="1031"/>
                  </a:lnTo>
                  <a:cubicBezTo>
                    <a:pt x="1808" y="1020"/>
                    <a:pt x="1812" y="1006"/>
                    <a:pt x="1823" y="999"/>
                  </a:cubicBezTo>
                  <a:cubicBezTo>
                    <a:pt x="1833" y="992"/>
                    <a:pt x="1848" y="996"/>
                    <a:pt x="1854" y="1007"/>
                  </a:cubicBezTo>
                  <a:close/>
                  <a:moveTo>
                    <a:pt x="1858" y="1014"/>
                  </a:moveTo>
                  <a:lnTo>
                    <a:pt x="1917" y="1063"/>
                  </a:lnTo>
                  <a:cubicBezTo>
                    <a:pt x="1926" y="1071"/>
                    <a:pt x="1928" y="1085"/>
                    <a:pt x="1920" y="1095"/>
                  </a:cubicBezTo>
                  <a:cubicBezTo>
                    <a:pt x="1912" y="1105"/>
                    <a:pt x="1897" y="1106"/>
                    <a:pt x="1887" y="1098"/>
                  </a:cubicBezTo>
                  <a:lnTo>
                    <a:pt x="1828" y="1050"/>
                  </a:lnTo>
                  <a:cubicBezTo>
                    <a:pt x="1819" y="1042"/>
                    <a:pt x="1817" y="1027"/>
                    <a:pt x="1825" y="1017"/>
                  </a:cubicBezTo>
                  <a:cubicBezTo>
                    <a:pt x="1833" y="1008"/>
                    <a:pt x="1848" y="1006"/>
                    <a:pt x="1858" y="1014"/>
                  </a:cubicBezTo>
                  <a:close/>
                  <a:moveTo>
                    <a:pt x="2023" y="1151"/>
                  </a:moveTo>
                  <a:lnTo>
                    <a:pt x="2095" y="1209"/>
                  </a:lnTo>
                  <a:cubicBezTo>
                    <a:pt x="2104" y="1217"/>
                    <a:pt x="2106" y="1232"/>
                    <a:pt x="2098" y="1242"/>
                  </a:cubicBezTo>
                  <a:cubicBezTo>
                    <a:pt x="2090" y="1252"/>
                    <a:pt x="2075" y="1253"/>
                    <a:pt x="2065" y="1245"/>
                  </a:cubicBezTo>
                  <a:lnTo>
                    <a:pt x="1994" y="1186"/>
                  </a:lnTo>
                  <a:cubicBezTo>
                    <a:pt x="1984" y="1178"/>
                    <a:pt x="1983" y="1164"/>
                    <a:pt x="1991" y="1154"/>
                  </a:cubicBezTo>
                  <a:cubicBezTo>
                    <a:pt x="1999" y="1144"/>
                    <a:pt x="2014" y="1143"/>
                    <a:pt x="2023" y="1151"/>
                  </a:cubicBezTo>
                  <a:close/>
                  <a:moveTo>
                    <a:pt x="2179" y="1327"/>
                  </a:moveTo>
                  <a:lnTo>
                    <a:pt x="2226" y="1406"/>
                  </a:lnTo>
                  <a:cubicBezTo>
                    <a:pt x="2233" y="1417"/>
                    <a:pt x="2229" y="1431"/>
                    <a:pt x="2218" y="1438"/>
                  </a:cubicBezTo>
                  <a:cubicBezTo>
                    <a:pt x="2207" y="1444"/>
                    <a:pt x="2193" y="1441"/>
                    <a:pt x="2186" y="1430"/>
                  </a:cubicBezTo>
                  <a:lnTo>
                    <a:pt x="2139" y="1351"/>
                  </a:lnTo>
                  <a:cubicBezTo>
                    <a:pt x="2133" y="1340"/>
                    <a:pt x="2136" y="1326"/>
                    <a:pt x="2147" y="1319"/>
                  </a:cubicBezTo>
                  <a:cubicBezTo>
                    <a:pt x="2158" y="1312"/>
                    <a:pt x="2172" y="1316"/>
                    <a:pt x="2179" y="1327"/>
                  </a:cubicBezTo>
                  <a:close/>
                  <a:moveTo>
                    <a:pt x="2290" y="1531"/>
                  </a:moveTo>
                  <a:lnTo>
                    <a:pt x="2329" y="1615"/>
                  </a:lnTo>
                  <a:cubicBezTo>
                    <a:pt x="2334" y="1626"/>
                    <a:pt x="2329" y="1640"/>
                    <a:pt x="2317" y="1645"/>
                  </a:cubicBezTo>
                  <a:cubicBezTo>
                    <a:pt x="2306" y="1651"/>
                    <a:pt x="2292" y="1646"/>
                    <a:pt x="2287" y="1634"/>
                  </a:cubicBezTo>
                  <a:lnTo>
                    <a:pt x="2248" y="1550"/>
                  </a:lnTo>
                  <a:cubicBezTo>
                    <a:pt x="2243" y="1539"/>
                    <a:pt x="2248" y="1525"/>
                    <a:pt x="2260" y="1520"/>
                  </a:cubicBezTo>
                  <a:cubicBezTo>
                    <a:pt x="2271" y="1514"/>
                    <a:pt x="2285" y="1519"/>
                    <a:pt x="2290" y="1531"/>
                  </a:cubicBezTo>
                  <a:close/>
                  <a:moveTo>
                    <a:pt x="2386" y="1741"/>
                  </a:moveTo>
                  <a:lnTo>
                    <a:pt x="2389" y="1747"/>
                  </a:lnTo>
                  <a:cubicBezTo>
                    <a:pt x="2394" y="1758"/>
                    <a:pt x="2389" y="1772"/>
                    <a:pt x="2377" y="1777"/>
                  </a:cubicBezTo>
                  <a:cubicBezTo>
                    <a:pt x="2366" y="1783"/>
                    <a:pt x="2352" y="1778"/>
                    <a:pt x="2347" y="1766"/>
                  </a:cubicBezTo>
                  <a:lnTo>
                    <a:pt x="2344" y="1760"/>
                  </a:lnTo>
                  <a:cubicBezTo>
                    <a:pt x="2339" y="1748"/>
                    <a:pt x="2344" y="1735"/>
                    <a:pt x="2355" y="1729"/>
                  </a:cubicBezTo>
                  <a:cubicBezTo>
                    <a:pt x="2367" y="1724"/>
                    <a:pt x="2381" y="1729"/>
                    <a:pt x="2386" y="1741"/>
                  </a:cubicBezTo>
                  <a:close/>
                  <a:moveTo>
                    <a:pt x="2388" y="1746"/>
                  </a:moveTo>
                  <a:lnTo>
                    <a:pt x="2428" y="1822"/>
                  </a:lnTo>
                  <a:cubicBezTo>
                    <a:pt x="2433" y="1833"/>
                    <a:pt x="2429" y="1847"/>
                    <a:pt x="2418" y="1853"/>
                  </a:cubicBezTo>
                  <a:cubicBezTo>
                    <a:pt x="2406" y="1858"/>
                    <a:pt x="2393" y="1854"/>
                    <a:pt x="2387" y="1843"/>
                  </a:cubicBezTo>
                  <a:lnTo>
                    <a:pt x="2347" y="1767"/>
                  </a:lnTo>
                  <a:cubicBezTo>
                    <a:pt x="2341" y="1756"/>
                    <a:pt x="2346" y="1742"/>
                    <a:pt x="2357" y="1736"/>
                  </a:cubicBezTo>
                  <a:cubicBezTo>
                    <a:pt x="2368" y="1730"/>
                    <a:pt x="2382" y="1735"/>
                    <a:pt x="2388" y="1746"/>
                  </a:cubicBezTo>
                  <a:close/>
                  <a:moveTo>
                    <a:pt x="2491" y="1944"/>
                  </a:moveTo>
                  <a:lnTo>
                    <a:pt x="2521" y="2002"/>
                  </a:lnTo>
                  <a:cubicBezTo>
                    <a:pt x="2527" y="2013"/>
                    <a:pt x="2523" y="2027"/>
                    <a:pt x="2512" y="2033"/>
                  </a:cubicBezTo>
                  <a:cubicBezTo>
                    <a:pt x="2500" y="2039"/>
                    <a:pt x="2486" y="2034"/>
                    <a:pt x="2480" y="2023"/>
                  </a:cubicBezTo>
                  <a:lnTo>
                    <a:pt x="2450" y="1965"/>
                  </a:lnTo>
                  <a:cubicBezTo>
                    <a:pt x="2445" y="1954"/>
                    <a:pt x="2449" y="1940"/>
                    <a:pt x="2460" y="1934"/>
                  </a:cubicBezTo>
                  <a:cubicBezTo>
                    <a:pt x="2472" y="1928"/>
                    <a:pt x="2485" y="1933"/>
                    <a:pt x="2491" y="1944"/>
                  </a:cubicBezTo>
                  <a:close/>
                  <a:moveTo>
                    <a:pt x="2514" y="1994"/>
                  </a:moveTo>
                  <a:lnTo>
                    <a:pt x="2536" y="2010"/>
                  </a:lnTo>
                  <a:cubicBezTo>
                    <a:pt x="2547" y="2017"/>
                    <a:pt x="2549" y="2032"/>
                    <a:pt x="2542" y="2042"/>
                  </a:cubicBezTo>
                  <a:cubicBezTo>
                    <a:pt x="2534" y="2052"/>
                    <a:pt x="2520" y="2055"/>
                    <a:pt x="2509" y="2047"/>
                  </a:cubicBezTo>
                  <a:lnTo>
                    <a:pt x="2487" y="2031"/>
                  </a:lnTo>
                  <a:cubicBezTo>
                    <a:pt x="2477" y="2024"/>
                    <a:pt x="2475" y="2009"/>
                    <a:pt x="2482" y="1999"/>
                  </a:cubicBezTo>
                  <a:cubicBezTo>
                    <a:pt x="2490" y="1989"/>
                    <a:pt x="2504" y="1986"/>
                    <a:pt x="2514" y="1994"/>
                  </a:cubicBezTo>
                  <a:close/>
                  <a:moveTo>
                    <a:pt x="2650" y="2093"/>
                  </a:moveTo>
                  <a:lnTo>
                    <a:pt x="2717" y="2157"/>
                  </a:lnTo>
                  <a:cubicBezTo>
                    <a:pt x="2726" y="2166"/>
                    <a:pt x="2726" y="2181"/>
                    <a:pt x="2717" y="2190"/>
                  </a:cubicBezTo>
                  <a:cubicBezTo>
                    <a:pt x="2709" y="2199"/>
                    <a:pt x="2694" y="2199"/>
                    <a:pt x="2685" y="2191"/>
                  </a:cubicBezTo>
                  <a:lnTo>
                    <a:pt x="2618" y="2127"/>
                  </a:lnTo>
                  <a:cubicBezTo>
                    <a:pt x="2609" y="2118"/>
                    <a:pt x="2609" y="2103"/>
                    <a:pt x="2618" y="2094"/>
                  </a:cubicBezTo>
                  <a:cubicBezTo>
                    <a:pt x="2627" y="2085"/>
                    <a:pt x="2641" y="2085"/>
                    <a:pt x="2650" y="2093"/>
                  </a:cubicBezTo>
                  <a:close/>
                  <a:moveTo>
                    <a:pt x="2817" y="2250"/>
                  </a:moveTo>
                  <a:lnTo>
                    <a:pt x="2887" y="2310"/>
                  </a:lnTo>
                  <a:cubicBezTo>
                    <a:pt x="2897" y="2319"/>
                    <a:pt x="2898" y="2333"/>
                    <a:pt x="2890" y="2343"/>
                  </a:cubicBezTo>
                  <a:cubicBezTo>
                    <a:pt x="2881" y="2353"/>
                    <a:pt x="2867" y="2354"/>
                    <a:pt x="2857" y="2345"/>
                  </a:cubicBezTo>
                  <a:lnTo>
                    <a:pt x="2787" y="2285"/>
                  </a:lnTo>
                  <a:cubicBezTo>
                    <a:pt x="2778" y="2277"/>
                    <a:pt x="2777" y="2262"/>
                    <a:pt x="2785" y="2253"/>
                  </a:cubicBezTo>
                  <a:cubicBezTo>
                    <a:pt x="2793" y="2243"/>
                    <a:pt x="2808" y="2242"/>
                    <a:pt x="2817" y="2250"/>
                  </a:cubicBezTo>
                  <a:close/>
                  <a:moveTo>
                    <a:pt x="2969" y="2430"/>
                  </a:moveTo>
                  <a:lnTo>
                    <a:pt x="3015" y="2509"/>
                  </a:lnTo>
                  <a:cubicBezTo>
                    <a:pt x="3022" y="2520"/>
                    <a:pt x="3018" y="2534"/>
                    <a:pt x="3007" y="2541"/>
                  </a:cubicBezTo>
                  <a:cubicBezTo>
                    <a:pt x="2996" y="2547"/>
                    <a:pt x="2982" y="2543"/>
                    <a:pt x="2975" y="2532"/>
                  </a:cubicBezTo>
                  <a:lnTo>
                    <a:pt x="2929" y="2453"/>
                  </a:lnTo>
                  <a:cubicBezTo>
                    <a:pt x="2923" y="2442"/>
                    <a:pt x="2927" y="2428"/>
                    <a:pt x="2938" y="2421"/>
                  </a:cubicBezTo>
                  <a:cubicBezTo>
                    <a:pt x="2949" y="2415"/>
                    <a:pt x="2963" y="2419"/>
                    <a:pt x="2969" y="2430"/>
                  </a:cubicBezTo>
                  <a:close/>
                  <a:moveTo>
                    <a:pt x="3105" y="2591"/>
                  </a:moveTo>
                  <a:lnTo>
                    <a:pt x="3170" y="2627"/>
                  </a:lnTo>
                  <a:cubicBezTo>
                    <a:pt x="3181" y="2633"/>
                    <a:pt x="3185" y="2647"/>
                    <a:pt x="3179" y="2659"/>
                  </a:cubicBezTo>
                  <a:cubicBezTo>
                    <a:pt x="3173" y="2670"/>
                    <a:pt x="3159" y="2674"/>
                    <a:pt x="3148" y="2667"/>
                  </a:cubicBezTo>
                  <a:lnTo>
                    <a:pt x="3082" y="2631"/>
                  </a:lnTo>
                  <a:cubicBezTo>
                    <a:pt x="3071" y="2625"/>
                    <a:pt x="3067" y="2611"/>
                    <a:pt x="3074" y="2600"/>
                  </a:cubicBezTo>
                  <a:cubicBezTo>
                    <a:pt x="3080" y="2589"/>
                    <a:pt x="3094" y="2585"/>
                    <a:pt x="3105" y="2591"/>
                  </a:cubicBezTo>
                  <a:close/>
                  <a:moveTo>
                    <a:pt x="3176" y="2632"/>
                  </a:moveTo>
                  <a:lnTo>
                    <a:pt x="3188" y="2646"/>
                  </a:lnTo>
                  <a:cubicBezTo>
                    <a:pt x="3196" y="2655"/>
                    <a:pt x="3195" y="2670"/>
                    <a:pt x="3185" y="2678"/>
                  </a:cubicBezTo>
                  <a:cubicBezTo>
                    <a:pt x="3176" y="2686"/>
                    <a:pt x="3161" y="2685"/>
                    <a:pt x="3153" y="2676"/>
                  </a:cubicBezTo>
                  <a:lnTo>
                    <a:pt x="3141" y="2662"/>
                  </a:lnTo>
                  <a:cubicBezTo>
                    <a:pt x="3133" y="2653"/>
                    <a:pt x="3134" y="2638"/>
                    <a:pt x="3144" y="2630"/>
                  </a:cubicBezTo>
                  <a:cubicBezTo>
                    <a:pt x="3153" y="2622"/>
                    <a:pt x="3168" y="2623"/>
                    <a:pt x="3176" y="2632"/>
                  </a:cubicBezTo>
                  <a:close/>
                  <a:moveTo>
                    <a:pt x="3278" y="2750"/>
                  </a:moveTo>
                  <a:lnTo>
                    <a:pt x="3307" y="2783"/>
                  </a:lnTo>
                  <a:cubicBezTo>
                    <a:pt x="3315" y="2793"/>
                    <a:pt x="3314" y="2807"/>
                    <a:pt x="3304" y="2816"/>
                  </a:cubicBezTo>
                  <a:cubicBezTo>
                    <a:pt x="3295" y="2824"/>
                    <a:pt x="3280" y="2823"/>
                    <a:pt x="3272" y="2813"/>
                  </a:cubicBezTo>
                  <a:lnTo>
                    <a:pt x="3243" y="2780"/>
                  </a:lnTo>
                  <a:cubicBezTo>
                    <a:pt x="3235" y="2771"/>
                    <a:pt x="3236" y="2756"/>
                    <a:pt x="3246" y="2748"/>
                  </a:cubicBezTo>
                  <a:cubicBezTo>
                    <a:pt x="3255" y="2739"/>
                    <a:pt x="3270" y="2741"/>
                    <a:pt x="3278" y="2750"/>
                  </a:cubicBezTo>
                  <a:close/>
                  <a:moveTo>
                    <a:pt x="3301" y="2778"/>
                  </a:moveTo>
                  <a:lnTo>
                    <a:pt x="3343" y="2802"/>
                  </a:lnTo>
                  <a:cubicBezTo>
                    <a:pt x="3354" y="2808"/>
                    <a:pt x="3358" y="2822"/>
                    <a:pt x="3352" y="2833"/>
                  </a:cubicBezTo>
                  <a:cubicBezTo>
                    <a:pt x="3345" y="2844"/>
                    <a:pt x="3331" y="2848"/>
                    <a:pt x="3320" y="2842"/>
                  </a:cubicBezTo>
                  <a:lnTo>
                    <a:pt x="3278" y="2819"/>
                  </a:lnTo>
                  <a:cubicBezTo>
                    <a:pt x="3267" y="2812"/>
                    <a:pt x="3263" y="2798"/>
                    <a:pt x="3269" y="2787"/>
                  </a:cubicBezTo>
                  <a:cubicBezTo>
                    <a:pt x="3275" y="2776"/>
                    <a:pt x="3289" y="2772"/>
                    <a:pt x="3301" y="2778"/>
                  </a:cubicBezTo>
                  <a:close/>
                  <a:moveTo>
                    <a:pt x="3463" y="2877"/>
                  </a:moveTo>
                  <a:lnTo>
                    <a:pt x="3533" y="2938"/>
                  </a:lnTo>
                  <a:cubicBezTo>
                    <a:pt x="3543" y="2946"/>
                    <a:pt x="3544" y="2961"/>
                    <a:pt x="3536" y="2970"/>
                  </a:cubicBezTo>
                  <a:cubicBezTo>
                    <a:pt x="3527" y="2980"/>
                    <a:pt x="3513" y="2981"/>
                    <a:pt x="3503" y="2973"/>
                  </a:cubicBezTo>
                  <a:lnTo>
                    <a:pt x="3433" y="2912"/>
                  </a:lnTo>
                  <a:cubicBezTo>
                    <a:pt x="3424" y="2904"/>
                    <a:pt x="3423" y="2889"/>
                    <a:pt x="3431" y="2880"/>
                  </a:cubicBezTo>
                  <a:cubicBezTo>
                    <a:pt x="3439" y="2870"/>
                    <a:pt x="3454" y="2869"/>
                    <a:pt x="3463" y="2877"/>
                  </a:cubicBezTo>
                  <a:close/>
                  <a:moveTo>
                    <a:pt x="3648" y="2987"/>
                  </a:moveTo>
                  <a:lnTo>
                    <a:pt x="3692" y="2999"/>
                  </a:lnTo>
                  <a:cubicBezTo>
                    <a:pt x="3704" y="3002"/>
                    <a:pt x="3712" y="3015"/>
                    <a:pt x="3708" y="3027"/>
                  </a:cubicBezTo>
                  <a:cubicBezTo>
                    <a:pt x="3705" y="3039"/>
                    <a:pt x="3692" y="3047"/>
                    <a:pt x="3680" y="3043"/>
                  </a:cubicBezTo>
                  <a:lnTo>
                    <a:pt x="3636" y="3031"/>
                  </a:lnTo>
                  <a:cubicBezTo>
                    <a:pt x="3624" y="3028"/>
                    <a:pt x="3616" y="3016"/>
                    <a:pt x="3620" y="3003"/>
                  </a:cubicBezTo>
                  <a:cubicBezTo>
                    <a:pt x="3623" y="2991"/>
                    <a:pt x="3636" y="2984"/>
                    <a:pt x="3648" y="2987"/>
                  </a:cubicBezTo>
                  <a:close/>
                  <a:moveTo>
                    <a:pt x="3693" y="2999"/>
                  </a:moveTo>
                  <a:lnTo>
                    <a:pt x="3737" y="3012"/>
                  </a:lnTo>
                  <a:cubicBezTo>
                    <a:pt x="3749" y="3016"/>
                    <a:pt x="3756" y="3028"/>
                    <a:pt x="3753" y="3041"/>
                  </a:cubicBezTo>
                  <a:cubicBezTo>
                    <a:pt x="3749" y="3053"/>
                    <a:pt x="3736" y="3060"/>
                    <a:pt x="3724" y="3056"/>
                  </a:cubicBezTo>
                  <a:lnTo>
                    <a:pt x="3680" y="3043"/>
                  </a:lnTo>
                  <a:cubicBezTo>
                    <a:pt x="3667" y="3040"/>
                    <a:pt x="3660" y="3027"/>
                    <a:pt x="3664" y="3015"/>
                  </a:cubicBezTo>
                  <a:cubicBezTo>
                    <a:pt x="3668" y="3002"/>
                    <a:pt x="3680" y="2995"/>
                    <a:pt x="3693" y="2999"/>
                  </a:cubicBezTo>
                  <a:close/>
                  <a:moveTo>
                    <a:pt x="3868" y="3043"/>
                  </a:moveTo>
                  <a:lnTo>
                    <a:pt x="3959" y="3056"/>
                  </a:lnTo>
                  <a:cubicBezTo>
                    <a:pt x="3972" y="3057"/>
                    <a:pt x="3981" y="3069"/>
                    <a:pt x="3979" y="3082"/>
                  </a:cubicBezTo>
                  <a:cubicBezTo>
                    <a:pt x="3977" y="3094"/>
                    <a:pt x="3966" y="3103"/>
                    <a:pt x="3953" y="3101"/>
                  </a:cubicBezTo>
                  <a:lnTo>
                    <a:pt x="3862" y="3089"/>
                  </a:lnTo>
                  <a:cubicBezTo>
                    <a:pt x="3849" y="3087"/>
                    <a:pt x="3840" y="3076"/>
                    <a:pt x="3842" y="3063"/>
                  </a:cubicBezTo>
                  <a:cubicBezTo>
                    <a:pt x="3844" y="3050"/>
                    <a:pt x="3855" y="3041"/>
                    <a:pt x="3868" y="3043"/>
                  </a:cubicBezTo>
                  <a:close/>
                </a:path>
              </a:pathLst>
            </a:custGeom>
            <a:solidFill>
              <a:srgbClr val="A00000"/>
            </a:solidFill>
            <a:ln w="1588" cap="flat">
              <a:solidFill>
                <a:srgbClr val="A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76" name="Freeform 65"/>
            <p:cNvSpPr>
              <a:spLocks/>
            </p:cNvSpPr>
            <p:nvPr/>
          </p:nvSpPr>
          <p:spPr bwMode="auto">
            <a:xfrm>
              <a:off x="534988" y="3241675"/>
              <a:ext cx="1593850" cy="1284287"/>
            </a:xfrm>
            <a:custGeom>
              <a:avLst/>
              <a:gdLst>
                <a:gd name="T0" fmla="*/ 0 w 1004"/>
                <a:gd name="T1" fmla="*/ 0 h 809"/>
                <a:gd name="T2" fmla="*/ 0 w 1004"/>
                <a:gd name="T3" fmla="*/ 0 h 809"/>
                <a:gd name="T4" fmla="*/ 0 w 1004"/>
                <a:gd name="T5" fmla="*/ 0 h 809"/>
                <a:gd name="T6" fmla="*/ 207 w 1004"/>
                <a:gd name="T7" fmla="*/ 0 h 809"/>
                <a:gd name="T8" fmla="*/ 207 w 1004"/>
                <a:gd name="T9" fmla="*/ 0 h 809"/>
                <a:gd name="T10" fmla="*/ 242 w 1004"/>
                <a:gd name="T11" fmla="*/ 13 h 809"/>
                <a:gd name="T12" fmla="*/ 242 w 1004"/>
                <a:gd name="T13" fmla="*/ 13 h 809"/>
                <a:gd name="T14" fmla="*/ 311 w 1004"/>
                <a:gd name="T15" fmla="*/ 54 h 809"/>
                <a:gd name="T16" fmla="*/ 311 w 1004"/>
                <a:gd name="T17" fmla="*/ 54 h 809"/>
                <a:gd name="T18" fmla="*/ 346 w 1004"/>
                <a:gd name="T19" fmla="*/ 129 h 809"/>
                <a:gd name="T20" fmla="*/ 346 w 1004"/>
                <a:gd name="T21" fmla="*/ 129 h 809"/>
                <a:gd name="T22" fmla="*/ 380 w 1004"/>
                <a:gd name="T23" fmla="*/ 200 h 809"/>
                <a:gd name="T24" fmla="*/ 380 w 1004"/>
                <a:gd name="T25" fmla="*/ 200 h 809"/>
                <a:gd name="T26" fmla="*/ 415 w 1004"/>
                <a:gd name="T27" fmla="*/ 250 h 809"/>
                <a:gd name="T28" fmla="*/ 415 w 1004"/>
                <a:gd name="T29" fmla="*/ 250 h 809"/>
                <a:gd name="T30" fmla="*/ 450 w 1004"/>
                <a:gd name="T31" fmla="*/ 296 h 809"/>
                <a:gd name="T32" fmla="*/ 450 w 1004"/>
                <a:gd name="T33" fmla="*/ 296 h 809"/>
                <a:gd name="T34" fmla="*/ 485 w 1004"/>
                <a:gd name="T35" fmla="*/ 380 h 809"/>
                <a:gd name="T36" fmla="*/ 485 w 1004"/>
                <a:gd name="T37" fmla="*/ 380 h 809"/>
                <a:gd name="T38" fmla="*/ 553 w 1004"/>
                <a:gd name="T39" fmla="*/ 434 h 809"/>
                <a:gd name="T40" fmla="*/ 553 w 1004"/>
                <a:gd name="T41" fmla="*/ 434 h 809"/>
                <a:gd name="T42" fmla="*/ 588 w 1004"/>
                <a:gd name="T43" fmla="*/ 487 h 809"/>
                <a:gd name="T44" fmla="*/ 588 w 1004"/>
                <a:gd name="T45" fmla="*/ 487 h 809"/>
                <a:gd name="T46" fmla="*/ 623 w 1004"/>
                <a:gd name="T47" fmla="*/ 586 h 809"/>
                <a:gd name="T48" fmla="*/ 623 w 1004"/>
                <a:gd name="T49" fmla="*/ 586 h 809"/>
                <a:gd name="T50" fmla="*/ 658 w 1004"/>
                <a:gd name="T51" fmla="*/ 622 h 809"/>
                <a:gd name="T52" fmla="*/ 658 w 1004"/>
                <a:gd name="T53" fmla="*/ 622 h 809"/>
                <a:gd name="T54" fmla="*/ 692 w 1004"/>
                <a:gd name="T55" fmla="*/ 666 h 809"/>
                <a:gd name="T56" fmla="*/ 692 w 1004"/>
                <a:gd name="T57" fmla="*/ 666 h 809"/>
                <a:gd name="T58" fmla="*/ 761 w 1004"/>
                <a:gd name="T59" fmla="*/ 684 h 809"/>
                <a:gd name="T60" fmla="*/ 761 w 1004"/>
                <a:gd name="T61" fmla="*/ 684 h 809"/>
                <a:gd name="T62" fmla="*/ 796 w 1004"/>
                <a:gd name="T63" fmla="*/ 711 h 809"/>
                <a:gd name="T64" fmla="*/ 796 w 1004"/>
                <a:gd name="T65" fmla="*/ 711 h 809"/>
                <a:gd name="T66" fmla="*/ 831 w 1004"/>
                <a:gd name="T67" fmla="*/ 747 h 809"/>
                <a:gd name="T68" fmla="*/ 831 w 1004"/>
                <a:gd name="T69" fmla="*/ 747 h 809"/>
                <a:gd name="T70" fmla="*/ 865 w 1004"/>
                <a:gd name="T71" fmla="*/ 764 h 809"/>
                <a:gd name="T72" fmla="*/ 865 w 1004"/>
                <a:gd name="T73" fmla="*/ 764 h 809"/>
                <a:gd name="T74" fmla="*/ 900 w 1004"/>
                <a:gd name="T75" fmla="*/ 774 h 809"/>
                <a:gd name="T76" fmla="*/ 900 w 1004"/>
                <a:gd name="T77" fmla="*/ 774 h 809"/>
                <a:gd name="T78" fmla="*/ 935 w 1004"/>
                <a:gd name="T79" fmla="*/ 791 h 809"/>
                <a:gd name="T80" fmla="*/ 935 w 1004"/>
                <a:gd name="T81" fmla="*/ 791 h 809"/>
                <a:gd name="T82" fmla="*/ 970 w 1004"/>
                <a:gd name="T83" fmla="*/ 800 h 809"/>
                <a:gd name="T84" fmla="*/ 970 w 1004"/>
                <a:gd name="T85" fmla="*/ 800 h 809"/>
                <a:gd name="T86" fmla="*/ 1004 w 1004"/>
                <a:gd name="T87" fmla="*/ 809 h 8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</a:cxnLst>
              <a:rect l="0" t="0" r="r" b="b"/>
              <a:pathLst>
                <a:path w="1004" h="809">
                  <a:moveTo>
                    <a:pt x="0" y="0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207" y="0"/>
                  </a:lnTo>
                  <a:lnTo>
                    <a:pt x="207" y="0"/>
                  </a:lnTo>
                  <a:lnTo>
                    <a:pt x="242" y="13"/>
                  </a:lnTo>
                  <a:lnTo>
                    <a:pt x="242" y="13"/>
                  </a:lnTo>
                  <a:lnTo>
                    <a:pt x="311" y="54"/>
                  </a:lnTo>
                  <a:lnTo>
                    <a:pt x="311" y="54"/>
                  </a:lnTo>
                  <a:lnTo>
                    <a:pt x="346" y="129"/>
                  </a:lnTo>
                  <a:lnTo>
                    <a:pt x="346" y="129"/>
                  </a:lnTo>
                  <a:lnTo>
                    <a:pt x="380" y="200"/>
                  </a:lnTo>
                  <a:lnTo>
                    <a:pt x="380" y="200"/>
                  </a:lnTo>
                  <a:lnTo>
                    <a:pt x="415" y="250"/>
                  </a:lnTo>
                  <a:lnTo>
                    <a:pt x="415" y="250"/>
                  </a:lnTo>
                  <a:lnTo>
                    <a:pt x="450" y="296"/>
                  </a:lnTo>
                  <a:lnTo>
                    <a:pt x="450" y="296"/>
                  </a:lnTo>
                  <a:lnTo>
                    <a:pt x="485" y="380"/>
                  </a:lnTo>
                  <a:lnTo>
                    <a:pt x="485" y="380"/>
                  </a:lnTo>
                  <a:lnTo>
                    <a:pt x="553" y="434"/>
                  </a:lnTo>
                  <a:lnTo>
                    <a:pt x="553" y="434"/>
                  </a:lnTo>
                  <a:lnTo>
                    <a:pt x="588" y="487"/>
                  </a:lnTo>
                  <a:lnTo>
                    <a:pt x="588" y="487"/>
                  </a:lnTo>
                  <a:lnTo>
                    <a:pt x="623" y="586"/>
                  </a:lnTo>
                  <a:lnTo>
                    <a:pt x="623" y="586"/>
                  </a:lnTo>
                  <a:lnTo>
                    <a:pt x="658" y="622"/>
                  </a:lnTo>
                  <a:lnTo>
                    <a:pt x="658" y="622"/>
                  </a:lnTo>
                  <a:lnTo>
                    <a:pt x="692" y="666"/>
                  </a:lnTo>
                  <a:lnTo>
                    <a:pt x="692" y="666"/>
                  </a:lnTo>
                  <a:lnTo>
                    <a:pt x="761" y="684"/>
                  </a:lnTo>
                  <a:lnTo>
                    <a:pt x="761" y="684"/>
                  </a:lnTo>
                  <a:lnTo>
                    <a:pt x="796" y="711"/>
                  </a:lnTo>
                  <a:lnTo>
                    <a:pt x="796" y="711"/>
                  </a:lnTo>
                  <a:lnTo>
                    <a:pt x="831" y="747"/>
                  </a:lnTo>
                  <a:lnTo>
                    <a:pt x="831" y="747"/>
                  </a:lnTo>
                  <a:lnTo>
                    <a:pt x="865" y="764"/>
                  </a:lnTo>
                  <a:lnTo>
                    <a:pt x="865" y="764"/>
                  </a:lnTo>
                  <a:lnTo>
                    <a:pt x="900" y="774"/>
                  </a:lnTo>
                  <a:lnTo>
                    <a:pt x="900" y="774"/>
                  </a:lnTo>
                  <a:lnTo>
                    <a:pt x="935" y="791"/>
                  </a:lnTo>
                  <a:lnTo>
                    <a:pt x="935" y="791"/>
                  </a:lnTo>
                  <a:lnTo>
                    <a:pt x="970" y="800"/>
                  </a:lnTo>
                  <a:lnTo>
                    <a:pt x="970" y="800"/>
                  </a:lnTo>
                  <a:lnTo>
                    <a:pt x="1004" y="809"/>
                  </a:lnTo>
                </a:path>
              </a:pathLst>
            </a:custGeom>
            <a:noFill/>
            <a:ln w="19050" cap="flat">
              <a:solidFill>
                <a:srgbClr val="A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77" name="Rectangle 66"/>
            <p:cNvSpPr>
              <a:spLocks noChangeArrowheads="1"/>
            </p:cNvSpPr>
            <p:nvPr/>
          </p:nvSpPr>
          <p:spPr bwMode="auto">
            <a:xfrm>
              <a:off x="725488" y="2955925"/>
              <a:ext cx="1636713" cy="1746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10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ild</a:t>
              </a:r>
              <a:r>
                <a:rPr kumimoji="0" lang="el-GR" altLang="el-G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el-GR" altLang="el-GR" sz="10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iron</a:t>
              </a:r>
              <a:r>
                <a:rPr kumimoji="0" lang="el-GR" altLang="el-G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el-GR" altLang="el-GR" sz="10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supplementation</a:t>
              </a:r>
              <a:endParaRPr kumimoji="0" lang="el-GR" altLang="el-G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8" name="Rectangle 67"/>
            <p:cNvSpPr>
              <a:spLocks noChangeArrowheads="1"/>
            </p:cNvSpPr>
            <p:nvPr/>
          </p:nvSpPr>
          <p:spPr bwMode="auto">
            <a:xfrm>
              <a:off x="915487" y="4739030"/>
              <a:ext cx="1136530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11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Days</a:t>
              </a:r>
              <a:r>
                <a:rPr kumimoji="0" lang="el-GR" altLang="el-GR" sz="11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of </a:t>
              </a:r>
              <a:r>
                <a:rPr kumimoji="0" lang="el-GR" altLang="el-GR" sz="11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adulthood</a:t>
              </a:r>
              <a:endParaRPr kumimoji="0" lang="el-GR" altLang="el-GR" sz="32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5" name="Rectangle 84"/>
            <p:cNvSpPr>
              <a:spLocks noChangeArrowheads="1"/>
            </p:cNvSpPr>
            <p:nvPr/>
          </p:nvSpPr>
          <p:spPr bwMode="auto">
            <a:xfrm>
              <a:off x="1927225" y="3303588"/>
              <a:ext cx="798295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N2+10mM FAC</a:t>
              </a:r>
              <a:endParaRPr kumimoji="0" lang="el-GR" altLang="el-GR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6" name="Line 85"/>
            <p:cNvSpPr>
              <a:spLocks noChangeShapeType="1"/>
            </p:cNvSpPr>
            <p:nvPr/>
          </p:nvSpPr>
          <p:spPr bwMode="auto">
            <a:xfrm>
              <a:off x="1712913" y="3372837"/>
              <a:ext cx="136525" cy="0"/>
            </a:xfrm>
            <a:prstGeom prst="line">
              <a:avLst/>
            </a:prstGeom>
            <a:noFill/>
            <a:ln w="19050" cap="flat">
              <a:solidFill>
                <a:srgbClr val="A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97" name="Rectangle 86"/>
            <p:cNvSpPr>
              <a:spLocks noChangeArrowheads="1"/>
            </p:cNvSpPr>
            <p:nvPr/>
          </p:nvSpPr>
          <p:spPr bwMode="auto">
            <a:xfrm>
              <a:off x="1927225" y="3484563"/>
              <a:ext cx="90088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N2;</a:t>
              </a:r>
              <a:r>
                <a:rPr kumimoji="0" lang="en-US" altLang="el-GR" sz="9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cisd-1(RNAi)</a:t>
              </a:r>
              <a:r>
                <a:rPr kumimoji="0" lang="en-US" altLang="el-GR" sz="9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+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l-GR" sz="900" dirty="0" smtClean="0">
                  <a:solidFill>
                    <a:srgbClr val="000000"/>
                  </a:solidFill>
                </a:rPr>
                <a:t>10mM FAC</a:t>
              </a:r>
              <a:endParaRPr kumimoji="0" lang="el-GR" altLang="el-GR" sz="20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01" name="Freeform 90"/>
            <p:cNvSpPr>
              <a:spLocks noEditPoints="1"/>
            </p:cNvSpPr>
            <p:nvPr/>
          </p:nvSpPr>
          <p:spPr bwMode="auto">
            <a:xfrm>
              <a:off x="1712913" y="3613537"/>
              <a:ext cx="134938" cy="19050"/>
            </a:xfrm>
            <a:custGeom>
              <a:avLst/>
              <a:gdLst>
                <a:gd name="T0" fmla="*/ 0 w 322"/>
                <a:gd name="T1" fmla="*/ 0 h 47"/>
                <a:gd name="T2" fmla="*/ 92 w 322"/>
                <a:gd name="T3" fmla="*/ 0 h 47"/>
                <a:gd name="T4" fmla="*/ 115 w 322"/>
                <a:gd name="T5" fmla="*/ 24 h 47"/>
                <a:gd name="T6" fmla="*/ 92 w 322"/>
                <a:gd name="T7" fmla="*/ 47 h 47"/>
                <a:gd name="T8" fmla="*/ 0 w 322"/>
                <a:gd name="T9" fmla="*/ 47 h 47"/>
                <a:gd name="T10" fmla="*/ 0 w 322"/>
                <a:gd name="T11" fmla="*/ 0 h 47"/>
                <a:gd name="T12" fmla="*/ 230 w 322"/>
                <a:gd name="T13" fmla="*/ 0 h 47"/>
                <a:gd name="T14" fmla="*/ 322 w 322"/>
                <a:gd name="T15" fmla="*/ 0 h 47"/>
                <a:gd name="T16" fmla="*/ 322 w 322"/>
                <a:gd name="T17" fmla="*/ 47 h 47"/>
                <a:gd name="T18" fmla="*/ 230 w 322"/>
                <a:gd name="T19" fmla="*/ 47 h 47"/>
                <a:gd name="T20" fmla="*/ 207 w 322"/>
                <a:gd name="T21" fmla="*/ 24 h 47"/>
                <a:gd name="T22" fmla="*/ 230 w 322"/>
                <a:gd name="T23" fmla="*/ 0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322" h="47">
                  <a:moveTo>
                    <a:pt x="0" y="0"/>
                  </a:moveTo>
                  <a:lnTo>
                    <a:pt x="92" y="0"/>
                  </a:lnTo>
                  <a:cubicBezTo>
                    <a:pt x="105" y="0"/>
                    <a:pt x="115" y="11"/>
                    <a:pt x="115" y="24"/>
                  </a:cubicBezTo>
                  <a:cubicBezTo>
                    <a:pt x="115" y="36"/>
                    <a:pt x="105" y="47"/>
                    <a:pt x="92" y="47"/>
                  </a:cubicBezTo>
                  <a:lnTo>
                    <a:pt x="0" y="47"/>
                  </a:lnTo>
                  <a:lnTo>
                    <a:pt x="0" y="0"/>
                  </a:lnTo>
                  <a:close/>
                  <a:moveTo>
                    <a:pt x="230" y="0"/>
                  </a:moveTo>
                  <a:lnTo>
                    <a:pt x="322" y="0"/>
                  </a:lnTo>
                  <a:lnTo>
                    <a:pt x="322" y="47"/>
                  </a:lnTo>
                  <a:lnTo>
                    <a:pt x="230" y="47"/>
                  </a:lnTo>
                  <a:cubicBezTo>
                    <a:pt x="218" y="47"/>
                    <a:pt x="207" y="36"/>
                    <a:pt x="207" y="24"/>
                  </a:cubicBezTo>
                  <a:cubicBezTo>
                    <a:pt x="207" y="11"/>
                    <a:pt x="218" y="0"/>
                    <a:pt x="230" y="0"/>
                  </a:cubicBezTo>
                  <a:close/>
                </a:path>
              </a:pathLst>
            </a:custGeom>
            <a:solidFill>
              <a:srgbClr val="A00000"/>
            </a:solidFill>
            <a:ln w="1588" cap="flat">
              <a:solidFill>
                <a:srgbClr val="A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102" name="Rectangle 66"/>
            <p:cNvSpPr>
              <a:spLocks noChangeArrowheads="1"/>
            </p:cNvSpPr>
            <p:nvPr/>
          </p:nvSpPr>
          <p:spPr bwMode="auto">
            <a:xfrm>
              <a:off x="935160" y="529480"/>
              <a:ext cx="112370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l-G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Normal conditions</a:t>
              </a:r>
              <a:endParaRPr kumimoji="0" lang="el-GR" altLang="el-GR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3" name="TextBox 102"/>
            <p:cNvSpPr txBox="1"/>
            <p:nvPr/>
          </p:nvSpPr>
          <p:spPr>
            <a:xfrm rot="16200000">
              <a:off x="-405791" y="3736345"/>
              <a:ext cx="118814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ercent survival</a:t>
              </a:r>
              <a:endParaRPr lang="el-GR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AutoShape 92"/>
            <p:cNvSpPr>
              <a:spLocks noChangeAspect="1" noChangeArrowheads="1" noTextEdit="1"/>
            </p:cNvSpPr>
            <p:nvPr/>
          </p:nvSpPr>
          <p:spPr bwMode="auto">
            <a:xfrm>
              <a:off x="78110" y="5392737"/>
              <a:ext cx="2706687" cy="20939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 sz="800"/>
            </a:p>
          </p:txBody>
        </p:sp>
        <p:sp>
          <p:nvSpPr>
            <p:cNvPr id="108" name="Rectangle 94"/>
            <p:cNvSpPr>
              <a:spLocks noChangeArrowheads="1"/>
            </p:cNvSpPr>
            <p:nvPr/>
          </p:nvSpPr>
          <p:spPr bwMode="auto">
            <a:xfrm>
              <a:off x="515938" y="7107238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el-GR" altLang="el-GR" sz="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9" name="Rectangle 95"/>
            <p:cNvSpPr>
              <a:spLocks noChangeArrowheads="1"/>
            </p:cNvSpPr>
            <p:nvPr/>
          </p:nvSpPr>
          <p:spPr bwMode="auto">
            <a:xfrm>
              <a:off x="795338" y="7107238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</a:t>
              </a:r>
              <a:endParaRPr kumimoji="0" lang="el-GR" altLang="el-GR" sz="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0" name="Rectangle 96"/>
            <p:cNvSpPr>
              <a:spLocks noChangeArrowheads="1"/>
            </p:cNvSpPr>
            <p:nvPr/>
          </p:nvSpPr>
          <p:spPr bwMode="auto">
            <a:xfrm>
              <a:off x="1042988" y="7107238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</a:t>
              </a:r>
              <a:endParaRPr kumimoji="0" lang="el-GR" altLang="el-GR" sz="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1" name="Rectangle 97"/>
            <p:cNvSpPr>
              <a:spLocks noChangeArrowheads="1"/>
            </p:cNvSpPr>
            <p:nvPr/>
          </p:nvSpPr>
          <p:spPr bwMode="auto">
            <a:xfrm>
              <a:off x="1316038" y="7107238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5</a:t>
              </a:r>
              <a:endParaRPr kumimoji="0" lang="el-GR" altLang="el-GR" sz="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2" name="Rectangle 98"/>
            <p:cNvSpPr>
              <a:spLocks noChangeArrowheads="1"/>
            </p:cNvSpPr>
            <p:nvPr/>
          </p:nvSpPr>
          <p:spPr bwMode="auto">
            <a:xfrm>
              <a:off x="1590675" y="7107238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</a:t>
              </a:r>
              <a:endParaRPr kumimoji="0" lang="el-GR" altLang="el-GR" sz="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3" name="Rectangle 99"/>
            <p:cNvSpPr>
              <a:spLocks noChangeArrowheads="1"/>
            </p:cNvSpPr>
            <p:nvPr/>
          </p:nvSpPr>
          <p:spPr bwMode="auto">
            <a:xfrm>
              <a:off x="1863725" y="7107238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5</a:t>
              </a:r>
              <a:endParaRPr kumimoji="0" lang="el-GR" altLang="el-GR" sz="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4" name="Rectangle 100"/>
            <p:cNvSpPr>
              <a:spLocks noChangeArrowheads="1"/>
            </p:cNvSpPr>
            <p:nvPr/>
          </p:nvSpPr>
          <p:spPr bwMode="auto">
            <a:xfrm>
              <a:off x="2138363" y="7107238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0</a:t>
              </a:r>
              <a:endParaRPr kumimoji="0" lang="el-GR" altLang="el-GR" sz="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5" name="Rectangle 101"/>
            <p:cNvSpPr>
              <a:spLocks noChangeArrowheads="1"/>
            </p:cNvSpPr>
            <p:nvPr/>
          </p:nvSpPr>
          <p:spPr bwMode="auto">
            <a:xfrm>
              <a:off x="2411413" y="7107238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5</a:t>
              </a:r>
              <a:endParaRPr kumimoji="0" lang="el-GR" altLang="el-GR" sz="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6" name="Freeform 102"/>
            <p:cNvSpPr>
              <a:spLocks noEditPoints="1"/>
            </p:cNvSpPr>
            <p:nvPr/>
          </p:nvSpPr>
          <p:spPr bwMode="auto">
            <a:xfrm>
              <a:off x="539750" y="7038975"/>
              <a:ext cx="1935162" cy="53975"/>
            </a:xfrm>
            <a:custGeom>
              <a:avLst/>
              <a:gdLst>
                <a:gd name="T0" fmla="*/ 0 w 1219"/>
                <a:gd name="T1" fmla="*/ 0 h 34"/>
                <a:gd name="T2" fmla="*/ 1219 w 1219"/>
                <a:gd name="T3" fmla="*/ 0 h 34"/>
                <a:gd name="T4" fmla="*/ 4 w 1219"/>
                <a:gd name="T5" fmla="*/ 0 h 34"/>
                <a:gd name="T6" fmla="*/ 4 w 1219"/>
                <a:gd name="T7" fmla="*/ 34 h 34"/>
                <a:gd name="T8" fmla="*/ 177 w 1219"/>
                <a:gd name="T9" fmla="*/ 0 h 34"/>
                <a:gd name="T10" fmla="*/ 177 w 1219"/>
                <a:gd name="T11" fmla="*/ 34 h 34"/>
                <a:gd name="T12" fmla="*/ 350 w 1219"/>
                <a:gd name="T13" fmla="*/ 0 h 34"/>
                <a:gd name="T14" fmla="*/ 350 w 1219"/>
                <a:gd name="T15" fmla="*/ 34 h 34"/>
                <a:gd name="T16" fmla="*/ 523 w 1219"/>
                <a:gd name="T17" fmla="*/ 0 h 34"/>
                <a:gd name="T18" fmla="*/ 523 w 1219"/>
                <a:gd name="T19" fmla="*/ 34 h 34"/>
                <a:gd name="T20" fmla="*/ 696 w 1219"/>
                <a:gd name="T21" fmla="*/ 0 h 34"/>
                <a:gd name="T22" fmla="*/ 696 w 1219"/>
                <a:gd name="T23" fmla="*/ 34 h 34"/>
                <a:gd name="T24" fmla="*/ 868 w 1219"/>
                <a:gd name="T25" fmla="*/ 0 h 34"/>
                <a:gd name="T26" fmla="*/ 868 w 1219"/>
                <a:gd name="T27" fmla="*/ 34 h 34"/>
                <a:gd name="T28" fmla="*/ 1041 w 1219"/>
                <a:gd name="T29" fmla="*/ 0 h 34"/>
                <a:gd name="T30" fmla="*/ 1041 w 1219"/>
                <a:gd name="T31" fmla="*/ 34 h 34"/>
                <a:gd name="T32" fmla="*/ 1215 w 1219"/>
                <a:gd name="T33" fmla="*/ 0 h 34"/>
                <a:gd name="T34" fmla="*/ 1215 w 1219"/>
                <a:gd name="T35" fmla="*/ 34 h 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219" h="34">
                  <a:moveTo>
                    <a:pt x="0" y="0"/>
                  </a:moveTo>
                  <a:lnTo>
                    <a:pt x="1219" y="0"/>
                  </a:lnTo>
                  <a:moveTo>
                    <a:pt x="4" y="0"/>
                  </a:moveTo>
                  <a:lnTo>
                    <a:pt x="4" y="34"/>
                  </a:lnTo>
                  <a:moveTo>
                    <a:pt x="177" y="0"/>
                  </a:moveTo>
                  <a:lnTo>
                    <a:pt x="177" y="34"/>
                  </a:lnTo>
                  <a:moveTo>
                    <a:pt x="350" y="0"/>
                  </a:moveTo>
                  <a:lnTo>
                    <a:pt x="350" y="34"/>
                  </a:lnTo>
                  <a:moveTo>
                    <a:pt x="523" y="0"/>
                  </a:moveTo>
                  <a:lnTo>
                    <a:pt x="523" y="34"/>
                  </a:lnTo>
                  <a:moveTo>
                    <a:pt x="696" y="0"/>
                  </a:moveTo>
                  <a:lnTo>
                    <a:pt x="696" y="34"/>
                  </a:lnTo>
                  <a:moveTo>
                    <a:pt x="868" y="0"/>
                  </a:moveTo>
                  <a:lnTo>
                    <a:pt x="868" y="34"/>
                  </a:lnTo>
                  <a:moveTo>
                    <a:pt x="1041" y="0"/>
                  </a:moveTo>
                  <a:lnTo>
                    <a:pt x="1041" y="34"/>
                  </a:lnTo>
                  <a:moveTo>
                    <a:pt x="1215" y="0"/>
                  </a:moveTo>
                  <a:lnTo>
                    <a:pt x="1215" y="34"/>
                  </a:lnTo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117" name="Rectangle 103"/>
            <p:cNvSpPr>
              <a:spLocks noChangeArrowheads="1"/>
            </p:cNvSpPr>
            <p:nvPr/>
          </p:nvSpPr>
          <p:spPr bwMode="auto">
            <a:xfrm>
              <a:off x="422275" y="6980238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el-GR" altLang="el-GR" sz="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8" name="Rectangle 104"/>
            <p:cNvSpPr>
              <a:spLocks noChangeArrowheads="1"/>
            </p:cNvSpPr>
            <p:nvPr/>
          </p:nvSpPr>
          <p:spPr bwMode="auto">
            <a:xfrm>
              <a:off x="368300" y="6726238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</a:t>
              </a:r>
              <a:endParaRPr kumimoji="0" lang="el-GR" altLang="el-GR" sz="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9" name="Rectangle 105"/>
            <p:cNvSpPr>
              <a:spLocks noChangeArrowheads="1"/>
            </p:cNvSpPr>
            <p:nvPr/>
          </p:nvSpPr>
          <p:spPr bwMode="auto">
            <a:xfrm>
              <a:off x="368300" y="6465888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0</a:t>
              </a:r>
              <a:endParaRPr kumimoji="0" lang="el-GR" altLang="el-GR" sz="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0" name="Rectangle 106"/>
            <p:cNvSpPr>
              <a:spLocks noChangeArrowheads="1"/>
            </p:cNvSpPr>
            <p:nvPr/>
          </p:nvSpPr>
          <p:spPr bwMode="auto">
            <a:xfrm>
              <a:off x="368300" y="6210300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0</a:t>
              </a:r>
              <a:endParaRPr kumimoji="0" lang="el-GR" altLang="el-GR" sz="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1" name="Rectangle 107"/>
            <p:cNvSpPr>
              <a:spLocks noChangeArrowheads="1"/>
            </p:cNvSpPr>
            <p:nvPr/>
          </p:nvSpPr>
          <p:spPr bwMode="auto">
            <a:xfrm>
              <a:off x="368300" y="5949950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0</a:t>
              </a:r>
              <a:endParaRPr kumimoji="0" lang="el-GR" altLang="el-GR" sz="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2" name="Rectangle 108"/>
            <p:cNvSpPr>
              <a:spLocks noChangeArrowheads="1"/>
            </p:cNvSpPr>
            <p:nvPr/>
          </p:nvSpPr>
          <p:spPr bwMode="auto">
            <a:xfrm>
              <a:off x="315913" y="5695950"/>
              <a:ext cx="17312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</a:t>
              </a:r>
              <a:endParaRPr kumimoji="0" lang="el-GR" altLang="el-GR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3" name="Freeform 109"/>
            <p:cNvSpPr>
              <a:spLocks noEditPoints="1"/>
            </p:cNvSpPr>
            <p:nvPr/>
          </p:nvSpPr>
          <p:spPr bwMode="auto">
            <a:xfrm>
              <a:off x="492125" y="5748338"/>
              <a:ext cx="53975" cy="1296988"/>
            </a:xfrm>
            <a:custGeom>
              <a:avLst/>
              <a:gdLst>
                <a:gd name="T0" fmla="*/ 34 w 34"/>
                <a:gd name="T1" fmla="*/ 817 h 817"/>
                <a:gd name="T2" fmla="*/ 34 w 34"/>
                <a:gd name="T3" fmla="*/ 0 h 817"/>
                <a:gd name="T4" fmla="*/ 34 w 34"/>
                <a:gd name="T5" fmla="*/ 813 h 817"/>
                <a:gd name="T6" fmla="*/ 0 w 34"/>
                <a:gd name="T7" fmla="*/ 813 h 817"/>
                <a:gd name="T8" fmla="*/ 34 w 34"/>
                <a:gd name="T9" fmla="*/ 651 h 817"/>
                <a:gd name="T10" fmla="*/ 0 w 34"/>
                <a:gd name="T11" fmla="*/ 651 h 817"/>
                <a:gd name="T12" fmla="*/ 34 w 34"/>
                <a:gd name="T13" fmla="*/ 489 h 817"/>
                <a:gd name="T14" fmla="*/ 0 w 34"/>
                <a:gd name="T15" fmla="*/ 489 h 817"/>
                <a:gd name="T16" fmla="*/ 34 w 34"/>
                <a:gd name="T17" fmla="*/ 327 h 817"/>
                <a:gd name="T18" fmla="*/ 0 w 34"/>
                <a:gd name="T19" fmla="*/ 327 h 817"/>
                <a:gd name="T20" fmla="*/ 34 w 34"/>
                <a:gd name="T21" fmla="*/ 166 h 817"/>
                <a:gd name="T22" fmla="*/ 0 w 34"/>
                <a:gd name="T23" fmla="*/ 166 h 817"/>
                <a:gd name="T24" fmla="*/ 34 w 34"/>
                <a:gd name="T25" fmla="*/ 4 h 817"/>
                <a:gd name="T26" fmla="*/ 0 w 34"/>
                <a:gd name="T27" fmla="*/ 4 h 8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34" h="817">
                  <a:moveTo>
                    <a:pt x="34" y="817"/>
                  </a:moveTo>
                  <a:lnTo>
                    <a:pt x="34" y="0"/>
                  </a:lnTo>
                  <a:moveTo>
                    <a:pt x="34" y="813"/>
                  </a:moveTo>
                  <a:lnTo>
                    <a:pt x="0" y="813"/>
                  </a:lnTo>
                  <a:moveTo>
                    <a:pt x="34" y="651"/>
                  </a:moveTo>
                  <a:lnTo>
                    <a:pt x="0" y="651"/>
                  </a:lnTo>
                  <a:moveTo>
                    <a:pt x="34" y="489"/>
                  </a:moveTo>
                  <a:lnTo>
                    <a:pt x="0" y="489"/>
                  </a:lnTo>
                  <a:moveTo>
                    <a:pt x="34" y="327"/>
                  </a:moveTo>
                  <a:lnTo>
                    <a:pt x="0" y="327"/>
                  </a:lnTo>
                  <a:moveTo>
                    <a:pt x="34" y="166"/>
                  </a:moveTo>
                  <a:lnTo>
                    <a:pt x="0" y="166"/>
                  </a:lnTo>
                  <a:moveTo>
                    <a:pt x="34" y="4"/>
                  </a:moveTo>
                  <a:lnTo>
                    <a:pt x="0" y="4"/>
                  </a:lnTo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124" name="Freeform 110"/>
            <p:cNvSpPr>
              <a:spLocks noEditPoints="1"/>
            </p:cNvSpPr>
            <p:nvPr/>
          </p:nvSpPr>
          <p:spPr bwMode="auto">
            <a:xfrm>
              <a:off x="546100" y="5745163"/>
              <a:ext cx="1474787" cy="1300163"/>
            </a:xfrm>
            <a:custGeom>
              <a:avLst/>
              <a:gdLst>
                <a:gd name="T0" fmla="*/ 92 w 3536"/>
                <a:gd name="T1" fmla="*/ 46 h 3113"/>
                <a:gd name="T2" fmla="*/ 322 w 3536"/>
                <a:gd name="T3" fmla="*/ 0 h 3113"/>
                <a:gd name="T4" fmla="*/ 207 w 3536"/>
                <a:gd name="T5" fmla="*/ 23 h 3113"/>
                <a:gd name="T6" fmla="*/ 576 w 3536"/>
                <a:gd name="T7" fmla="*/ 23 h 3113"/>
                <a:gd name="T8" fmla="*/ 461 w 3536"/>
                <a:gd name="T9" fmla="*/ 0 h 3113"/>
                <a:gd name="T10" fmla="*/ 783 w 3536"/>
                <a:gd name="T11" fmla="*/ 46 h 3113"/>
                <a:gd name="T12" fmla="*/ 923 w 3536"/>
                <a:gd name="T13" fmla="*/ 26 h 3113"/>
                <a:gd name="T14" fmla="*/ 915 w 3536"/>
                <a:gd name="T15" fmla="*/ 71 h 3113"/>
                <a:gd name="T16" fmla="*/ 1011 w 3536"/>
                <a:gd name="T17" fmla="*/ 74 h 3113"/>
                <a:gd name="T18" fmla="*/ 901 w 3536"/>
                <a:gd name="T19" fmla="*/ 37 h 3113"/>
                <a:gd name="T20" fmla="*/ 1202 w 3536"/>
                <a:gd name="T21" fmla="*/ 212 h 3113"/>
                <a:gd name="T22" fmla="*/ 1130 w 3536"/>
                <a:gd name="T23" fmla="*/ 143 h 3113"/>
                <a:gd name="T24" fmla="*/ 1180 w 3536"/>
                <a:gd name="T25" fmla="*/ 229 h 3113"/>
                <a:gd name="T26" fmla="*/ 1312 w 3536"/>
                <a:gd name="T27" fmla="*/ 291 h 3113"/>
                <a:gd name="T28" fmla="*/ 1281 w 3536"/>
                <a:gd name="T29" fmla="*/ 324 h 3113"/>
                <a:gd name="T30" fmla="*/ 1371 w 3536"/>
                <a:gd name="T31" fmla="*/ 368 h 3113"/>
                <a:gd name="T32" fmla="*/ 1303 w 3536"/>
                <a:gd name="T33" fmla="*/ 306 h 3113"/>
                <a:gd name="T34" fmla="*/ 1459 w 3536"/>
                <a:gd name="T35" fmla="*/ 547 h 3113"/>
                <a:gd name="T36" fmla="*/ 1446 w 3536"/>
                <a:gd name="T37" fmla="*/ 484 h 3113"/>
                <a:gd name="T38" fmla="*/ 1458 w 3536"/>
                <a:gd name="T39" fmla="*/ 587 h 3113"/>
                <a:gd name="T40" fmla="*/ 1573 w 3536"/>
                <a:gd name="T41" fmla="*/ 676 h 3113"/>
                <a:gd name="T42" fmla="*/ 1535 w 3536"/>
                <a:gd name="T43" fmla="*/ 702 h 3113"/>
                <a:gd name="T44" fmla="*/ 1623 w 3536"/>
                <a:gd name="T45" fmla="*/ 754 h 3113"/>
                <a:gd name="T46" fmla="*/ 1567 w 3536"/>
                <a:gd name="T47" fmla="*/ 708 h 3113"/>
                <a:gd name="T48" fmla="*/ 1722 w 3536"/>
                <a:gd name="T49" fmla="*/ 957 h 3113"/>
                <a:gd name="T50" fmla="*/ 1696 w 3536"/>
                <a:gd name="T51" fmla="*/ 872 h 3113"/>
                <a:gd name="T52" fmla="*/ 1700 w 3536"/>
                <a:gd name="T53" fmla="*/ 973 h 3113"/>
                <a:gd name="T54" fmla="*/ 1797 w 3536"/>
                <a:gd name="T55" fmla="*/ 1082 h 3113"/>
                <a:gd name="T56" fmla="*/ 1754 w 3536"/>
                <a:gd name="T57" fmla="*/ 1100 h 3113"/>
                <a:gd name="T58" fmla="*/ 1971 w 3536"/>
                <a:gd name="T59" fmla="*/ 1333 h 3113"/>
                <a:gd name="T60" fmla="*/ 1869 w 3536"/>
                <a:gd name="T61" fmla="*/ 1273 h 3113"/>
                <a:gd name="T62" fmla="*/ 2121 w 3536"/>
                <a:gd name="T63" fmla="*/ 1498 h 3113"/>
                <a:gd name="T64" fmla="*/ 2074 w 3536"/>
                <a:gd name="T65" fmla="*/ 1425 h 3113"/>
                <a:gd name="T66" fmla="*/ 2098 w 3536"/>
                <a:gd name="T67" fmla="*/ 1521 h 3113"/>
                <a:gd name="T68" fmla="*/ 2204 w 3536"/>
                <a:gd name="T69" fmla="*/ 1621 h 3113"/>
                <a:gd name="T70" fmla="*/ 2163 w 3536"/>
                <a:gd name="T71" fmla="*/ 1643 h 3113"/>
                <a:gd name="T72" fmla="*/ 2333 w 3536"/>
                <a:gd name="T73" fmla="*/ 1919 h 3113"/>
                <a:gd name="T74" fmla="*/ 2270 w 3536"/>
                <a:gd name="T75" fmla="*/ 1820 h 3113"/>
                <a:gd name="T76" fmla="*/ 2376 w 3536"/>
                <a:gd name="T77" fmla="*/ 2095 h 3113"/>
                <a:gd name="T78" fmla="*/ 2383 w 3536"/>
                <a:gd name="T79" fmla="*/ 2048 h 3113"/>
                <a:gd name="T80" fmla="*/ 2381 w 3536"/>
                <a:gd name="T81" fmla="*/ 2150 h 3113"/>
                <a:gd name="T82" fmla="*/ 2486 w 3536"/>
                <a:gd name="T83" fmla="*/ 2251 h 3113"/>
                <a:gd name="T84" fmla="*/ 2445 w 3536"/>
                <a:gd name="T85" fmla="*/ 2272 h 3113"/>
                <a:gd name="T86" fmla="*/ 2528 w 3536"/>
                <a:gd name="T87" fmla="*/ 2335 h 3113"/>
                <a:gd name="T88" fmla="*/ 2492 w 3536"/>
                <a:gd name="T89" fmla="*/ 2309 h 3113"/>
                <a:gd name="T90" fmla="*/ 2605 w 3536"/>
                <a:gd name="T91" fmla="*/ 2578 h 3113"/>
                <a:gd name="T92" fmla="*/ 2581 w 3536"/>
                <a:gd name="T93" fmla="*/ 2463 h 3113"/>
                <a:gd name="T94" fmla="*/ 2709 w 3536"/>
                <a:gd name="T95" fmla="*/ 2758 h 3113"/>
                <a:gd name="T96" fmla="*/ 2833 w 3536"/>
                <a:gd name="T97" fmla="*/ 2834 h 3113"/>
                <a:gd name="T98" fmla="*/ 2796 w 3536"/>
                <a:gd name="T99" fmla="*/ 2862 h 3113"/>
                <a:gd name="T100" fmla="*/ 3031 w 3536"/>
                <a:gd name="T101" fmla="*/ 2960 h 3113"/>
                <a:gd name="T102" fmla="*/ 2967 w 3536"/>
                <a:gd name="T103" fmla="*/ 2970 h 3113"/>
                <a:gd name="T104" fmla="*/ 3103 w 3536"/>
                <a:gd name="T105" fmla="*/ 2999 h 3113"/>
                <a:gd name="T106" fmla="*/ 3030 w 3536"/>
                <a:gd name="T107" fmla="*/ 2960 h 3113"/>
                <a:gd name="T108" fmla="*/ 3285 w 3536"/>
                <a:gd name="T109" fmla="*/ 3062 h 3113"/>
                <a:gd name="T110" fmla="*/ 3294 w 3536"/>
                <a:gd name="T111" fmla="*/ 3016 h 3113"/>
                <a:gd name="T112" fmla="*/ 3285 w 3536"/>
                <a:gd name="T113" fmla="*/ 3062 h 3113"/>
                <a:gd name="T114" fmla="*/ 3536 w 3536"/>
                <a:gd name="T115" fmla="*/ 3068 h 3113"/>
                <a:gd name="T116" fmla="*/ 3445 w 3536"/>
                <a:gd name="T117" fmla="*/ 3049 h 31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</a:cxnLst>
              <a:rect l="0" t="0" r="r" b="b"/>
              <a:pathLst>
                <a:path w="3536" h="3113">
                  <a:moveTo>
                    <a:pt x="0" y="0"/>
                  </a:moveTo>
                  <a:lnTo>
                    <a:pt x="92" y="0"/>
                  </a:lnTo>
                  <a:cubicBezTo>
                    <a:pt x="105" y="0"/>
                    <a:pt x="115" y="11"/>
                    <a:pt x="115" y="23"/>
                  </a:cubicBezTo>
                  <a:cubicBezTo>
                    <a:pt x="115" y="36"/>
                    <a:pt x="105" y="46"/>
                    <a:pt x="92" y="46"/>
                  </a:cubicBezTo>
                  <a:lnTo>
                    <a:pt x="0" y="46"/>
                  </a:lnTo>
                  <a:lnTo>
                    <a:pt x="0" y="0"/>
                  </a:lnTo>
                  <a:close/>
                  <a:moveTo>
                    <a:pt x="230" y="0"/>
                  </a:moveTo>
                  <a:lnTo>
                    <a:pt x="322" y="0"/>
                  </a:lnTo>
                  <a:cubicBezTo>
                    <a:pt x="335" y="0"/>
                    <a:pt x="345" y="11"/>
                    <a:pt x="345" y="23"/>
                  </a:cubicBezTo>
                  <a:cubicBezTo>
                    <a:pt x="345" y="36"/>
                    <a:pt x="335" y="46"/>
                    <a:pt x="322" y="46"/>
                  </a:cubicBezTo>
                  <a:lnTo>
                    <a:pt x="230" y="46"/>
                  </a:lnTo>
                  <a:cubicBezTo>
                    <a:pt x="217" y="46"/>
                    <a:pt x="207" y="36"/>
                    <a:pt x="207" y="23"/>
                  </a:cubicBezTo>
                  <a:cubicBezTo>
                    <a:pt x="207" y="11"/>
                    <a:pt x="217" y="0"/>
                    <a:pt x="230" y="0"/>
                  </a:cubicBezTo>
                  <a:close/>
                  <a:moveTo>
                    <a:pt x="461" y="0"/>
                  </a:moveTo>
                  <a:lnTo>
                    <a:pt x="553" y="0"/>
                  </a:lnTo>
                  <a:cubicBezTo>
                    <a:pt x="565" y="0"/>
                    <a:pt x="576" y="11"/>
                    <a:pt x="576" y="23"/>
                  </a:cubicBezTo>
                  <a:cubicBezTo>
                    <a:pt x="576" y="36"/>
                    <a:pt x="565" y="46"/>
                    <a:pt x="553" y="46"/>
                  </a:cubicBezTo>
                  <a:lnTo>
                    <a:pt x="461" y="46"/>
                  </a:lnTo>
                  <a:cubicBezTo>
                    <a:pt x="448" y="46"/>
                    <a:pt x="438" y="36"/>
                    <a:pt x="438" y="23"/>
                  </a:cubicBezTo>
                  <a:cubicBezTo>
                    <a:pt x="438" y="11"/>
                    <a:pt x="448" y="0"/>
                    <a:pt x="461" y="0"/>
                  </a:cubicBezTo>
                  <a:close/>
                  <a:moveTo>
                    <a:pt x="691" y="0"/>
                  </a:moveTo>
                  <a:lnTo>
                    <a:pt x="783" y="0"/>
                  </a:lnTo>
                  <a:cubicBezTo>
                    <a:pt x="796" y="0"/>
                    <a:pt x="806" y="11"/>
                    <a:pt x="806" y="23"/>
                  </a:cubicBezTo>
                  <a:cubicBezTo>
                    <a:pt x="806" y="36"/>
                    <a:pt x="796" y="46"/>
                    <a:pt x="783" y="46"/>
                  </a:cubicBezTo>
                  <a:lnTo>
                    <a:pt x="691" y="46"/>
                  </a:lnTo>
                  <a:cubicBezTo>
                    <a:pt x="678" y="46"/>
                    <a:pt x="668" y="36"/>
                    <a:pt x="668" y="23"/>
                  </a:cubicBezTo>
                  <a:cubicBezTo>
                    <a:pt x="668" y="11"/>
                    <a:pt x="678" y="0"/>
                    <a:pt x="691" y="0"/>
                  </a:cubicBezTo>
                  <a:close/>
                  <a:moveTo>
                    <a:pt x="923" y="26"/>
                  </a:moveTo>
                  <a:lnTo>
                    <a:pt x="926" y="26"/>
                  </a:lnTo>
                  <a:cubicBezTo>
                    <a:pt x="938" y="29"/>
                    <a:pt x="946" y="41"/>
                    <a:pt x="944" y="53"/>
                  </a:cubicBezTo>
                  <a:cubicBezTo>
                    <a:pt x="942" y="66"/>
                    <a:pt x="930" y="74"/>
                    <a:pt x="917" y="72"/>
                  </a:cubicBezTo>
                  <a:lnTo>
                    <a:pt x="915" y="71"/>
                  </a:lnTo>
                  <a:cubicBezTo>
                    <a:pt x="902" y="69"/>
                    <a:pt x="894" y="57"/>
                    <a:pt x="896" y="44"/>
                  </a:cubicBezTo>
                  <a:cubicBezTo>
                    <a:pt x="899" y="32"/>
                    <a:pt x="911" y="23"/>
                    <a:pt x="923" y="26"/>
                  </a:cubicBezTo>
                  <a:close/>
                  <a:moveTo>
                    <a:pt x="933" y="29"/>
                  </a:moveTo>
                  <a:lnTo>
                    <a:pt x="1011" y="74"/>
                  </a:lnTo>
                  <a:cubicBezTo>
                    <a:pt x="1022" y="80"/>
                    <a:pt x="1025" y="94"/>
                    <a:pt x="1019" y="105"/>
                  </a:cubicBezTo>
                  <a:cubicBezTo>
                    <a:pt x="1013" y="116"/>
                    <a:pt x="999" y="120"/>
                    <a:pt x="988" y="114"/>
                  </a:cubicBezTo>
                  <a:lnTo>
                    <a:pt x="910" y="69"/>
                  </a:lnTo>
                  <a:cubicBezTo>
                    <a:pt x="899" y="63"/>
                    <a:pt x="895" y="48"/>
                    <a:pt x="901" y="37"/>
                  </a:cubicBezTo>
                  <a:cubicBezTo>
                    <a:pt x="908" y="26"/>
                    <a:pt x="922" y="23"/>
                    <a:pt x="933" y="29"/>
                  </a:cubicBezTo>
                  <a:close/>
                  <a:moveTo>
                    <a:pt x="1130" y="143"/>
                  </a:moveTo>
                  <a:lnTo>
                    <a:pt x="1194" y="180"/>
                  </a:lnTo>
                  <a:cubicBezTo>
                    <a:pt x="1205" y="186"/>
                    <a:pt x="1209" y="201"/>
                    <a:pt x="1202" y="212"/>
                  </a:cubicBezTo>
                  <a:cubicBezTo>
                    <a:pt x="1196" y="223"/>
                    <a:pt x="1182" y="226"/>
                    <a:pt x="1171" y="220"/>
                  </a:cubicBezTo>
                  <a:lnTo>
                    <a:pt x="1107" y="183"/>
                  </a:lnTo>
                  <a:cubicBezTo>
                    <a:pt x="1096" y="177"/>
                    <a:pt x="1092" y="163"/>
                    <a:pt x="1099" y="152"/>
                  </a:cubicBezTo>
                  <a:cubicBezTo>
                    <a:pt x="1105" y="141"/>
                    <a:pt x="1119" y="137"/>
                    <a:pt x="1130" y="143"/>
                  </a:cubicBezTo>
                  <a:close/>
                  <a:moveTo>
                    <a:pt x="1198" y="183"/>
                  </a:moveTo>
                  <a:lnTo>
                    <a:pt x="1212" y="196"/>
                  </a:lnTo>
                  <a:cubicBezTo>
                    <a:pt x="1221" y="205"/>
                    <a:pt x="1221" y="219"/>
                    <a:pt x="1213" y="228"/>
                  </a:cubicBezTo>
                  <a:cubicBezTo>
                    <a:pt x="1204" y="238"/>
                    <a:pt x="1189" y="238"/>
                    <a:pt x="1180" y="229"/>
                  </a:cubicBezTo>
                  <a:lnTo>
                    <a:pt x="1167" y="217"/>
                  </a:lnTo>
                  <a:cubicBezTo>
                    <a:pt x="1157" y="208"/>
                    <a:pt x="1157" y="193"/>
                    <a:pt x="1166" y="184"/>
                  </a:cubicBezTo>
                  <a:cubicBezTo>
                    <a:pt x="1174" y="175"/>
                    <a:pt x="1189" y="174"/>
                    <a:pt x="1198" y="183"/>
                  </a:cubicBezTo>
                  <a:close/>
                  <a:moveTo>
                    <a:pt x="1312" y="291"/>
                  </a:moveTo>
                  <a:lnTo>
                    <a:pt x="1331" y="309"/>
                  </a:lnTo>
                  <a:cubicBezTo>
                    <a:pt x="1341" y="317"/>
                    <a:pt x="1341" y="332"/>
                    <a:pt x="1332" y="341"/>
                  </a:cubicBezTo>
                  <a:cubicBezTo>
                    <a:pt x="1324" y="350"/>
                    <a:pt x="1309" y="351"/>
                    <a:pt x="1300" y="342"/>
                  </a:cubicBezTo>
                  <a:lnTo>
                    <a:pt x="1281" y="324"/>
                  </a:lnTo>
                  <a:cubicBezTo>
                    <a:pt x="1271" y="315"/>
                    <a:pt x="1271" y="301"/>
                    <a:pt x="1280" y="292"/>
                  </a:cubicBezTo>
                  <a:cubicBezTo>
                    <a:pt x="1289" y="282"/>
                    <a:pt x="1303" y="282"/>
                    <a:pt x="1312" y="291"/>
                  </a:cubicBezTo>
                  <a:close/>
                  <a:moveTo>
                    <a:pt x="1335" y="313"/>
                  </a:moveTo>
                  <a:lnTo>
                    <a:pt x="1371" y="368"/>
                  </a:lnTo>
                  <a:cubicBezTo>
                    <a:pt x="1378" y="379"/>
                    <a:pt x="1375" y="393"/>
                    <a:pt x="1364" y="400"/>
                  </a:cubicBezTo>
                  <a:cubicBezTo>
                    <a:pt x="1353" y="407"/>
                    <a:pt x="1339" y="404"/>
                    <a:pt x="1332" y="393"/>
                  </a:cubicBezTo>
                  <a:lnTo>
                    <a:pt x="1296" y="338"/>
                  </a:lnTo>
                  <a:cubicBezTo>
                    <a:pt x="1289" y="327"/>
                    <a:pt x="1292" y="313"/>
                    <a:pt x="1303" y="306"/>
                  </a:cubicBezTo>
                  <a:cubicBezTo>
                    <a:pt x="1314" y="299"/>
                    <a:pt x="1328" y="302"/>
                    <a:pt x="1335" y="313"/>
                  </a:cubicBezTo>
                  <a:close/>
                  <a:moveTo>
                    <a:pt x="1446" y="484"/>
                  </a:moveTo>
                  <a:lnTo>
                    <a:pt x="1466" y="515"/>
                  </a:lnTo>
                  <a:cubicBezTo>
                    <a:pt x="1472" y="526"/>
                    <a:pt x="1469" y="540"/>
                    <a:pt x="1459" y="547"/>
                  </a:cubicBezTo>
                  <a:cubicBezTo>
                    <a:pt x="1448" y="554"/>
                    <a:pt x="1434" y="551"/>
                    <a:pt x="1427" y="540"/>
                  </a:cubicBezTo>
                  <a:lnTo>
                    <a:pt x="1407" y="509"/>
                  </a:lnTo>
                  <a:cubicBezTo>
                    <a:pt x="1400" y="499"/>
                    <a:pt x="1403" y="485"/>
                    <a:pt x="1414" y="478"/>
                  </a:cubicBezTo>
                  <a:cubicBezTo>
                    <a:pt x="1425" y="471"/>
                    <a:pt x="1439" y="474"/>
                    <a:pt x="1446" y="484"/>
                  </a:cubicBezTo>
                  <a:close/>
                  <a:moveTo>
                    <a:pt x="1465" y="515"/>
                  </a:moveTo>
                  <a:lnTo>
                    <a:pt x="1496" y="561"/>
                  </a:lnTo>
                  <a:cubicBezTo>
                    <a:pt x="1503" y="572"/>
                    <a:pt x="1500" y="586"/>
                    <a:pt x="1490" y="593"/>
                  </a:cubicBezTo>
                  <a:cubicBezTo>
                    <a:pt x="1479" y="600"/>
                    <a:pt x="1465" y="597"/>
                    <a:pt x="1458" y="587"/>
                  </a:cubicBezTo>
                  <a:lnTo>
                    <a:pt x="1427" y="540"/>
                  </a:lnTo>
                  <a:cubicBezTo>
                    <a:pt x="1420" y="530"/>
                    <a:pt x="1423" y="516"/>
                    <a:pt x="1433" y="508"/>
                  </a:cubicBezTo>
                  <a:cubicBezTo>
                    <a:pt x="1444" y="501"/>
                    <a:pt x="1458" y="504"/>
                    <a:pt x="1465" y="515"/>
                  </a:cubicBezTo>
                  <a:close/>
                  <a:moveTo>
                    <a:pt x="1573" y="676"/>
                  </a:moveTo>
                  <a:lnTo>
                    <a:pt x="1598" y="715"/>
                  </a:lnTo>
                  <a:cubicBezTo>
                    <a:pt x="1606" y="725"/>
                    <a:pt x="1603" y="739"/>
                    <a:pt x="1592" y="747"/>
                  </a:cubicBezTo>
                  <a:cubicBezTo>
                    <a:pt x="1581" y="754"/>
                    <a:pt x="1567" y="751"/>
                    <a:pt x="1560" y="740"/>
                  </a:cubicBezTo>
                  <a:lnTo>
                    <a:pt x="1535" y="702"/>
                  </a:lnTo>
                  <a:cubicBezTo>
                    <a:pt x="1527" y="691"/>
                    <a:pt x="1530" y="677"/>
                    <a:pt x="1541" y="670"/>
                  </a:cubicBezTo>
                  <a:cubicBezTo>
                    <a:pt x="1552" y="663"/>
                    <a:pt x="1566" y="666"/>
                    <a:pt x="1573" y="676"/>
                  </a:cubicBezTo>
                  <a:close/>
                  <a:moveTo>
                    <a:pt x="1599" y="715"/>
                  </a:moveTo>
                  <a:lnTo>
                    <a:pt x="1623" y="754"/>
                  </a:lnTo>
                  <a:cubicBezTo>
                    <a:pt x="1630" y="765"/>
                    <a:pt x="1627" y="779"/>
                    <a:pt x="1616" y="786"/>
                  </a:cubicBezTo>
                  <a:cubicBezTo>
                    <a:pt x="1605" y="793"/>
                    <a:pt x="1591" y="789"/>
                    <a:pt x="1584" y="779"/>
                  </a:cubicBezTo>
                  <a:lnTo>
                    <a:pt x="1560" y="740"/>
                  </a:lnTo>
                  <a:cubicBezTo>
                    <a:pt x="1553" y="729"/>
                    <a:pt x="1556" y="715"/>
                    <a:pt x="1567" y="708"/>
                  </a:cubicBezTo>
                  <a:cubicBezTo>
                    <a:pt x="1578" y="701"/>
                    <a:pt x="1592" y="704"/>
                    <a:pt x="1599" y="715"/>
                  </a:cubicBezTo>
                  <a:close/>
                  <a:moveTo>
                    <a:pt x="1696" y="872"/>
                  </a:moveTo>
                  <a:lnTo>
                    <a:pt x="1729" y="925"/>
                  </a:lnTo>
                  <a:cubicBezTo>
                    <a:pt x="1736" y="936"/>
                    <a:pt x="1733" y="950"/>
                    <a:pt x="1722" y="957"/>
                  </a:cubicBezTo>
                  <a:cubicBezTo>
                    <a:pt x="1711" y="964"/>
                    <a:pt x="1697" y="960"/>
                    <a:pt x="1690" y="949"/>
                  </a:cubicBezTo>
                  <a:lnTo>
                    <a:pt x="1657" y="896"/>
                  </a:lnTo>
                  <a:cubicBezTo>
                    <a:pt x="1650" y="885"/>
                    <a:pt x="1654" y="871"/>
                    <a:pt x="1664" y="864"/>
                  </a:cubicBezTo>
                  <a:cubicBezTo>
                    <a:pt x="1675" y="858"/>
                    <a:pt x="1689" y="861"/>
                    <a:pt x="1696" y="872"/>
                  </a:cubicBezTo>
                  <a:close/>
                  <a:moveTo>
                    <a:pt x="1731" y="928"/>
                  </a:moveTo>
                  <a:lnTo>
                    <a:pt x="1743" y="955"/>
                  </a:lnTo>
                  <a:cubicBezTo>
                    <a:pt x="1748" y="967"/>
                    <a:pt x="1742" y="980"/>
                    <a:pt x="1730" y="985"/>
                  </a:cubicBezTo>
                  <a:cubicBezTo>
                    <a:pt x="1719" y="990"/>
                    <a:pt x="1705" y="985"/>
                    <a:pt x="1700" y="973"/>
                  </a:cubicBezTo>
                  <a:lnTo>
                    <a:pt x="1689" y="946"/>
                  </a:lnTo>
                  <a:cubicBezTo>
                    <a:pt x="1684" y="935"/>
                    <a:pt x="1689" y="921"/>
                    <a:pt x="1701" y="916"/>
                  </a:cubicBezTo>
                  <a:cubicBezTo>
                    <a:pt x="1713" y="911"/>
                    <a:pt x="1726" y="917"/>
                    <a:pt x="1731" y="928"/>
                  </a:cubicBezTo>
                  <a:close/>
                  <a:moveTo>
                    <a:pt x="1797" y="1082"/>
                  </a:moveTo>
                  <a:lnTo>
                    <a:pt x="1833" y="1167"/>
                  </a:lnTo>
                  <a:cubicBezTo>
                    <a:pt x="1838" y="1179"/>
                    <a:pt x="1832" y="1192"/>
                    <a:pt x="1821" y="1197"/>
                  </a:cubicBezTo>
                  <a:cubicBezTo>
                    <a:pt x="1809" y="1202"/>
                    <a:pt x="1795" y="1197"/>
                    <a:pt x="1790" y="1185"/>
                  </a:cubicBezTo>
                  <a:lnTo>
                    <a:pt x="1754" y="1100"/>
                  </a:lnTo>
                  <a:cubicBezTo>
                    <a:pt x="1749" y="1089"/>
                    <a:pt x="1755" y="1075"/>
                    <a:pt x="1766" y="1070"/>
                  </a:cubicBezTo>
                  <a:cubicBezTo>
                    <a:pt x="1778" y="1065"/>
                    <a:pt x="1792" y="1071"/>
                    <a:pt x="1797" y="1082"/>
                  </a:cubicBezTo>
                  <a:close/>
                  <a:moveTo>
                    <a:pt x="1902" y="1271"/>
                  </a:moveTo>
                  <a:lnTo>
                    <a:pt x="1971" y="1333"/>
                  </a:lnTo>
                  <a:cubicBezTo>
                    <a:pt x="1980" y="1341"/>
                    <a:pt x="1981" y="1356"/>
                    <a:pt x="1973" y="1365"/>
                  </a:cubicBezTo>
                  <a:cubicBezTo>
                    <a:pt x="1964" y="1375"/>
                    <a:pt x="1949" y="1375"/>
                    <a:pt x="1940" y="1367"/>
                  </a:cubicBezTo>
                  <a:lnTo>
                    <a:pt x="1871" y="1306"/>
                  </a:lnTo>
                  <a:cubicBezTo>
                    <a:pt x="1862" y="1297"/>
                    <a:pt x="1861" y="1283"/>
                    <a:pt x="1869" y="1273"/>
                  </a:cubicBezTo>
                  <a:cubicBezTo>
                    <a:pt x="1878" y="1264"/>
                    <a:pt x="1892" y="1263"/>
                    <a:pt x="1902" y="1271"/>
                  </a:cubicBezTo>
                  <a:close/>
                  <a:moveTo>
                    <a:pt x="2074" y="1425"/>
                  </a:moveTo>
                  <a:lnTo>
                    <a:pt x="2119" y="1465"/>
                  </a:lnTo>
                  <a:cubicBezTo>
                    <a:pt x="2129" y="1474"/>
                    <a:pt x="2130" y="1488"/>
                    <a:pt x="2121" y="1498"/>
                  </a:cubicBezTo>
                  <a:cubicBezTo>
                    <a:pt x="2113" y="1507"/>
                    <a:pt x="2098" y="1508"/>
                    <a:pt x="2089" y="1500"/>
                  </a:cubicBezTo>
                  <a:lnTo>
                    <a:pt x="2043" y="1459"/>
                  </a:lnTo>
                  <a:cubicBezTo>
                    <a:pt x="2034" y="1451"/>
                    <a:pt x="2033" y="1436"/>
                    <a:pt x="2041" y="1426"/>
                  </a:cubicBezTo>
                  <a:cubicBezTo>
                    <a:pt x="2050" y="1417"/>
                    <a:pt x="2064" y="1416"/>
                    <a:pt x="2074" y="1425"/>
                  </a:cubicBezTo>
                  <a:close/>
                  <a:moveTo>
                    <a:pt x="2124" y="1472"/>
                  </a:moveTo>
                  <a:lnTo>
                    <a:pt x="2139" y="1499"/>
                  </a:lnTo>
                  <a:cubicBezTo>
                    <a:pt x="2145" y="1510"/>
                    <a:pt x="2141" y="1524"/>
                    <a:pt x="2129" y="1530"/>
                  </a:cubicBezTo>
                  <a:cubicBezTo>
                    <a:pt x="2118" y="1536"/>
                    <a:pt x="2104" y="1532"/>
                    <a:pt x="2098" y="1521"/>
                  </a:cubicBezTo>
                  <a:lnTo>
                    <a:pt x="2084" y="1493"/>
                  </a:lnTo>
                  <a:cubicBezTo>
                    <a:pt x="2078" y="1482"/>
                    <a:pt x="2082" y="1468"/>
                    <a:pt x="2093" y="1462"/>
                  </a:cubicBezTo>
                  <a:cubicBezTo>
                    <a:pt x="2105" y="1456"/>
                    <a:pt x="2118" y="1461"/>
                    <a:pt x="2124" y="1472"/>
                  </a:cubicBezTo>
                  <a:close/>
                  <a:moveTo>
                    <a:pt x="2204" y="1621"/>
                  </a:moveTo>
                  <a:lnTo>
                    <a:pt x="2247" y="1703"/>
                  </a:lnTo>
                  <a:cubicBezTo>
                    <a:pt x="2253" y="1714"/>
                    <a:pt x="2249" y="1728"/>
                    <a:pt x="2237" y="1734"/>
                  </a:cubicBezTo>
                  <a:cubicBezTo>
                    <a:pt x="2226" y="1740"/>
                    <a:pt x="2212" y="1735"/>
                    <a:pt x="2206" y="1724"/>
                  </a:cubicBezTo>
                  <a:lnTo>
                    <a:pt x="2163" y="1643"/>
                  </a:lnTo>
                  <a:cubicBezTo>
                    <a:pt x="2157" y="1632"/>
                    <a:pt x="2161" y="1618"/>
                    <a:pt x="2173" y="1612"/>
                  </a:cubicBezTo>
                  <a:cubicBezTo>
                    <a:pt x="2184" y="1606"/>
                    <a:pt x="2198" y="1610"/>
                    <a:pt x="2204" y="1621"/>
                  </a:cubicBezTo>
                  <a:close/>
                  <a:moveTo>
                    <a:pt x="2300" y="1833"/>
                  </a:moveTo>
                  <a:lnTo>
                    <a:pt x="2333" y="1919"/>
                  </a:lnTo>
                  <a:cubicBezTo>
                    <a:pt x="2338" y="1931"/>
                    <a:pt x="2332" y="1944"/>
                    <a:pt x="2320" y="1949"/>
                  </a:cubicBezTo>
                  <a:cubicBezTo>
                    <a:pt x="2308" y="1954"/>
                    <a:pt x="2295" y="1948"/>
                    <a:pt x="2290" y="1936"/>
                  </a:cubicBezTo>
                  <a:lnTo>
                    <a:pt x="2257" y="1850"/>
                  </a:lnTo>
                  <a:cubicBezTo>
                    <a:pt x="2253" y="1838"/>
                    <a:pt x="2258" y="1824"/>
                    <a:pt x="2270" y="1820"/>
                  </a:cubicBezTo>
                  <a:cubicBezTo>
                    <a:pt x="2282" y="1815"/>
                    <a:pt x="2296" y="1821"/>
                    <a:pt x="2300" y="1833"/>
                  </a:cubicBezTo>
                  <a:close/>
                  <a:moveTo>
                    <a:pt x="2383" y="2048"/>
                  </a:moveTo>
                  <a:lnTo>
                    <a:pt x="2389" y="2066"/>
                  </a:lnTo>
                  <a:cubicBezTo>
                    <a:pt x="2394" y="2078"/>
                    <a:pt x="2388" y="2091"/>
                    <a:pt x="2376" y="2095"/>
                  </a:cubicBezTo>
                  <a:cubicBezTo>
                    <a:pt x="2364" y="2100"/>
                    <a:pt x="2351" y="2094"/>
                    <a:pt x="2346" y="2082"/>
                  </a:cubicBezTo>
                  <a:lnTo>
                    <a:pt x="2340" y="2065"/>
                  </a:lnTo>
                  <a:cubicBezTo>
                    <a:pt x="2335" y="2053"/>
                    <a:pt x="2341" y="2040"/>
                    <a:pt x="2353" y="2035"/>
                  </a:cubicBezTo>
                  <a:cubicBezTo>
                    <a:pt x="2365" y="2030"/>
                    <a:pt x="2378" y="2036"/>
                    <a:pt x="2383" y="2048"/>
                  </a:cubicBezTo>
                  <a:close/>
                  <a:moveTo>
                    <a:pt x="2388" y="2063"/>
                  </a:moveTo>
                  <a:lnTo>
                    <a:pt x="2422" y="2129"/>
                  </a:lnTo>
                  <a:cubicBezTo>
                    <a:pt x="2428" y="2140"/>
                    <a:pt x="2424" y="2154"/>
                    <a:pt x="2412" y="2160"/>
                  </a:cubicBezTo>
                  <a:cubicBezTo>
                    <a:pt x="2401" y="2165"/>
                    <a:pt x="2387" y="2161"/>
                    <a:pt x="2381" y="2150"/>
                  </a:cubicBezTo>
                  <a:lnTo>
                    <a:pt x="2347" y="2085"/>
                  </a:lnTo>
                  <a:cubicBezTo>
                    <a:pt x="2341" y="2073"/>
                    <a:pt x="2346" y="2059"/>
                    <a:pt x="2357" y="2053"/>
                  </a:cubicBezTo>
                  <a:cubicBezTo>
                    <a:pt x="2368" y="2048"/>
                    <a:pt x="2382" y="2052"/>
                    <a:pt x="2388" y="2063"/>
                  </a:cubicBezTo>
                  <a:close/>
                  <a:moveTo>
                    <a:pt x="2486" y="2251"/>
                  </a:moveTo>
                  <a:lnTo>
                    <a:pt x="2521" y="2319"/>
                  </a:lnTo>
                  <a:cubicBezTo>
                    <a:pt x="2527" y="2331"/>
                    <a:pt x="2523" y="2344"/>
                    <a:pt x="2512" y="2350"/>
                  </a:cubicBezTo>
                  <a:cubicBezTo>
                    <a:pt x="2500" y="2356"/>
                    <a:pt x="2486" y="2352"/>
                    <a:pt x="2480" y="2341"/>
                  </a:cubicBezTo>
                  <a:lnTo>
                    <a:pt x="2445" y="2272"/>
                  </a:lnTo>
                  <a:cubicBezTo>
                    <a:pt x="2439" y="2261"/>
                    <a:pt x="2444" y="2247"/>
                    <a:pt x="2455" y="2241"/>
                  </a:cubicBezTo>
                  <a:cubicBezTo>
                    <a:pt x="2466" y="2235"/>
                    <a:pt x="2480" y="2240"/>
                    <a:pt x="2486" y="2251"/>
                  </a:cubicBezTo>
                  <a:close/>
                  <a:moveTo>
                    <a:pt x="2522" y="2321"/>
                  </a:moveTo>
                  <a:lnTo>
                    <a:pt x="2528" y="2335"/>
                  </a:lnTo>
                  <a:cubicBezTo>
                    <a:pt x="2533" y="2347"/>
                    <a:pt x="2527" y="2360"/>
                    <a:pt x="2516" y="2365"/>
                  </a:cubicBezTo>
                  <a:cubicBezTo>
                    <a:pt x="2504" y="2370"/>
                    <a:pt x="2490" y="2365"/>
                    <a:pt x="2486" y="2353"/>
                  </a:cubicBezTo>
                  <a:lnTo>
                    <a:pt x="2480" y="2339"/>
                  </a:lnTo>
                  <a:cubicBezTo>
                    <a:pt x="2475" y="2327"/>
                    <a:pt x="2480" y="2314"/>
                    <a:pt x="2492" y="2309"/>
                  </a:cubicBezTo>
                  <a:cubicBezTo>
                    <a:pt x="2504" y="2304"/>
                    <a:pt x="2517" y="2309"/>
                    <a:pt x="2522" y="2321"/>
                  </a:cubicBezTo>
                  <a:close/>
                  <a:moveTo>
                    <a:pt x="2581" y="2463"/>
                  </a:moveTo>
                  <a:lnTo>
                    <a:pt x="2617" y="2548"/>
                  </a:lnTo>
                  <a:cubicBezTo>
                    <a:pt x="2622" y="2560"/>
                    <a:pt x="2616" y="2573"/>
                    <a:pt x="2605" y="2578"/>
                  </a:cubicBezTo>
                  <a:cubicBezTo>
                    <a:pt x="2593" y="2583"/>
                    <a:pt x="2579" y="2577"/>
                    <a:pt x="2574" y="2566"/>
                  </a:cubicBezTo>
                  <a:lnTo>
                    <a:pt x="2539" y="2481"/>
                  </a:lnTo>
                  <a:cubicBezTo>
                    <a:pt x="2534" y="2469"/>
                    <a:pt x="2540" y="2455"/>
                    <a:pt x="2551" y="2450"/>
                  </a:cubicBezTo>
                  <a:cubicBezTo>
                    <a:pt x="2563" y="2445"/>
                    <a:pt x="2577" y="2451"/>
                    <a:pt x="2581" y="2463"/>
                  </a:cubicBezTo>
                  <a:close/>
                  <a:moveTo>
                    <a:pt x="2679" y="2659"/>
                  </a:moveTo>
                  <a:lnTo>
                    <a:pt x="2743" y="2726"/>
                  </a:lnTo>
                  <a:cubicBezTo>
                    <a:pt x="2752" y="2736"/>
                    <a:pt x="2751" y="2750"/>
                    <a:pt x="2742" y="2759"/>
                  </a:cubicBezTo>
                  <a:cubicBezTo>
                    <a:pt x="2733" y="2768"/>
                    <a:pt x="2718" y="2767"/>
                    <a:pt x="2709" y="2758"/>
                  </a:cubicBezTo>
                  <a:lnTo>
                    <a:pt x="2646" y="2691"/>
                  </a:lnTo>
                  <a:cubicBezTo>
                    <a:pt x="2637" y="2682"/>
                    <a:pt x="2638" y="2667"/>
                    <a:pt x="2647" y="2659"/>
                  </a:cubicBezTo>
                  <a:cubicBezTo>
                    <a:pt x="2656" y="2650"/>
                    <a:pt x="2671" y="2650"/>
                    <a:pt x="2679" y="2659"/>
                  </a:cubicBezTo>
                  <a:close/>
                  <a:moveTo>
                    <a:pt x="2833" y="2834"/>
                  </a:moveTo>
                  <a:lnTo>
                    <a:pt x="2888" y="2908"/>
                  </a:lnTo>
                  <a:cubicBezTo>
                    <a:pt x="2896" y="2918"/>
                    <a:pt x="2894" y="2932"/>
                    <a:pt x="2884" y="2940"/>
                  </a:cubicBezTo>
                  <a:cubicBezTo>
                    <a:pt x="2874" y="2948"/>
                    <a:pt x="2860" y="2946"/>
                    <a:pt x="2852" y="2936"/>
                  </a:cubicBezTo>
                  <a:lnTo>
                    <a:pt x="2796" y="2862"/>
                  </a:lnTo>
                  <a:cubicBezTo>
                    <a:pt x="2788" y="2852"/>
                    <a:pt x="2790" y="2838"/>
                    <a:pt x="2800" y="2830"/>
                  </a:cubicBezTo>
                  <a:cubicBezTo>
                    <a:pt x="2811" y="2822"/>
                    <a:pt x="2825" y="2824"/>
                    <a:pt x="2833" y="2834"/>
                  </a:cubicBezTo>
                  <a:close/>
                  <a:moveTo>
                    <a:pt x="2995" y="2952"/>
                  </a:moveTo>
                  <a:lnTo>
                    <a:pt x="3031" y="2960"/>
                  </a:lnTo>
                  <a:cubicBezTo>
                    <a:pt x="3043" y="2963"/>
                    <a:pt x="3051" y="2975"/>
                    <a:pt x="3048" y="2988"/>
                  </a:cubicBezTo>
                  <a:cubicBezTo>
                    <a:pt x="3046" y="3000"/>
                    <a:pt x="3033" y="3008"/>
                    <a:pt x="3021" y="3005"/>
                  </a:cubicBezTo>
                  <a:lnTo>
                    <a:pt x="2985" y="2998"/>
                  </a:lnTo>
                  <a:cubicBezTo>
                    <a:pt x="2973" y="2995"/>
                    <a:pt x="2965" y="2983"/>
                    <a:pt x="2967" y="2970"/>
                  </a:cubicBezTo>
                  <a:cubicBezTo>
                    <a:pt x="2970" y="2958"/>
                    <a:pt x="2982" y="2950"/>
                    <a:pt x="2995" y="2952"/>
                  </a:cubicBezTo>
                  <a:close/>
                  <a:moveTo>
                    <a:pt x="3030" y="2960"/>
                  </a:moveTo>
                  <a:lnTo>
                    <a:pt x="3085" y="2972"/>
                  </a:lnTo>
                  <a:cubicBezTo>
                    <a:pt x="3097" y="2974"/>
                    <a:pt x="3105" y="2987"/>
                    <a:pt x="3103" y="2999"/>
                  </a:cubicBezTo>
                  <a:cubicBezTo>
                    <a:pt x="3100" y="3011"/>
                    <a:pt x="3088" y="3019"/>
                    <a:pt x="3075" y="3017"/>
                  </a:cubicBezTo>
                  <a:lnTo>
                    <a:pt x="3021" y="3005"/>
                  </a:lnTo>
                  <a:cubicBezTo>
                    <a:pt x="3008" y="3003"/>
                    <a:pt x="3001" y="2990"/>
                    <a:pt x="3003" y="2978"/>
                  </a:cubicBezTo>
                  <a:cubicBezTo>
                    <a:pt x="3006" y="2965"/>
                    <a:pt x="3018" y="2958"/>
                    <a:pt x="3030" y="2960"/>
                  </a:cubicBezTo>
                  <a:close/>
                  <a:moveTo>
                    <a:pt x="3220" y="3001"/>
                  </a:moveTo>
                  <a:lnTo>
                    <a:pt x="3294" y="3017"/>
                  </a:lnTo>
                  <a:cubicBezTo>
                    <a:pt x="3307" y="3019"/>
                    <a:pt x="3315" y="3031"/>
                    <a:pt x="3312" y="3044"/>
                  </a:cubicBezTo>
                  <a:cubicBezTo>
                    <a:pt x="3309" y="3056"/>
                    <a:pt x="3297" y="3064"/>
                    <a:pt x="3285" y="3062"/>
                  </a:cubicBezTo>
                  <a:lnTo>
                    <a:pt x="3210" y="3046"/>
                  </a:lnTo>
                  <a:cubicBezTo>
                    <a:pt x="3198" y="3043"/>
                    <a:pt x="3190" y="3031"/>
                    <a:pt x="3193" y="3018"/>
                  </a:cubicBezTo>
                  <a:cubicBezTo>
                    <a:pt x="3195" y="3006"/>
                    <a:pt x="3208" y="2998"/>
                    <a:pt x="3220" y="3001"/>
                  </a:cubicBezTo>
                  <a:close/>
                  <a:moveTo>
                    <a:pt x="3294" y="3016"/>
                  </a:moveTo>
                  <a:lnTo>
                    <a:pt x="3310" y="3020"/>
                  </a:lnTo>
                  <a:cubicBezTo>
                    <a:pt x="3323" y="3023"/>
                    <a:pt x="3331" y="3035"/>
                    <a:pt x="3328" y="3047"/>
                  </a:cubicBezTo>
                  <a:cubicBezTo>
                    <a:pt x="3325" y="3060"/>
                    <a:pt x="3313" y="3068"/>
                    <a:pt x="3301" y="3065"/>
                  </a:cubicBezTo>
                  <a:lnTo>
                    <a:pt x="3285" y="3062"/>
                  </a:lnTo>
                  <a:cubicBezTo>
                    <a:pt x="3272" y="3059"/>
                    <a:pt x="3264" y="3047"/>
                    <a:pt x="3267" y="3034"/>
                  </a:cubicBezTo>
                  <a:cubicBezTo>
                    <a:pt x="3269" y="3022"/>
                    <a:pt x="3282" y="3014"/>
                    <a:pt x="3294" y="3016"/>
                  </a:cubicBezTo>
                  <a:close/>
                  <a:moveTo>
                    <a:pt x="3445" y="3049"/>
                  </a:moveTo>
                  <a:lnTo>
                    <a:pt x="3536" y="3068"/>
                  </a:lnTo>
                  <a:lnTo>
                    <a:pt x="3526" y="3113"/>
                  </a:lnTo>
                  <a:lnTo>
                    <a:pt x="3436" y="3094"/>
                  </a:lnTo>
                  <a:cubicBezTo>
                    <a:pt x="3423" y="3091"/>
                    <a:pt x="3415" y="3079"/>
                    <a:pt x="3418" y="3066"/>
                  </a:cubicBezTo>
                  <a:cubicBezTo>
                    <a:pt x="3421" y="3054"/>
                    <a:pt x="3433" y="3046"/>
                    <a:pt x="3445" y="3049"/>
                  </a:cubicBezTo>
                  <a:close/>
                </a:path>
              </a:pathLst>
            </a:custGeom>
            <a:solidFill>
              <a:srgbClr val="FF6000"/>
            </a:solidFill>
            <a:ln w="1588" cap="flat">
              <a:solidFill>
                <a:srgbClr val="FF6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125" name="Freeform 111"/>
            <p:cNvSpPr>
              <a:spLocks/>
            </p:cNvSpPr>
            <p:nvPr/>
          </p:nvSpPr>
          <p:spPr bwMode="auto">
            <a:xfrm>
              <a:off x="546100" y="5754688"/>
              <a:ext cx="1428750" cy="1284288"/>
            </a:xfrm>
            <a:custGeom>
              <a:avLst/>
              <a:gdLst>
                <a:gd name="T0" fmla="*/ 0 w 900"/>
                <a:gd name="T1" fmla="*/ 0 h 809"/>
                <a:gd name="T2" fmla="*/ 0 w 900"/>
                <a:gd name="T3" fmla="*/ 0 h 809"/>
                <a:gd name="T4" fmla="*/ 0 w 900"/>
                <a:gd name="T5" fmla="*/ 0 h 809"/>
                <a:gd name="T6" fmla="*/ 207 w 900"/>
                <a:gd name="T7" fmla="*/ 0 h 809"/>
                <a:gd name="T8" fmla="*/ 207 w 900"/>
                <a:gd name="T9" fmla="*/ 0 h 809"/>
                <a:gd name="T10" fmla="*/ 242 w 900"/>
                <a:gd name="T11" fmla="*/ 29 h 809"/>
                <a:gd name="T12" fmla="*/ 242 w 900"/>
                <a:gd name="T13" fmla="*/ 29 h 809"/>
                <a:gd name="T14" fmla="*/ 311 w 900"/>
                <a:gd name="T15" fmla="*/ 79 h 809"/>
                <a:gd name="T16" fmla="*/ 311 w 900"/>
                <a:gd name="T17" fmla="*/ 79 h 809"/>
                <a:gd name="T18" fmla="*/ 346 w 900"/>
                <a:gd name="T19" fmla="*/ 122 h 809"/>
                <a:gd name="T20" fmla="*/ 346 w 900"/>
                <a:gd name="T21" fmla="*/ 122 h 809"/>
                <a:gd name="T22" fmla="*/ 380 w 900"/>
                <a:gd name="T23" fmla="*/ 201 h 809"/>
                <a:gd name="T24" fmla="*/ 380 w 900"/>
                <a:gd name="T25" fmla="*/ 201 h 809"/>
                <a:gd name="T26" fmla="*/ 415 w 900"/>
                <a:gd name="T27" fmla="*/ 265 h 809"/>
                <a:gd name="T28" fmla="*/ 415 w 900"/>
                <a:gd name="T29" fmla="*/ 265 h 809"/>
                <a:gd name="T30" fmla="*/ 449 w 900"/>
                <a:gd name="T31" fmla="*/ 372 h 809"/>
                <a:gd name="T32" fmla="*/ 449 w 900"/>
                <a:gd name="T33" fmla="*/ 372 h 809"/>
                <a:gd name="T34" fmla="*/ 484 w 900"/>
                <a:gd name="T35" fmla="*/ 441 h 809"/>
                <a:gd name="T36" fmla="*/ 484 w 900"/>
                <a:gd name="T37" fmla="*/ 441 h 809"/>
                <a:gd name="T38" fmla="*/ 553 w 900"/>
                <a:gd name="T39" fmla="*/ 548 h 809"/>
                <a:gd name="T40" fmla="*/ 553 w 900"/>
                <a:gd name="T41" fmla="*/ 548 h 809"/>
                <a:gd name="T42" fmla="*/ 588 w 900"/>
                <a:gd name="T43" fmla="*/ 610 h 809"/>
                <a:gd name="T44" fmla="*/ 588 w 900"/>
                <a:gd name="T45" fmla="*/ 610 h 809"/>
                <a:gd name="T46" fmla="*/ 622 w 900"/>
                <a:gd name="T47" fmla="*/ 694 h 809"/>
                <a:gd name="T48" fmla="*/ 622 w 900"/>
                <a:gd name="T49" fmla="*/ 694 h 809"/>
                <a:gd name="T50" fmla="*/ 657 w 900"/>
                <a:gd name="T51" fmla="*/ 732 h 809"/>
                <a:gd name="T52" fmla="*/ 657 w 900"/>
                <a:gd name="T53" fmla="*/ 732 h 809"/>
                <a:gd name="T54" fmla="*/ 692 w 900"/>
                <a:gd name="T55" fmla="*/ 763 h 809"/>
                <a:gd name="T56" fmla="*/ 692 w 900"/>
                <a:gd name="T57" fmla="*/ 763 h 809"/>
                <a:gd name="T58" fmla="*/ 761 w 900"/>
                <a:gd name="T59" fmla="*/ 778 h 809"/>
                <a:gd name="T60" fmla="*/ 761 w 900"/>
                <a:gd name="T61" fmla="*/ 778 h 809"/>
                <a:gd name="T62" fmla="*/ 830 w 900"/>
                <a:gd name="T63" fmla="*/ 794 h 809"/>
                <a:gd name="T64" fmla="*/ 830 w 900"/>
                <a:gd name="T65" fmla="*/ 794 h 809"/>
                <a:gd name="T66" fmla="*/ 864 w 900"/>
                <a:gd name="T67" fmla="*/ 801 h 809"/>
                <a:gd name="T68" fmla="*/ 864 w 900"/>
                <a:gd name="T69" fmla="*/ 801 h 809"/>
                <a:gd name="T70" fmla="*/ 900 w 900"/>
                <a:gd name="T71" fmla="*/ 809 h 8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</a:cxnLst>
              <a:rect l="0" t="0" r="r" b="b"/>
              <a:pathLst>
                <a:path w="900" h="809">
                  <a:moveTo>
                    <a:pt x="0" y="0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207" y="0"/>
                  </a:lnTo>
                  <a:lnTo>
                    <a:pt x="207" y="0"/>
                  </a:lnTo>
                  <a:lnTo>
                    <a:pt x="242" y="29"/>
                  </a:lnTo>
                  <a:lnTo>
                    <a:pt x="242" y="29"/>
                  </a:lnTo>
                  <a:lnTo>
                    <a:pt x="311" y="79"/>
                  </a:lnTo>
                  <a:lnTo>
                    <a:pt x="311" y="79"/>
                  </a:lnTo>
                  <a:lnTo>
                    <a:pt x="346" y="122"/>
                  </a:lnTo>
                  <a:lnTo>
                    <a:pt x="346" y="122"/>
                  </a:lnTo>
                  <a:lnTo>
                    <a:pt x="380" y="201"/>
                  </a:lnTo>
                  <a:lnTo>
                    <a:pt x="380" y="201"/>
                  </a:lnTo>
                  <a:lnTo>
                    <a:pt x="415" y="265"/>
                  </a:lnTo>
                  <a:lnTo>
                    <a:pt x="415" y="265"/>
                  </a:lnTo>
                  <a:lnTo>
                    <a:pt x="449" y="372"/>
                  </a:lnTo>
                  <a:lnTo>
                    <a:pt x="449" y="372"/>
                  </a:lnTo>
                  <a:lnTo>
                    <a:pt x="484" y="441"/>
                  </a:lnTo>
                  <a:lnTo>
                    <a:pt x="484" y="441"/>
                  </a:lnTo>
                  <a:lnTo>
                    <a:pt x="553" y="548"/>
                  </a:lnTo>
                  <a:lnTo>
                    <a:pt x="553" y="548"/>
                  </a:lnTo>
                  <a:lnTo>
                    <a:pt x="588" y="610"/>
                  </a:lnTo>
                  <a:lnTo>
                    <a:pt x="588" y="610"/>
                  </a:lnTo>
                  <a:lnTo>
                    <a:pt x="622" y="694"/>
                  </a:lnTo>
                  <a:lnTo>
                    <a:pt x="622" y="694"/>
                  </a:lnTo>
                  <a:lnTo>
                    <a:pt x="657" y="732"/>
                  </a:lnTo>
                  <a:lnTo>
                    <a:pt x="657" y="732"/>
                  </a:lnTo>
                  <a:lnTo>
                    <a:pt x="692" y="763"/>
                  </a:lnTo>
                  <a:lnTo>
                    <a:pt x="692" y="763"/>
                  </a:lnTo>
                  <a:lnTo>
                    <a:pt x="761" y="778"/>
                  </a:lnTo>
                  <a:lnTo>
                    <a:pt x="761" y="778"/>
                  </a:lnTo>
                  <a:lnTo>
                    <a:pt x="830" y="794"/>
                  </a:lnTo>
                  <a:lnTo>
                    <a:pt x="830" y="794"/>
                  </a:lnTo>
                  <a:lnTo>
                    <a:pt x="864" y="801"/>
                  </a:lnTo>
                  <a:lnTo>
                    <a:pt x="864" y="801"/>
                  </a:lnTo>
                  <a:lnTo>
                    <a:pt x="900" y="809"/>
                  </a:lnTo>
                </a:path>
              </a:pathLst>
            </a:custGeom>
            <a:noFill/>
            <a:ln w="19050" cap="flat">
              <a:solidFill>
                <a:srgbClr val="FF6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126" name="Rectangle 112"/>
            <p:cNvSpPr>
              <a:spLocks noChangeArrowheads="1"/>
            </p:cNvSpPr>
            <p:nvPr/>
          </p:nvSpPr>
          <p:spPr bwMode="auto">
            <a:xfrm>
              <a:off x="712789" y="5440364"/>
              <a:ext cx="1668462" cy="1746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igh </a:t>
              </a:r>
              <a:r>
                <a:rPr kumimoji="0" lang="el-GR" altLang="el-GR" sz="10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iron</a:t>
              </a:r>
              <a:r>
                <a:rPr kumimoji="0" lang="el-GR" altLang="el-G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el-GR" altLang="el-GR" sz="10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supplementation</a:t>
              </a:r>
              <a:endParaRPr kumimoji="0" lang="el-GR" altLang="el-G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7" name="Rectangle 113"/>
            <p:cNvSpPr>
              <a:spLocks noChangeArrowheads="1"/>
            </p:cNvSpPr>
            <p:nvPr/>
          </p:nvSpPr>
          <p:spPr bwMode="auto">
            <a:xfrm>
              <a:off x="913900" y="7269249"/>
              <a:ext cx="1136530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11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Days</a:t>
              </a:r>
              <a:r>
                <a:rPr kumimoji="0" lang="el-GR" altLang="el-GR" sz="11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of </a:t>
              </a:r>
              <a:r>
                <a:rPr kumimoji="0" lang="el-GR" altLang="el-GR" sz="11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adulthood</a:t>
              </a:r>
              <a:endParaRPr kumimoji="0" lang="el-GR" altLang="el-GR" sz="32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4" name="Rectangle 130"/>
            <p:cNvSpPr>
              <a:spLocks noChangeArrowheads="1"/>
            </p:cNvSpPr>
            <p:nvPr/>
          </p:nvSpPr>
          <p:spPr bwMode="auto">
            <a:xfrm>
              <a:off x="1836738" y="5816600"/>
              <a:ext cx="798295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N2+30mM FAC</a:t>
              </a:r>
              <a:endParaRPr kumimoji="0" lang="el-GR" altLang="el-GR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5" name="Line 131"/>
            <p:cNvSpPr>
              <a:spLocks noChangeShapeType="1"/>
            </p:cNvSpPr>
            <p:nvPr/>
          </p:nvSpPr>
          <p:spPr bwMode="auto">
            <a:xfrm>
              <a:off x="1624013" y="5885849"/>
              <a:ext cx="138112" cy="0"/>
            </a:xfrm>
            <a:prstGeom prst="line">
              <a:avLst/>
            </a:prstGeom>
            <a:noFill/>
            <a:ln w="19050" cap="flat">
              <a:solidFill>
                <a:srgbClr val="FF6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146" name="Rectangle 132"/>
            <p:cNvSpPr>
              <a:spLocks noChangeArrowheads="1"/>
            </p:cNvSpPr>
            <p:nvPr/>
          </p:nvSpPr>
          <p:spPr bwMode="auto">
            <a:xfrm>
              <a:off x="1836738" y="5997575"/>
              <a:ext cx="93294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N2;</a:t>
              </a:r>
              <a:r>
                <a:rPr kumimoji="0" lang="en-US" altLang="el-GR" sz="9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cisd-1(RNAi) </a:t>
              </a:r>
              <a:r>
                <a:rPr kumimoji="0" lang="en-US" altLang="el-GR" sz="9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+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l-GR" sz="900" i="0" dirty="0" smtClean="0">
                  <a:solidFill>
                    <a:srgbClr val="000000"/>
                  </a:solidFill>
                </a:rPr>
                <a:t>30mM FAC</a:t>
              </a:r>
              <a:endParaRPr kumimoji="0" lang="el-GR" altLang="el-GR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0" name="Freeform 136"/>
            <p:cNvSpPr>
              <a:spLocks noEditPoints="1"/>
            </p:cNvSpPr>
            <p:nvPr/>
          </p:nvSpPr>
          <p:spPr bwMode="auto">
            <a:xfrm>
              <a:off x="1624013" y="6126549"/>
              <a:ext cx="134937" cy="19050"/>
            </a:xfrm>
            <a:custGeom>
              <a:avLst/>
              <a:gdLst>
                <a:gd name="T0" fmla="*/ 0 w 323"/>
                <a:gd name="T1" fmla="*/ 0 h 47"/>
                <a:gd name="T2" fmla="*/ 93 w 323"/>
                <a:gd name="T3" fmla="*/ 0 h 47"/>
                <a:gd name="T4" fmla="*/ 116 w 323"/>
                <a:gd name="T5" fmla="*/ 24 h 47"/>
                <a:gd name="T6" fmla="*/ 93 w 323"/>
                <a:gd name="T7" fmla="*/ 47 h 47"/>
                <a:gd name="T8" fmla="*/ 0 w 323"/>
                <a:gd name="T9" fmla="*/ 47 h 47"/>
                <a:gd name="T10" fmla="*/ 0 w 323"/>
                <a:gd name="T11" fmla="*/ 0 h 47"/>
                <a:gd name="T12" fmla="*/ 231 w 323"/>
                <a:gd name="T13" fmla="*/ 0 h 47"/>
                <a:gd name="T14" fmla="*/ 323 w 323"/>
                <a:gd name="T15" fmla="*/ 0 h 47"/>
                <a:gd name="T16" fmla="*/ 323 w 323"/>
                <a:gd name="T17" fmla="*/ 47 h 47"/>
                <a:gd name="T18" fmla="*/ 231 w 323"/>
                <a:gd name="T19" fmla="*/ 47 h 47"/>
                <a:gd name="T20" fmla="*/ 208 w 323"/>
                <a:gd name="T21" fmla="*/ 24 h 47"/>
                <a:gd name="T22" fmla="*/ 231 w 323"/>
                <a:gd name="T23" fmla="*/ 0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323" h="47">
                  <a:moveTo>
                    <a:pt x="0" y="0"/>
                  </a:moveTo>
                  <a:lnTo>
                    <a:pt x="93" y="0"/>
                  </a:lnTo>
                  <a:cubicBezTo>
                    <a:pt x="105" y="0"/>
                    <a:pt x="116" y="11"/>
                    <a:pt x="116" y="24"/>
                  </a:cubicBezTo>
                  <a:cubicBezTo>
                    <a:pt x="116" y="36"/>
                    <a:pt x="105" y="47"/>
                    <a:pt x="93" y="47"/>
                  </a:cubicBezTo>
                  <a:lnTo>
                    <a:pt x="0" y="47"/>
                  </a:lnTo>
                  <a:lnTo>
                    <a:pt x="0" y="0"/>
                  </a:lnTo>
                  <a:close/>
                  <a:moveTo>
                    <a:pt x="231" y="0"/>
                  </a:moveTo>
                  <a:lnTo>
                    <a:pt x="323" y="0"/>
                  </a:lnTo>
                  <a:lnTo>
                    <a:pt x="323" y="47"/>
                  </a:lnTo>
                  <a:lnTo>
                    <a:pt x="231" y="47"/>
                  </a:lnTo>
                  <a:cubicBezTo>
                    <a:pt x="218" y="47"/>
                    <a:pt x="208" y="36"/>
                    <a:pt x="208" y="24"/>
                  </a:cubicBezTo>
                  <a:cubicBezTo>
                    <a:pt x="208" y="11"/>
                    <a:pt x="218" y="0"/>
                    <a:pt x="231" y="0"/>
                  </a:cubicBezTo>
                  <a:close/>
                </a:path>
              </a:pathLst>
            </a:custGeom>
            <a:solidFill>
              <a:srgbClr val="FF6000"/>
            </a:solidFill>
            <a:ln w="1588" cap="flat">
              <a:solidFill>
                <a:srgbClr val="FF6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151" name="TextBox 150"/>
            <p:cNvSpPr txBox="1"/>
            <p:nvPr/>
          </p:nvSpPr>
          <p:spPr>
            <a:xfrm rot="16200000">
              <a:off x="-405791" y="6252523"/>
              <a:ext cx="118814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ercent survival</a:t>
              </a:r>
              <a:endParaRPr lang="el-GR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AutoShape 138"/>
            <p:cNvSpPr>
              <a:spLocks noChangeAspect="1" noChangeArrowheads="1" noTextEdit="1"/>
            </p:cNvSpPr>
            <p:nvPr/>
          </p:nvSpPr>
          <p:spPr bwMode="auto">
            <a:xfrm>
              <a:off x="3429000" y="657225"/>
              <a:ext cx="3213100" cy="1900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 dirty="0"/>
            </a:p>
          </p:txBody>
        </p:sp>
        <p:sp>
          <p:nvSpPr>
            <p:cNvPr id="154" name="Rectangle 140"/>
            <p:cNvSpPr>
              <a:spLocks noChangeArrowheads="1"/>
            </p:cNvSpPr>
            <p:nvPr/>
          </p:nvSpPr>
          <p:spPr bwMode="auto">
            <a:xfrm>
              <a:off x="3876675" y="2187575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el-GR" altLang="el-GR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5" name="Rectangle 141"/>
            <p:cNvSpPr>
              <a:spLocks noChangeArrowheads="1"/>
            </p:cNvSpPr>
            <p:nvPr/>
          </p:nvSpPr>
          <p:spPr bwMode="auto">
            <a:xfrm>
              <a:off x="4157663" y="2187575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</a:t>
              </a:r>
              <a:endParaRPr kumimoji="0" lang="el-GR" altLang="el-G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6" name="Rectangle 142"/>
            <p:cNvSpPr>
              <a:spLocks noChangeArrowheads="1"/>
            </p:cNvSpPr>
            <p:nvPr/>
          </p:nvSpPr>
          <p:spPr bwMode="auto">
            <a:xfrm>
              <a:off x="4405313" y="2187575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</a:t>
              </a:r>
              <a:endParaRPr kumimoji="0" lang="el-GR" altLang="el-G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7" name="Rectangle 143"/>
            <p:cNvSpPr>
              <a:spLocks noChangeArrowheads="1"/>
            </p:cNvSpPr>
            <p:nvPr/>
          </p:nvSpPr>
          <p:spPr bwMode="auto">
            <a:xfrm>
              <a:off x="4678363" y="2187575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5</a:t>
              </a:r>
              <a:endParaRPr kumimoji="0" lang="el-GR" altLang="el-G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8" name="Rectangle 144"/>
            <p:cNvSpPr>
              <a:spLocks noChangeArrowheads="1"/>
            </p:cNvSpPr>
            <p:nvPr/>
          </p:nvSpPr>
          <p:spPr bwMode="auto">
            <a:xfrm>
              <a:off x="4953000" y="2187575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</a:t>
              </a:r>
              <a:endParaRPr kumimoji="0" lang="el-GR" altLang="el-G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9" name="Rectangle 145"/>
            <p:cNvSpPr>
              <a:spLocks noChangeArrowheads="1"/>
            </p:cNvSpPr>
            <p:nvPr/>
          </p:nvSpPr>
          <p:spPr bwMode="auto">
            <a:xfrm>
              <a:off x="5226050" y="2187575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5</a:t>
              </a:r>
              <a:endParaRPr kumimoji="0" lang="el-GR" altLang="el-G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0" name="Rectangle 146"/>
            <p:cNvSpPr>
              <a:spLocks noChangeArrowheads="1"/>
            </p:cNvSpPr>
            <p:nvPr/>
          </p:nvSpPr>
          <p:spPr bwMode="auto">
            <a:xfrm>
              <a:off x="5500688" y="2187575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0</a:t>
              </a:r>
              <a:endParaRPr kumimoji="0" lang="el-GR" altLang="el-G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1" name="Rectangle 147"/>
            <p:cNvSpPr>
              <a:spLocks noChangeArrowheads="1"/>
            </p:cNvSpPr>
            <p:nvPr/>
          </p:nvSpPr>
          <p:spPr bwMode="auto">
            <a:xfrm>
              <a:off x="5775325" y="2187575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5</a:t>
              </a:r>
              <a:endParaRPr kumimoji="0" lang="el-GR" altLang="el-G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2" name="Freeform 148"/>
            <p:cNvSpPr>
              <a:spLocks noEditPoints="1"/>
            </p:cNvSpPr>
            <p:nvPr/>
          </p:nvSpPr>
          <p:spPr bwMode="auto">
            <a:xfrm>
              <a:off x="3900488" y="2120900"/>
              <a:ext cx="1938338" cy="53975"/>
            </a:xfrm>
            <a:custGeom>
              <a:avLst/>
              <a:gdLst>
                <a:gd name="T0" fmla="*/ 0 w 1221"/>
                <a:gd name="T1" fmla="*/ 0 h 34"/>
                <a:gd name="T2" fmla="*/ 1221 w 1221"/>
                <a:gd name="T3" fmla="*/ 0 h 34"/>
                <a:gd name="T4" fmla="*/ 4 w 1221"/>
                <a:gd name="T5" fmla="*/ 0 h 34"/>
                <a:gd name="T6" fmla="*/ 4 w 1221"/>
                <a:gd name="T7" fmla="*/ 34 h 34"/>
                <a:gd name="T8" fmla="*/ 177 w 1221"/>
                <a:gd name="T9" fmla="*/ 0 h 34"/>
                <a:gd name="T10" fmla="*/ 177 w 1221"/>
                <a:gd name="T11" fmla="*/ 34 h 34"/>
                <a:gd name="T12" fmla="*/ 350 w 1221"/>
                <a:gd name="T13" fmla="*/ 0 h 34"/>
                <a:gd name="T14" fmla="*/ 350 w 1221"/>
                <a:gd name="T15" fmla="*/ 34 h 34"/>
                <a:gd name="T16" fmla="*/ 524 w 1221"/>
                <a:gd name="T17" fmla="*/ 0 h 34"/>
                <a:gd name="T18" fmla="*/ 524 w 1221"/>
                <a:gd name="T19" fmla="*/ 34 h 34"/>
                <a:gd name="T20" fmla="*/ 696 w 1221"/>
                <a:gd name="T21" fmla="*/ 0 h 34"/>
                <a:gd name="T22" fmla="*/ 696 w 1221"/>
                <a:gd name="T23" fmla="*/ 34 h 34"/>
                <a:gd name="T24" fmla="*/ 870 w 1221"/>
                <a:gd name="T25" fmla="*/ 0 h 34"/>
                <a:gd name="T26" fmla="*/ 870 w 1221"/>
                <a:gd name="T27" fmla="*/ 34 h 34"/>
                <a:gd name="T28" fmla="*/ 1043 w 1221"/>
                <a:gd name="T29" fmla="*/ 0 h 34"/>
                <a:gd name="T30" fmla="*/ 1043 w 1221"/>
                <a:gd name="T31" fmla="*/ 34 h 34"/>
                <a:gd name="T32" fmla="*/ 1217 w 1221"/>
                <a:gd name="T33" fmla="*/ 0 h 34"/>
                <a:gd name="T34" fmla="*/ 1217 w 1221"/>
                <a:gd name="T35" fmla="*/ 34 h 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221" h="34">
                  <a:moveTo>
                    <a:pt x="0" y="0"/>
                  </a:moveTo>
                  <a:lnTo>
                    <a:pt x="1221" y="0"/>
                  </a:lnTo>
                  <a:moveTo>
                    <a:pt x="4" y="0"/>
                  </a:moveTo>
                  <a:lnTo>
                    <a:pt x="4" y="34"/>
                  </a:lnTo>
                  <a:moveTo>
                    <a:pt x="177" y="0"/>
                  </a:moveTo>
                  <a:lnTo>
                    <a:pt x="177" y="34"/>
                  </a:lnTo>
                  <a:moveTo>
                    <a:pt x="350" y="0"/>
                  </a:moveTo>
                  <a:lnTo>
                    <a:pt x="350" y="34"/>
                  </a:lnTo>
                  <a:moveTo>
                    <a:pt x="524" y="0"/>
                  </a:moveTo>
                  <a:lnTo>
                    <a:pt x="524" y="34"/>
                  </a:lnTo>
                  <a:moveTo>
                    <a:pt x="696" y="0"/>
                  </a:moveTo>
                  <a:lnTo>
                    <a:pt x="696" y="34"/>
                  </a:lnTo>
                  <a:moveTo>
                    <a:pt x="870" y="0"/>
                  </a:moveTo>
                  <a:lnTo>
                    <a:pt x="870" y="34"/>
                  </a:lnTo>
                  <a:moveTo>
                    <a:pt x="1043" y="0"/>
                  </a:moveTo>
                  <a:lnTo>
                    <a:pt x="1043" y="34"/>
                  </a:lnTo>
                  <a:moveTo>
                    <a:pt x="1217" y="0"/>
                  </a:moveTo>
                  <a:lnTo>
                    <a:pt x="1217" y="34"/>
                  </a:lnTo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163" name="Rectangle 149"/>
            <p:cNvSpPr>
              <a:spLocks noChangeArrowheads="1"/>
            </p:cNvSpPr>
            <p:nvPr/>
          </p:nvSpPr>
          <p:spPr bwMode="auto">
            <a:xfrm>
              <a:off x="3783013" y="2060575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el-GR" altLang="el-G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4" name="Rectangle 150"/>
            <p:cNvSpPr>
              <a:spLocks noChangeArrowheads="1"/>
            </p:cNvSpPr>
            <p:nvPr/>
          </p:nvSpPr>
          <p:spPr bwMode="auto">
            <a:xfrm>
              <a:off x="3729038" y="1806575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</a:t>
              </a:r>
              <a:endParaRPr kumimoji="0" lang="el-GR" altLang="el-G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5" name="Rectangle 151"/>
            <p:cNvSpPr>
              <a:spLocks noChangeArrowheads="1"/>
            </p:cNvSpPr>
            <p:nvPr/>
          </p:nvSpPr>
          <p:spPr bwMode="auto">
            <a:xfrm>
              <a:off x="3729038" y="1546225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0</a:t>
              </a:r>
              <a:endParaRPr kumimoji="0" lang="el-GR" altLang="el-G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6" name="Rectangle 152"/>
            <p:cNvSpPr>
              <a:spLocks noChangeArrowheads="1"/>
            </p:cNvSpPr>
            <p:nvPr/>
          </p:nvSpPr>
          <p:spPr bwMode="auto">
            <a:xfrm>
              <a:off x="3729038" y="1292225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0</a:t>
              </a:r>
              <a:endParaRPr kumimoji="0" lang="el-GR" altLang="el-G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7" name="Rectangle 153"/>
            <p:cNvSpPr>
              <a:spLocks noChangeArrowheads="1"/>
            </p:cNvSpPr>
            <p:nvPr/>
          </p:nvSpPr>
          <p:spPr bwMode="auto">
            <a:xfrm>
              <a:off x="3729038" y="1038225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0</a:t>
              </a:r>
              <a:endParaRPr kumimoji="0" lang="el-GR" altLang="el-G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8" name="Rectangle 154"/>
            <p:cNvSpPr>
              <a:spLocks noChangeArrowheads="1"/>
            </p:cNvSpPr>
            <p:nvPr/>
          </p:nvSpPr>
          <p:spPr bwMode="auto">
            <a:xfrm>
              <a:off x="3676650" y="777875"/>
              <a:ext cx="17312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</a:t>
              </a:r>
              <a:endParaRPr kumimoji="0" lang="el-GR" altLang="el-GR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9" name="Freeform 155"/>
            <p:cNvSpPr>
              <a:spLocks noEditPoints="1"/>
            </p:cNvSpPr>
            <p:nvPr/>
          </p:nvSpPr>
          <p:spPr bwMode="auto">
            <a:xfrm>
              <a:off x="3852863" y="830263"/>
              <a:ext cx="53975" cy="1296988"/>
            </a:xfrm>
            <a:custGeom>
              <a:avLst/>
              <a:gdLst>
                <a:gd name="T0" fmla="*/ 34 w 34"/>
                <a:gd name="T1" fmla="*/ 817 h 817"/>
                <a:gd name="T2" fmla="*/ 34 w 34"/>
                <a:gd name="T3" fmla="*/ 0 h 817"/>
                <a:gd name="T4" fmla="*/ 34 w 34"/>
                <a:gd name="T5" fmla="*/ 813 h 817"/>
                <a:gd name="T6" fmla="*/ 0 w 34"/>
                <a:gd name="T7" fmla="*/ 813 h 817"/>
                <a:gd name="T8" fmla="*/ 34 w 34"/>
                <a:gd name="T9" fmla="*/ 651 h 817"/>
                <a:gd name="T10" fmla="*/ 0 w 34"/>
                <a:gd name="T11" fmla="*/ 651 h 817"/>
                <a:gd name="T12" fmla="*/ 34 w 34"/>
                <a:gd name="T13" fmla="*/ 489 h 817"/>
                <a:gd name="T14" fmla="*/ 0 w 34"/>
                <a:gd name="T15" fmla="*/ 489 h 817"/>
                <a:gd name="T16" fmla="*/ 34 w 34"/>
                <a:gd name="T17" fmla="*/ 328 h 817"/>
                <a:gd name="T18" fmla="*/ 0 w 34"/>
                <a:gd name="T19" fmla="*/ 328 h 817"/>
                <a:gd name="T20" fmla="*/ 34 w 34"/>
                <a:gd name="T21" fmla="*/ 166 h 817"/>
                <a:gd name="T22" fmla="*/ 0 w 34"/>
                <a:gd name="T23" fmla="*/ 166 h 817"/>
                <a:gd name="T24" fmla="*/ 34 w 34"/>
                <a:gd name="T25" fmla="*/ 4 h 817"/>
                <a:gd name="T26" fmla="*/ 0 w 34"/>
                <a:gd name="T27" fmla="*/ 4 h 8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34" h="817">
                  <a:moveTo>
                    <a:pt x="34" y="817"/>
                  </a:moveTo>
                  <a:lnTo>
                    <a:pt x="34" y="0"/>
                  </a:lnTo>
                  <a:moveTo>
                    <a:pt x="34" y="813"/>
                  </a:moveTo>
                  <a:lnTo>
                    <a:pt x="0" y="813"/>
                  </a:lnTo>
                  <a:moveTo>
                    <a:pt x="34" y="651"/>
                  </a:moveTo>
                  <a:lnTo>
                    <a:pt x="0" y="651"/>
                  </a:lnTo>
                  <a:moveTo>
                    <a:pt x="34" y="489"/>
                  </a:moveTo>
                  <a:lnTo>
                    <a:pt x="0" y="489"/>
                  </a:lnTo>
                  <a:moveTo>
                    <a:pt x="34" y="328"/>
                  </a:moveTo>
                  <a:lnTo>
                    <a:pt x="0" y="328"/>
                  </a:lnTo>
                  <a:moveTo>
                    <a:pt x="34" y="166"/>
                  </a:moveTo>
                  <a:lnTo>
                    <a:pt x="0" y="166"/>
                  </a:lnTo>
                  <a:moveTo>
                    <a:pt x="34" y="4"/>
                  </a:moveTo>
                  <a:lnTo>
                    <a:pt x="0" y="4"/>
                  </a:lnTo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170" name="Freeform 156"/>
            <p:cNvSpPr>
              <a:spLocks/>
            </p:cNvSpPr>
            <p:nvPr/>
          </p:nvSpPr>
          <p:spPr bwMode="auto">
            <a:xfrm>
              <a:off x="3906838" y="836613"/>
              <a:ext cx="1539875" cy="1284288"/>
            </a:xfrm>
            <a:custGeom>
              <a:avLst/>
              <a:gdLst>
                <a:gd name="T0" fmla="*/ 0 w 970"/>
                <a:gd name="T1" fmla="*/ 0 h 809"/>
                <a:gd name="T2" fmla="*/ 0 w 970"/>
                <a:gd name="T3" fmla="*/ 0 h 809"/>
                <a:gd name="T4" fmla="*/ 0 w 970"/>
                <a:gd name="T5" fmla="*/ 0 h 809"/>
                <a:gd name="T6" fmla="*/ 69 w 970"/>
                <a:gd name="T7" fmla="*/ 0 h 809"/>
                <a:gd name="T8" fmla="*/ 69 w 970"/>
                <a:gd name="T9" fmla="*/ 0 h 809"/>
                <a:gd name="T10" fmla="*/ 138 w 970"/>
                <a:gd name="T11" fmla="*/ 0 h 809"/>
                <a:gd name="T12" fmla="*/ 138 w 970"/>
                <a:gd name="T13" fmla="*/ 0 h 809"/>
                <a:gd name="T14" fmla="*/ 173 w 970"/>
                <a:gd name="T15" fmla="*/ 0 h 809"/>
                <a:gd name="T16" fmla="*/ 173 w 970"/>
                <a:gd name="T17" fmla="*/ 0 h 809"/>
                <a:gd name="T18" fmla="*/ 208 w 970"/>
                <a:gd name="T19" fmla="*/ 0 h 809"/>
                <a:gd name="T20" fmla="*/ 208 w 970"/>
                <a:gd name="T21" fmla="*/ 0 h 809"/>
                <a:gd name="T22" fmla="*/ 277 w 970"/>
                <a:gd name="T23" fmla="*/ 14 h 809"/>
                <a:gd name="T24" fmla="*/ 277 w 970"/>
                <a:gd name="T25" fmla="*/ 14 h 809"/>
                <a:gd name="T26" fmla="*/ 312 w 970"/>
                <a:gd name="T27" fmla="*/ 43 h 809"/>
                <a:gd name="T28" fmla="*/ 312 w 970"/>
                <a:gd name="T29" fmla="*/ 43 h 809"/>
                <a:gd name="T30" fmla="*/ 346 w 970"/>
                <a:gd name="T31" fmla="*/ 80 h 809"/>
                <a:gd name="T32" fmla="*/ 346 w 970"/>
                <a:gd name="T33" fmla="*/ 80 h 809"/>
                <a:gd name="T34" fmla="*/ 381 w 970"/>
                <a:gd name="T35" fmla="*/ 115 h 809"/>
                <a:gd name="T36" fmla="*/ 381 w 970"/>
                <a:gd name="T37" fmla="*/ 115 h 809"/>
                <a:gd name="T38" fmla="*/ 416 w 970"/>
                <a:gd name="T39" fmla="*/ 195 h 809"/>
                <a:gd name="T40" fmla="*/ 416 w 970"/>
                <a:gd name="T41" fmla="*/ 195 h 809"/>
                <a:gd name="T42" fmla="*/ 450 w 970"/>
                <a:gd name="T43" fmla="*/ 245 h 809"/>
                <a:gd name="T44" fmla="*/ 450 w 970"/>
                <a:gd name="T45" fmla="*/ 245 h 809"/>
                <a:gd name="T46" fmla="*/ 485 w 970"/>
                <a:gd name="T47" fmla="*/ 327 h 809"/>
                <a:gd name="T48" fmla="*/ 485 w 970"/>
                <a:gd name="T49" fmla="*/ 327 h 809"/>
                <a:gd name="T50" fmla="*/ 520 w 970"/>
                <a:gd name="T51" fmla="*/ 399 h 809"/>
                <a:gd name="T52" fmla="*/ 520 w 970"/>
                <a:gd name="T53" fmla="*/ 399 h 809"/>
                <a:gd name="T54" fmla="*/ 554 w 970"/>
                <a:gd name="T55" fmla="*/ 495 h 809"/>
                <a:gd name="T56" fmla="*/ 554 w 970"/>
                <a:gd name="T57" fmla="*/ 495 h 809"/>
                <a:gd name="T58" fmla="*/ 589 w 970"/>
                <a:gd name="T59" fmla="*/ 576 h 809"/>
                <a:gd name="T60" fmla="*/ 589 w 970"/>
                <a:gd name="T61" fmla="*/ 576 h 809"/>
                <a:gd name="T62" fmla="*/ 623 w 970"/>
                <a:gd name="T63" fmla="*/ 600 h 809"/>
                <a:gd name="T64" fmla="*/ 623 w 970"/>
                <a:gd name="T65" fmla="*/ 600 h 809"/>
                <a:gd name="T66" fmla="*/ 658 w 970"/>
                <a:gd name="T67" fmla="*/ 653 h 809"/>
                <a:gd name="T68" fmla="*/ 658 w 970"/>
                <a:gd name="T69" fmla="*/ 653 h 809"/>
                <a:gd name="T70" fmla="*/ 692 w 970"/>
                <a:gd name="T71" fmla="*/ 704 h 809"/>
                <a:gd name="T72" fmla="*/ 692 w 970"/>
                <a:gd name="T73" fmla="*/ 704 h 809"/>
                <a:gd name="T74" fmla="*/ 728 w 970"/>
                <a:gd name="T75" fmla="*/ 757 h 809"/>
                <a:gd name="T76" fmla="*/ 728 w 970"/>
                <a:gd name="T77" fmla="*/ 757 h 809"/>
                <a:gd name="T78" fmla="*/ 796 w 970"/>
                <a:gd name="T79" fmla="*/ 783 h 809"/>
                <a:gd name="T80" fmla="*/ 796 w 970"/>
                <a:gd name="T81" fmla="*/ 783 h 809"/>
                <a:gd name="T82" fmla="*/ 831 w 970"/>
                <a:gd name="T83" fmla="*/ 792 h 809"/>
                <a:gd name="T84" fmla="*/ 831 w 970"/>
                <a:gd name="T85" fmla="*/ 792 h 809"/>
                <a:gd name="T86" fmla="*/ 901 w 970"/>
                <a:gd name="T87" fmla="*/ 801 h 809"/>
                <a:gd name="T88" fmla="*/ 901 w 970"/>
                <a:gd name="T89" fmla="*/ 801 h 809"/>
                <a:gd name="T90" fmla="*/ 970 w 970"/>
                <a:gd name="T91" fmla="*/ 809 h 8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</a:cxnLst>
              <a:rect l="0" t="0" r="r" b="b"/>
              <a:pathLst>
                <a:path w="970" h="809">
                  <a:moveTo>
                    <a:pt x="0" y="0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69" y="0"/>
                  </a:lnTo>
                  <a:lnTo>
                    <a:pt x="69" y="0"/>
                  </a:lnTo>
                  <a:lnTo>
                    <a:pt x="138" y="0"/>
                  </a:lnTo>
                  <a:lnTo>
                    <a:pt x="138" y="0"/>
                  </a:lnTo>
                  <a:lnTo>
                    <a:pt x="173" y="0"/>
                  </a:lnTo>
                  <a:lnTo>
                    <a:pt x="173" y="0"/>
                  </a:lnTo>
                  <a:lnTo>
                    <a:pt x="208" y="0"/>
                  </a:lnTo>
                  <a:lnTo>
                    <a:pt x="208" y="0"/>
                  </a:lnTo>
                  <a:lnTo>
                    <a:pt x="277" y="14"/>
                  </a:lnTo>
                  <a:lnTo>
                    <a:pt x="277" y="14"/>
                  </a:lnTo>
                  <a:lnTo>
                    <a:pt x="312" y="43"/>
                  </a:lnTo>
                  <a:lnTo>
                    <a:pt x="312" y="43"/>
                  </a:lnTo>
                  <a:lnTo>
                    <a:pt x="346" y="80"/>
                  </a:lnTo>
                  <a:lnTo>
                    <a:pt x="346" y="80"/>
                  </a:lnTo>
                  <a:lnTo>
                    <a:pt x="381" y="115"/>
                  </a:lnTo>
                  <a:lnTo>
                    <a:pt x="381" y="115"/>
                  </a:lnTo>
                  <a:lnTo>
                    <a:pt x="416" y="195"/>
                  </a:lnTo>
                  <a:lnTo>
                    <a:pt x="416" y="195"/>
                  </a:lnTo>
                  <a:lnTo>
                    <a:pt x="450" y="245"/>
                  </a:lnTo>
                  <a:lnTo>
                    <a:pt x="450" y="245"/>
                  </a:lnTo>
                  <a:lnTo>
                    <a:pt x="485" y="327"/>
                  </a:lnTo>
                  <a:lnTo>
                    <a:pt x="485" y="327"/>
                  </a:lnTo>
                  <a:lnTo>
                    <a:pt x="520" y="399"/>
                  </a:lnTo>
                  <a:lnTo>
                    <a:pt x="520" y="399"/>
                  </a:lnTo>
                  <a:lnTo>
                    <a:pt x="554" y="495"/>
                  </a:lnTo>
                  <a:lnTo>
                    <a:pt x="554" y="495"/>
                  </a:lnTo>
                  <a:lnTo>
                    <a:pt x="589" y="576"/>
                  </a:lnTo>
                  <a:lnTo>
                    <a:pt x="589" y="576"/>
                  </a:lnTo>
                  <a:lnTo>
                    <a:pt x="623" y="600"/>
                  </a:lnTo>
                  <a:lnTo>
                    <a:pt x="623" y="600"/>
                  </a:lnTo>
                  <a:lnTo>
                    <a:pt x="658" y="653"/>
                  </a:lnTo>
                  <a:lnTo>
                    <a:pt x="658" y="653"/>
                  </a:lnTo>
                  <a:lnTo>
                    <a:pt x="692" y="704"/>
                  </a:lnTo>
                  <a:lnTo>
                    <a:pt x="692" y="704"/>
                  </a:lnTo>
                  <a:lnTo>
                    <a:pt x="728" y="757"/>
                  </a:lnTo>
                  <a:lnTo>
                    <a:pt x="728" y="757"/>
                  </a:lnTo>
                  <a:lnTo>
                    <a:pt x="796" y="783"/>
                  </a:lnTo>
                  <a:lnTo>
                    <a:pt x="796" y="783"/>
                  </a:lnTo>
                  <a:lnTo>
                    <a:pt x="831" y="792"/>
                  </a:lnTo>
                  <a:lnTo>
                    <a:pt x="831" y="792"/>
                  </a:lnTo>
                  <a:lnTo>
                    <a:pt x="901" y="801"/>
                  </a:lnTo>
                  <a:lnTo>
                    <a:pt x="901" y="801"/>
                  </a:lnTo>
                  <a:lnTo>
                    <a:pt x="970" y="809"/>
                  </a:lnTo>
                </a:path>
              </a:pathLst>
            </a:custGeom>
            <a:noFill/>
            <a:ln w="19050" cap="flat">
              <a:solidFill>
                <a:srgbClr val="00C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171" name="Freeform 157"/>
            <p:cNvSpPr>
              <a:spLocks/>
            </p:cNvSpPr>
            <p:nvPr/>
          </p:nvSpPr>
          <p:spPr bwMode="auto">
            <a:xfrm>
              <a:off x="3906838" y="836613"/>
              <a:ext cx="1374775" cy="1284288"/>
            </a:xfrm>
            <a:custGeom>
              <a:avLst/>
              <a:gdLst>
                <a:gd name="T0" fmla="*/ 0 w 866"/>
                <a:gd name="T1" fmla="*/ 0 h 809"/>
                <a:gd name="T2" fmla="*/ 0 w 866"/>
                <a:gd name="T3" fmla="*/ 0 h 809"/>
                <a:gd name="T4" fmla="*/ 0 w 866"/>
                <a:gd name="T5" fmla="*/ 0 h 809"/>
                <a:gd name="T6" fmla="*/ 69 w 866"/>
                <a:gd name="T7" fmla="*/ 0 h 809"/>
                <a:gd name="T8" fmla="*/ 69 w 866"/>
                <a:gd name="T9" fmla="*/ 0 h 809"/>
                <a:gd name="T10" fmla="*/ 138 w 866"/>
                <a:gd name="T11" fmla="*/ 0 h 809"/>
                <a:gd name="T12" fmla="*/ 138 w 866"/>
                <a:gd name="T13" fmla="*/ 0 h 809"/>
                <a:gd name="T14" fmla="*/ 173 w 866"/>
                <a:gd name="T15" fmla="*/ 18 h 809"/>
                <a:gd name="T16" fmla="*/ 173 w 866"/>
                <a:gd name="T17" fmla="*/ 18 h 809"/>
                <a:gd name="T18" fmla="*/ 208 w 866"/>
                <a:gd name="T19" fmla="*/ 53 h 809"/>
                <a:gd name="T20" fmla="*/ 208 w 866"/>
                <a:gd name="T21" fmla="*/ 53 h 809"/>
                <a:gd name="T22" fmla="*/ 277 w 866"/>
                <a:gd name="T23" fmla="*/ 116 h 809"/>
                <a:gd name="T24" fmla="*/ 277 w 866"/>
                <a:gd name="T25" fmla="*/ 116 h 809"/>
                <a:gd name="T26" fmla="*/ 312 w 866"/>
                <a:gd name="T27" fmla="*/ 161 h 809"/>
                <a:gd name="T28" fmla="*/ 312 w 866"/>
                <a:gd name="T29" fmla="*/ 161 h 809"/>
                <a:gd name="T30" fmla="*/ 346 w 866"/>
                <a:gd name="T31" fmla="*/ 186 h 809"/>
                <a:gd name="T32" fmla="*/ 346 w 866"/>
                <a:gd name="T33" fmla="*/ 186 h 809"/>
                <a:gd name="T34" fmla="*/ 381 w 866"/>
                <a:gd name="T35" fmla="*/ 212 h 809"/>
                <a:gd name="T36" fmla="*/ 381 w 866"/>
                <a:gd name="T37" fmla="*/ 212 h 809"/>
                <a:gd name="T38" fmla="*/ 416 w 866"/>
                <a:gd name="T39" fmla="*/ 244 h 809"/>
                <a:gd name="T40" fmla="*/ 416 w 866"/>
                <a:gd name="T41" fmla="*/ 244 h 809"/>
                <a:gd name="T42" fmla="*/ 450 w 866"/>
                <a:gd name="T43" fmla="*/ 345 h 809"/>
                <a:gd name="T44" fmla="*/ 450 w 866"/>
                <a:gd name="T45" fmla="*/ 345 h 809"/>
                <a:gd name="T46" fmla="*/ 485 w 866"/>
                <a:gd name="T47" fmla="*/ 422 h 809"/>
                <a:gd name="T48" fmla="*/ 485 w 866"/>
                <a:gd name="T49" fmla="*/ 422 h 809"/>
                <a:gd name="T50" fmla="*/ 520 w 866"/>
                <a:gd name="T51" fmla="*/ 485 h 809"/>
                <a:gd name="T52" fmla="*/ 520 w 866"/>
                <a:gd name="T53" fmla="*/ 485 h 809"/>
                <a:gd name="T54" fmla="*/ 554 w 866"/>
                <a:gd name="T55" fmla="*/ 587 h 809"/>
                <a:gd name="T56" fmla="*/ 554 w 866"/>
                <a:gd name="T57" fmla="*/ 587 h 809"/>
                <a:gd name="T58" fmla="*/ 589 w 866"/>
                <a:gd name="T59" fmla="*/ 618 h 809"/>
                <a:gd name="T60" fmla="*/ 589 w 866"/>
                <a:gd name="T61" fmla="*/ 618 h 809"/>
                <a:gd name="T62" fmla="*/ 623 w 866"/>
                <a:gd name="T63" fmla="*/ 663 h 809"/>
                <a:gd name="T64" fmla="*/ 623 w 866"/>
                <a:gd name="T65" fmla="*/ 663 h 809"/>
                <a:gd name="T66" fmla="*/ 658 w 866"/>
                <a:gd name="T67" fmla="*/ 701 h 809"/>
                <a:gd name="T68" fmla="*/ 658 w 866"/>
                <a:gd name="T69" fmla="*/ 701 h 809"/>
                <a:gd name="T70" fmla="*/ 692 w 866"/>
                <a:gd name="T71" fmla="*/ 733 h 809"/>
                <a:gd name="T72" fmla="*/ 692 w 866"/>
                <a:gd name="T73" fmla="*/ 733 h 809"/>
                <a:gd name="T74" fmla="*/ 728 w 866"/>
                <a:gd name="T75" fmla="*/ 764 h 809"/>
                <a:gd name="T76" fmla="*/ 728 w 866"/>
                <a:gd name="T77" fmla="*/ 764 h 809"/>
                <a:gd name="T78" fmla="*/ 796 w 866"/>
                <a:gd name="T79" fmla="*/ 784 h 809"/>
                <a:gd name="T80" fmla="*/ 796 w 866"/>
                <a:gd name="T81" fmla="*/ 784 h 809"/>
                <a:gd name="T82" fmla="*/ 831 w 866"/>
                <a:gd name="T83" fmla="*/ 803 h 809"/>
                <a:gd name="T84" fmla="*/ 831 w 866"/>
                <a:gd name="T85" fmla="*/ 803 h 809"/>
                <a:gd name="T86" fmla="*/ 866 w 866"/>
                <a:gd name="T87" fmla="*/ 809 h 8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</a:cxnLst>
              <a:rect l="0" t="0" r="r" b="b"/>
              <a:pathLst>
                <a:path w="866" h="809">
                  <a:moveTo>
                    <a:pt x="0" y="0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69" y="0"/>
                  </a:lnTo>
                  <a:lnTo>
                    <a:pt x="69" y="0"/>
                  </a:lnTo>
                  <a:lnTo>
                    <a:pt x="138" y="0"/>
                  </a:lnTo>
                  <a:lnTo>
                    <a:pt x="138" y="0"/>
                  </a:lnTo>
                  <a:lnTo>
                    <a:pt x="173" y="18"/>
                  </a:lnTo>
                  <a:lnTo>
                    <a:pt x="173" y="18"/>
                  </a:lnTo>
                  <a:lnTo>
                    <a:pt x="208" y="53"/>
                  </a:lnTo>
                  <a:lnTo>
                    <a:pt x="208" y="53"/>
                  </a:lnTo>
                  <a:lnTo>
                    <a:pt x="277" y="116"/>
                  </a:lnTo>
                  <a:lnTo>
                    <a:pt x="277" y="116"/>
                  </a:lnTo>
                  <a:lnTo>
                    <a:pt x="312" y="161"/>
                  </a:lnTo>
                  <a:lnTo>
                    <a:pt x="312" y="161"/>
                  </a:lnTo>
                  <a:lnTo>
                    <a:pt x="346" y="186"/>
                  </a:lnTo>
                  <a:lnTo>
                    <a:pt x="346" y="186"/>
                  </a:lnTo>
                  <a:lnTo>
                    <a:pt x="381" y="212"/>
                  </a:lnTo>
                  <a:lnTo>
                    <a:pt x="381" y="212"/>
                  </a:lnTo>
                  <a:lnTo>
                    <a:pt x="416" y="244"/>
                  </a:lnTo>
                  <a:lnTo>
                    <a:pt x="416" y="244"/>
                  </a:lnTo>
                  <a:lnTo>
                    <a:pt x="450" y="345"/>
                  </a:lnTo>
                  <a:lnTo>
                    <a:pt x="450" y="345"/>
                  </a:lnTo>
                  <a:lnTo>
                    <a:pt x="485" y="422"/>
                  </a:lnTo>
                  <a:lnTo>
                    <a:pt x="485" y="422"/>
                  </a:lnTo>
                  <a:lnTo>
                    <a:pt x="520" y="485"/>
                  </a:lnTo>
                  <a:lnTo>
                    <a:pt x="520" y="485"/>
                  </a:lnTo>
                  <a:lnTo>
                    <a:pt x="554" y="587"/>
                  </a:lnTo>
                  <a:lnTo>
                    <a:pt x="554" y="587"/>
                  </a:lnTo>
                  <a:lnTo>
                    <a:pt x="589" y="618"/>
                  </a:lnTo>
                  <a:lnTo>
                    <a:pt x="589" y="618"/>
                  </a:lnTo>
                  <a:lnTo>
                    <a:pt x="623" y="663"/>
                  </a:lnTo>
                  <a:lnTo>
                    <a:pt x="623" y="663"/>
                  </a:lnTo>
                  <a:lnTo>
                    <a:pt x="658" y="701"/>
                  </a:lnTo>
                  <a:lnTo>
                    <a:pt x="658" y="701"/>
                  </a:lnTo>
                  <a:lnTo>
                    <a:pt x="692" y="733"/>
                  </a:lnTo>
                  <a:lnTo>
                    <a:pt x="692" y="733"/>
                  </a:lnTo>
                  <a:lnTo>
                    <a:pt x="728" y="764"/>
                  </a:lnTo>
                  <a:lnTo>
                    <a:pt x="728" y="764"/>
                  </a:lnTo>
                  <a:lnTo>
                    <a:pt x="796" y="784"/>
                  </a:lnTo>
                  <a:lnTo>
                    <a:pt x="796" y="784"/>
                  </a:lnTo>
                  <a:lnTo>
                    <a:pt x="831" y="803"/>
                  </a:lnTo>
                  <a:lnTo>
                    <a:pt x="831" y="803"/>
                  </a:lnTo>
                  <a:lnTo>
                    <a:pt x="866" y="809"/>
                  </a:lnTo>
                </a:path>
              </a:pathLst>
            </a:custGeom>
            <a:noFill/>
            <a:ln w="19050" cap="flat">
              <a:solidFill>
                <a:srgbClr val="0000C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172" name="Freeform 158"/>
            <p:cNvSpPr>
              <a:spLocks/>
            </p:cNvSpPr>
            <p:nvPr/>
          </p:nvSpPr>
          <p:spPr bwMode="auto">
            <a:xfrm>
              <a:off x="3906838" y="836613"/>
              <a:ext cx="1263650" cy="1284288"/>
            </a:xfrm>
            <a:custGeom>
              <a:avLst/>
              <a:gdLst>
                <a:gd name="T0" fmla="*/ 0 w 796"/>
                <a:gd name="T1" fmla="*/ 0 h 809"/>
                <a:gd name="T2" fmla="*/ 0 w 796"/>
                <a:gd name="T3" fmla="*/ 0 h 809"/>
                <a:gd name="T4" fmla="*/ 0 w 796"/>
                <a:gd name="T5" fmla="*/ 0 h 809"/>
                <a:gd name="T6" fmla="*/ 69 w 796"/>
                <a:gd name="T7" fmla="*/ 0 h 809"/>
                <a:gd name="T8" fmla="*/ 69 w 796"/>
                <a:gd name="T9" fmla="*/ 0 h 809"/>
                <a:gd name="T10" fmla="*/ 138 w 796"/>
                <a:gd name="T11" fmla="*/ 0 h 809"/>
                <a:gd name="T12" fmla="*/ 138 w 796"/>
                <a:gd name="T13" fmla="*/ 0 h 809"/>
                <a:gd name="T14" fmla="*/ 173 w 796"/>
                <a:gd name="T15" fmla="*/ 0 h 809"/>
                <a:gd name="T16" fmla="*/ 173 w 796"/>
                <a:gd name="T17" fmla="*/ 0 h 809"/>
                <a:gd name="T18" fmla="*/ 208 w 796"/>
                <a:gd name="T19" fmla="*/ 14 h 809"/>
                <a:gd name="T20" fmla="*/ 208 w 796"/>
                <a:gd name="T21" fmla="*/ 14 h 809"/>
                <a:gd name="T22" fmla="*/ 277 w 796"/>
                <a:gd name="T23" fmla="*/ 81 h 809"/>
                <a:gd name="T24" fmla="*/ 277 w 796"/>
                <a:gd name="T25" fmla="*/ 81 h 809"/>
                <a:gd name="T26" fmla="*/ 312 w 796"/>
                <a:gd name="T27" fmla="*/ 140 h 809"/>
                <a:gd name="T28" fmla="*/ 312 w 796"/>
                <a:gd name="T29" fmla="*/ 140 h 809"/>
                <a:gd name="T30" fmla="*/ 346 w 796"/>
                <a:gd name="T31" fmla="*/ 207 h 809"/>
                <a:gd name="T32" fmla="*/ 346 w 796"/>
                <a:gd name="T33" fmla="*/ 207 h 809"/>
                <a:gd name="T34" fmla="*/ 381 w 796"/>
                <a:gd name="T35" fmla="*/ 291 h 809"/>
                <a:gd name="T36" fmla="*/ 381 w 796"/>
                <a:gd name="T37" fmla="*/ 291 h 809"/>
                <a:gd name="T38" fmla="*/ 416 w 796"/>
                <a:gd name="T39" fmla="*/ 340 h 809"/>
                <a:gd name="T40" fmla="*/ 416 w 796"/>
                <a:gd name="T41" fmla="*/ 340 h 809"/>
                <a:gd name="T42" fmla="*/ 450 w 796"/>
                <a:gd name="T43" fmla="*/ 383 h 809"/>
                <a:gd name="T44" fmla="*/ 450 w 796"/>
                <a:gd name="T45" fmla="*/ 383 h 809"/>
                <a:gd name="T46" fmla="*/ 485 w 796"/>
                <a:gd name="T47" fmla="*/ 525 h 809"/>
                <a:gd name="T48" fmla="*/ 485 w 796"/>
                <a:gd name="T49" fmla="*/ 525 h 809"/>
                <a:gd name="T50" fmla="*/ 520 w 796"/>
                <a:gd name="T51" fmla="*/ 620 h 809"/>
                <a:gd name="T52" fmla="*/ 520 w 796"/>
                <a:gd name="T53" fmla="*/ 620 h 809"/>
                <a:gd name="T54" fmla="*/ 554 w 796"/>
                <a:gd name="T55" fmla="*/ 696 h 809"/>
                <a:gd name="T56" fmla="*/ 554 w 796"/>
                <a:gd name="T57" fmla="*/ 696 h 809"/>
                <a:gd name="T58" fmla="*/ 589 w 796"/>
                <a:gd name="T59" fmla="*/ 733 h 809"/>
                <a:gd name="T60" fmla="*/ 589 w 796"/>
                <a:gd name="T61" fmla="*/ 733 h 809"/>
                <a:gd name="T62" fmla="*/ 623 w 796"/>
                <a:gd name="T63" fmla="*/ 762 h 809"/>
                <a:gd name="T64" fmla="*/ 623 w 796"/>
                <a:gd name="T65" fmla="*/ 762 h 809"/>
                <a:gd name="T66" fmla="*/ 658 w 796"/>
                <a:gd name="T67" fmla="*/ 781 h 809"/>
                <a:gd name="T68" fmla="*/ 658 w 796"/>
                <a:gd name="T69" fmla="*/ 781 h 809"/>
                <a:gd name="T70" fmla="*/ 692 w 796"/>
                <a:gd name="T71" fmla="*/ 790 h 809"/>
                <a:gd name="T72" fmla="*/ 692 w 796"/>
                <a:gd name="T73" fmla="*/ 790 h 809"/>
                <a:gd name="T74" fmla="*/ 728 w 796"/>
                <a:gd name="T75" fmla="*/ 799 h 809"/>
                <a:gd name="T76" fmla="*/ 728 w 796"/>
                <a:gd name="T77" fmla="*/ 799 h 809"/>
                <a:gd name="T78" fmla="*/ 796 w 796"/>
                <a:gd name="T79" fmla="*/ 809 h 8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</a:cxnLst>
              <a:rect l="0" t="0" r="r" b="b"/>
              <a:pathLst>
                <a:path w="796" h="809">
                  <a:moveTo>
                    <a:pt x="0" y="0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69" y="0"/>
                  </a:lnTo>
                  <a:lnTo>
                    <a:pt x="69" y="0"/>
                  </a:lnTo>
                  <a:lnTo>
                    <a:pt x="138" y="0"/>
                  </a:lnTo>
                  <a:lnTo>
                    <a:pt x="138" y="0"/>
                  </a:lnTo>
                  <a:lnTo>
                    <a:pt x="173" y="0"/>
                  </a:lnTo>
                  <a:lnTo>
                    <a:pt x="173" y="0"/>
                  </a:lnTo>
                  <a:lnTo>
                    <a:pt x="208" y="14"/>
                  </a:lnTo>
                  <a:lnTo>
                    <a:pt x="208" y="14"/>
                  </a:lnTo>
                  <a:lnTo>
                    <a:pt x="277" y="81"/>
                  </a:lnTo>
                  <a:lnTo>
                    <a:pt x="277" y="81"/>
                  </a:lnTo>
                  <a:lnTo>
                    <a:pt x="312" y="140"/>
                  </a:lnTo>
                  <a:lnTo>
                    <a:pt x="312" y="140"/>
                  </a:lnTo>
                  <a:lnTo>
                    <a:pt x="346" y="207"/>
                  </a:lnTo>
                  <a:lnTo>
                    <a:pt x="346" y="207"/>
                  </a:lnTo>
                  <a:lnTo>
                    <a:pt x="381" y="291"/>
                  </a:lnTo>
                  <a:lnTo>
                    <a:pt x="381" y="291"/>
                  </a:lnTo>
                  <a:lnTo>
                    <a:pt x="416" y="340"/>
                  </a:lnTo>
                  <a:lnTo>
                    <a:pt x="416" y="340"/>
                  </a:lnTo>
                  <a:lnTo>
                    <a:pt x="450" y="383"/>
                  </a:lnTo>
                  <a:lnTo>
                    <a:pt x="450" y="383"/>
                  </a:lnTo>
                  <a:lnTo>
                    <a:pt x="485" y="525"/>
                  </a:lnTo>
                  <a:lnTo>
                    <a:pt x="485" y="525"/>
                  </a:lnTo>
                  <a:lnTo>
                    <a:pt x="520" y="620"/>
                  </a:lnTo>
                  <a:lnTo>
                    <a:pt x="520" y="620"/>
                  </a:lnTo>
                  <a:lnTo>
                    <a:pt x="554" y="696"/>
                  </a:lnTo>
                  <a:lnTo>
                    <a:pt x="554" y="696"/>
                  </a:lnTo>
                  <a:lnTo>
                    <a:pt x="589" y="733"/>
                  </a:lnTo>
                  <a:lnTo>
                    <a:pt x="589" y="733"/>
                  </a:lnTo>
                  <a:lnTo>
                    <a:pt x="623" y="762"/>
                  </a:lnTo>
                  <a:lnTo>
                    <a:pt x="623" y="762"/>
                  </a:lnTo>
                  <a:lnTo>
                    <a:pt x="658" y="781"/>
                  </a:lnTo>
                  <a:lnTo>
                    <a:pt x="658" y="781"/>
                  </a:lnTo>
                  <a:lnTo>
                    <a:pt x="692" y="790"/>
                  </a:lnTo>
                  <a:lnTo>
                    <a:pt x="692" y="790"/>
                  </a:lnTo>
                  <a:lnTo>
                    <a:pt x="728" y="799"/>
                  </a:lnTo>
                  <a:lnTo>
                    <a:pt x="728" y="799"/>
                  </a:lnTo>
                  <a:lnTo>
                    <a:pt x="796" y="809"/>
                  </a:lnTo>
                </a:path>
              </a:pathLst>
            </a:custGeom>
            <a:noFill/>
            <a:ln w="19050" cap="flat">
              <a:solidFill>
                <a:srgbClr val="A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173" name="Freeform 159"/>
            <p:cNvSpPr>
              <a:spLocks/>
            </p:cNvSpPr>
            <p:nvPr/>
          </p:nvSpPr>
          <p:spPr bwMode="auto">
            <a:xfrm>
              <a:off x="3906838" y="836613"/>
              <a:ext cx="1484313" cy="1284288"/>
            </a:xfrm>
            <a:custGeom>
              <a:avLst/>
              <a:gdLst>
                <a:gd name="T0" fmla="*/ 0 w 935"/>
                <a:gd name="T1" fmla="*/ 0 h 809"/>
                <a:gd name="T2" fmla="*/ 0 w 935"/>
                <a:gd name="T3" fmla="*/ 0 h 809"/>
                <a:gd name="T4" fmla="*/ 0 w 935"/>
                <a:gd name="T5" fmla="*/ 0 h 809"/>
                <a:gd name="T6" fmla="*/ 69 w 935"/>
                <a:gd name="T7" fmla="*/ 0 h 809"/>
                <a:gd name="T8" fmla="*/ 69 w 935"/>
                <a:gd name="T9" fmla="*/ 0 h 809"/>
                <a:gd name="T10" fmla="*/ 138 w 935"/>
                <a:gd name="T11" fmla="*/ 0 h 809"/>
                <a:gd name="T12" fmla="*/ 138 w 935"/>
                <a:gd name="T13" fmla="*/ 0 h 809"/>
                <a:gd name="T14" fmla="*/ 173 w 935"/>
                <a:gd name="T15" fmla="*/ 0 h 809"/>
                <a:gd name="T16" fmla="*/ 173 w 935"/>
                <a:gd name="T17" fmla="*/ 0 h 809"/>
                <a:gd name="T18" fmla="*/ 208 w 935"/>
                <a:gd name="T19" fmla="*/ 0 h 809"/>
                <a:gd name="T20" fmla="*/ 208 w 935"/>
                <a:gd name="T21" fmla="*/ 0 h 809"/>
                <a:gd name="T22" fmla="*/ 277 w 935"/>
                <a:gd name="T23" fmla="*/ 0 h 809"/>
                <a:gd name="T24" fmla="*/ 277 w 935"/>
                <a:gd name="T25" fmla="*/ 0 h 809"/>
                <a:gd name="T26" fmla="*/ 312 w 935"/>
                <a:gd name="T27" fmla="*/ 8 h 809"/>
                <a:gd name="T28" fmla="*/ 312 w 935"/>
                <a:gd name="T29" fmla="*/ 8 h 809"/>
                <a:gd name="T30" fmla="*/ 346 w 935"/>
                <a:gd name="T31" fmla="*/ 33 h 809"/>
                <a:gd name="T32" fmla="*/ 346 w 935"/>
                <a:gd name="T33" fmla="*/ 33 h 809"/>
                <a:gd name="T34" fmla="*/ 381 w 935"/>
                <a:gd name="T35" fmla="*/ 64 h 809"/>
                <a:gd name="T36" fmla="*/ 381 w 935"/>
                <a:gd name="T37" fmla="*/ 64 h 809"/>
                <a:gd name="T38" fmla="*/ 416 w 935"/>
                <a:gd name="T39" fmla="*/ 103 h 809"/>
                <a:gd name="T40" fmla="*/ 416 w 935"/>
                <a:gd name="T41" fmla="*/ 103 h 809"/>
                <a:gd name="T42" fmla="*/ 450 w 935"/>
                <a:gd name="T43" fmla="*/ 183 h 809"/>
                <a:gd name="T44" fmla="*/ 450 w 935"/>
                <a:gd name="T45" fmla="*/ 183 h 809"/>
                <a:gd name="T46" fmla="*/ 485 w 935"/>
                <a:gd name="T47" fmla="*/ 290 h 809"/>
                <a:gd name="T48" fmla="*/ 485 w 935"/>
                <a:gd name="T49" fmla="*/ 290 h 809"/>
                <a:gd name="T50" fmla="*/ 520 w 935"/>
                <a:gd name="T51" fmla="*/ 397 h 809"/>
                <a:gd name="T52" fmla="*/ 520 w 935"/>
                <a:gd name="T53" fmla="*/ 397 h 809"/>
                <a:gd name="T54" fmla="*/ 554 w 935"/>
                <a:gd name="T55" fmla="*/ 496 h 809"/>
                <a:gd name="T56" fmla="*/ 554 w 935"/>
                <a:gd name="T57" fmla="*/ 496 h 809"/>
                <a:gd name="T58" fmla="*/ 589 w 935"/>
                <a:gd name="T59" fmla="*/ 553 h 809"/>
                <a:gd name="T60" fmla="*/ 589 w 935"/>
                <a:gd name="T61" fmla="*/ 553 h 809"/>
                <a:gd name="T62" fmla="*/ 623 w 935"/>
                <a:gd name="T63" fmla="*/ 611 h 809"/>
                <a:gd name="T64" fmla="*/ 623 w 935"/>
                <a:gd name="T65" fmla="*/ 611 h 809"/>
                <a:gd name="T66" fmla="*/ 658 w 935"/>
                <a:gd name="T67" fmla="*/ 702 h 809"/>
                <a:gd name="T68" fmla="*/ 658 w 935"/>
                <a:gd name="T69" fmla="*/ 702 h 809"/>
                <a:gd name="T70" fmla="*/ 692 w 935"/>
                <a:gd name="T71" fmla="*/ 727 h 809"/>
                <a:gd name="T72" fmla="*/ 692 w 935"/>
                <a:gd name="T73" fmla="*/ 727 h 809"/>
                <a:gd name="T74" fmla="*/ 728 w 935"/>
                <a:gd name="T75" fmla="*/ 760 h 809"/>
                <a:gd name="T76" fmla="*/ 728 w 935"/>
                <a:gd name="T77" fmla="*/ 760 h 809"/>
                <a:gd name="T78" fmla="*/ 796 w 935"/>
                <a:gd name="T79" fmla="*/ 777 h 809"/>
                <a:gd name="T80" fmla="*/ 796 w 935"/>
                <a:gd name="T81" fmla="*/ 777 h 809"/>
                <a:gd name="T82" fmla="*/ 831 w 935"/>
                <a:gd name="T83" fmla="*/ 784 h 809"/>
                <a:gd name="T84" fmla="*/ 831 w 935"/>
                <a:gd name="T85" fmla="*/ 784 h 809"/>
                <a:gd name="T86" fmla="*/ 901 w 935"/>
                <a:gd name="T87" fmla="*/ 801 h 809"/>
                <a:gd name="T88" fmla="*/ 901 w 935"/>
                <a:gd name="T89" fmla="*/ 801 h 809"/>
                <a:gd name="T90" fmla="*/ 935 w 935"/>
                <a:gd name="T91" fmla="*/ 809 h 8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</a:cxnLst>
              <a:rect l="0" t="0" r="r" b="b"/>
              <a:pathLst>
                <a:path w="935" h="809">
                  <a:moveTo>
                    <a:pt x="0" y="0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69" y="0"/>
                  </a:lnTo>
                  <a:lnTo>
                    <a:pt x="69" y="0"/>
                  </a:lnTo>
                  <a:lnTo>
                    <a:pt x="138" y="0"/>
                  </a:lnTo>
                  <a:lnTo>
                    <a:pt x="138" y="0"/>
                  </a:lnTo>
                  <a:lnTo>
                    <a:pt x="173" y="0"/>
                  </a:lnTo>
                  <a:lnTo>
                    <a:pt x="173" y="0"/>
                  </a:lnTo>
                  <a:lnTo>
                    <a:pt x="208" y="0"/>
                  </a:lnTo>
                  <a:lnTo>
                    <a:pt x="208" y="0"/>
                  </a:lnTo>
                  <a:lnTo>
                    <a:pt x="277" y="0"/>
                  </a:lnTo>
                  <a:lnTo>
                    <a:pt x="277" y="0"/>
                  </a:lnTo>
                  <a:lnTo>
                    <a:pt x="312" y="8"/>
                  </a:lnTo>
                  <a:lnTo>
                    <a:pt x="312" y="8"/>
                  </a:lnTo>
                  <a:lnTo>
                    <a:pt x="346" y="33"/>
                  </a:lnTo>
                  <a:lnTo>
                    <a:pt x="346" y="33"/>
                  </a:lnTo>
                  <a:lnTo>
                    <a:pt x="381" y="64"/>
                  </a:lnTo>
                  <a:lnTo>
                    <a:pt x="381" y="64"/>
                  </a:lnTo>
                  <a:lnTo>
                    <a:pt x="416" y="103"/>
                  </a:lnTo>
                  <a:lnTo>
                    <a:pt x="416" y="103"/>
                  </a:lnTo>
                  <a:lnTo>
                    <a:pt x="450" y="183"/>
                  </a:lnTo>
                  <a:lnTo>
                    <a:pt x="450" y="183"/>
                  </a:lnTo>
                  <a:lnTo>
                    <a:pt x="485" y="290"/>
                  </a:lnTo>
                  <a:lnTo>
                    <a:pt x="485" y="290"/>
                  </a:lnTo>
                  <a:lnTo>
                    <a:pt x="520" y="397"/>
                  </a:lnTo>
                  <a:lnTo>
                    <a:pt x="520" y="397"/>
                  </a:lnTo>
                  <a:lnTo>
                    <a:pt x="554" y="496"/>
                  </a:lnTo>
                  <a:lnTo>
                    <a:pt x="554" y="496"/>
                  </a:lnTo>
                  <a:lnTo>
                    <a:pt x="589" y="553"/>
                  </a:lnTo>
                  <a:lnTo>
                    <a:pt x="589" y="553"/>
                  </a:lnTo>
                  <a:lnTo>
                    <a:pt x="623" y="611"/>
                  </a:lnTo>
                  <a:lnTo>
                    <a:pt x="623" y="611"/>
                  </a:lnTo>
                  <a:lnTo>
                    <a:pt x="658" y="702"/>
                  </a:lnTo>
                  <a:lnTo>
                    <a:pt x="658" y="702"/>
                  </a:lnTo>
                  <a:lnTo>
                    <a:pt x="692" y="727"/>
                  </a:lnTo>
                  <a:lnTo>
                    <a:pt x="692" y="727"/>
                  </a:lnTo>
                  <a:lnTo>
                    <a:pt x="728" y="760"/>
                  </a:lnTo>
                  <a:lnTo>
                    <a:pt x="728" y="760"/>
                  </a:lnTo>
                  <a:lnTo>
                    <a:pt x="796" y="777"/>
                  </a:lnTo>
                  <a:lnTo>
                    <a:pt x="796" y="777"/>
                  </a:lnTo>
                  <a:lnTo>
                    <a:pt x="831" y="784"/>
                  </a:lnTo>
                  <a:lnTo>
                    <a:pt x="831" y="784"/>
                  </a:lnTo>
                  <a:lnTo>
                    <a:pt x="901" y="801"/>
                  </a:lnTo>
                  <a:lnTo>
                    <a:pt x="901" y="801"/>
                  </a:lnTo>
                  <a:lnTo>
                    <a:pt x="935" y="809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174" name="Rectangle 160"/>
            <p:cNvSpPr>
              <a:spLocks noChangeArrowheads="1"/>
            </p:cNvSpPr>
            <p:nvPr/>
          </p:nvSpPr>
          <p:spPr bwMode="auto">
            <a:xfrm>
              <a:off x="4410075" y="2341563"/>
              <a:ext cx="1136530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11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Days</a:t>
              </a:r>
              <a:r>
                <a:rPr kumimoji="0" lang="el-GR" altLang="el-GR" sz="11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of </a:t>
              </a:r>
              <a:r>
                <a:rPr kumimoji="0" lang="el-GR" altLang="el-GR" sz="11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adulthood</a:t>
              </a:r>
              <a:endParaRPr kumimoji="0" lang="el-GR" altLang="el-GR" sz="32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1" name="Rectangle 177"/>
            <p:cNvSpPr>
              <a:spLocks noChangeArrowheads="1"/>
            </p:cNvSpPr>
            <p:nvPr/>
          </p:nvSpPr>
          <p:spPr bwMode="auto">
            <a:xfrm>
              <a:off x="5106914" y="825386"/>
              <a:ext cx="147476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N2</a:t>
              </a:r>
              <a:endParaRPr kumimoji="0" lang="el-GR" altLang="el-GR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2" name="Line 178"/>
            <p:cNvSpPr>
              <a:spLocks noChangeShapeType="1"/>
            </p:cNvSpPr>
            <p:nvPr/>
          </p:nvSpPr>
          <p:spPr bwMode="auto">
            <a:xfrm>
              <a:off x="4892602" y="894635"/>
              <a:ext cx="138113" cy="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193" name="Rectangle 179"/>
            <p:cNvSpPr>
              <a:spLocks noChangeArrowheads="1"/>
            </p:cNvSpPr>
            <p:nvPr/>
          </p:nvSpPr>
          <p:spPr bwMode="auto">
            <a:xfrm>
              <a:off x="5106914" y="998423"/>
              <a:ext cx="833562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N2;</a:t>
              </a:r>
              <a:r>
                <a:rPr lang="en-US" altLang="el-GR" sz="900" i="1" dirty="0" smtClean="0">
                  <a:solidFill>
                    <a:srgbClr val="000000"/>
                  </a:solidFill>
                </a:rPr>
                <a:t>cisd-1(RNAi)</a:t>
              </a:r>
              <a:endParaRPr kumimoji="0" lang="el-GR" altLang="el-GR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6" name="Line 182"/>
            <p:cNvSpPr>
              <a:spLocks noChangeShapeType="1"/>
            </p:cNvSpPr>
            <p:nvPr/>
          </p:nvSpPr>
          <p:spPr bwMode="auto">
            <a:xfrm>
              <a:off x="4892602" y="1067672"/>
              <a:ext cx="138113" cy="0"/>
            </a:xfrm>
            <a:prstGeom prst="line">
              <a:avLst/>
            </a:prstGeom>
            <a:noFill/>
            <a:ln w="19050" cap="flat">
              <a:solidFill>
                <a:srgbClr val="A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197" name="Rectangle 183"/>
            <p:cNvSpPr>
              <a:spLocks noChangeArrowheads="1"/>
            </p:cNvSpPr>
            <p:nvPr/>
          </p:nvSpPr>
          <p:spPr bwMode="auto">
            <a:xfrm>
              <a:off x="5106914" y="1173048"/>
              <a:ext cx="814325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N2;</a:t>
              </a:r>
              <a:r>
                <a:rPr kumimoji="0" lang="en-US" altLang="el-GR" sz="9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ed-9(RNAi)</a:t>
              </a:r>
              <a:endParaRPr kumimoji="0" lang="el-GR" altLang="el-GR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9" name="Line 185"/>
            <p:cNvSpPr>
              <a:spLocks noChangeShapeType="1"/>
            </p:cNvSpPr>
            <p:nvPr/>
          </p:nvSpPr>
          <p:spPr bwMode="auto">
            <a:xfrm>
              <a:off x="4892602" y="1242297"/>
              <a:ext cx="138113" cy="0"/>
            </a:xfrm>
            <a:prstGeom prst="line">
              <a:avLst/>
            </a:prstGeom>
            <a:noFill/>
            <a:ln w="19050" cap="flat">
              <a:solidFill>
                <a:srgbClr val="0000C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200" name="Rectangle 186"/>
            <p:cNvSpPr>
              <a:spLocks noChangeArrowheads="1"/>
            </p:cNvSpPr>
            <p:nvPr/>
          </p:nvSpPr>
          <p:spPr bwMode="auto">
            <a:xfrm>
              <a:off x="5106914" y="1346086"/>
              <a:ext cx="634789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el-GR" altLang="el-GR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N2;</a:t>
              </a:r>
              <a:r>
                <a:rPr lang="en-GB" altLang="el-GR" sz="900" i="1" dirty="0" smtClean="0">
                  <a:solidFill>
                    <a:srgbClr val="000000"/>
                  </a:solidFill>
                </a:rPr>
                <a:t>cisd-1;</a:t>
              </a:r>
            </a:p>
            <a:p>
              <a:pPr lvl="0" defTabSz="914400"/>
              <a:r>
                <a:rPr lang="en-GB" altLang="el-GR" sz="900" i="1" dirty="0" smtClean="0">
                  <a:solidFill>
                    <a:srgbClr val="000000"/>
                  </a:solidFill>
                </a:rPr>
                <a:t>ced-9(RNAi</a:t>
              </a:r>
              <a:r>
                <a:rPr lang="en-GB" altLang="el-GR" sz="900" i="1" dirty="0">
                  <a:solidFill>
                    <a:srgbClr val="000000"/>
                  </a:solidFill>
                </a:rPr>
                <a:t>)</a:t>
              </a:r>
              <a:endParaRPr kumimoji="0" lang="el-GR" altLang="el-GR" sz="20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04" name="Line 190"/>
            <p:cNvSpPr>
              <a:spLocks noChangeShapeType="1"/>
            </p:cNvSpPr>
            <p:nvPr/>
          </p:nvSpPr>
          <p:spPr bwMode="auto">
            <a:xfrm>
              <a:off x="4892602" y="1484585"/>
              <a:ext cx="138113" cy="0"/>
            </a:xfrm>
            <a:prstGeom prst="line">
              <a:avLst/>
            </a:prstGeom>
            <a:noFill/>
            <a:ln w="19050" cap="flat">
              <a:solidFill>
                <a:srgbClr val="00C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205" name="TextBox 204"/>
            <p:cNvSpPr txBox="1"/>
            <p:nvPr/>
          </p:nvSpPr>
          <p:spPr>
            <a:xfrm rot="16200000">
              <a:off x="2947010" y="1334748"/>
              <a:ext cx="118814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ercent survival</a:t>
              </a:r>
              <a:endParaRPr lang="el-GR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8" name="Δεξιά αγκύλη 207"/>
            <p:cNvSpPr/>
            <p:nvPr/>
          </p:nvSpPr>
          <p:spPr>
            <a:xfrm>
              <a:off x="5954416" y="855796"/>
              <a:ext cx="45719" cy="258276"/>
            </a:xfrm>
            <a:prstGeom prst="righ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l-GR"/>
            </a:p>
          </p:txBody>
        </p:sp>
        <p:sp>
          <p:nvSpPr>
            <p:cNvPr id="209" name="Rectangle 498"/>
            <p:cNvSpPr>
              <a:spLocks noChangeArrowheads="1"/>
            </p:cNvSpPr>
            <p:nvPr/>
          </p:nvSpPr>
          <p:spPr bwMode="auto">
            <a:xfrm rot="5400000">
              <a:off x="5895247" y="890701"/>
              <a:ext cx="28212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l-GR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****</a:t>
              </a:r>
              <a:endParaRPr kumimoji="0" lang="el-GR" altLang="el-GR" sz="4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0" name="Δεξιά αγκύλη 209"/>
            <p:cNvSpPr/>
            <p:nvPr/>
          </p:nvSpPr>
          <p:spPr>
            <a:xfrm>
              <a:off x="2859108" y="3361378"/>
              <a:ext cx="45719" cy="258276"/>
            </a:xfrm>
            <a:prstGeom prst="righ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l-GR"/>
            </a:p>
          </p:txBody>
        </p:sp>
        <p:sp>
          <p:nvSpPr>
            <p:cNvPr id="211" name="Rectangle 498"/>
            <p:cNvSpPr>
              <a:spLocks noChangeArrowheads="1"/>
            </p:cNvSpPr>
            <p:nvPr/>
          </p:nvSpPr>
          <p:spPr bwMode="auto">
            <a:xfrm>
              <a:off x="2955244" y="3420706"/>
              <a:ext cx="7053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l-GR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*</a:t>
              </a:r>
              <a:endParaRPr kumimoji="0" lang="el-GR" altLang="el-GR" sz="4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2" name="Δεξιά αγκύλη 211"/>
            <p:cNvSpPr/>
            <p:nvPr/>
          </p:nvSpPr>
          <p:spPr>
            <a:xfrm>
              <a:off x="2799567" y="5870827"/>
              <a:ext cx="45719" cy="258276"/>
            </a:xfrm>
            <a:prstGeom prst="righ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l-GR"/>
            </a:p>
          </p:txBody>
        </p:sp>
        <p:sp>
          <p:nvSpPr>
            <p:cNvPr id="213" name="Rectangle 498"/>
            <p:cNvSpPr>
              <a:spLocks noChangeArrowheads="1"/>
            </p:cNvSpPr>
            <p:nvPr/>
          </p:nvSpPr>
          <p:spPr bwMode="auto">
            <a:xfrm>
              <a:off x="2895703" y="5930155"/>
              <a:ext cx="14106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l-GR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**</a:t>
              </a:r>
              <a:endParaRPr kumimoji="0" lang="el-GR" altLang="el-GR" sz="4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4" name="Δεξιά αγκύλη 213"/>
            <p:cNvSpPr/>
            <p:nvPr/>
          </p:nvSpPr>
          <p:spPr>
            <a:xfrm>
              <a:off x="6300710" y="1099780"/>
              <a:ext cx="45719" cy="396000"/>
            </a:xfrm>
            <a:prstGeom prst="righ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l-GR"/>
            </a:p>
          </p:txBody>
        </p:sp>
        <p:sp>
          <p:nvSpPr>
            <p:cNvPr id="215" name="Rectangle 498"/>
            <p:cNvSpPr>
              <a:spLocks noChangeArrowheads="1"/>
            </p:cNvSpPr>
            <p:nvPr/>
          </p:nvSpPr>
          <p:spPr bwMode="auto">
            <a:xfrm rot="5400000">
              <a:off x="6238692" y="1194679"/>
              <a:ext cx="28212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l-GR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****</a:t>
              </a:r>
              <a:endParaRPr kumimoji="0" lang="el-GR" altLang="el-GR" sz="4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6" name="Rectangle 66"/>
            <p:cNvSpPr>
              <a:spLocks noChangeArrowheads="1"/>
            </p:cNvSpPr>
            <p:nvPr/>
          </p:nvSpPr>
          <p:spPr bwMode="auto">
            <a:xfrm>
              <a:off x="4468862" y="529480"/>
              <a:ext cx="112370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l-G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Normal conditions</a:t>
              </a:r>
              <a:endParaRPr kumimoji="0" lang="el-GR" altLang="el-GR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8" name="AutoShape 192"/>
            <p:cNvSpPr>
              <a:spLocks noChangeAspect="1" noChangeArrowheads="1" noTextEdit="1"/>
            </p:cNvSpPr>
            <p:nvPr/>
          </p:nvSpPr>
          <p:spPr bwMode="auto">
            <a:xfrm>
              <a:off x="3429000" y="2868613"/>
              <a:ext cx="3427413" cy="20939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 dirty="0"/>
            </a:p>
          </p:txBody>
        </p:sp>
        <p:sp>
          <p:nvSpPr>
            <p:cNvPr id="219" name="Rectangle 194"/>
            <p:cNvSpPr>
              <a:spLocks noChangeArrowheads="1"/>
            </p:cNvSpPr>
            <p:nvPr/>
          </p:nvSpPr>
          <p:spPr bwMode="auto">
            <a:xfrm>
              <a:off x="3876675" y="4594225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el-GR" altLang="el-GR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0" name="Rectangle 195"/>
            <p:cNvSpPr>
              <a:spLocks noChangeArrowheads="1"/>
            </p:cNvSpPr>
            <p:nvPr/>
          </p:nvSpPr>
          <p:spPr bwMode="auto">
            <a:xfrm>
              <a:off x="4156075" y="4594225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</a:t>
              </a:r>
              <a:endParaRPr kumimoji="0" lang="el-GR" altLang="el-G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1" name="Rectangle 196"/>
            <p:cNvSpPr>
              <a:spLocks noChangeArrowheads="1"/>
            </p:cNvSpPr>
            <p:nvPr/>
          </p:nvSpPr>
          <p:spPr bwMode="auto">
            <a:xfrm>
              <a:off x="4403725" y="4594225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</a:t>
              </a:r>
              <a:endParaRPr kumimoji="0" lang="el-GR" altLang="el-G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2" name="Rectangle 197"/>
            <p:cNvSpPr>
              <a:spLocks noChangeArrowheads="1"/>
            </p:cNvSpPr>
            <p:nvPr/>
          </p:nvSpPr>
          <p:spPr bwMode="auto">
            <a:xfrm>
              <a:off x="4678363" y="4594225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5</a:t>
              </a:r>
              <a:endParaRPr kumimoji="0" lang="el-GR" altLang="el-G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3" name="Rectangle 198"/>
            <p:cNvSpPr>
              <a:spLocks noChangeArrowheads="1"/>
            </p:cNvSpPr>
            <p:nvPr/>
          </p:nvSpPr>
          <p:spPr bwMode="auto">
            <a:xfrm>
              <a:off x="4951413" y="4594225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</a:t>
              </a:r>
              <a:endParaRPr kumimoji="0" lang="el-GR" altLang="el-G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4" name="Rectangle 199"/>
            <p:cNvSpPr>
              <a:spLocks noChangeArrowheads="1"/>
            </p:cNvSpPr>
            <p:nvPr/>
          </p:nvSpPr>
          <p:spPr bwMode="auto">
            <a:xfrm>
              <a:off x="5224463" y="4594225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5</a:t>
              </a:r>
              <a:endParaRPr kumimoji="0" lang="el-GR" altLang="el-G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5" name="Rectangle 200"/>
            <p:cNvSpPr>
              <a:spLocks noChangeArrowheads="1"/>
            </p:cNvSpPr>
            <p:nvPr/>
          </p:nvSpPr>
          <p:spPr bwMode="auto">
            <a:xfrm>
              <a:off x="5499100" y="4594225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0</a:t>
              </a:r>
              <a:endParaRPr kumimoji="0" lang="el-GR" altLang="el-G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6" name="Rectangle 201"/>
            <p:cNvSpPr>
              <a:spLocks noChangeArrowheads="1"/>
            </p:cNvSpPr>
            <p:nvPr/>
          </p:nvSpPr>
          <p:spPr bwMode="auto">
            <a:xfrm>
              <a:off x="5772150" y="4594225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5</a:t>
              </a:r>
              <a:endParaRPr kumimoji="0" lang="el-GR" altLang="el-G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7" name="Freeform 202"/>
            <p:cNvSpPr>
              <a:spLocks noEditPoints="1"/>
            </p:cNvSpPr>
            <p:nvPr/>
          </p:nvSpPr>
          <p:spPr bwMode="auto">
            <a:xfrm>
              <a:off x="3900488" y="4525963"/>
              <a:ext cx="1935163" cy="53975"/>
            </a:xfrm>
            <a:custGeom>
              <a:avLst/>
              <a:gdLst>
                <a:gd name="T0" fmla="*/ 0 w 1219"/>
                <a:gd name="T1" fmla="*/ 0 h 34"/>
                <a:gd name="T2" fmla="*/ 1219 w 1219"/>
                <a:gd name="T3" fmla="*/ 0 h 34"/>
                <a:gd name="T4" fmla="*/ 4 w 1219"/>
                <a:gd name="T5" fmla="*/ 0 h 34"/>
                <a:gd name="T6" fmla="*/ 4 w 1219"/>
                <a:gd name="T7" fmla="*/ 34 h 34"/>
                <a:gd name="T8" fmla="*/ 177 w 1219"/>
                <a:gd name="T9" fmla="*/ 0 h 34"/>
                <a:gd name="T10" fmla="*/ 177 w 1219"/>
                <a:gd name="T11" fmla="*/ 34 h 34"/>
                <a:gd name="T12" fmla="*/ 350 w 1219"/>
                <a:gd name="T13" fmla="*/ 0 h 34"/>
                <a:gd name="T14" fmla="*/ 350 w 1219"/>
                <a:gd name="T15" fmla="*/ 34 h 34"/>
                <a:gd name="T16" fmla="*/ 523 w 1219"/>
                <a:gd name="T17" fmla="*/ 0 h 34"/>
                <a:gd name="T18" fmla="*/ 523 w 1219"/>
                <a:gd name="T19" fmla="*/ 34 h 34"/>
                <a:gd name="T20" fmla="*/ 696 w 1219"/>
                <a:gd name="T21" fmla="*/ 0 h 34"/>
                <a:gd name="T22" fmla="*/ 696 w 1219"/>
                <a:gd name="T23" fmla="*/ 34 h 34"/>
                <a:gd name="T24" fmla="*/ 869 w 1219"/>
                <a:gd name="T25" fmla="*/ 0 h 34"/>
                <a:gd name="T26" fmla="*/ 869 w 1219"/>
                <a:gd name="T27" fmla="*/ 34 h 34"/>
                <a:gd name="T28" fmla="*/ 1042 w 1219"/>
                <a:gd name="T29" fmla="*/ 0 h 34"/>
                <a:gd name="T30" fmla="*/ 1042 w 1219"/>
                <a:gd name="T31" fmla="*/ 34 h 34"/>
                <a:gd name="T32" fmla="*/ 1215 w 1219"/>
                <a:gd name="T33" fmla="*/ 0 h 34"/>
                <a:gd name="T34" fmla="*/ 1215 w 1219"/>
                <a:gd name="T35" fmla="*/ 34 h 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219" h="34">
                  <a:moveTo>
                    <a:pt x="0" y="0"/>
                  </a:moveTo>
                  <a:lnTo>
                    <a:pt x="1219" y="0"/>
                  </a:lnTo>
                  <a:moveTo>
                    <a:pt x="4" y="0"/>
                  </a:moveTo>
                  <a:lnTo>
                    <a:pt x="4" y="34"/>
                  </a:lnTo>
                  <a:moveTo>
                    <a:pt x="177" y="0"/>
                  </a:moveTo>
                  <a:lnTo>
                    <a:pt x="177" y="34"/>
                  </a:lnTo>
                  <a:moveTo>
                    <a:pt x="350" y="0"/>
                  </a:moveTo>
                  <a:lnTo>
                    <a:pt x="350" y="34"/>
                  </a:lnTo>
                  <a:moveTo>
                    <a:pt x="523" y="0"/>
                  </a:moveTo>
                  <a:lnTo>
                    <a:pt x="523" y="34"/>
                  </a:lnTo>
                  <a:moveTo>
                    <a:pt x="696" y="0"/>
                  </a:moveTo>
                  <a:lnTo>
                    <a:pt x="696" y="34"/>
                  </a:lnTo>
                  <a:moveTo>
                    <a:pt x="869" y="0"/>
                  </a:moveTo>
                  <a:lnTo>
                    <a:pt x="869" y="34"/>
                  </a:lnTo>
                  <a:moveTo>
                    <a:pt x="1042" y="0"/>
                  </a:moveTo>
                  <a:lnTo>
                    <a:pt x="1042" y="34"/>
                  </a:lnTo>
                  <a:moveTo>
                    <a:pt x="1215" y="0"/>
                  </a:moveTo>
                  <a:lnTo>
                    <a:pt x="1215" y="34"/>
                  </a:lnTo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228" name="Rectangle 203"/>
            <p:cNvSpPr>
              <a:spLocks noChangeArrowheads="1"/>
            </p:cNvSpPr>
            <p:nvPr/>
          </p:nvSpPr>
          <p:spPr bwMode="auto">
            <a:xfrm>
              <a:off x="3783013" y="4467225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el-GR" altLang="el-GR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9" name="Rectangle 204"/>
            <p:cNvSpPr>
              <a:spLocks noChangeArrowheads="1"/>
            </p:cNvSpPr>
            <p:nvPr/>
          </p:nvSpPr>
          <p:spPr bwMode="auto">
            <a:xfrm>
              <a:off x="3729038" y="4213225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</a:t>
              </a:r>
              <a:endParaRPr kumimoji="0" lang="el-GR" altLang="el-GR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0" name="Rectangle 205"/>
            <p:cNvSpPr>
              <a:spLocks noChangeArrowheads="1"/>
            </p:cNvSpPr>
            <p:nvPr/>
          </p:nvSpPr>
          <p:spPr bwMode="auto">
            <a:xfrm>
              <a:off x="3729038" y="3952875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0</a:t>
              </a:r>
              <a:endParaRPr kumimoji="0" lang="el-GR" altLang="el-GR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1" name="Rectangle 206"/>
            <p:cNvSpPr>
              <a:spLocks noChangeArrowheads="1"/>
            </p:cNvSpPr>
            <p:nvPr/>
          </p:nvSpPr>
          <p:spPr bwMode="auto">
            <a:xfrm>
              <a:off x="3729038" y="3697288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0</a:t>
              </a:r>
              <a:endParaRPr kumimoji="0" lang="el-GR" altLang="el-GR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2" name="Rectangle 207"/>
            <p:cNvSpPr>
              <a:spLocks noChangeArrowheads="1"/>
            </p:cNvSpPr>
            <p:nvPr/>
          </p:nvSpPr>
          <p:spPr bwMode="auto">
            <a:xfrm>
              <a:off x="3729038" y="3436938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0</a:t>
              </a:r>
              <a:endParaRPr kumimoji="0" lang="el-GR" altLang="el-GR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3" name="Rectangle 208"/>
            <p:cNvSpPr>
              <a:spLocks noChangeArrowheads="1"/>
            </p:cNvSpPr>
            <p:nvPr/>
          </p:nvSpPr>
          <p:spPr bwMode="auto">
            <a:xfrm>
              <a:off x="3676650" y="3182938"/>
              <a:ext cx="17312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</a:t>
              </a:r>
              <a:endParaRPr kumimoji="0" lang="el-GR" altLang="el-GR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4" name="Freeform 209"/>
            <p:cNvSpPr>
              <a:spLocks noEditPoints="1"/>
            </p:cNvSpPr>
            <p:nvPr/>
          </p:nvSpPr>
          <p:spPr bwMode="auto">
            <a:xfrm>
              <a:off x="3852863" y="3235325"/>
              <a:ext cx="53975" cy="1296987"/>
            </a:xfrm>
            <a:custGeom>
              <a:avLst/>
              <a:gdLst>
                <a:gd name="T0" fmla="*/ 34 w 34"/>
                <a:gd name="T1" fmla="*/ 817 h 817"/>
                <a:gd name="T2" fmla="*/ 34 w 34"/>
                <a:gd name="T3" fmla="*/ 0 h 817"/>
                <a:gd name="T4" fmla="*/ 34 w 34"/>
                <a:gd name="T5" fmla="*/ 813 h 817"/>
                <a:gd name="T6" fmla="*/ 0 w 34"/>
                <a:gd name="T7" fmla="*/ 813 h 817"/>
                <a:gd name="T8" fmla="*/ 34 w 34"/>
                <a:gd name="T9" fmla="*/ 651 h 817"/>
                <a:gd name="T10" fmla="*/ 0 w 34"/>
                <a:gd name="T11" fmla="*/ 651 h 817"/>
                <a:gd name="T12" fmla="*/ 34 w 34"/>
                <a:gd name="T13" fmla="*/ 489 h 817"/>
                <a:gd name="T14" fmla="*/ 0 w 34"/>
                <a:gd name="T15" fmla="*/ 489 h 817"/>
                <a:gd name="T16" fmla="*/ 34 w 34"/>
                <a:gd name="T17" fmla="*/ 327 h 817"/>
                <a:gd name="T18" fmla="*/ 0 w 34"/>
                <a:gd name="T19" fmla="*/ 327 h 817"/>
                <a:gd name="T20" fmla="*/ 34 w 34"/>
                <a:gd name="T21" fmla="*/ 166 h 817"/>
                <a:gd name="T22" fmla="*/ 0 w 34"/>
                <a:gd name="T23" fmla="*/ 166 h 817"/>
                <a:gd name="T24" fmla="*/ 34 w 34"/>
                <a:gd name="T25" fmla="*/ 4 h 817"/>
                <a:gd name="T26" fmla="*/ 0 w 34"/>
                <a:gd name="T27" fmla="*/ 4 h 8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34" h="817">
                  <a:moveTo>
                    <a:pt x="34" y="817"/>
                  </a:moveTo>
                  <a:lnTo>
                    <a:pt x="34" y="0"/>
                  </a:lnTo>
                  <a:moveTo>
                    <a:pt x="34" y="813"/>
                  </a:moveTo>
                  <a:lnTo>
                    <a:pt x="0" y="813"/>
                  </a:lnTo>
                  <a:moveTo>
                    <a:pt x="34" y="651"/>
                  </a:moveTo>
                  <a:lnTo>
                    <a:pt x="0" y="651"/>
                  </a:lnTo>
                  <a:moveTo>
                    <a:pt x="34" y="489"/>
                  </a:moveTo>
                  <a:lnTo>
                    <a:pt x="0" y="489"/>
                  </a:lnTo>
                  <a:moveTo>
                    <a:pt x="34" y="327"/>
                  </a:moveTo>
                  <a:lnTo>
                    <a:pt x="0" y="327"/>
                  </a:lnTo>
                  <a:moveTo>
                    <a:pt x="34" y="166"/>
                  </a:moveTo>
                  <a:lnTo>
                    <a:pt x="0" y="166"/>
                  </a:lnTo>
                  <a:moveTo>
                    <a:pt x="34" y="4"/>
                  </a:moveTo>
                  <a:lnTo>
                    <a:pt x="0" y="4"/>
                  </a:lnTo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235" name="Freeform 210"/>
            <p:cNvSpPr>
              <a:spLocks noEditPoints="1"/>
            </p:cNvSpPr>
            <p:nvPr/>
          </p:nvSpPr>
          <p:spPr bwMode="auto">
            <a:xfrm>
              <a:off x="3906838" y="3232150"/>
              <a:ext cx="1365250" cy="1301750"/>
            </a:xfrm>
            <a:custGeom>
              <a:avLst/>
              <a:gdLst>
                <a:gd name="T0" fmla="*/ 92 w 3273"/>
                <a:gd name="T1" fmla="*/ 46 h 3114"/>
                <a:gd name="T2" fmla="*/ 261 w 3273"/>
                <a:gd name="T3" fmla="*/ 0 h 3114"/>
                <a:gd name="T4" fmla="*/ 207 w 3273"/>
                <a:gd name="T5" fmla="*/ 23 h 3114"/>
                <a:gd name="T6" fmla="*/ 345 w 3273"/>
                <a:gd name="T7" fmla="*/ 23 h 3114"/>
                <a:gd name="T8" fmla="*/ 261 w 3273"/>
                <a:gd name="T9" fmla="*/ 0 h 3114"/>
                <a:gd name="T10" fmla="*/ 525 w 3273"/>
                <a:gd name="T11" fmla="*/ 46 h 3114"/>
                <a:gd name="T12" fmla="*/ 525 w 3273"/>
                <a:gd name="T13" fmla="*/ 0 h 3114"/>
                <a:gd name="T14" fmla="*/ 525 w 3273"/>
                <a:gd name="T15" fmla="*/ 46 h 3114"/>
                <a:gd name="T16" fmla="*/ 783 w 3273"/>
                <a:gd name="T17" fmla="*/ 0 h 3114"/>
                <a:gd name="T18" fmla="*/ 668 w 3273"/>
                <a:gd name="T19" fmla="*/ 23 h 3114"/>
                <a:gd name="T20" fmla="*/ 1032 w 3273"/>
                <a:gd name="T21" fmla="*/ 71 h 3114"/>
                <a:gd name="T22" fmla="*/ 923 w 3273"/>
                <a:gd name="T23" fmla="*/ 26 h 3114"/>
                <a:gd name="T24" fmla="*/ 1168 w 3273"/>
                <a:gd name="T25" fmla="*/ 195 h 3114"/>
                <a:gd name="T26" fmla="*/ 1194 w 3273"/>
                <a:gd name="T27" fmla="*/ 157 h 3114"/>
                <a:gd name="T28" fmla="*/ 1171 w 3273"/>
                <a:gd name="T29" fmla="*/ 197 h 3114"/>
                <a:gd name="T30" fmla="*/ 1380 w 3273"/>
                <a:gd name="T31" fmla="*/ 331 h 3114"/>
                <a:gd name="T32" fmla="*/ 1308 w 3273"/>
                <a:gd name="T33" fmla="*/ 238 h 3114"/>
                <a:gd name="T34" fmla="*/ 1456 w 3273"/>
                <a:gd name="T35" fmla="*/ 538 h 3114"/>
                <a:gd name="T36" fmla="*/ 1441 w 3273"/>
                <a:gd name="T37" fmla="*/ 455 h 3114"/>
                <a:gd name="T38" fmla="*/ 1450 w 3273"/>
                <a:gd name="T39" fmla="*/ 558 h 3114"/>
                <a:gd name="T40" fmla="*/ 1575 w 3273"/>
                <a:gd name="T41" fmla="*/ 635 h 3114"/>
                <a:gd name="T42" fmla="*/ 1539 w 3273"/>
                <a:gd name="T43" fmla="*/ 664 h 3114"/>
                <a:gd name="T44" fmla="*/ 1625 w 3273"/>
                <a:gd name="T45" fmla="*/ 717 h 3114"/>
                <a:gd name="T46" fmla="*/ 1569 w 3273"/>
                <a:gd name="T47" fmla="*/ 656 h 3114"/>
                <a:gd name="T48" fmla="*/ 1717 w 3273"/>
                <a:gd name="T49" fmla="*/ 955 h 3114"/>
                <a:gd name="T50" fmla="*/ 1687 w 3273"/>
                <a:gd name="T51" fmla="*/ 841 h 3114"/>
                <a:gd name="T52" fmla="*/ 1826 w 3273"/>
                <a:gd name="T53" fmla="*/ 1094 h 3114"/>
                <a:gd name="T54" fmla="*/ 1862 w 3273"/>
                <a:gd name="T55" fmla="*/ 1065 h 3114"/>
                <a:gd name="T56" fmla="*/ 1824 w 3273"/>
                <a:gd name="T57" fmla="*/ 1091 h 3114"/>
                <a:gd name="T58" fmla="*/ 1993 w 3273"/>
                <a:gd name="T59" fmla="*/ 1257 h 3114"/>
                <a:gd name="T60" fmla="*/ 1926 w 3273"/>
                <a:gd name="T61" fmla="*/ 1200 h 3114"/>
                <a:gd name="T62" fmla="*/ 1992 w 3273"/>
                <a:gd name="T63" fmla="*/ 1320 h 3114"/>
                <a:gd name="T64" fmla="*/ 1995 w 3273"/>
                <a:gd name="T65" fmla="*/ 1262 h 3114"/>
                <a:gd name="T66" fmla="*/ 2040 w 3273"/>
                <a:gd name="T67" fmla="*/ 1523 h 3114"/>
                <a:gd name="T68" fmla="*/ 2131 w 3273"/>
                <a:gd name="T69" fmla="*/ 1638 h 3114"/>
                <a:gd name="T70" fmla="*/ 2087 w 3273"/>
                <a:gd name="T71" fmla="*/ 1653 h 3114"/>
                <a:gd name="T72" fmla="*/ 2236 w 3273"/>
                <a:gd name="T73" fmla="*/ 1943 h 3114"/>
                <a:gd name="T74" fmla="*/ 2176 w 3273"/>
                <a:gd name="T75" fmla="*/ 1841 h 3114"/>
                <a:gd name="T76" fmla="*/ 2339 w 3273"/>
                <a:gd name="T77" fmla="*/ 2169 h 3114"/>
                <a:gd name="T78" fmla="*/ 2294 w 3273"/>
                <a:gd name="T79" fmla="*/ 2060 h 3114"/>
                <a:gd name="T80" fmla="*/ 2437 w 3273"/>
                <a:gd name="T81" fmla="*/ 2353 h 3114"/>
                <a:gd name="T82" fmla="*/ 2549 w 3273"/>
                <a:gd name="T83" fmla="*/ 2447 h 3114"/>
                <a:gd name="T84" fmla="*/ 2508 w 3273"/>
                <a:gd name="T85" fmla="*/ 2468 h 3114"/>
                <a:gd name="T86" fmla="*/ 2712 w 3273"/>
                <a:gd name="T87" fmla="*/ 2718 h 3114"/>
                <a:gd name="T88" fmla="*/ 2622 w 3273"/>
                <a:gd name="T89" fmla="*/ 2643 h 3114"/>
                <a:gd name="T90" fmla="*/ 2884 w 3273"/>
                <a:gd name="T91" fmla="*/ 2895 h 3114"/>
                <a:gd name="T92" fmla="*/ 2799 w 3273"/>
                <a:gd name="T93" fmla="*/ 2814 h 3114"/>
                <a:gd name="T94" fmla="*/ 3013 w 3273"/>
                <a:gd name="T95" fmla="*/ 3005 h 3114"/>
                <a:gd name="T96" fmla="*/ 3038 w 3273"/>
                <a:gd name="T97" fmla="*/ 2966 h 3114"/>
                <a:gd name="T98" fmla="*/ 3013 w 3273"/>
                <a:gd name="T99" fmla="*/ 3005 h 3114"/>
                <a:gd name="T100" fmla="*/ 3273 w 3273"/>
                <a:gd name="T101" fmla="*/ 3069 h 3114"/>
                <a:gd name="T102" fmla="*/ 3183 w 3273"/>
                <a:gd name="T103" fmla="*/ 3051 h 31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</a:cxnLst>
              <a:rect l="0" t="0" r="r" b="b"/>
              <a:pathLst>
                <a:path w="3273" h="3114">
                  <a:moveTo>
                    <a:pt x="0" y="0"/>
                  </a:moveTo>
                  <a:lnTo>
                    <a:pt x="92" y="0"/>
                  </a:lnTo>
                  <a:cubicBezTo>
                    <a:pt x="105" y="0"/>
                    <a:pt x="115" y="11"/>
                    <a:pt x="115" y="23"/>
                  </a:cubicBezTo>
                  <a:cubicBezTo>
                    <a:pt x="115" y="36"/>
                    <a:pt x="105" y="46"/>
                    <a:pt x="92" y="46"/>
                  </a:cubicBezTo>
                  <a:lnTo>
                    <a:pt x="0" y="46"/>
                  </a:lnTo>
                  <a:lnTo>
                    <a:pt x="0" y="0"/>
                  </a:lnTo>
                  <a:close/>
                  <a:moveTo>
                    <a:pt x="230" y="0"/>
                  </a:moveTo>
                  <a:lnTo>
                    <a:pt x="261" y="0"/>
                  </a:lnTo>
                  <a:cubicBezTo>
                    <a:pt x="274" y="0"/>
                    <a:pt x="284" y="11"/>
                    <a:pt x="284" y="23"/>
                  </a:cubicBezTo>
                  <a:cubicBezTo>
                    <a:pt x="284" y="36"/>
                    <a:pt x="274" y="46"/>
                    <a:pt x="261" y="46"/>
                  </a:cubicBezTo>
                  <a:lnTo>
                    <a:pt x="230" y="46"/>
                  </a:lnTo>
                  <a:cubicBezTo>
                    <a:pt x="217" y="46"/>
                    <a:pt x="207" y="36"/>
                    <a:pt x="207" y="23"/>
                  </a:cubicBezTo>
                  <a:cubicBezTo>
                    <a:pt x="207" y="11"/>
                    <a:pt x="217" y="0"/>
                    <a:pt x="230" y="0"/>
                  </a:cubicBezTo>
                  <a:close/>
                  <a:moveTo>
                    <a:pt x="261" y="0"/>
                  </a:moveTo>
                  <a:lnTo>
                    <a:pt x="322" y="0"/>
                  </a:lnTo>
                  <a:cubicBezTo>
                    <a:pt x="335" y="0"/>
                    <a:pt x="345" y="11"/>
                    <a:pt x="345" y="23"/>
                  </a:cubicBezTo>
                  <a:cubicBezTo>
                    <a:pt x="345" y="36"/>
                    <a:pt x="335" y="46"/>
                    <a:pt x="322" y="46"/>
                  </a:cubicBezTo>
                  <a:lnTo>
                    <a:pt x="261" y="46"/>
                  </a:lnTo>
                  <a:cubicBezTo>
                    <a:pt x="248" y="46"/>
                    <a:pt x="238" y="36"/>
                    <a:pt x="238" y="23"/>
                  </a:cubicBezTo>
                  <a:cubicBezTo>
                    <a:pt x="238" y="11"/>
                    <a:pt x="248" y="0"/>
                    <a:pt x="261" y="0"/>
                  </a:cubicBezTo>
                  <a:close/>
                  <a:moveTo>
                    <a:pt x="461" y="0"/>
                  </a:moveTo>
                  <a:lnTo>
                    <a:pt x="525" y="0"/>
                  </a:lnTo>
                  <a:cubicBezTo>
                    <a:pt x="537" y="0"/>
                    <a:pt x="548" y="11"/>
                    <a:pt x="548" y="23"/>
                  </a:cubicBezTo>
                  <a:cubicBezTo>
                    <a:pt x="548" y="36"/>
                    <a:pt x="537" y="46"/>
                    <a:pt x="525" y="46"/>
                  </a:cubicBezTo>
                  <a:lnTo>
                    <a:pt x="461" y="46"/>
                  </a:lnTo>
                  <a:cubicBezTo>
                    <a:pt x="448" y="46"/>
                    <a:pt x="438" y="36"/>
                    <a:pt x="438" y="23"/>
                  </a:cubicBezTo>
                  <a:cubicBezTo>
                    <a:pt x="438" y="11"/>
                    <a:pt x="448" y="0"/>
                    <a:pt x="461" y="0"/>
                  </a:cubicBezTo>
                  <a:close/>
                  <a:moveTo>
                    <a:pt x="525" y="0"/>
                  </a:moveTo>
                  <a:lnTo>
                    <a:pt x="553" y="0"/>
                  </a:lnTo>
                  <a:cubicBezTo>
                    <a:pt x="565" y="0"/>
                    <a:pt x="576" y="11"/>
                    <a:pt x="576" y="23"/>
                  </a:cubicBezTo>
                  <a:cubicBezTo>
                    <a:pt x="576" y="36"/>
                    <a:pt x="565" y="46"/>
                    <a:pt x="553" y="46"/>
                  </a:cubicBezTo>
                  <a:lnTo>
                    <a:pt x="525" y="46"/>
                  </a:lnTo>
                  <a:cubicBezTo>
                    <a:pt x="512" y="46"/>
                    <a:pt x="502" y="36"/>
                    <a:pt x="502" y="23"/>
                  </a:cubicBezTo>
                  <a:cubicBezTo>
                    <a:pt x="502" y="11"/>
                    <a:pt x="512" y="0"/>
                    <a:pt x="525" y="0"/>
                  </a:cubicBezTo>
                  <a:close/>
                  <a:moveTo>
                    <a:pt x="691" y="0"/>
                  </a:moveTo>
                  <a:lnTo>
                    <a:pt x="783" y="0"/>
                  </a:lnTo>
                  <a:cubicBezTo>
                    <a:pt x="796" y="0"/>
                    <a:pt x="806" y="11"/>
                    <a:pt x="806" y="23"/>
                  </a:cubicBezTo>
                  <a:cubicBezTo>
                    <a:pt x="806" y="36"/>
                    <a:pt x="796" y="46"/>
                    <a:pt x="783" y="46"/>
                  </a:cubicBezTo>
                  <a:lnTo>
                    <a:pt x="691" y="46"/>
                  </a:lnTo>
                  <a:cubicBezTo>
                    <a:pt x="678" y="46"/>
                    <a:pt x="668" y="36"/>
                    <a:pt x="668" y="23"/>
                  </a:cubicBezTo>
                  <a:cubicBezTo>
                    <a:pt x="668" y="11"/>
                    <a:pt x="678" y="0"/>
                    <a:pt x="691" y="0"/>
                  </a:cubicBezTo>
                  <a:close/>
                  <a:moveTo>
                    <a:pt x="923" y="26"/>
                  </a:moveTo>
                  <a:lnTo>
                    <a:pt x="1014" y="44"/>
                  </a:lnTo>
                  <a:cubicBezTo>
                    <a:pt x="1026" y="46"/>
                    <a:pt x="1034" y="58"/>
                    <a:pt x="1032" y="71"/>
                  </a:cubicBezTo>
                  <a:cubicBezTo>
                    <a:pt x="1030" y="83"/>
                    <a:pt x="1018" y="91"/>
                    <a:pt x="1005" y="89"/>
                  </a:cubicBezTo>
                  <a:lnTo>
                    <a:pt x="915" y="71"/>
                  </a:lnTo>
                  <a:cubicBezTo>
                    <a:pt x="902" y="69"/>
                    <a:pt x="894" y="57"/>
                    <a:pt x="896" y="44"/>
                  </a:cubicBezTo>
                  <a:cubicBezTo>
                    <a:pt x="899" y="32"/>
                    <a:pt x="911" y="24"/>
                    <a:pt x="923" y="26"/>
                  </a:cubicBezTo>
                  <a:close/>
                  <a:moveTo>
                    <a:pt x="1141" y="115"/>
                  </a:moveTo>
                  <a:lnTo>
                    <a:pt x="1197" y="159"/>
                  </a:lnTo>
                  <a:cubicBezTo>
                    <a:pt x="1207" y="167"/>
                    <a:pt x="1208" y="181"/>
                    <a:pt x="1201" y="191"/>
                  </a:cubicBezTo>
                  <a:cubicBezTo>
                    <a:pt x="1193" y="201"/>
                    <a:pt x="1178" y="203"/>
                    <a:pt x="1168" y="195"/>
                  </a:cubicBezTo>
                  <a:lnTo>
                    <a:pt x="1112" y="151"/>
                  </a:lnTo>
                  <a:cubicBezTo>
                    <a:pt x="1102" y="143"/>
                    <a:pt x="1101" y="129"/>
                    <a:pt x="1109" y="119"/>
                  </a:cubicBezTo>
                  <a:cubicBezTo>
                    <a:pt x="1116" y="109"/>
                    <a:pt x="1131" y="107"/>
                    <a:pt x="1141" y="115"/>
                  </a:cubicBezTo>
                  <a:close/>
                  <a:moveTo>
                    <a:pt x="1194" y="157"/>
                  </a:moveTo>
                  <a:lnTo>
                    <a:pt x="1212" y="168"/>
                  </a:lnTo>
                  <a:cubicBezTo>
                    <a:pt x="1223" y="174"/>
                    <a:pt x="1227" y="188"/>
                    <a:pt x="1221" y="199"/>
                  </a:cubicBezTo>
                  <a:cubicBezTo>
                    <a:pt x="1214" y="210"/>
                    <a:pt x="1200" y="214"/>
                    <a:pt x="1189" y="207"/>
                  </a:cubicBezTo>
                  <a:lnTo>
                    <a:pt x="1171" y="197"/>
                  </a:lnTo>
                  <a:cubicBezTo>
                    <a:pt x="1160" y="191"/>
                    <a:pt x="1156" y="176"/>
                    <a:pt x="1163" y="165"/>
                  </a:cubicBezTo>
                  <a:cubicBezTo>
                    <a:pt x="1169" y="154"/>
                    <a:pt x="1183" y="151"/>
                    <a:pt x="1194" y="157"/>
                  </a:cubicBezTo>
                  <a:close/>
                  <a:moveTo>
                    <a:pt x="1339" y="249"/>
                  </a:moveTo>
                  <a:lnTo>
                    <a:pt x="1380" y="331"/>
                  </a:lnTo>
                  <a:cubicBezTo>
                    <a:pt x="1385" y="343"/>
                    <a:pt x="1381" y="356"/>
                    <a:pt x="1369" y="362"/>
                  </a:cubicBezTo>
                  <a:cubicBezTo>
                    <a:pt x="1358" y="368"/>
                    <a:pt x="1344" y="363"/>
                    <a:pt x="1338" y="352"/>
                  </a:cubicBezTo>
                  <a:lnTo>
                    <a:pt x="1298" y="269"/>
                  </a:lnTo>
                  <a:cubicBezTo>
                    <a:pt x="1292" y="258"/>
                    <a:pt x="1297" y="244"/>
                    <a:pt x="1308" y="238"/>
                  </a:cubicBezTo>
                  <a:cubicBezTo>
                    <a:pt x="1319" y="233"/>
                    <a:pt x="1333" y="237"/>
                    <a:pt x="1339" y="249"/>
                  </a:cubicBezTo>
                  <a:close/>
                  <a:moveTo>
                    <a:pt x="1441" y="455"/>
                  </a:moveTo>
                  <a:lnTo>
                    <a:pt x="1467" y="507"/>
                  </a:lnTo>
                  <a:cubicBezTo>
                    <a:pt x="1472" y="519"/>
                    <a:pt x="1468" y="532"/>
                    <a:pt x="1456" y="538"/>
                  </a:cubicBezTo>
                  <a:cubicBezTo>
                    <a:pt x="1445" y="544"/>
                    <a:pt x="1431" y="539"/>
                    <a:pt x="1426" y="528"/>
                  </a:cubicBezTo>
                  <a:lnTo>
                    <a:pt x="1400" y="476"/>
                  </a:lnTo>
                  <a:cubicBezTo>
                    <a:pt x="1394" y="464"/>
                    <a:pt x="1399" y="450"/>
                    <a:pt x="1410" y="445"/>
                  </a:cubicBezTo>
                  <a:cubicBezTo>
                    <a:pt x="1422" y="439"/>
                    <a:pt x="1435" y="444"/>
                    <a:pt x="1441" y="455"/>
                  </a:cubicBezTo>
                  <a:close/>
                  <a:moveTo>
                    <a:pt x="1464" y="503"/>
                  </a:moveTo>
                  <a:lnTo>
                    <a:pt x="1486" y="529"/>
                  </a:lnTo>
                  <a:cubicBezTo>
                    <a:pt x="1494" y="538"/>
                    <a:pt x="1493" y="553"/>
                    <a:pt x="1483" y="561"/>
                  </a:cubicBezTo>
                  <a:cubicBezTo>
                    <a:pt x="1473" y="569"/>
                    <a:pt x="1459" y="568"/>
                    <a:pt x="1450" y="558"/>
                  </a:cubicBezTo>
                  <a:lnTo>
                    <a:pt x="1429" y="532"/>
                  </a:lnTo>
                  <a:cubicBezTo>
                    <a:pt x="1420" y="522"/>
                    <a:pt x="1422" y="508"/>
                    <a:pt x="1431" y="500"/>
                  </a:cubicBezTo>
                  <a:cubicBezTo>
                    <a:pt x="1441" y="492"/>
                    <a:pt x="1456" y="493"/>
                    <a:pt x="1464" y="503"/>
                  </a:cubicBezTo>
                  <a:close/>
                  <a:moveTo>
                    <a:pt x="1575" y="635"/>
                  </a:moveTo>
                  <a:lnTo>
                    <a:pt x="1597" y="661"/>
                  </a:lnTo>
                  <a:cubicBezTo>
                    <a:pt x="1605" y="671"/>
                    <a:pt x="1604" y="686"/>
                    <a:pt x="1594" y="694"/>
                  </a:cubicBezTo>
                  <a:cubicBezTo>
                    <a:pt x="1584" y="702"/>
                    <a:pt x="1570" y="701"/>
                    <a:pt x="1562" y="691"/>
                  </a:cubicBezTo>
                  <a:lnTo>
                    <a:pt x="1539" y="664"/>
                  </a:lnTo>
                  <a:cubicBezTo>
                    <a:pt x="1531" y="654"/>
                    <a:pt x="1532" y="640"/>
                    <a:pt x="1542" y="632"/>
                  </a:cubicBezTo>
                  <a:cubicBezTo>
                    <a:pt x="1552" y="624"/>
                    <a:pt x="1566" y="625"/>
                    <a:pt x="1575" y="635"/>
                  </a:cubicBezTo>
                  <a:close/>
                  <a:moveTo>
                    <a:pt x="1600" y="666"/>
                  </a:moveTo>
                  <a:lnTo>
                    <a:pt x="1625" y="717"/>
                  </a:lnTo>
                  <a:cubicBezTo>
                    <a:pt x="1631" y="729"/>
                    <a:pt x="1626" y="742"/>
                    <a:pt x="1615" y="748"/>
                  </a:cubicBezTo>
                  <a:cubicBezTo>
                    <a:pt x="1604" y="754"/>
                    <a:pt x="1590" y="749"/>
                    <a:pt x="1584" y="738"/>
                  </a:cubicBezTo>
                  <a:lnTo>
                    <a:pt x="1559" y="686"/>
                  </a:lnTo>
                  <a:cubicBezTo>
                    <a:pt x="1553" y="675"/>
                    <a:pt x="1558" y="661"/>
                    <a:pt x="1569" y="656"/>
                  </a:cubicBezTo>
                  <a:cubicBezTo>
                    <a:pt x="1580" y="650"/>
                    <a:pt x="1594" y="655"/>
                    <a:pt x="1600" y="666"/>
                  </a:cubicBezTo>
                  <a:close/>
                  <a:moveTo>
                    <a:pt x="1687" y="841"/>
                  </a:moveTo>
                  <a:lnTo>
                    <a:pt x="1728" y="924"/>
                  </a:lnTo>
                  <a:cubicBezTo>
                    <a:pt x="1733" y="935"/>
                    <a:pt x="1729" y="949"/>
                    <a:pt x="1717" y="955"/>
                  </a:cubicBezTo>
                  <a:cubicBezTo>
                    <a:pt x="1706" y="960"/>
                    <a:pt x="1692" y="956"/>
                    <a:pt x="1686" y="944"/>
                  </a:cubicBezTo>
                  <a:lnTo>
                    <a:pt x="1645" y="862"/>
                  </a:lnTo>
                  <a:cubicBezTo>
                    <a:pt x="1640" y="850"/>
                    <a:pt x="1644" y="836"/>
                    <a:pt x="1656" y="831"/>
                  </a:cubicBezTo>
                  <a:cubicBezTo>
                    <a:pt x="1667" y="825"/>
                    <a:pt x="1681" y="830"/>
                    <a:pt x="1687" y="841"/>
                  </a:cubicBezTo>
                  <a:close/>
                  <a:moveTo>
                    <a:pt x="1818" y="1019"/>
                  </a:moveTo>
                  <a:lnTo>
                    <a:pt x="1860" y="1062"/>
                  </a:lnTo>
                  <a:cubicBezTo>
                    <a:pt x="1868" y="1071"/>
                    <a:pt x="1868" y="1086"/>
                    <a:pt x="1859" y="1095"/>
                  </a:cubicBezTo>
                  <a:cubicBezTo>
                    <a:pt x="1850" y="1103"/>
                    <a:pt x="1835" y="1103"/>
                    <a:pt x="1826" y="1094"/>
                  </a:cubicBezTo>
                  <a:lnTo>
                    <a:pt x="1785" y="1051"/>
                  </a:lnTo>
                  <a:cubicBezTo>
                    <a:pt x="1776" y="1041"/>
                    <a:pt x="1776" y="1027"/>
                    <a:pt x="1785" y="1018"/>
                  </a:cubicBezTo>
                  <a:cubicBezTo>
                    <a:pt x="1794" y="1009"/>
                    <a:pt x="1809" y="1010"/>
                    <a:pt x="1818" y="1019"/>
                  </a:cubicBezTo>
                  <a:close/>
                  <a:moveTo>
                    <a:pt x="1862" y="1065"/>
                  </a:moveTo>
                  <a:lnTo>
                    <a:pt x="1880" y="1092"/>
                  </a:lnTo>
                  <a:cubicBezTo>
                    <a:pt x="1887" y="1102"/>
                    <a:pt x="1884" y="1116"/>
                    <a:pt x="1874" y="1124"/>
                  </a:cubicBezTo>
                  <a:cubicBezTo>
                    <a:pt x="1863" y="1131"/>
                    <a:pt x="1849" y="1128"/>
                    <a:pt x="1842" y="1117"/>
                  </a:cubicBezTo>
                  <a:lnTo>
                    <a:pt x="1824" y="1091"/>
                  </a:lnTo>
                  <a:cubicBezTo>
                    <a:pt x="1817" y="1081"/>
                    <a:pt x="1820" y="1066"/>
                    <a:pt x="1830" y="1059"/>
                  </a:cubicBezTo>
                  <a:cubicBezTo>
                    <a:pt x="1841" y="1052"/>
                    <a:pt x="1855" y="1055"/>
                    <a:pt x="1862" y="1065"/>
                  </a:cubicBezTo>
                  <a:close/>
                  <a:moveTo>
                    <a:pt x="1958" y="1206"/>
                  </a:moveTo>
                  <a:lnTo>
                    <a:pt x="1993" y="1257"/>
                  </a:lnTo>
                  <a:cubicBezTo>
                    <a:pt x="2000" y="1268"/>
                    <a:pt x="1997" y="1282"/>
                    <a:pt x="1987" y="1289"/>
                  </a:cubicBezTo>
                  <a:cubicBezTo>
                    <a:pt x="1976" y="1296"/>
                    <a:pt x="1962" y="1294"/>
                    <a:pt x="1954" y="1283"/>
                  </a:cubicBezTo>
                  <a:lnTo>
                    <a:pt x="1920" y="1232"/>
                  </a:lnTo>
                  <a:cubicBezTo>
                    <a:pt x="1912" y="1221"/>
                    <a:pt x="1915" y="1207"/>
                    <a:pt x="1926" y="1200"/>
                  </a:cubicBezTo>
                  <a:cubicBezTo>
                    <a:pt x="1936" y="1193"/>
                    <a:pt x="1951" y="1195"/>
                    <a:pt x="1958" y="1206"/>
                  </a:cubicBezTo>
                  <a:close/>
                  <a:moveTo>
                    <a:pt x="1995" y="1262"/>
                  </a:moveTo>
                  <a:lnTo>
                    <a:pt x="2005" y="1291"/>
                  </a:lnTo>
                  <a:cubicBezTo>
                    <a:pt x="2010" y="1303"/>
                    <a:pt x="2004" y="1316"/>
                    <a:pt x="1992" y="1320"/>
                  </a:cubicBezTo>
                  <a:cubicBezTo>
                    <a:pt x="1980" y="1324"/>
                    <a:pt x="1966" y="1318"/>
                    <a:pt x="1962" y="1306"/>
                  </a:cubicBezTo>
                  <a:lnTo>
                    <a:pt x="1952" y="1278"/>
                  </a:lnTo>
                  <a:cubicBezTo>
                    <a:pt x="1948" y="1266"/>
                    <a:pt x="1954" y="1253"/>
                    <a:pt x="1966" y="1248"/>
                  </a:cubicBezTo>
                  <a:cubicBezTo>
                    <a:pt x="1978" y="1244"/>
                    <a:pt x="1991" y="1250"/>
                    <a:pt x="1995" y="1262"/>
                  </a:cubicBezTo>
                  <a:close/>
                  <a:moveTo>
                    <a:pt x="2052" y="1421"/>
                  </a:moveTo>
                  <a:lnTo>
                    <a:pt x="2084" y="1507"/>
                  </a:lnTo>
                  <a:cubicBezTo>
                    <a:pt x="2088" y="1519"/>
                    <a:pt x="2082" y="1532"/>
                    <a:pt x="2070" y="1537"/>
                  </a:cubicBezTo>
                  <a:cubicBezTo>
                    <a:pt x="2058" y="1541"/>
                    <a:pt x="2045" y="1535"/>
                    <a:pt x="2040" y="1523"/>
                  </a:cubicBezTo>
                  <a:lnTo>
                    <a:pt x="2009" y="1436"/>
                  </a:lnTo>
                  <a:cubicBezTo>
                    <a:pt x="2005" y="1424"/>
                    <a:pt x="2011" y="1411"/>
                    <a:pt x="2023" y="1407"/>
                  </a:cubicBezTo>
                  <a:cubicBezTo>
                    <a:pt x="2035" y="1402"/>
                    <a:pt x="2048" y="1409"/>
                    <a:pt x="2052" y="1421"/>
                  </a:cubicBezTo>
                  <a:close/>
                  <a:moveTo>
                    <a:pt x="2131" y="1638"/>
                  </a:moveTo>
                  <a:lnTo>
                    <a:pt x="2161" y="1725"/>
                  </a:lnTo>
                  <a:cubicBezTo>
                    <a:pt x="2165" y="1737"/>
                    <a:pt x="2159" y="1750"/>
                    <a:pt x="2146" y="1754"/>
                  </a:cubicBezTo>
                  <a:cubicBezTo>
                    <a:pt x="2134" y="1758"/>
                    <a:pt x="2121" y="1752"/>
                    <a:pt x="2117" y="1740"/>
                  </a:cubicBezTo>
                  <a:lnTo>
                    <a:pt x="2087" y="1653"/>
                  </a:lnTo>
                  <a:cubicBezTo>
                    <a:pt x="2083" y="1641"/>
                    <a:pt x="2089" y="1628"/>
                    <a:pt x="2101" y="1623"/>
                  </a:cubicBezTo>
                  <a:cubicBezTo>
                    <a:pt x="2113" y="1619"/>
                    <a:pt x="2127" y="1626"/>
                    <a:pt x="2131" y="1638"/>
                  </a:cubicBezTo>
                  <a:close/>
                  <a:moveTo>
                    <a:pt x="2206" y="1855"/>
                  </a:moveTo>
                  <a:lnTo>
                    <a:pt x="2236" y="1943"/>
                  </a:lnTo>
                  <a:cubicBezTo>
                    <a:pt x="2240" y="1955"/>
                    <a:pt x="2234" y="1968"/>
                    <a:pt x="2221" y="1972"/>
                  </a:cubicBezTo>
                  <a:cubicBezTo>
                    <a:pt x="2209" y="1976"/>
                    <a:pt x="2196" y="1970"/>
                    <a:pt x="2192" y="1958"/>
                  </a:cubicBezTo>
                  <a:lnTo>
                    <a:pt x="2162" y="1870"/>
                  </a:lnTo>
                  <a:cubicBezTo>
                    <a:pt x="2158" y="1858"/>
                    <a:pt x="2164" y="1845"/>
                    <a:pt x="2176" y="1841"/>
                  </a:cubicBezTo>
                  <a:cubicBezTo>
                    <a:pt x="2189" y="1837"/>
                    <a:pt x="2202" y="1843"/>
                    <a:pt x="2206" y="1855"/>
                  </a:cubicBezTo>
                  <a:close/>
                  <a:moveTo>
                    <a:pt x="2294" y="2060"/>
                  </a:moveTo>
                  <a:lnTo>
                    <a:pt x="2345" y="2137"/>
                  </a:lnTo>
                  <a:cubicBezTo>
                    <a:pt x="2352" y="2147"/>
                    <a:pt x="2349" y="2162"/>
                    <a:pt x="2339" y="2169"/>
                  </a:cubicBezTo>
                  <a:cubicBezTo>
                    <a:pt x="2328" y="2176"/>
                    <a:pt x="2314" y="2173"/>
                    <a:pt x="2307" y="2163"/>
                  </a:cubicBezTo>
                  <a:lnTo>
                    <a:pt x="2255" y="2086"/>
                  </a:lnTo>
                  <a:cubicBezTo>
                    <a:pt x="2248" y="2075"/>
                    <a:pt x="2251" y="2061"/>
                    <a:pt x="2262" y="2054"/>
                  </a:cubicBezTo>
                  <a:cubicBezTo>
                    <a:pt x="2272" y="2047"/>
                    <a:pt x="2287" y="2050"/>
                    <a:pt x="2294" y="2060"/>
                  </a:cubicBezTo>
                  <a:close/>
                  <a:moveTo>
                    <a:pt x="2423" y="2251"/>
                  </a:moveTo>
                  <a:lnTo>
                    <a:pt x="2475" y="2327"/>
                  </a:lnTo>
                  <a:cubicBezTo>
                    <a:pt x="2482" y="2337"/>
                    <a:pt x="2480" y="2351"/>
                    <a:pt x="2469" y="2359"/>
                  </a:cubicBezTo>
                  <a:cubicBezTo>
                    <a:pt x="2459" y="2366"/>
                    <a:pt x="2445" y="2363"/>
                    <a:pt x="2437" y="2353"/>
                  </a:cubicBezTo>
                  <a:lnTo>
                    <a:pt x="2385" y="2277"/>
                  </a:lnTo>
                  <a:cubicBezTo>
                    <a:pt x="2377" y="2267"/>
                    <a:pt x="2380" y="2252"/>
                    <a:pt x="2391" y="2245"/>
                  </a:cubicBezTo>
                  <a:cubicBezTo>
                    <a:pt x="2401" y="2238"/>
                    <a:pt x="2415" y="2240"/>
                    <a:pt x="2423" y="2251"/>
                  </a:cubicBezTo>
                  <a:close/>
                  <a:moveTo>
                    <a:pt x="2549" y="2447"/>
                  </a:moveTo>
                  <a:lnTo>
                    <a:pt x="2591" y="2528"/>
                  </a:lnTo>
                  <a:cubicBezTo>
                    <a:pt x="2597" y="2540"/>
                    <a:pt x="2593" y="2553"/>
                    <a:pt x="2582" y="2559"/>
                  </a:cubicBezTo>
                  <a:cubicBezTo>
                    <a:pt x="2570" y="2565"/>
                    <a:pt x="2556" y="2561"/>
                    <a:pt x="2551" y="2550"/>
                  </a:cubicBezTo>
                  <a:lnTo>
                    <a:pt x="2508" y="2468"/>
                  </a:lnTo>
                  <a:cubicBezTo>
                    <a:pt x="2502" y="2457"/>
                    <a:pt x="2507" y="2443"/>
                    <a:pt x="2518" y="2437"/>
                  </a:cubicBezTo>
                  <a:cubicBezTo>
                    <a:pt x="2529" y="2431"/>
                    <a:pt x="2543" y="2435"/>
                    <a:pt x="2549" y="2447"/>
                  </a:cubicBezTo>
                  <a:close/>
                  <a:moveTo>
                    <a:pt x="2654" y="2646"/>
                  </a:moveTo>
                  <a:lnTo>
                    <a:pt x="2712" y="2718"/>
                  </a:lnTo>
                  <a:cubicBezTo>
                    <a:pt x="2720" y="2728"/>
                    <a:pt x="2719" y="2742"/>
                    <a:pt x="2709" y="2750"/>
                  </a:cubicBezTo>
                  <a:cubicBezTo>
                    <a:pt x="2699" y="2758"/>
                    <a:pt x="2684" y="2757"/>
                    <a:pt x="2676" y="2747"/>
                  </a:cubicBezTo>
                  <a:lnTo>
                    <a:pt x="2618" y="2675"/>
                  </a:lnTo>
                  <a:cubicBezTo>
                    <a:pt x="2610" y="2665"/>
                    <a:pt x="2612" y="2651"/>
                    <a:pt x="2622" y="2643"/>
                  </a:cubicBezTo>
                  <a:cubicBezTo>
                    <a:pt x="2631" y="2635"/>
                    <a:pt x="2646" y="2636"/>
                    <a:pt x="2654" y="2646"/>
                  </a:cubicBezTo>
                  <a:close/>
                  <a:moveTo>
                    <a:pt x="2799" y="2814"/>
                  </a:moveTo>
                  <a:lnTo>
                    <a:pt x="2877" y="2863"/>
                  </a:lnTo>
                  <a:cubicBezTo>
                    <a:pt x="2888" y="2870"/>
                    <a:pt x="2891" y="2884"/>
                    <a:pt x="2884" y="2895"/>
                  </a:cubicBezTo>
                  <a:cubicBezTo>
                    <a:pt x="2877" y="2906"/>
                    <a:pt x="2863" y="2909"/>
                    <a:pt x="2852" y="2902"/>
                  </a:cubicBezTo>
                  <a:lnTo>
                    <a:pt x="2775" y="2853"/>
                  </a:lnTo>
                  <a:cubicBezTo>
                    <a:pt x="2764" y="2846"/>
                    <a:pt x="2761" y="2832"/>
                    <a:pt x="2768" y="2821"/>
                  </a:cubicBezTo>
                  <a:cubicBezTo>
                    <a:pt x="2774" y="2810"/>
                    <a:pt x="2789" y="2807"/>
                    <a:pt x="2799" y="2814"/>
                  </a:cubicBezTo>
                  <a:close/>
                  <a:moveTo>
                    <a:pt x="2994" y="2938"/>
                  </a:moveTo>
                  <a:lnTo>
                    <a:pt x="3038" y="2966"/>
                  </a:lnTo>
                  <a:cubicBezTo>
                    <a:pt x="3049" y="2973"/>
                    <a:pt x="3052" y="2987"/>
                    <a:pt x="3045" y="2998"/>
                  </a:cubicBezTo>
                  <a:cubicBezTo>
                    <a:pt x="3038" y="3008"/>
                    <a:pt x="3024" y="3012"/>
                    <a:pt x="3013" y="3005"/>
                  </a:cubicBezTo>
                  <a:lnTo>
                    <a:pt x="2969" y="2976"/>
                  </a:lnTo>
                  <a:cubicBezTo>
                    <a:pt x="2958" y="2970"/>
                    <a:pt x="2955" y="2955"/>
                    <a:pt x="2962" y="2945"/>
                  </a:cubicBezTo>
                  <a:cubicBezTo>
                    <a:pt x="2969" y="2934"/>
                    <a:pt x="2983" y="2931"/>
                    <a:pt x="2994" y="2938"/>
                  </a:cubicBezTo>
                  <a:close/>
                  <a:moveTo>
                    <a:pt x="3038" y="2966"/>
                  </a:moveTo>
                  <a:lnTo>
                    <a:pt x="3071" y="2987"/>
                  </a:lnTo>
                  <a:cubicBezTo>
                    <a:pt x="3082" y="2994"/>
                    <a:pt x="3085" y="3008"/>
                    <a:pt x="3079" y="3019"/>
                  </a:cubicBezTo>
                  <a:cubicBezTo>
                    <a:pt x="3072" y="3030"/>
                    <a:pt x="3058" y="3033"/>
                    <a:pt x="3047" y="3026"/>
                  </a:cubicBezTo>
                  <a:lnTo>
                    <a:pt x="3013" y="3005"/>
                  </a:lnTo>
                  <a:cubicBezTo>
                    <a:pt x="3003" y="2998"/>
                    <a:pt x="2999" y="2984"/>
                    <a:pt x="3006" y="2973"/>
                  </a:cubicBezTo>
                  <a:cubicBezTo>
                    <a:pt x="3013" y="2962"/>
                    <a:pt x="3027" y="2959"/>
                    <a:pt x="3038" y="2966"/>
                  </a:cubicBezTo>
                  <a:close/>
                  <a:moveTo>
                    <a:pt x="3183" y="3051"/>
                  </a:moveTo>
                  <a:lnTo>
                    <a:pt x="3273" y="3069"/>
                  </a:lnTo>
                  <a:lnTo>
                    <a:pt x="3265" y="3114"/>
                  </a:lnTo>
                  <a:lnTo>
                    <a:pt x="3174" y="3096"/>
                  </a:lnTo>
                  <a:cubicBezTo>
                    <a:pt x="3162" y="3094"/>
                    <a:pt x="3154" y="3082"/>
                    <a:pt x="3156" y="3069"/>
                  </a:cubicBezTo>
                  <a:cubicBezTo>
                    <a:pt x="3158" y="3057"/>
                    <a:pt x="3171" y="3049"/>
                    <a:pt x="3183" y="3051"/>
                  </a:cubicBezTo>
                  <a:close/>
                </a:path>
              </a:pathLst>
            </a:custGeom>
            <a:solidFill>
              <a:srgbClr val="00C000"/>
            </a:solidFill>
            <a:ln w="1588" cap="flat">
              <a:solidFill>
                <a:srgbClr val="00C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236" name="Freeform 211"/>
            <p:cNvSpPr>
              <a:spLocks noEditPoints="1"/>
            </p:cNvSpPr>
            <p:nvPr/>
          </p:nvSpPr>
          <p:spPr bwMode="auto">
            <a:xfrm>
              <a:off x="3906838" y="3230563"/>
              <a:ext cx="1393825" cy="1300162"/>
            </a:xfrm>
            <a:custGeom>
              <a:avLst/>
              <a:gdLst>
                <a:gd name="T0" fmla="*/ 92 w 3339"/>
                <a:gd name="T1" fmla="*/ 48 h 3110"/>
                <a:gd name="T2" fmla="*/ 261 w 3339"/>
                <a:gd name="T3" fmla="*/ 2 h 3110"/>
                <a:gd name="T4" fmla="*/ 207 w 3339"/>
                <a:gd name="T5" fmla="*/ 25 h 3110"/>
                <a:gd name="T6" fmla="*/ 345 w 3339"/>
                <a:gd name="T7" fmla="*/ 25 h 3110"/>
                <a:gd name="T8" fmla="*/ 261 w 3339"/>
                <a:gd name="T9" fmla="*/ 2 h 3110"/>
                <a:gd name="T10" fmla="*/ 525 w 3339"/>
                <a:gd name="T11" fmla="*/ 48 h 3110"/>
                <a:gd name="T12" fmla="*/ 529 w 3339"/>
                <a:gd name="T13" fmla="*/ 3 h 3110"/>
                <a:gd name="T14" fmla="*/ 520 w 3339"/>
                <a:gd name="T15" fmla="*/ 48 h 3110"/>
                <a:gd name="T16" fmla="*/ 782 w 3339"/>
                <a:gd name="T17" fmla="*/ 57 h 3110"/>
                <a:gd name="T18" fmla="*/ 665 w 3339"/>
                <a:gd name="T19" fmla="*/ 55 h 3110"/>
                <a:gd name="T20" fmla="*/ 981 w 3339"/>
                <a:gd name="T21" fmla="*/ 228 h 3110"/>
                <a:gd name="T22" fmla="*/ 904 w 3339"/>
                <a:gd name="T23" fmla="*/ 140 h 3110"/>
                <a:gd name="T24" fmla="*/ 1152 w 3339"/>
                <a:gd name="T25" fmla="*/ 350 h 3110"/>
                <a:gd name="T26" fmla="*/ 1297 w 3339"/>
                <a:gd name="T27" fmla="*/ 361 h 3110"/>
                <a:gd name="T28" fmla="*/ 1279 w 3339"/>
                <a:gd name="T29" fmla="*/ 404 h 3110"/>
                <a:gd name="T30" fmla="*/ 1378 w 3339"/>
                <a:gd name="T31" fmla="*/ 419 h 3110"/>
                <a:gd name="T32" fmla="*/ 1299 w 3339"/>
                <a:gd name="T33" fmla="*/ 379 h 3110"/>
                <a:gd name="T34" fmla="*/ 1542 w 3339"/>
                <a:gd name="T35" fmla="*/ 615 h 3110"/>
                <a:gd name="T36" fmla="*/ 1480 w 3339"/>
                <a:gd name="T37" fmla="*/ 514 h 3110"/>
                <a:gd name="T38" fmla="*/ 1626 w 3339"/>
                <a:gd name="T39" fmla="*/ 802 h 3110"/>
                <a:gd name="T40" fmla="*/ 1728 w 3339"/>
                <a:gd name="T41" fmla="*/ 906 h 3110"/>
                <a:gd name="T42" fmla="*/ 1686 w 3339"/>
                <a:gd name="T43" fmla="*/ 926 h 3110"/>
                <a:gd name="T44" fmla="*/ 1768 w 3339"/>
                <a:gd name="T45" fmla="*/ 988 h 3110"/>
                <a:gd name="T46" fmla="*/ 1700 w 3339"/>
                <a:gd name="T47" fmla="*/ 901 h 3110"/>
                <a:gd name="T48" fmla="*/ 1853 w 3339"/>
                <a:gd name="T49" fmla="*/ 1213 h 3110"/>
                <a:gd name="T50" fmla="*/ 1829 w 3339"/>
                <a:gd name="T51" fmla="*/ 1112 h 3110"/>
                <a:gd name="T52" fmla="*/ 1829 w 3339"/>
                <a:gd name="T53" fmla="*/ 1216 h 3110"/>
                <a:gd name="T54" fmla="*/ 1935 w 3339"/>
                <a:gd name="T55" fmla="*/ 1316 h 3110"/>
                <a:gd name="T56" fmla="*/ 1895 w 3339"/>
                <a:gd name="T57" fmla="*/ 1338 h 3110"/>
                <a:gd name="T58" fmla="*/ 2098 w 3339"/>
                <a:gd name="T59" fmla="*/ 1593 h 3110"/>
                <a:gd name="T60" fmla="*/ 2018 w 3339"/>
                <a:gd name="T61" fmla="*/ 1507 h 3110"/>
                <a:gd name="T62" fmla="*/ 2170 w 3339"/>
                <a:gd name="T63" fmla="*/ 1840 h 3110"/>
                <a:gd name="T64" fmla="*/ 2155 w 3339"/>
                <a:gd name="T65" fmla="*/ 1724 h 3110"/>
                <a:gd name="T66" fmla="*/ 2214 w 3339"/>
                <a:gd name="T67" fmla="*/ 2044 h 3110"/>
                <a:gd name="T68" fmla="*/ 2321 w 3339"/>
                <a:gd name="T69" fmla="*/ 2148 h 3110"/>
                <a:gd name="T70" fmla="*/ 2281 w 3339"/>
                <a:gd name="T71" fmla="*/ 2169 h 3110"/>
                <a:gd name="T72" fmla="*/ 2505 w 3339"/>
                <a:gd name="T73" fmla="*/ 2404 h 3110"/>
                <a:gd name="T74" fmla="*/ 2411 w 3339"/>
                <a:gd name="T75" fmla="*/ 2333 h 3110"/>
                <a:gd name="T76" fmla="*/ 2624 w 3339"/>
                <a:gd name="T77" fmla="*/ 2632 h 3110"/>
                <a:gd name="T78" fmla="*/ 2583 w 3339"/>
                <a:gd name="T79" fmla="*/ 2522 h 3110"/>
                <a:gd name="T80" fmla="*/ 2695 w 3339"/>
                <a:gd name="T81" fmla="*/ 2828 h 3110"/>
                <a:gd name="T82" fmla="*/ 2798 w 3339"/>
                <a:gd name="T83" fmla="*/ 2905 h 3110"/>
                <a:gd name="T84" fmla="*/ 2783 w 3339"/>
                <a:gd name="T85" fmla="*/ 2949 h 3110"/>
                <a:gd name="T86" fmla="*/ 3033 w 3339"/>
                <a:gd name="T87" fmla="*/ 2986 h 3110"/>
                <a:gd name="T88" fmla="*/ 2986 w 3339"/>
                <a:gd name="T89" fmla="*/ 2994 h 3110"/>
                <a:gd name="T90" fmla="*/ 3113 w 3339"/>
                <a:gd name="T91" fmla="*/ 3048 h 3110"/>
                <a:gd name="T92" fmla="*/ 3035 w 3339"/>
                <a:gd name="T93" fmla="*/ 2987 h 3110"/>
                <a:gd name="T94" fmla="*/ 3313 w 3339"/>
                <a:gd name="T95" fmla="*/ 3109 h 31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</a:cxnLst>
              <a:rect l="0" t="0" r="r" b="b"/>
              <a:pathLst>
                <a:path w="3339" h="3110">
                  <a:moveTo>
                    <a:pt x="0" y="2"/>
                  </a:moveTo>
                  <a:lnTo>
                    <a:pt x="92" y="2"/>
                  </a:lnTo>
                  <a:cubicBezTo>
                    <a:pt x="105" y="2"/>
                    <a:pt x="115" y="13"/>
                    <a:pt x="115" y="25"/>
                  </a:cubicBezTo>
                  <a:cubicBezTo>
                    <a:pt x="115" y="38"/>
                    <a:pt x="105" y="48"/>
                    <a:pt x="92" y="48"/>
                  </a:cubicBezTo>
                  <a:lnTo>
                    <a:pt x="0" y="48"/>
                  </a:lnTo>
                  <a:lnTo>
                    <a:pt x="0" y="2"/>
                  </a:lnTo>
                  <a:close/>
                  <a:moveTo>
                    <a:pt x="230" y="2"/>
                  </a:moveTo>
                  <a:lnTo>
                    <a:pt x="261" y="2"/>
                  </a:lnTo>
                  <a:cubicBezTo>
                    <a:pt x="274" y="2"/>
                    <a:pt x="284" y="13"/>
                    <a:pt x="284" y="25"/>
                  </a:cubicBezTo>
                  <a:cubicBezTo>
                    <a:pt x="284" y="38"/>
                    <a:pt x="274" y="48"/>
                    <a:pt x="261" y="48"/>
                  </a:cubicBezTo>
                  <a:lnTo>
                    <a:pt x="230" y="48"/>
                  </a:lnTo>
                  <a:cubicBezTo>
                    <a:pt x="217" y="48"/>
                    <a:pt x="207" y="38"/>
                    <a:pt x="207" y="25"/>
                  </a:cubicBezTo>
                  <a:cubicBezTo>
                    <a:pt x="207" y="13"/>
                    <a:pt x="217" y="2"/>
                    <a:pt x="230" y="2"/>
                  </a:cubicBezTo>
                  <a:close/>
                  <a:moveTo>
                    <a:pt x="261" y="2"/>
                  </a:moveTo>
                  <a:lnTo>
                    <a:pt x="322" y="2"/>
                  </a:lnTo>
                  <a:cubicBezTo>
                    <a:pt x="335" y="2"/>
                    <a:pt x="345" y="13"/>
                    <a:pt x="345" y="25"/>
                  </a:cubicBezTo>
                  <a:cubicBezTo>
                    <a:pt x="345" y="38"/>
                    <a:pt x="335" y="48"/>
                    <a:pt x="322" y="48"/>
                  </a:cubicBezTo>
                  <a:lnTo>
                    <a:pt x="261" y="48"/>
                  </a:lnTo>
                  <a:cubicBezTo>
                    <a:pt x="248" y="48"/>
                    <a:pt x="238" y="38"/>
                    <a:pt x="238" y="25"/>
                  </a:cubicBezTo>
                  <a:cubicBezTo>
                    <a:pt x="238" y="13"/>
                    <a:pt x="248" y="2"/>
                    <a:pt x="261" y="2"/>
                  </a:cubicBezTo>
                  <a:close/>
                  <a:moveTo>
                    <a:pt x="461" y="2"/>
                  </a:moveTo>
                  <a:lnTo>
                    <a:pt x="525" y="2"/>
                  </a:lnTo>
                  <a:cubicBezTo>
                    <a:pt x="537" y="2"/>
                    <a:pt x="548" y="13"/>
                    <a:pt x="548" y="25"/>
                  </a:cubicBezTo>
                  <a:cubicBezTo>
                    <a:pt x="548" y="38"/>
                    <a:pt x="537" y="48"/>
                    <a:pt x="525" y="48"/>
                  </a:cubicBezTo>
                  <a:lnTo>
                    <a:pt x="461" y="48"/>
                  </a:lnTo>
                  <a:cubicBezTo>
                    <a:pt x="448" y="48"/>
                    <a:pt x="438" y="38"/>
                    <a:pt x="438" y="25"/>
                  </a:cubicBezTo>
                  <a:cubicBezTo>
                    <a:pt x="438" y="13"/>
                    <a:pt x="448" y="2"/>
                    <a:pt x="461" y="2"/>
                  </a:cubicBezTo>
                  <a:close/>
                  <a:moveTo>
                    <a:pt x="529" y="3"/>
                  </a:moveTo>
                  <a:lnTo>
                    <a:pt x="557" y="9"/>
                  </a:lnTo>
                  <a:cubicBezTo>
                    <a:pt x="569" y="11"/>
                    <a:pt x="577" y="23"/>
                    <a:pt x="575" y="36"/>
                  </a:cubicBezTo>
                  <a:cubicBezTo>
                    <a:pt x="572" y="48"/>
                    <a:pt x="560" y="56"/>
                    <a:pt x="547" y="54"/>
                  </a:cubicBezTo>
                  <a:lnTo>
                    <a:pt x="520" y="48"/>
                  </a:lnTo>
                  <a:cubicBezTo>
                    <a:pt x="507" y="45"/>
                    <a:pt x="499" y="33"/>
                    <a:pt x="502" y="21"/>
                  </a:cubicBezTo>
                  <a:cubicBezTo>
                    <a:pt x="505" y="8"/>
                    <a:pt x="517" y="0"/>
                    <a:pt x="529" y="3"/>
                  </a:cubicBezTo>
                  <a:close/>
                  <a:moveTo>
                    <a:pt x="692" y="37"/>
                  </a:moveTo>
                  <a:lnTo>
                    <a:pt x="782" y="57"/>
                  </a:lnTo>
                  <a:cubicBezTo>
                    <a:pt x="795" y="59"/>
                    <a:pt x="803" y="72"/>
                    <a:pt x="800" y="84"/>
                  </a:cubicBezTo>
                  <a:cubicBezTo>
                    <a:pt x="797" y="97"/>
                    <a:pt x="785" y="105"/>
                    <a:pt x="773" y="102"/>
                  </a:cubicBezTo>
                  <a:lnTo>
                    <a:pt x="683" y="82"/>
                  </a:lnTo>
                  <a:cubicBezTo>
                    <a:pt x="670" y="80"/>
                    <a:pt x="662" y="67"/>
                    <a:pt x="665" y="55"/>
                  </a:cubicBezTo>
                  <a:cubicBezTo>
                    <a:pt x="668" y="43"/>
                    <a:pt x="680" y="35"/>
                    <a:pt x="692" y="37"/>
                  </a:cubicBezTo>
                  <a:close/>
                  <a:moveTo>
                    <a:pt x="904" y="140"/>
                  </a:moveTo>
                  <a:lnTo>
                    <a:pt x="977" y="196"/>
                  </a:lnTo>
                  <a:cubicBezTo>
                    <a:pt x="987" y="203"/>
                    <a:pt x="989" y="218"/>
                    <a:pt x="981" y="228"/>
                  </a:cubicBezTo>
                  <a:cubicBezTo>
                    <a:pt x="974" y="238"/>
                    <a:pt x="959" y="240"/>
                    <a:pt x="949" y="232"/>
                  </a:cubicBezTo>
                  <a:lnTo>
                    <a:pt x="876" y="177"/>
                  </a:lnTo>
                  <a:cubicBezTo>
                    <a:pt x="866" y="169"/>
                    <a:pt x="864" y="155"/>
                    <a:pt x="871" y="145"/>
                  </a:cubicBezTo>
                  <a:cubicBezTo>
                    <a:pt x="879" y="134"/>
                    <a:pt x="893" y="132"/>
                    <a:pt x="904" y="140"/>
                  </a:cubicBezTo>
                  <a:close/>
                  <a:moveTo>
                    <a:pt x="1086" y="271"/>
                  </a:moveTo>
                  <a:lnTo>
                    <a:pt x="1170" y="307"/>
                  </a:lnTo>
                  <a:cubicBezTo>
                    <a:pt x="1182" y="312"/>
                    <a:pt x="1187" y="326"/>
                    <a:pt x="1182" y="338"/>
                  </a:cubicBezTo>
                  <a:cubicBezTo>
                    <a:pt x="1177" y="349"/>
                    <a:pt x="1164" y="355"/>
                    <a:pt x="1152" y="350"/>
                  </a:cubicBezTo>
                  <a:lnTo>
                    <a:pt x="1067" y="313"/>
                  </a:lnTo>
                  <a:cubicBezTo>
                    <a:pt x="1056" y="308"/>
                    <a:pt x="1050" y="295"/>
                    <a:pt x="1055" y="283"/>
                  </a:cubicBezTo>
                  <a:cubicBezTo>
                    <a:pt x="1060" y="271"/>
                    <a:pt x="1074" y="266"/>
                    <a:pt x="1086" y="271"/>
                  </a:cubicBezTo>
                  <a:close/>
                  <a:moveTo>
                    <a:pt x="1297" y="361"/>
                  </a:moveTo>
                  <a:lnTo>
                    <a:pt x="1325" y="373"/>
                  </a:lnTo>
                  <a:cubicBezTo>
                    <a:pt x="1336" y="378"/>
                    <a:pt x="1342" y="391"/>
                    <a:pt x="1337" y="403"/>
                  </a:cubicBezTo>
                  <a:cubicBezTo>
                    <a:pt x="1332" y="415"/>
                    <a:pt x="1318" y="420"/>
                    <a:pt x="1307" y="415"/>
                  </a:cubicBezTo>
                  <a:lnTo>
                    <a:pt x="1279" y="404"/>
                  </a:lnTo>
                  <a:cubicBezTo>
                    <a:pt x="1268" y="399"/>
                    <a:pt x="1262" y="385"/>
                    <a:pt x="1267" y="374"/>
                  </a:cubicBezTo>
                  <a:cubicBezTo>
                    <a:pt x="1272" y="362"/>
                    <a:pt x="1286" y="356"/>
                    <a:pt x="1297" y="361"/>
                  </a:cubicBezTo>
                  <a:close/>
                  <a:moveTo>
                    <a:pt x="1331" y="377"/>
                  </a:moveTo>
                  <a:lnTo>
                    <a:pt x="1378" y="419"/>
                  </a:lnTo>
                  <a:cubicBezTo>
                    <a:pt x="1387" y="427"/>
                    <a:pt x="1388" y="442"/>
                    <a:pt x="1379" y="451"/>
                  </a:cubicBezTo>
                  <a:cubicBezTo>
                    <a:pt x="1371" y="461"/>
                    <a:pt x="1356" y="462"/>
                    <a:pt x="1347" y="453"/>
                  </a:cubicBezTo>
                  <a:lnTo>
                    <a:pt x="1300" y="411"/>
                  </a:lnTo>
                  <a:cubicBezTo>
                    <a:pt x="1291" y="403"/>
                    <a:pt x="1290" y="388"/>
                    <a:pt x="1299" y="379"/>
                  </a:cubicBezTo>
                  <a:cubicBezTo>
                    <a:pt x="1307" y="369"/>
                    <a:pt x="1322" y="368"/>
                    <a:pt x="1331" y="377"/>
                  </a:cubicBezTo>
                  <a:close/>
                  <a:moveTo>
                    <a:pt x="1480" y="514"/>
                  </a:moveTo>
                  <a:lnTo>
                    <a:pt x="1543" y="582"/>
                  </a:lnTo>
                  <a:cubicBezTo>
                    <a:pt x="1551" y="591"/>
                    <a:pt x="1551" y="606"/>
                    <a:pt x="1542" y="615"/>
                  </a:cubicBezTo>
                  <a:cubicBezTo>
                    <a:pt x="1532" y="623"/>
                    <a:pt x="1518" y="623"/>
                    <a:pt x="1509" y="613"/>
                  </a:cubicBezTo>
                  <a:lnTo>
                    <a:pt x="1446" y="546"/>
                  </a:lnTo>
                  <a:cubicBezTo>
                    <a:pt x="1438" y="536"/>
                    <a:pt x="1438" y="522"/>
                    <a:pt x="1448" y="513"/>
                  </a:cubicBezTo>
                  <a:cubicBezTo>
                    <a:pt x="1457" y="505"/>
                    <a:pt x="1471" y="505"/>
                    <a:pt x="1480" y="514"/>
                  </a:cubicBezTo>
                  <a:close/>
                  <a:moveTo>
                    <a:pt x="1626" y="699"/>
                  </a:moveTo>
                  <a:lnTo>
                    <a:pt x="1667" y="781"/>
                  </a:lnTo>
                  <a:cubicBezTo>
                    <a:pt x="1673" y="793"/>
                    <a:pt x="1668" y="807"/>
                    <a:pt x="1656" y="812"/>
                  </a:cubicBezTo>
                  <a:cubicBezTo>
                    <a:pt x="1645" y="818"/>
                    <a:pt x="1631" y="813"/>
                    <a:pt x="1626" y="802"/>
                  </a:cubicBezTo>
                  <a:lnTo>
                    <a:pt x="1585" y="719"/>
                  </a:lnTo>
                  <a:cubicBezTo>
                    <a:pt x="1579" y="708"/>
                    <a:pt x="1584" y="694"/>
                    <a:pt x="1596" y="688"/>
                  </a:cubicBezTo>
                  <a:cubicBezTo>
                    <a:pt x="1607" y="683"/>
                    <a:pt x="1621" y="687"/>
                    <a:pt x="1626" y="699"/>
                  </a:cubicBezTo>
                  <a:close/>
                  <a:moveTo>
                    <a:pt x="1728" y="906"/>
                  </a:moveTo>
                  <a:lnTo>
                    <a:pt x="1731" y="911"/>
                  </a:lnTo>
                  <a:cubicBezTo>
                    <a:pt x="1736" y="923"/>
                    <a:pt x="1731" y="936"/>
                    <a:pt x="1720" y="942"/>
                  </a:cubicBezTo>
                  <a:cubicBezTo>
                    <a:pt x="1709" y="948"/>
                    <a:pt x="1695" y="943"/>
                    <a:pt x="1689" y="931"/>
                  </a:cubicBezTo>
                  <a:lnTo>
                    <a:pt x="1686" y="926"/>
                  </a:lnTo>
                  <a:cubicBezTo>
                    <a:pt x="1681" y="914"/>
                    <a:pt x="1686" y="901"/>
                    <a:pt x="1697" y="895"/>
                  </a:cubicBezTo>
                  <a:cubicBezTo>
                    <a:pt x="1708" y="889"/>
                    <a:pt x="1722" y="894"/>
                    <a:pt x="1728" y="906"/>
                  </a:cubicBezTo>
                  <a:close/>
                  <a:moveTo>
                    <a:pt x="1731" y="911"/>
                  </a:moveTo>
                  <a:lnTo>
                    <a:pt x="1768" y="988"/>
                  </a:lnTo>
                  <a:cubicBezTo>
                    <a:pt x="1774" y="1000"/>
                    <a:pt x="1769" y="1014"/>
                    <a:pt x="1758" y="1019"/>
                  </a:cubicBezTo>
                  <a:cubicBezTo>
                    <a:pt x="1746" y="1025"/>
                    <a:pt x="1733" y="1020"/>
                    <a:pt x="1727" y="1009"/>
                  </a:cubicBezTo>
                  <a:lnTo>
                    <a:pt x="1689" y="931"/>
                  </a:lnTo>
                  <a:cubicBezTo>
                    <a:pt x="1684" y="920"/>
                    <a:pt x="1688" y="906"/>
                    <a:pt x="1700" y="901"/>
                  </a:cubicBezTo>
                  <a:cubicBezTo>
                    <a:pt x="1711" y="895"/>
                    <a:pt x="1725" y="900"/>
                    <a:pt x="1731" y="911"/>
                  </a:cubicBezTo>
                  <a:close/>
                  <a:moveTo>
                    <a:pt x="1829" y="1112"/>
                  </a:moveTo>
                  <a:lnTo>
                    <a:pt x="1864" y="1183"/>
                  </a:lnTo>
                  <a:cubicBezTo>
                    <a:pt x="1869" y="1194"/>
                    <a:pt x="1865" y="1208"/>
                    <a:pt x="1853" y="1213"/>
                  </a:cubicBezTo>
                  <a:cubicBezTo>
                    <a:pt x="1842" y="1219"/>
                    <a:pt x="1828" y="1214"/>
                    <a:pt x="1822" y="1203"/>
                  </a:cubicBezTo>
                  <a:lnTo>
                    <a:pt x="1788" y="1133"/>
                  </a:lnTo>
                  <a:cubicBezTo>
                    <a:pt x="1782" y="1121"/>
                    <a:pt x="1787" y="1107"/>
                    <a:pt x="1798" y="1102"/>
                  </a:cubicBezTo>
                  <a:cubicBezTo>
                    <a:pt x="1810" y="1096"/>
                    <a:pt x="1824" y="1101"/>
                    <a:pt x="1829" y="1112"/>
                  </a:cubicBezTo>
                  <a:close/>
                  <a:moveTo>
                    <a:pt x="1863" y="1182"/>
                  </a:moveTo>
                  <a:lnTo>
                    <a:pt x="1870" y="1194"/>
                  </a:lnTo>
                  <a:cubicBezTo>
                    <a:pt x="1876" y="1205"/>
                    <a:pt x="1872" y="1219"/>
                    <a:pt x="1861" y="1225"/>
                  </a:cubicBezTo>
                  <a:cubicBezTo>
                    <a:pt x="1849" y="1231"/>
                    <a:pt x="1835" y="1227"/>
                    <a:pt x="1829" y="1216"/>
                  </a:cubicBezTo>
                  <a:lnTo>
                    <a:pt x="1823" y="1204"/>
                  </a:lnTo>
                  <a:cubicBezTo>
                    <a:pt x="1817" y="1192"/>
                    <a:pt x="1821" y="1178"/>
                    <a:pt x="1832" y="1172"/>
                  </a:cubicBezTo>
                  <a:cubicBezTo>
                    <a:pt x="1843" y="1166"/>
                    <a:pt x="1857" y="1171"/>
                    <a:pt x="1863" y="1182"/>
                  </a:cubicBezTo>
                  <a:close/>
                  <a:moveTo>
                    <a:pt x="1935" y="1316"/>
                  </a:moveTo>
                  <a:lnTo>
                    <a:pt x="1979" y="1397"/>
                  </a:lnTo>
                  <a:cubicBezTo>
                    <a:pt x="1985" y="1408"/>
                    <a:pt x="1981" y="1422"/>
                    <a:pt x="1969" y="1428"/>
                  </a:cubicBezTo>
                  <a:cubicBezTo>
                    <a:pt x="1958" y="1434"/>
                    <a:pt x="1944" y="1430"/>
                    <a:pt x="1938" y="1419"/>
                  </a:cubicBezTo>
                  <a:lnTo>
                    <a:pt x="1895" y="1338"/>
                  </a:lnTo>
                  <a:cubicBezTo>
                    <a:pt x="1889" y="1327"/>
                    <a:pt x="1893" y="1313"/>
                    <a:pt x="1904" y="1307"/>
                  </a:cubicBezTo>
                  <a:cubicBezTo>
                    <a:pt x="1915" y="1301"/>
                    <a:pt x="1929" y="1305"/>
                    <a:pt x="1935" y="1316"/>
                  </a:cubicBezTo>
                  <a:close/>
                  <a:moveTo>
                    <a:pt x="2049" y="1514"/>
                  </a:moveTo>
                  <a:lnTo>
                    <a:pt x="2098" y="1593"/>
                  </a:lnTo>
                  <a:cubicBezTo>
                    <a:pt x="2105" y="1603"/>
                    <a:pt x="2101" y="1618"/>
                    <a:pt x="2091" y="1624"/>
                  </a:cubicBezTo>
                  <a:cubicBezTo>
                    <a:pt x="2080" y="1631"/>
                    <a:pt x="2066" y="1628"/>
                    <a:pt x="2059" y="1617"/>
                  </a:cubicBezTo>
                  <a:lnTo>
                    <a:pt x="2010" y="1539"/>
                  </a:lnTo>
                  <a:cubicBezTo>
                    <a:pt x="2004" y="1528"/>
                    <a:pt x="2007" y="1514"/>
                    <a:pt x="2018" y="1507"/>
                  </a:cubicBezTo>
                  <a:cubicBezTo>
                    <a:pt x="2028" y="1500"/>
                    <a:pt x="2043" y="1503"/>
                    <a:pt x="2049" y="1514"/>
                  </a:cubicBezTo>
                  <a:close/>
                  <a:moveTo>
                    <a:pt x="2155" y="1724"/>
                  </a:moveTo>
                  <a:lnTo>
                    <a:pt x="2184" y="1811"/>
                  </a:lnTo>
                  <a:cubicBezTo>
                    <a:pt x="2188" y="1823"/>
                    <a:pt x="2182" y="1836"/>
                    <a:pt x="2170" y="1840"/>
                  </a:cubicBezTo>
                  <a:cubicBezTo>
                    <a:pt x="2158" y="1844"/>
                    <a:pt x="2145" y="1838"/>
                    <a:pt x="2140" y="1826"/>
                  </a:cubicBezTo>
                  <a:lnTo>
                    <a:pt x="2111" y="1738"/>
                  </a:lnTo>
                  <a:cubicBezTo>
                    <a:pt x="2107" y="1726"/>
                    <a:pt x="2113" y="1713"/>
                    <a:pt x="2125" y="1709"/>
                  </a:cubicBezTo>
                  <a:cubicBezTo>
                    <a:pt x="2138" y="1705"/>
                    <a:pt x="2151" y="1711"/>
                    <a:pt x="2155" y="1724"/>
                  </a:cubicBezTo>
                  <a:close/>
                  <a:moveTo>
                    <a:pt x="2228" y="1942"/>
                  </a:moveTo>
                  <a:lnTo>
                    <a:pt x="2258" y="2029"/>
                  </a:lnTo>
                  <a:cubicBezTo>
                    <a:pt x="2262" y="2041"/>
                    <a:pt x="2255" y="2054"/>
                    <a:pt x="2243" y="2058"/>
                  </a:cubicBezTo>
                  <a:cubicBezTo>
                    <a:pt x="2231" y="2062"/>
                    <a:pt x="2218" y="2056"/>
                    <a:pt x="2214" y="2044"/>
                  </a:cubicBezTo>
                  <a:lnTo>
                    <a:pt x="2185" y="1957"/>
                  </a:lnTo>
                  <a:cubicBezTo>
                    <a:pt x="2181" y="1945"/>
                    <a:pt x="2187" y="1931"/>
                    <a:pt x="2199" y="1927"/>
                  </a:cubicBezTo>
                  <a:cubicBezTo>
                    <a:pt x="2211" y="1923"/>
                    <a:pt x="2224" y="1930"/>
                    <a:pt x="2228" y="1942"/>
                  </a:cubicBezTo>
                  <a:close/>
                  <a:moveTo>
                    <a:pt x="2321" y="2148"/>
                  </a:moveTo>
                  <a:lnTo>
                    <a:pt x="2365" y="2229"/>
                  </a:lnTo>
                  <a:cubicBezTo>
                    <a:pt x="2371" y="2240"/>
                    <a:pt x="2367" y="2254"/>
                    <a:pt x="2355" y="2260"/>
                  </a:cubicBezTo>
                  <a:cubicBezTo>
                    <a:pt x="2344" y="2266"/>
                    <a:pt x="2330" y="2262"/>
                    <a:pt x="2324" y="2251"/>
                  </a:cubicBezTo>
                  <a:lnTo>
                    <a:pt x="2281" y="2169"/>
                  </a:lnTo>
                  <a:cubicBezTo>
                    <a:pt x="2275" y="2158"/>
                    <a:pt x="2279" y="2144"/>
                    <a:pt x="2290" y="2138"/>
                  </a:cubicBezTo>
                  <a:cubicBezTo>
                    <a:pt x="2301" y="2132"/>
                    <a:pt x="2315" y="2136"/>
                    <a:pt x="2321" y="2148"/>
                  </a:cubicBezTo>
                  <a:close/>
                  <a:moveTo>
                    <a:pt x="2444" y="2335"/>
                  </a:moveTo>
                  <a:lnTo>
                    <a:pt x="2505" y="2404"/>
                  </a:lnTo>
                  <a:cubicBezTo>
                    <a:pt x="2513" y="2413"/>
                    <a:pt x="2512" y="2428"/>
                    <a:pt x="2503" y="2436"/>
                  </a:cubicBezTo>
                  <a:cubicBezTo>
                    <a:pt x="2493" y="2445"/>
                    <a:pt x="2479" y="2444"/>
                    <a:pt x="2470" y="2434"/>
                  </a:cubicBezTo>
                  <a:lnTo>
                    <a:pt x="2409" y="2365"/>
                  </a:lnTo>
                  <a:cubicBezTo>
                    <a:pt x="2401" y="2356"/>
                    <a:pt x="2402" y="2341"/>
                    <a:pt x="2411" y="2333"/>
                  </a:cubicBezTo>
                  <a:cubicBezTo>
                    <a:pt x="2421" y="2324"/>
                    <a:pt x="2435" y="2325"/>
                    <a:pt x="2444" y="2335"/>
                  </a:cubicBezTo>
                  <a:close/>
                  <a:moveTo>
                    <a:pt x="2583" y="2522"/>
                  </a:moveTo>
                  <a:lnTo>
                    <a:pt x="2631" y="2601"/>
                  </a:lnTo>
                  <a:cubicBezTo>
                    <a:pt x="2638" y="2611"/>
                    <a:pt x="2635" y="2626"/>
                    <a:pt x="2624" y="2632"/>
                  </a:cubicBezTo>
                  <a:cubicBezTo>
                    <a:pt x="2613" y="2639"/>
                    <a:pt x="2599" y="2636"/>
                    <a:pt x="2592" y="2625"/>
                  </a:cubicBezTo>
                  <a:lnTo>
                    <a:pt x="2544" y="2547"/>
                  </a:lnTo>
                  <a:cubicBezTo>
                    <a:pt x="2537" y="2536"/>
                    <a:pt x="2540" y="2522"/>
                    <a:pt x="2551" y="2515"/>
                  </a:cubicBezTo>
                  <a:cubicBezTo>
                    <a:pt x="2562" y="2508"/>
                    <a:pt x="2576" y="2511"/>
                    <a:pt x="2583" y="2522"/>
                  </a:cubicBezTo>
                  <a:close/>
                  <a:moveTo>
                    <a:pt x="2696" y="2725"/>
                  </a:moveTo>
                  <a:lnTo>
                    <a:pt x="2737" y="2808"/>
                  </a:lnTo>
                  <a:cubicBezTo>
                    <a:pt x="2742" y="2819"/>
                    <a:pt x="2737" y="2833"/>
                    <a:pt x="2726" y="2839"/>
                  </a:cubicBezTo>
                  <a:cubicBezTo>
                    <a:pt x="2715" y="2844"/>
                    <a:pt x="2701" y="2840"/>
                    <a:pt x="2695" y="2828"/>
                  </a:cubicBezTo>
                  <a:lnTo>
                    <a:pt x="2655" y="2745"/>
                  </a:lnTo>
                  <a:cubicBezTo>
                    <a:pt x="2649" y="2734"/>
                    <a:pt x="2654" y="2720"/>
                    <a:pt x="2666" y="2714"/>
                  </a:cubicBezTo>
                  <a:cubicBezTo>
                    <a:pt x="2677" y="2709"/>
                    <a:pt x="2691" y="2714"/>
                    <a:pt x="2696" y="2725"/>
                  </a:cubicBezTo>
                  <a:close/>
                  <a:moveTo>
                    <a:pt x="2798" y="2905"/>
                  </a:moveTo>
                  <a:lnTo>
                    <a:pt x="2885" y="2935"/>
                  </a:lnTo>
                  <a:cubicBezTo>
                    <a:pt x="2897" y="2939"/>
                    <a:pt x="2903" y="2952"/>
                    <a:pt x="2899" y="2964"/>
                  </a:cubicBezTo>
                  <a:cubicBezTo>
                    <a:pt x="2895" y="2976"/>
                    <a:pt x="2882" y="2983"/>
                    <a:pt x="2870" y="2979"/>
                  </a:cubicBezTo>
                  <a:lnTo>
                    <a:pt x="2783" y="2949"/>
                  </a:lnTo>
                  <a:cubicBezTo>
                    <a:pt x="2771" y="2945"/>
                    <a:pt x="2764" y="2931"/>
                    <a:pt x="2768" y="2919"/>
                  </a:cubicBezTo>
                  <a:cubicBezTo>
                    <a:pt x="2772" y="2907"/>
                    <a:pt x="2786" y="2901"/>
                    <a:pt x="2798" y="2905"/>
                  </a:cubicBezTo>
                  <a:close/>
                  <a:moveTo>
                    <a:pt x="3016" y="2980"/>
                  </a:moveTo>
                  <a:lnTo>
                    <a:pt x="3033" y="2986"/>
                  </a:lnTo>
                  <a:cubicBezTo>
                    <a:pt x="3045" y="2990"/>
                    <a:pt x="3052" y="3003"/>
                    <a:pt x="3047" y="3015"/>
                  </a:cubicBezTo>
                  <a:cubicBezTo>
                    <a:pt x="3043" y="3027"/>
                    <a:pt x="3030" y="3034"/>
                    <a:pt x="3018" y="3030"/>
                  </a:cubicBezTo>
                  <a:lnTo>
                    <a:pt x="3001" y="3023"/>
                  </a:lnTo>
                  <a:cubicBezTo>
                    <a:pt x="2989" y="3019"/>
                    <a:pt x="2982" y="3006"/>
                    <a:pt x="2986" y="2994"/>
                  </a:cubicBezTo>
                  <a:cubicBezTo>
                    <a:pt x="2990" y="2982"/>
                    <a:pt x="3003" y="2976"/>
                    <a:pt x="3016" y="2980"/>
                  </a:cubicBezTo>
                  <a:close/>
                  <a:moveTo>
                    <a:pt x="3035" y="2987"/>
                  </a:moveTo>
                  <a:lnTo>
                    <a:pt x="3102" y="3018"/>
                  </a:lnTo>
                  <a:cubicBezTo>
                    <a:pt x="3114" y="3023"/>
                    <a:pt x="3119" y="3037"/>
                    <a:pt x="3113" y="3048"/>
                  </a:cubicBezTo>
                  <a:cubicBezTo>
                    <a:pt x="3108" y="3060"/>
                    <a:pt x="3094" y="3065"/>
                    <a:pt x="3083" y="3059"/>
                  </a:cubicBezTo>
                  <a:lnTo>
                    <a:pt x="3016" y="3029"/>
                  </a:lnTo>
                  <a:cubicBezTo>
                    <a:pt x="3004" y="3023"/>
                    <a:pt x="2999" y="3010"/>
                    <a:pt x="3005" y="2998"/>
                  </a:cubicBezTo>
                  <a:cubicBezTo>
                    <a:pt x="3010" y="2987"/>
                    <a:pt x="3024" y="2981"/>
                    <a:pt x="3035" y="2987"/>
                  </a:cubicBezTo>
                  <a:close/>
                  <a:moveTo>
                    <a:pt x="3226" y="3053"/>
                  </a:moveTo>
                  <a:lnTo>
                    <a:pt x="3318" y="3063"/>
                  </a:lnTo>
                  <a:cubicBezTo>
                    <a:pt x="3330" y="3064"/>
                    <a:pt x="3339" y="3076"/>
                    <a:pt x="3338" y="3088"/>
                  </a:cubicBezTo>
                  <a:cubicBezTo>
                    <a:pt x="3337" y="3101"/>
                    <a:pt x="3325" y="3110"/>
                    <a:pt x="3313" y="3109"/>
                  </a:cubicBezTo>
                  <a:lnTo>
                    <a:pt x="3221" y="3099"/>
                  </a:lnTo>
                  <a:cubicBezTo>
                    <a:pt x="3208" y="3098"/>
                    <a:pt x="3199" y="3086"/>
                    <a:pt x="3201" y="3074"/>
                  </a:cubicBezTo>
                  <a:cubicBezTo>
                    <a:pt x="3202" y="3061"/>
                    <a:pt x="3213" y="3052"/>
                    <a:pt x="3226" y="3053"/>
                  </a:cubicBezTo>
                  <a:close/>
                </a:path>
              </a:pathLst>
            </a:custGeom>
            <a:solidFill>
              <a:srgbClr val="0000C0"/>
            </a:solidFill>
            <a:ln w="1588" cap="flat">
              <a:solidFill>
                <a:srgbClr val="0000C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237" name="Freeform 212"/>
            <p:cNvSpPr>
              <a:spLocks noEditPoints="1"/>
            </p:cNvSpPr>
            <p:nvPr/>
          </p:nvSpPr>
          <p:spPr bwMode="auto">
            <a:xfrm>
              <a:off x="3906838" y="3232150"/>
              <a:ext cx="1484313" cy="1303337"/>
            </a:xfrm>
            <a:custGeom>
              <a:avLst/>
              <a:gdLst>
                <a:gd name="T0" fmla="*/ 92 w 3557"/>
                <a:gd name="T1" fmla="*/ 46 h 3118"/>
                <a:gd name="T2" fmla="*/ 261 w 3557"/>
                <a:gd name="T3" fmla="*/ 0 h 3118"/>
                <a:gd name="T4" fmla="*/ 207 w 3557"/>
                <a:gd name="T5" fmla="*/ 23 h 3118"/>
                <a:gd name="T6" fmla="*/ 345 w 3557"/>
                <a:gd name="T7" fmla="*/ 23 h 3118"/>
                <a:gd name="T8" fmla="*/ 261 w 3557"/>
                <a:gd name="T9" fmla="*/ 0 h 3118"/>
                <a:gd name="T10" fmla="*/ 525 w 3557"/>
                <a:gd name="T11" fmla="*/ 46 h 3118"/>
                <a:gd name="T12" fmla="*/ 525 w 3557"/>
                <a:gd name="T13" fmla="*/ 0 h 3118"/>
                <a:gd name="T14" fmla="*/ 525 w 3557"/>
                <a:gd name="T15" fmla="*/ 46 h 3118"/>
                <a:gd name="T16" fmla="*/ 785 w 3557"/>
                <a:gd name="T17" fmla="*/ 22 h 3118"/>
                <a:gd name="T18" fmla="*/ 668 w 3557"/>
                <a:gd name="T19" fmla="*/ 25 h 3118"/>
                <a:gd name="T20" fmla="*/ 1010 w 3557"/>
                <a:gd name="T21" fmla="*/ 154 h 3118"/>
                <a:gd name="T22" fmla="*/ 916 w 3557"/>
                <a:gd name="T23" fmla="*/ 83 h 3118"/>
                <a:gd name="T24" fmla="*/ 1150 w 3557"/>
                <a:gd name="T25" fmla="*/ 303 h 3118"/>
                <a:gd name="T26" fmla="*/ 1301 w 3557"/>
                <a:gd name="T27" fmla="*/ 302 h 3118"/>
                <a:gd name="T28" fmla="*/ 1292 w 3557"/>
                <a:gd name="T29" fmla="*/ 347 h 3118"/>
                <a:gd name="T30" fmla="*/ 1362 w 3557"/>
                <a:gd name="T31" fmla="*/ 389 h 3118"/>
                <a:gd name="T32" fmla="*/ 1308 w 3557"/>
                <a:gd name="T33" fmla="*/ 306 h 3118"/>
                <a:gd name="T34" fmla="*/ 1424 w 3557"/>
                <a:gd name="T35" fmla="*/ 635 h 3118"/>
                <a:gd name="T36" fmla="*/ 1408 w 3557"/>
                <a:gd name="T37" fmla="*/ 519 h 3118"/>
                <a:gd name="T38" fmla="*/ 1511 w 3557"/>
                <a:gd name="T39" fmla="*/ 825 h 3118"/>
                <a:gd name="T40" fmla="*/ 1629 w 3557"/>
                <a:gd name="T41" fmla="*/ 911 h 3118"/>
                <a:gd name="T42" fmla="*/ 1591 w 3557"/>
                <a:gd name="T43" fmla="*/ 938 h 3118"/>
                <a:gd name="T44" fmla="*/ 1821 w 3557"/>
                <a:gd name="T45" fmla="*/ 1168 h 3118"/>
                <a:gd name="T46" fmla="*/ 1732 w 3557"/>
                <a:gd name="T47" fmla="*/ 1092 h 3118"/>
                <a:gd name="T48" fmla="*/ 1972 w 3557"/>
                <a:gd name="T49" fmla="*/ 1371 h 3118"/>
                <a:gd name="T50" fmla="*/ 1911 w 3557"/>
                <a:gd name="T51" fmla="*/ 1271 h 3118"/>
                <a:gd name="T52" fmla="*/ 2069 w 3557"/>
                <a:gd name="T53" fmla="*/ 1556 h 3118"/>
                <a:gd name="T54" fmla="*/ 2176 w 3557"/>
                <a:gd name="T55" fmla="*/ 1653 h 3118"/>
                <a:gd name="T56" fmla="*/ 2135 w 3557"/>
                <a:gd name="T57" fmla="*/ 1675 h 3118"/>
                <a:gd name="T58" fmla="*/ 2317 w 3557"/>
                <a:gd name="T59" fmla="*/ 1945 h 3118"/>
                <a:gd name="T60" fmla="*/ 2250 w 3557"/>
                <a:gd name="T61" fmla="*/ 1848 h 3118"/>
                <a:gd name="T62" fmla="*/ 2377 w 3557"/>
                <a:gd name="T63" fmla="*/ 2144 h 3118"/>
                <a:gd name="T64" fmla="*/ 2371 w 3557"/>
                <a:gd name="T65" fmla="*/ 2072 h 3118"/>
                <a:gd name="T66" fmla="*/ 2372 w 3557"/>
                <a:gd name="T67" fmla="*/ 2175 h 3118"/>
                <a:gd name="T68" fmla="*/ 2483 w 3557"/>
                <a:gd name="T69" fmla="*/ 2270 h 3118"/>
                <a:gd name="T70" fmla="*/ 2443 w 3557"/>
                <a:gd name="T71" fmla="*/ 2293 h 3118"/>
                <a:gd name="T72" fmla="*/ 2530 w 3557"/>
                <a:gd name="T73" fmla="*/ 2342 h 3118"/>
                <a:gd name="T74" fmla="*/ 2485 w 3557"/>
                <a:gd name="T75" fmla="*/ 2329 h 3118"/>
                <a:gd name="T76" fmla="*/ 2647 w 3557"/>
                <a:gd name="T77" fmla="*/ 2500 h 3118"/>
                <a:gd name="T78" fmla="*/ 2625 w 3557"/>
                <a:gd name="T79" fmla="*/ 2443 h 3118"/>
                <a:gd name="T80" fmla="*/ 2642 w 3557"/>
                <a:gd name="T81" fmla="*/ 2545 h 3118"/>
                <a:gd name="T82" fmla="*/ 2752 w 3557"/>
                <a:gd name="T83" fmla="*/ 2640 h 3118"/>
                <a:gd name="T84" fmla="*/ 2712 w 3557"/>
                <a:gd name="T85" fmla="*/ 2664 h 3118"/>
                <a:gd name="T86" fmla="*/ 2802 w 3557"/>
                <a:gd name="T87" fmla="*/ 2708 h 3118"/>
                <a:gd name="T88" fmla="*/ 2747 w 3557"/>
                <a:gd name="T89" fmla="*/ 2691 h 3118"/>
                <a:gd name="T90" fmla="*/ 2980 w 3557"/>
                <a:gd name="T91" fmla="*/ 2890 h 3118"/>
                <a:gd name="T92" fmla="*/ 2907 w 3557"/>
                <a:gd name="T93" fmla="*/ 2797 h 3118"/>
                <a:gd name="T94" fmla="*/ 3137 w 3557"/>
                <a:gd name="T95" fmla="*/ 3027 h 3118"/>
                <a:gd name="T96" fmla="*/ 3287 w 3557"/>
                <a:gd name="T97" fmla="*/ 3030 h 3118"/>
                <a:gd name="T98" fmla="*/ 3273 w 3557"/>
                <a:gd name="T99" fmla="*/ 3074 h 3118"/>
                <a:gd name="T100" fmla="*/ 3375 w 3557"/>
                <a:gd name="T101" fmla="*/ 3044 h 3118"/>
                <a:gd name="T102" fmla="*/ 3267 w 3557"/>
                <a:gd name="T103" fmla="*/ 3051 h 3118"/>
                <a:gd name="T104" fmla="*/ 3550 w 3557"/>
                <a:gd name="T105" fmla="*/ 3118 h 31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</a:cxnLst>
              <a:rect l="0" t="0" r="r" b="b"/>
              <a:pathLst>
                <a:path w="3557" h="3118">
                  <a:moveTo>
                    <a:pt x="0" y="0"/>
                  </a:moveTo>
                  <a:lnTo>
                    <a:pt x="92" y="0"/>
                  </a:lnTo>
                  <a:cubicBezTo>
                    <a:pt x="105" y="0"/>
                    <a:pt x="115" y="11"/>
                    <a:pt x="115" y="23"/>
                  </a:cubicBezTo>
                  <a:cubicBezTo>
                    <a:pt x="115" y="36"/>
                    <a:pt x="105" y="46"/>
                    <a:pt x="92" y="46"/>
                  </a:cubicBezTo>
                  <a:lnTo>
                    <a:pt x="0" y="46"/>
                  </a:lnTo>
                  <a:lnTo>
                    <a:pt x="0" y="0"/>
                  </a:lnTo>
                  <a:close/>
                  <a:moveTo>
                    <a:pt x="230" y="0"/>
                  </a:moveTo>
                  <a:lnTo>
                    <a:pt x="261" y="0"/>
                  </a:lnTo>
                  <a:cubicBezTo>
                    <a:pt x="274" y="0"/>
                    <a:pt x="284" y="11"/>
                    <a:pt x="284" y="23"/>
                  </a:cubicBezTo>
                  <a:cubicBezTo>
                    <a:pt x="284" y="36"/>
                    <a:pt x="274" y="46"/>
                    <a:pt x="261" y="46"/>
                  </a:cubicBezTo>
                  <a:lnTo>
                    <a:pt x="230" y="46"/>
                  </a:lnTo>
                  <a:cubicBezTo>
                    <a:pt x="217" y="46"/>
                    <a:pt x="207" y="36"/>
                    <a:pt x="207" y="23"/>
                  </a:cubicBezTo>
                  <a:cubicBezTo>
                    <a:pt x="207" y="11"/>
                    <a:pt x="217" y="0"/>
                    <a:pt x="230" y="0"/>
                  </a:cubicBezTo>
                  <a:close/>
                  <a:moveTo>
                    <a:pt x="261" y="0"/>
                  </a:moveTo>
                  <a:lnTo>
                    <a:pt x="322" y="0"/>
                  </a:lnTo>
                  <a:cubicBezTo>
                    <a:pt x="335" y="0"/>
                    <a:pt x="345" y="11"/>
                    <a:pt x="345" y="23"/>
                  </a:cubicBezTo>
                  <a:cubicBezTo>
                    <a:pt x="345" y="36"/>
                    <a:pt x="335" y="46"/>
                    <a:pt x="322" y="46"/>
                  </a:cubicBezTo>
                  <a:lnTo>
                    <a:pt x="261" y="46"/>
                  </a:lnTo>
                  <a:cubicBezTo>
                    <a:pt x="248" y="46"/>
                    <a:pt x="238" y="36"/>
                    <a:pt x="238" y="23"/>
                  </a:cubicBezTo>
                  <a:cubicBezTo>
                    <a:pt x="238" y="11"/>
                    <a:pt x="248" y="0"/>
                    <a:pt x="261" y="0"/>
                  </a:cubicBezTo>
                  <a:close/>
                  <a:moveTo>
                    <a:pt x="461" y="0"/>
                  </a:moveTo>
                  <a:lnTo>
                    <a:pt x="525" y="0"/>
                  </a:lnTo>
                  <a:cubicBezTo>
                    <a:pt x="537" y="0"/>
                    <a:pt x="548" y="11"/>
                    <a:pt x="548" y="23"/>
                  </a:cubicBezTo>
                  <a:cubicBezTo>
                    <a:pt x="548" y="36"/>
                    <a:pt x="537" y="46"/>
                    <a:pt x="525" y="46"/>
                  </a:cubicBezTo>
                  <a:lnTo>
                    <a:pt x="461" y="46"/>
                  </a:lnTo>
                  <a:cubicBezTo>
                    <a:pt x="448" y="46"/>
                    <a:pt x="438" y="36"/>
                    <a:pt x="438" y="23"/>
                  </a:cubicBezTo>
                  <a:cubicBezTo>
                    <a:pt x="438" y="11"/>
                    <a:pt x="448" y="0"/>
                    <a:pt x="461" y="0"/>
                  </a:cubicBezTo>
                  <a:close/>
                  <a:moveTo>
                    <a:pt x="525" y="0"/>
                  </a:moveTo>
                  <a:lnTo>
                    <a:pt x="553" y="0"/>
                  </a:lnTo>
                  <a:cubicBezTo>
                    <a:pt x="565" y="0"/>
                    <a:pt x="576" y="11"/>
                    <a:pt x="576" y="23"/>
                  </a:cubicBezTo>
                  <a:cubicBezTo>
                    <a:pt x="576" y="36"/>
                    <a:pt x="565" y="46"/>
                    <a:pt x="553" y="46"/>
                  </a:cubicBezTo>
                  <a:lnTo>
                    <a:pt x="525" y="46"/>
                  </a:lnTo>
                  <a:cubicBezTo>
                    <a:pt x="512" y="46"/>
                    <a:pt x="502" y="36"/>
                    <a:pt x="502" y="23"/>
                  </a:cubicBezTo>
                  <a:cubicBezTo>
                    <a:pt x="502" y="11"/>
                    <a:pt x="512" y="0"/>
                    <a:pt x="525" y="0"/>
                  </a:cubicBezTo>
                  <a:close/>
                  <a:moveTo>
                    <a:pt x="694" y="6"/>
                  </a:moveTo>
                  <a:lnTo>
                    <a:pt x="785" y="22"/>
                  </a:lnTo>
                  <a:cubicBezTo>
                    <a:pt x="798" y="25"/>
                    <a:pt x="806" y="37"/>
                    <a:pt x="804" y="49"/>
                  </a:cubicBezTo>
                  <a:cubicBezTo>
                    <a:pt x="802" y="62"/>
                    <a:pt x="790" y="70"/>
                    <a:pt x="777" y="68"/>
                  </a:cubicBezTo>
                  <a:lnTo>
                    <a:pt x="686" y="52"/>
                  </a:lnTo>
                  <a:cubicBezTo>
                    <a:pt x="674" y="50"/>
                    <a:pt x="666" y="38"/>
                    <a:pt x="668" y="25"/>
                  </a:cubicBezTo>
                  <a:cubicBezTo>
                    <a:pt x="670" y="13"/>
                    <a:pt x="682" y="4"/>
                    <a:pt x="694" y="6"/>
                  </a:cubicBezTo>
                  <a:close/>
                  <a:moveTo>
                    <a:pt x="916" y="83"/>
                  </a:moveTo>
                  <a:lnTo>
                    <a:pt x="999" y="123"/>
                  </a:lnTo>
                  <a:cubicBezTo>
                    <a:pt x="1011" y="129"/>
                    <a:pt x="1015" y="143"/>
                    <a:pt x="1010" y="154"/>
                  </a:cubicBezTo>
                  <a:cubicBezTo>
                    <a:pt x="1004" y="165"/>
                    <a:pt x="991" y="170"/>
                    <a:pt x="979" y="165"/>
                  </a:cubicBezTo>
                  <a:lnTo>
                    <a:pt x="896" y="124"/>
                  </a:lnTo>
                  <a:cubicBezTo>
                    <a:pt x="885" y="119"/>
                    <a:pt x="880" y="105"/>
                    <a:pt x="885" y="94"/>
                  </a:cubicBezTo>
                  <a:cubicBezTo>
                    <a:pt x="891" y="82"/>
                    <a:pt x="905" y="77"/>
                    <a:pt x="916" y="83"/>
                  </a:cubicBezTo>
                  <a:close/>
                  <a:moveTo>
                    <a:pt x="1117" y="206"/>
                  </a:moveTo>
                  <a:lnTo>
                    <a:pt x="1183" y="270"/>
                  </a:lnTo>
                  <a:cubicBezTo>
                    <a:pt x="1192" y="279"/>
                    <a:pt x="1192" y="294"/>
                    <a:pt x="1183" y="303"/>
                  </a:cubicBezTo>
                  <a:cubicBezTo>
                    <a:pt x="1174" y="312"/>
                    <a:pt x="1160" y="312"/>
                    <a:pt x="1150" y="303"/>
                  </a:cubicBezTo>
                  <a:lnTo>
                    <a:pt x="1085" y="239"/>
                  </a:lnTo>
                  <a:cubicBezTo>
                    <a:pt x="1076" y="230"/>
                    <a:pt x="1075" y="215"/>
                    <a:pt x="1084" y="206"/>
                  </a:cubicBezTo>
                  <a:cubicBezTo>
                    <a:pt x="1093" y="197"/>
                    <a:pt x="1108" y="197"/>
                    <a:pt x="1117" y="206"/>
                  </a:cubicBezTo>
                  <a:close/>
                  <a:moveTo>
                    <a:pt x="1301" y="302"/>
                  </a:moveTo>
                  <a:lnTo>
                    <a:pt x="1320" y="305"/>
                  </a:lnTo>
                  <a:cubicBezTo>
                    <a:pt x="1332" y="308"/>
                    <a:pt x="1341" y="320"/>
                    <a:pt x="1338" y="332"/>
                  </a:cubicBezTo>
                  <a:cubicBezTo>
                    <a:pt x="1336" y="345"/>
                    <a:pt x="1324" y="353"/>
                    <a:pt x="1311" y="351"/>
                  </a:cubicBezTo>
                  <a:lnTo>
                    <a:pt x="1292" y="347"/>
                  </a:lnTo>
                  <a:cubicBezTo>
                    <a:pt x="1280" y="345"/>
                    <a:pt x="1271" y="332"/>
                    <a:pt x="1274" y="320"/>
                  </a:cubicBezTo>
                  <a:cubicBezTo>
                    <a:pt x="1276" y="307"/>
                    <a:pt x="1288" y="299"/>
                    <a:pt x="1301" y="302"/>
                  </a:cubicBezTo>
                  <a:close/>
                  <a:moveTo>
                    <a:pt x="1337" y="320"/>
                  </a:moveTo>
                  <a:lnTo>
                    <a:pt x="1362" y="389"/>
                  </a:lnTo>
                  <a:cubicBezTo>
                    <a:pt x="1366" y="401"/>
                    <a:pt x="1360" y="414"/>
                    <a:pt x="1348" y="418"/>
                  </a:cubicBezTo>
                  <a:cubicBezTo>
                    <a:pt x="1336" y="422"/>
                    <a:pt x="1322" y="416"/>
                    <a:pt x="1318" y="404"/>
                  </a:cubicBezTo>
                  <a:lnTo>
                    <a:pt x="1294" y="336"/>
                  </a:lnTo>
                  <a:cubicBezTo>
                    <a:pt x="1290" y="324"/>
                    <a:pt x="1296" y="311"/>
                    <a:pt x="1308" y="306"/>
                  </a:cubicBezTo>
                  <a:cubicBezTo>
                    <a:pt x="1320" y="302"/>
                    <a:pt x="1333" y="308"/>
                    <a:pt x="1337" y="320"/>
                  </a:cubicBezTo>
                  <a:close/>
                  <a:moveTo>
                    <a:pt x="1408" y="519"/>
                  </a:moveTo>
                  <a:lnTo>
                    <a:pt x="1438" y="606"/>
                  </a:lnTo>
                  <a:cubicBezTo>
                    <a:pt x="1443" y="618"/>
                    <a:pt x="1436" y="631"/>
                    <a:pt x="1424" y="635"/>
                  </a:cubicBezTo>
                  <a:cubicBezTo>
                    <a:pt x="1412" y="640"/>
                    <a:pt x="1399" y="633"/>
                    <a:pt x="1395" y="621"/>
                  </a:cubicBezTo>
                  <a:lnTo>
                    <a:pt x="1364" y="534"/>
                  </a:lnTo>
                  <a:cubicBezTo>
                    <a:pt x="1360" y="522"/>
                    <a:pt x="1366" y="509"/>
                    <a:pt x="1378" y="505"/>
                  </a:cubicBezTo>
                  <a:cubicBezTo>
                    <a:pt x="1390" y="501"/>
                    <a:pt x="1403" y="507"/>
                    <a:pt x="1408" y="519"/>
                  </a:cubicBezTo>
                  <a:close/>
                  <a:moveTo>
                    <a:pt x="1494" y="724"/>
                  </a:moveTo>
                  <a:lnTo>
                    <a:pt x="1548" y="798"/>
                  </a:lnTo>
                  <a:cubicBezTo>
                    <a:pt x="1556" y="809"/>
                    <a:pt x="1553" y="823"/>
                    <a:pt x="1543" y="831"/>
                  </a:cubicBezTo>
                  <a:cubicBezTo>
                    <a:pt x="1533" y="838"/>
                    <a:pt x="1518" y="836"/>
                    <a:pt x="1511" y="825"/>
                  </a:cubicBezTo>
                  <a:lnTo>
                    <a:pt x="1457" y="751"/>
                  </a:lnTo>
                  <a:cubicBezTo>
                    <a:pt x="1449" y="740"/>
                    <a:pt x="1452" y="726"/>
                    <a:pt x="1462" y="719"/>
                  </a:cubicBezTo>
                  <a:cubicBezTo>
                    <a:pt x="1472" y="711"/>
                    <a:pt x="1487" y="713"/>
                    <a:pt x="1494" y="724"/>
                  </a:cubicBezTo>
                  <a:close/>
                  <a:moveTo>
                    <a:pt x="1629" y="911"/>
                  </a:moveTo>
                  <a:lnTo>
                    <a:pt x="1682" y="986"/>
                  </a:lnTo>
                  <a:cubicBezTo>
                    <a:pt x="1689" y="997"/>
                    <a:pt x="1687" y="1011"/>
                    <a:pt x="1677" y="1018"/>
                  </a:cubicBezTo>
                  <a:cubicBezTo>
                    <a:pt x="1666" y="1026"/>
                    <a:pt x="1652" y="1023"/>
                    <a:pt x="1645" y="1013"/>
                  </a:cubicBezTo>
                  <a:lnTo>
                    <a:pt x="1591" y="938"/>
                  </a:lnTo>
                  <a:cubicBezTo>
                    <a:pt x="1584" y="927"/>
                    <a:pt x="1586" y="913"/>
                    <a:pt x="1597" y="906"/>
                  </a:cubicBezTo>
                  <a:cubicBezTo>
                    <a:pt x="1607" y="898"/>
                    <a:pt x="1621" y="901"/>
                    <a:pt x="1629" y="911"/>
                  </a:cubicBezTo>
                  <a:close/>
                  <a:moveTo>
                    <a:pt x="1764" y="1096"/>
                  </a:moveTo>
                  <a:lnTo>
                    <a:pt x="1821" y="1168"/>
                  </a:lnTo>
                  <a:cubicBezTo>
                    <a:pt x="1829" y="1178"/>
                    <a:pt x="1828" y="1192"/>
                    <a:pt x="1818" y="1200"/>
                  </a:cubicBezTo>
                  <a:cubicBezTo>
                    <a:pt x="1808" y="1208"/>
                    <a:pt x="1793" y="1207"/>
                    <a:pt x="1785" y="1197"/>
                  </a:cubicBezTo>
                  <a:lnTo>
                    <a:pt x="1728" y="1125"/>
                  </a:lnTo>
                  <a:cubicBezTo>
                    <a:pt x="1720" y="1115"/>
                    <a:pt x="1722" y="1100"/>
                    <a:pt x="1732" y="1092"/>
                  </a:cubicBezTo>
                  <a:cubicBezTo>
                    <a:pt x="1741" y="1084"/>
                    <a:pt x="1756" y="1086"/>
                    <a:pt x="1764" y="1096"/>
                  </a:cubicBezTo>
                  <a:close/>
                  <a:moveTo>
                    <a:pt x="1911" y="1271"/>
                  </a:moveTo>
                  <a:lnTo>
                    <a:pt x="1974" y="1339"/>
                  </a:lnTo>
                  <a:cubicBezTo>
                    <a:pt x="1982" y="1348"/>
                    <a:pt x="1982" y="1362"/>
                    <a:pt x="1972" y="1371"/>
                  </a:cubicBezTo>
                  <a:cubicBezTo>
                    <a:pt x="1963" y="1380"/>
                    <a:pt x="1948" y="1379"/>
                    <a:pt x="1940" y="1370"/>
                  </a:cubicBezTo>
                  <a:lnTo>
                    <a:pt x="1877" y="1302"/>
                  </a:lnTo>
                  <a:cubicBezTo>
                    <a:pt x="1868" y="1293"/>
                    <a:pt x="1869" y="1278"/>
                    <a:pt x="1878" y="1270"/>
                  </a:cubicBezTo>
                  <a:cubicBezTo>
                    <a:pt x="1888" y="1261"/>
                    <a:pt x="1902" y="1262"/>
                    <a:pt x="1911" y="1271"/>
                  </a:cubicBezTo>
                  <a:close/>
                  <a:moveTo>
                    <a:pt x="2056" y="1454"/>
                  </a:moveTo>
                  <a:lnTo>
                    <a:pt x="2107" y="1530"/>
                  </a:lnTo>
                  <a:cubicBezTo>
                    <a:pt x="2114" y="1541"/>
                    <a:pt x="2111" y="1555"/>
                    <a:pt x="2101" y="1562"/>
                  </a:cubicBezTo>
                  <a:cubicBezTo>
                    <a:pt x="2090" y="1569"/>
                    <a:pt x="2076" y="1567"/>
                    <a:pt x="2069" y="1556"/>
                  </a:cubicBezTo>
                  <a:lnTo>
                    <a:pt x="2018" y="1479"/>
                  </a:lnTo>
                  <a:cubicBezTo>
                    <a:pt x="2010" y="1469"/>
                    <a:pt x="2013" y="1455"/>
                    <a:pt x="2024" y="1447"/>
                  </a:cubicBezTo>
                  <a:cubicBezTo>
                    <a:pt x="2034" y="1440"/>
                    <a:pt x="2049" y="1443"/>
                    <a:pt x="2056" y="1454"/>
                  </a:cubicBezTo>
                  <a:close/>
                  <a:moveTo>
                    <a:pt x="2176" y="1653"/>
                  </a:moveTo>
                  <a:lnTo>
                    <a:pt x="2219" y="1734"/>
                  </a:lnTo>
                  <a:cubicBezTo>
                    <a:pt x="2225" y="1746"/>
                    <a:pt x="2221" y="1760"/>
                    <a:pt x="2209" y="1765"/>
                  </a:cubicBezTo>
                  <a:cubicBezTo>
                    <a:pt x="2198" y="1771"/>
                    <a:pt x="2184" y="1767"/>
                    <a:pt x="2178" y="1756"/>
                  </a:cubicBezTo>
                  <a:lnTo>
                    <a:pt x="2135" y="1675"/>
                  </a:lnTo>
                  <a:cubicBezTo>
                    <a:pt x="2129" y="1663"/>
                    <a:pt x="2133" y="1649"/>
                    <a:pt x="2145" y="1643"/>
                  </a:cubicBezTo>
                  <a:cubicBezTo>
                    <a:pt x="2156" y="1637"/>
                    <a:pt x="2170" y="1642"/>
                    <a:pt x="2176" y="1653"/>
                  </a:cubicBezTo>
                  <a:close/>
                  <a:moveTo>
                    <a:pt x="2280" y="1860"/>
                  </a:moveTo>
                  <a:lnTo>
                    <a:pt x="2317" y="1945"/>
                  </a:lnTo>
                  <a:cubicBezTo>
                    <a:pt x="2322" y="1957"/>
                    <a:pt x="2316" y="1970"/>
                    <a:pt x="2305" y="1975"/>
                  </a:cubicBezTo>
                  <a:cubicBezTo>
                    <a:pt x="2293" y="1980"/>
                    <a:pt x="2279" y="1975"/>
                    <a:pt x="2274" y="1963"/>
                  </a:cubicBezTo>
                  <a:lnTo>
                    <a:pt x="2238" y="1878"/>
                  </a:lnTo>
                  <a:cubicBezTo>
                    <a:pt x="2233" y="1867"/>
                    <a:pt x="2238" y="1853"/>
                    <a:pt x="2250" y="1848"/>
                  </a:cubicBezTo>
                  <a:cubicBezTo>
                    <a:pt x="2262" y="1843"/>
                    <a:pt x="2275" y="1848"/>
                    <a:pt x="2280" y="1860"/>
                  </a:cubicBezTo>
                  <a:close/>
                  <a:moveTo>
                    <a:pt x="2371" y="2072"/>
                  </a:moveTo>
                  <a:lnTo>
                    <a:pt x="2389" y="2113"/>
                  </a:lnTo>
                  <a:cubicBezTo>
                    <a:pt x="2394" y="2125"/>
                    <a:pt x="2389" y="2139"/>
                    <a:pt x="2377" y="2144"/>
                  </a:cubicBezTo>
                  <a:cubicBezTo>
                    <a:pt x="2365" y="2149"/>
                    <a:pt x="2352" y="2143"/>
                    <a:pt x="2347" y="2132"/>
                  </a:cubicBezTo>
                  <a:lnTo>
                    <a:pt x="2329" y="2090"/>
                  </a:lnTo>
                  <a:cubicBezTo>
                    <a:pt x="2324" y="2078"/>
                    <a:pt x="2329" y="2065"/>
                    <a:pt x="2341" y="2060"/>
                  </a:cubicBezTo>
                  <a:cubicBezTo>
                    <a:pt x="2353" y="2055"/>
                    <a:pt x="2366" y="2060"/>
                    <a:pt x="2371" y="2072"/>
                  </a:cubicBezTo>
                  <a:close/>
                  <a:moveTo>
                    <a:pt x="2388" y="2111"/>
                  </a:moveTo>
                  <a:lnTo>
                    <a:pt x="2412" y="2151"/>
                  </a:lnTo>
                  <a:cubicBezTo>
                    <a:pt x="2418" y="2162"/>
                    <a:pt x="2415" y="2176"/>
                    <a:pt x="2404" y="2183"/>
                  </a:cubicBezTo>
                  <a:cubicBezTo>
                    <a:pt x="2393" y="2189"/>
                    <a:pt x="2379" y="2186"/>
                    <a:pt x="2372" y="2175"/>
                  </a:cubicBezTo>
                  <a:lnTo>
                    <a:pt x="2348" y="2134"/>
                  </a:lnTo>
                  <a:cubicBezTo>
                    <a:pt x="2341" y="2123"/>
                    <a:pt x="2345" y="2109"/>
                    <a:pt x="2356" y="2103"/>
                  </a:cubicBezTo>
                  <a:cubicBezTo>
                    <a:pt x="2367" y="2096"/>
                    <a:pt x="2381" y="2100"/>
                    <a:pt x="2388" y="2111"/>
                  </a:cubicBezTo>
                  <a:close/>
                  <a:moveTo>
                    <a:pt x="2483" y="2270"/>
                  </a:moveTo>
                  <a:lnTo>
                    <a:pt x="2521" y="2333"/>
                  </a:lnTo>
                  <a:cubicBezTo>
                    <a:pt x="2527" y="2344"/>
                    <a:pt x="2524" y="2359"/>
                    <a:pt x="2513" y="2365"/>
                  </a:cubicBezTo>
                  <a:cubicBezTo>
                    <a:pt x="2502" y="2372"/>
                    <a:pt x="2488" y="2368"/>
                    <a:pt x="2481" y="2357"/>
                  </a:cubicBezTo>
                  <a:lnTo>
                    <a:pt x="2443" y="2293"/>
                  </a:lnTo>
                  <a:cubicBezTo>
                    <a:pt x="2437" y="2282"/>
                    <a:pt x="2440" y="2268"/>
                    <a:pt x="2451" y="2262"/>
                  </a:cubicBezTo>
                  <a:cubicBezTo>
                    <a:pt x="2462" y="2255"/>
                    <a:pt x="2476" y="2259"/>
                    <a:pt x="2483" y="2270"/>
                  </a:cubicBezTo>
                  <a:close/>
                  <a:moveTo>
                    <a:pt x="2518" y="2329"/>
                  </a:moveTo>
                  <a:lnTo>
                    <a:pt x="2530" y="2342"/>
                  </a:lnTo>
                  <a:cubicBezTo>
                    <a:pt x="2539" y="2352"/>
                    <a:pt x="2538" y="2366"/>
                    <a:pt x="2529" y="2375"/>
                  </a:cubicBezTo>
                  <a:cubicBezTo>
                    <a:pt x="2520" y="2384"/>
                    <a:pt x="2505" y="2383"/>
                    <a:pt x="2496" y="2374"/>
                  </a:cubicBezTo>
                  <a:lnTo>
                    <a:pt x="2484" y="2361"/>
                  </a:lnTo>
                  <a:cubicBezTo>
                    <a:pt x="2475" y="2352"/>
                    <a:pt x="2476" y="2337"/>
                    <a:pt x="2485" y="2329"/>
                  </a:cubicBezTo>
                  <a:cubicBezTo>
                    <a:pt x="2494" y="2320"/>
                    <a:pt x="2509" y="2320"/>
                    <a:pt x="2518" y="2329"/>
                  </a:cubicBezTo>
                  <a:close/>
                  <a:moveTo>
                    <a:pt x="2625" y="2443"/>
                  </a:moveTo>
                  <a:lnTo>
                    <a:pt x="2648" y="2468"/>
                  </a:lnTo>
                  <a:cubicBezTo>
                    <a:pt x="2657" y="2477"/>
                    <a:pt x="2657" y="2492"/>
                    <a:pt x="2647" y="2500"/>
                  </a:cubicBezTo>
                  <a:cubicBezTo>
                    <a:pt x="2638" y="2509"/>
                    <a:pt x="2623" y="2509"/>
                    <a:pt x="2615" y="2499"/>
                  </a:cubicBezTo>
                  <a:lnTo>
                    <a:pt x="2591" y="2475"/>
                  </a:lnTo>
                  <a:cubicBezTo>
                    <a:pt x="2583" y="2465"/>
                    <a:pt x="2583" y="2451"/>
                    <a:pt x="2592" y="2442"/>
                  </a:cubicBezTo>
                  <a:cubicBezTo>
                    <a:pt x="2602" y="2433"/>
                    <a:pt x="2616" y="2434"/>
                    <a:pt x="2625" y="2443"/>
                  </a:cubicBezTo>
                  <a:close/>
                  <a:moveTo>
                    <a:pt x="2651" y="2472"/>
                  </a:moveTo>
                  <a:lnTo>
                    <a:pt x="2681" y="2522"/>
                  </a:lnTo>
                  <a:cubicBezTo>
                    <a:pt x="2688" y="2533"/>
                    <a:pt x="2684" y="2547"/>
                    <a:pt x="2673" y="2553"/>
                  </a:cubicBezTo>
                  <a:cubicBezTo>
                    <a:pt x="2662" y="2560"/>
                    <a:pt x="2648" y="2556"/>
                    <a:pt x="2642" y="2545"/>
                  </a:cubicBezTo>
                  <a:lnTo>
                    <a:pt x="2612" y="2495"/>
                  </a:lnTo>
                  <a:cubicBezTo>
                    <a:pt x="2605" y="2484"/>
                    <a:pt x="2609" y="2470"/>
                    <a:pt x="2620" y="2464"/>
                  </a:cubicBezTo>
                  <a:cubicBezTo>
                    <a:pt x="2631" y="2457"/>
                    <a:pt x="2645" y="2461"/>
                    <a:pt x="2651" y="2472"/>
                  </a:cubicBezTo>
                  <a:close/>
                  <a:moveTo>
                    <a:pt x="2752" y="2640"/>
                  </a:moveTo>
                  <a:lnTo>
                    <a:pt x="2784" y="2694"/>
                  </a:lnTo>
                  <a:cubicBezTo>
                    <a:pt x="2791" y="2705"/>
                    <a:pt x="2787" y="2719"/>
                    <a:pt x="2776" y="2726"/>
                  </a:cubicBezTo>
                  <a:cubicBezTo>
                    <a:pt x="2765" y="2733"/>
                    <a:pt x="2751" y="2729"/>
                    <a:pt x="2745" y="2718"/>
                  </a:cubicBezTo>
                  <a:lnTo>
                    <a:pt x="2712" y="2664"/>
                  </a:lnTo>
                  <a:cubicBezTo>
                    <a:pt x="2706" y="2653"/>
                    <a:pt x="2709" y="2639"/>
                    <a:pt x="2720" y="2632"/>
                  </a:cubicBezTo>
                  <a:cubicBezTo>
                    <a:pt x="2731" y="2626"/>
                    <a:pt x="2745" y="2629"/>
                    <a:pt x="2752" y="2640"/>
                  </a:cubicBezTo>
                  <a:close/>
                  <a:moveTo>
                    <a:pt x="2780" y="2689"/>
                  </a:moveTo>
                  <a:lnTo>
                    <a:pt x="2802" y="2708"/>
                  </a:lnTo>
                  <a:cubicBezTo>
                    <a:pt x="2811" y="2716"/>
                    <a:pt x="2813" y="2730"/>
                    <a:pt x="2804" y="2740"/>
                  </a:cubicBezTo>
                  <a:cubicBezTo>
                    <a:pt x="2796" y="2750"/>
                    <a:pt x="2781" y="2751"/>
                    <a:pt x="2772" y="2743"/>
                  </a:cubicBezTo>
                  <a:lnTo>
                    <a:pt x="2750" y="2724"/>
                  </a:lnTo>
                  <a:cubicBezTo>
                    <a:pt x="2740" y="2715"/>
                    <a:pt x="2739" y="2701"/>
                    <a:pt x="2747" y="2691"/>
                  </a:cubicBezTo>
                  <a:cubicBezTo>
                    <a:pt x="2755" y="2682"/>
                    <a:pt x="2770" y="2680"/>
                    <a:pt x="2780" y="2689"/>
                  </a:cubicBezTo>
                  <a:close/>
                  <a:moveTo>
                    <a:pt x="2907" y="2797"/>
                  </a:moveTo>
                  <a:lnTo>
                    <a:pt x="2977" y="2857"/>
                  </a:lnTo>
                  <a:cubicBezTo>
                    <a:pt x="2987" y="2865"/>
                    <a:pt x="2988" y="2880"/>
                    <a:pt x="2980" y="2890"/>
                  </a:cubicBezTo>
                  <a:cubicBezTo>
                    <a:pt x="2971" y="2899"/>
                    <a:pt x="2957" y="2900"/>
                    <a:pt x="2947" y="2892"/>
                  </a:cubicBezTo>
                  <a:lnTo>
                    <a:pt x="2877" y="2832"/>
                  </a:lnTo>
                  <a:cubicBezTo>
                    <a:pt x="2867" y="2824"/>
                    <a:pt x="2866" y="2810"/>
                    <a:pt x="2874" y="2800"/>
                  </a:cubicBezTo>
                  <a:cubicBezTo>
                    <a:pt x="2883" y="2790"/>
                    <a:pt x="2897" y="2789"/>
                    <a:pt x="2907" y="2797"/>
                  </a:cubicBezTo>
                  <a:close/>
                  <a:moveTo>
                    <a:pt x="3084" y="2939"/>
                  </a:moveTo>
                  <a:lnTo>
                    <a:pt x="3162" y="2988"/>
                  </a:lnTo>
                  <a:cubicBezTo>
                    <a:pt x="3173" y="2995"/>
                    <a:pt x="3176" y="3009"/>
                    <a:pt x="3169" y="3020"/>
                  </a:cubicBezTo>
                  <a:cubicBezTo>
                    <a:pt x="3162" y="3031"/>
                    <a:pt x="3148" y="3034"/>
                    <a:pt x="3137" y="3027"/>
                  </a:cubicBezTo>
                  <a:lnTo>
                    <a:pt x="3059" y="2978"/>
                  </a:lnTo>
                  <a:cubicBezTo>
                    <a:pt x="3049" y="2971"/>
                    <a:pt x="3045" y="2957"/>
                    <a:pt x="3052" y="2946"/>
                  </a:cubicBezTo>
                  <a:cubicBezTo>
                    <a:pt x="3059" y="2935"/>
                    <a:pt x="3073" y="2932"/>
                    <a:pt x="3084" y="2939"/>
                  </a:cubicBezTo>
                  <a:close/>
                  <a:moveTo>
                    <a:pt x="3287" y="3030"/>
                  </a:moveTo>
                  <a:lnTo>
                    <a:pt x="3296" y="3032"/>
                  </a:lnTo>
                  <a:cubicBezTo>
                    <a:pt x="3308" y="3036"/>
                    <a:pt x="3315" y="3049"/>
                    <a:pt x="3311" y="3061"/>
                  </a:cubicBezTo>
                  <a:cubicBezTo>
                    <a:pt x="3308" y="3073"/>
                    <a:pt x="3295" y="3080"/>
                    <a:pt x="3282" y="3076"/>
                  </a:cubicBezTo>
                  <a:lnTo>
                    <a:pt x="3273" y="3074"/>
                  </a:lnTo>
                  <a:cubicBezTo>
                    <a:pt x="3261" y="3070"/>
                    <a:pt x="3254" y="3057"/>
                    <a:pt x="3258" y="3045"/>
                  </a:cubicBezTo>
                  <a:cubicBezTo>
                    <a:pt x="3262" y="3032"/>
                    <a:pt x="3275" y="3026"/>
                    <a:pt x="3287" y="3030"/>
                  </a:cubicBezTo>
                  <a:close/>
                  <a:moveTo>
                    <a:pt x="3293" y="3032"/>
                  </a:moveTo>
                  <a:lnTo>
                    <a:pt x="3375" y="3044"/>
                  </a:lnTo>
                  <a:cubicBezTo>
                    <a:pt x="3387" y="3046"/>
                    <a:pt x="3396" y="3058"/>
                    <a:pt x="3394" y="3071"/>
                  </a:cubicBezTo>
                  <a:cubicBezTo>
                    <a:pt x="3392" y="3083"/>
                    <a:pt x="3380" y="3092"/>
                    <a:pt x="3367" y="3090"/>
                  </a:cubicBezTo>
                  <a:lnTo>
                    <a:pt x="3286" y="3077"/>
                  </a:lnTo>
                  <a:cubicBezTo>
                    <a:pt x="3273" y="3075"/>
                    <a:pt x="3265" y="3063"/>
                    <a:pt x="3267" y="3051"/>
                  </a:cubicBezTo>
                  <a:cubicBezTo>
                    <a:pt x="3269" y="3038"/>
                    <a:pt x="3280" y="3030"/>
                    <a:pt x="3293" y="3032"/>
                  </a:cubicBezTo>
                  <a:close/>
                  <a:moveTo>
                    <a:pt x="3511" y="3066"/>
                  </a:moveTo>
                  <a:lnTo>
                    <a:pt x="3557" y="3073"/>
                  </a:lnTo>
                  <a:lnTo>
                    <a:pt x="3550" y="3118"/>
                  </a:lnTo>
                  <a:lnTo>
                    <a:pt x="3504" y="3111"/>
                  </a:lnTo>
                  <a:cubicBezTo>
                    <a:pt x="3491" y="3109"/>
                    <a:pt x="3483" y="3097"/>
                    <a:pt x="3485" y="3085"/>
                  </a:cubicBezTo>
                  <a:cubicBezTo>
                    <a:pt x="3487" y="3072"/>
                    <a:pt x="3499" y="3064"/>
                    <a:pt x="3511" y="3066"/>
                  </a:cubicBezTo>
                  <a:close/>
                </a:path>
              </a:pathLst>
            </a:custGeom>
            <a:solidFill>
              <a:srgbClr val="A00000"/>
            </a:solidFill>
            <a:ln w="1588" cap="flat">
              <a:solidFill>
                <a:srgbClr val="A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238" name="Freeform 213"/>
            <p:cNvSpPr>
              <a:spLocks noEditPoints="1"/>
            </p:cNvSpPr>
            <p:nvPr/>
          </p:nvSpPr>
          <p:spPr bwMode="auto">
            <a:xfrm>
              <a:off x="3906838" y="3230563"/>
              <a:ext cx="1320800" cy="1304925"/>
            </a:xfrm>
            <a:custGeom>
              <a:avLst/>
              <a:gdLst>
                <a:gd name="T0" fmla="*/ 92 w 3163"/>
                <a:gd name="T1" fmla="*/ 48 h 3120"/>
                <a:gd name="T2" fmla="*/ 261 w 3163"/>
                <a:gd name="T3" fmla="*/ 2 h 3120"/>
                <a:gd name="T4" fmla="*/ 207 w 3163"/>
                <a:gd name="T5" fmla="*/ 25 h 3120"/>
                <a:gd name="T6" fmla="*/ 345 w 3163"/>
                <a:gd name="T7" fmla="*/ 25 h 3120"/>
                <a:gd name="T8" fmla="*/ 261 w 3163"/>
                <a:gd name="T9" fmla="*/ 2 h 3120"/>
                <a:gd name="T10" fmla="*/ 525 w 3163"/>
                <a:gd name="T11" fmla="*/ 48 h 3120"/>
                <a:gd name="T12" fmla="*/ 529 w 3163"/>
                <a:gd name="T13" fmla="*/ 3 h 3120"/>
                <a:gd name="T14" fmla="*/ 520 w 3163"/>
                <a:gd name="T15" fmla="*/ 48 h 3120"/>
                <a:gd name="T16" fmla="*/ 781 w 3163"/>
                <a:gd name="T17" fmla="*/ 28 h 3120"/>
                <a:gd name="T18" fmla="*/ 666 w 3163"/>
                <a:gd name="T19" fmla="*/ 51 h 3120"/>
                <a:gd name="T20" fmla="*/ 955 w 3163"/>
                <a:gd name="T21" fmla="*/ 232 h 3120"/>
                <a:gd name="T22" fmla="*/ 894 w 3163"/>
                <a:gd name="T23" fmla="*/ 132 h 3120"/>
                <a:gd name="T24" fmla="*/ 1035 w 3163"/>
                <a:gd name="T25" fmla="*/ 353 h 3120"/>
                <a:gd name="T26" fmla="*/ 1060 w 3163"/>
                <a:gd name="T27" fmla="*/ 316 h 3120"/>
                <a:gd name="T28" fmla="*/ 1044 w 3163"/>
                <a:gd name="T29" fmla="*/ 359 h 3120"/>
                <a:gd name="T30" fmla="*/ 1308 w 3163"/>
                <a:gd name="T31" fmla="*/ 480 h 3120"/>
                <a:gd name="T32" fmla="*/ 1210 w 3163"/>
                <a:gd name="T33" fmla="*/ 416 h 3120"/>
                <a:gd name="T34" fmla="*/ 1403 w 3163"/>
                <a:gd name="T35" fmla="*/ 722 h 3120"/>
                <a:gd name="T36" fmla="*/ 1379 w 3163"/>
                <a:gd name="T37" fmla="*/ 607 h 3120"/>
                <a:gd name="T38" fmla="*/ 1459 w 3163"/>
                <a:gd name="T39" fmla="*/ 922 h 3120"/>
                <a:gd name="T40" fmla="*/ 1551 w 3163"/>
                <a:gd name="T41" fmla="*/ 1036 h 3120"/>
                <a:gd name="T42" fmla="*/ 1508 w 3163"/>
                <a:gd name="T43" fmla="*/ 1052 h 3120"/>
                <a:gd name="T44" fmla="*/ 1647 w 3163"/>
                <a:gd name="T45" fmla="*/ 1346 h 3120"/>
                <a:gd name="T46" fmla="*/ 1596 w 3163"/>
                <a:gd name="T47" fmla="*/ 1240 h 3120"/>
                <a:gd name="T48" fmla="*/ 1688 w 3163"/>
                <a:gd name="T49" fmla="*/ 1597 h 3120"/>
                <a:gd name="T50" fmla="*/ 1682 w 3163"/>
                <a:gd name="T51" fmla="*/ 1480 h 3120"/>
                <a:gd name="T52" fmla="*/ 1734 w 3163"/>
                <a:gd name="T53" fmla="*/ 1801 h 3120"/>
                <a:gd name="T54" fmla="*/ 1828 w 3163"/>
                <a:gd name="T55" fmla="*/ 1912 h 3120"/>
                <a:gd name="T56" fmla="*/ 1785 w 3163"/>
                <a:gd name="T57" fmla="*/ 1930 h 3120"/>
                <a:gd name="T58" fmla="*/ 1989 w 3163"/>
                <a:gd name="T59" fmla="*/ 2107 h 3120"/>
                <a:gd name="T60" fmla="*/ 1926 w 3163"/>
                <a:gd name="T61" fmla="*/ 2083 h 3120"/>
                <a:gd name="T62" fmla="*/ 2008 w 3163"/>
                <a:gd name="T63" fmla="*/ 2191 h 3120"/>
                <a:gd name="T64" fmla="*/ 1994 w 3163"/>
                <a:gd name="T65" fmla="*/ 2114 h 3120"/>
                <a:gd name="T66" fmla="*/ 2084 w 3163"/>
                <a:gd name="T67" fmla="*/ 2386 h 3120"/>
                <a:gd name="T68" fmla="*/ 2208 w 3163"/>
                <a:gd name="T69" fmla="*/ 2469 h 3120"/>
                <a:gd name="T70" fmla="*/ 2172 w 3163"/>
                <a:gd name="T71" fmla="*/ 2498 h 3120"/>
                <a:gd name="T72" fmla="*/ 2266 w 3163"/>
                <a:gd name="T73" fmla="*/ 2538 h 3120"/>
                <a:gd name="T74" fmla="*/ 2221 w 3163"/>
                <a:gd name="T75" fmla="*/ 2525 h 3120"/>
                <a:gd name="T76" fmla="*/ 2384 w 3163"/>
                <a:gd name="T77" fmla="*/ 2697 h 3120"/>
                <a:gd name="T78" fmla="*/ 2361 w 3163"/>
                <a:gd name="T79" fmla="*/ 2639 h 3120"/>
                <a:gd name="T80" fmla="*/ 2381 w 3163"/>
                <a:gd name="T81" fmla="*/ 2741 h 3120"/>
                <a:gd name="T82" fmla="*/ 2496 w 3163"/>
                <a:gd name="T83" fmla="*/ 2829 h 3120"/>
                <a:gd name="T84" fmla="*/ 2458 w 3163"/>
                <a:gd name="T85" fmla="*/ 2855 h 3120"/>
                <a:gd name="T86" fmla="*/ 2552 w 3163"/>
                <a:gd name="T87" fmla="*/ 2898 h 3120"/>
                <a:gd name="T88" fmla="*/ 2485 w 3163"/>
                <a:gd name="T89" fmla="*/ 2860 h 3120"/>
                <a:gd name="T90" fmla="*/ 2647 w 3163"/>
                <a:gd name="T91" fmla="*/ 3032 h 3120"/>
                <a:gd name="T92" fmla="*/ 2647 w 3163"/>
                <a:gd name="T93" fmla="*/ 2998 h 3120"/>
                <a:gd name="T94" fmla="*/ 2715 w 3163"/>
                <a:gd name="T95" fmla="*/ 3057 h 3120"/>
                <a:gd name="T96" fmla="*/ 2859 w 3163"/>
                <a:gd name="T97" fmla="*/ 3031 h 3120"/>
                <a:gd name="T98" fmla="*/ 2854 w 3163"/>
                <a:gd name="T99" fmla="*/ 3076 h 3120"/>
                <a:gd name="T100" fmla="*/ 3163 w 3163"/>
                <a:gd name="T101" fmla="*/ 3075 h 3120"/>
                <a:gd name="T102" fmla="*/ 3089 w 3163"/>
                <a:gd name="T103" fmla="*/ 3060 h 31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</a:cxnLst>
              <a:rect l="0" t="0" r="r" b="b"/>
              <a:pathLst>
                <a:path w="3163" h="3120">
                  <a:moveTo>
                    <a:pt x="0" y="2"/>
                  </a:moveTo>
                  <a:lnTo>
                    <a:pt x="92" y="2"/>
                  </a:lnTo>
                  <a:cubicBezTo>
                    <a:pt x="105" y="2"/>
                    <a:pt x="115" y="13"/>
                    <a:pt x="115" y="25"/>
                  </a:cubicBezTo>
                  <a:cubicBezTo>
                    <a:pt x="115" y="38"/>
                    <a:pt x="105" y="48"/>
                    <a:pt x="92" y="48"/>
                  </a:cubicBezTo>
                  <a:lnTo>
                    <a:pt x="0" y="48"/>
                  </a:lnTo>
                  <a:lnTo>
                    <a:pt x="0" y="2"/>
                  </a:lnTo>
                  <a:close/>
                  <a:moveTo>
                    <a:pt x="230" y="2"/>
                  </a:moveTo>
                  <a:lnTo>
                    <a:pt x="261" y="2"/>
                  </a:lnTo>
                  <a:cubicBezTo>
                    <a:pt x="274" y="2"/>
                    <a:pt x="284" y="13"/>
                    <a:pt x="284" y="25"/>
                  </a:cubicBezTo>
                  <a:cubicBezTo>
                    <a:pt x="284" y="38"/>
                    <a:pt x="274" y="48"/>
                    <a:pt x="261" y="48"/>
                  </a:cubicBezTo>
                  <a:lnTo>
                    <a:pt x="230" y="48"/>
                  </a:lnTo>
                  <a:cubicBezTo>
                    <a:pt x="217" y="48"/>
                    <a:pt x="207" y="38"/>
                    <a:pt x="207" y="25"/>
                  </a:cubicBezTo>
                  <a:cubicBezTo>
                    <a:pt x="207" y="13"/>
                    <a:pt x="217" y="2"/>
                    <a:pt x="230" y="2"/>
                  </a:cubicBezTo>
                  <a:close/>
                  <a:moveTo>
                    <a:pt x="261" y="2"/>
                  </a:moveTo>
                  <a:lnTo>
                    <a:pt x="322" y="2"/>
                  </a:lnTo>
                  <a:cubicBezTo>
                    <a:pt x="335" y="2"/>
                    <a:pt x="345" y="13"/>
                    <a:pt x="345" y="25"/>
                  </a:cubicBezTo>
                  <a:cubicBezTo>
                    <a:pt x="345" y="38"/>
                    <a:pt x="335" y="48"/>
                    <a:pt x="322" y="48"/>
                  </a:cubicBezTo>
                  <a:lnTo>
                    <a:pt x="261" y="48"/>
                  </a:lnTo>
                  <a:cubicBezTo>
                    <a:pt x="248" y="48"/>
                    <a:pt x="238" y="38"/>
                    <a:pt x="238" y="25"/>
                  </a:cubicBezTo>
                  <a:cubicBezTo>
                    <a:pt x="238" y="13"/>
                    <a:pt x="248" y="2"/>
                    <a:pt x="261" y="2"/>
                  </a:cubicBezTo>
                  <a:close/>
                  <a:moveTo>
                    <a:pt x="461" y="2"/>
                  </a:moveTo>
                  <a:lnTo>
                    <a:pt x="525" y="2"/>
                  </a:lnTo>
                  <a:cubicBezTo>
                    <a:pt x="537" y="2"/>
                    <a:pt x="548" y="13"/>
                    <a:pt x="548" y="25"/>
                  </a:cubicBezTo>
                  <a:cubicBezTo>
                    <a:pt x="548" y="38"/>
                    <a:pt x="537" y="48"/>
                    <a:pt x="525" y="48"/>
                  </a:cubicBezTo>
                  <a:lnTo>
                    <a:pt x="461" y="48"/>
                  </a:lnTo>
                  <a:cubicBezTo>
                    <a:pt x="448" y="48"/>
                    <a:pt x="438" y="38"/>
                    <a:pt x="438" y="25"/>
                  </a:cubicBezTo>
                  <a:cubicBezTo>
                    <a:pt x="438" y="13"/>
                    <a:pt x="448" y="2"/>
                    <a:pt x="461" y="2"/>
                  </a:cubicBezTo>
                  <a:close/>
                  <a:moveTo>
                    <a:pt x="529" y="3"/>
                  </a:moveTo>
                  <a:lnTo>
                    <a:pt x="557" y="8"/>
                  </a:lnTo>
                  <a:cubicBezTo>
                    <a:pt x="569" y="10"/>
                    <a:pt x="577" y="23"/>
                    <a:pt x="575" y="35"/>
                  </a:cubicBezTo>
                  <a:cubicBezTo>
                    <a:pt x="572" y="48"/>
                    <a:pt x="560" y="56"/>
                    <a:pt x="548" y="53"/>
                  </a:cubicBezTo>
                  <a:lnTo>
                    <a:pt x="520" y="48"/>
                  </a:lnTo>
                  <a:cubicBezTo>
                    <a:pt x="508" y="46"/>
                    <a:pt x="500" y="33"/>
                    <a:pt x="502" y="21"/>
                  </a:cubicBezTo>
                  <a:cubicBezTo>
                    <a:pt x="504" y="9"/>
                    <a:pt x="516" y="0"/>
                    <a:pt x="529" y="3"/>
                  </a:cubicBezTo>
                  <a:close/>
                  <a:moveTo>
                    <a:pt x="689" y="28"/>
                  </a:moveTo>
                  <a:lnTo>
                    <a:pt x="781" y="28"/>
                  </a:lnTo>
                  <a:cubicBezTo>
                    <a:pt x="793" y="28"/>
                    <a:pt x="804" y="38"/>
                    <a:pt x="804" y="51"/>
                  </a:cubicBezTo>
                  <a:cubicBezTo>
                    <a:pt x="804" y="64"/>
                    <a:pt x="793" y="74"/>
                    <a:pt x="781" y="74"/>
                  </a:cubicBezTo>
                  <a:lnTo>
                    <a:pt x="689" y="74"/>
                  </a:lnTo>
                  <a:cubicBezTo>
                    <a:pt x="676" y="74"/>
                    <a:pt x="666" y="64"/>
                    <a:pt x="666" y="51"/>
                  </a:cubicBezTo>
                  <a:cubicBezTo>
                    <a:pt x="666" y="38"/>
                    <a:pt x="676" y="28"/>
                    <a:pt x="689" y="28"/>
                  </a:cubicBezTo>
                  <a:close/>
                  <a:moveTo>
                    <a:pt x="894" y="132"/>
                  </a:moveTo>
                  <a:lnTo>
                    <a:pt x="956" y="199"/>
                  </a:lnTo>
                  <a:cubicBezTo>
                    <a:pt x="965" y="209"/>
                    <a:pt x="964" y="223"/>
                    <a:pt x="955" y="232"/>
                  </a:cubicBezTo>
                  <a:cubicBezTo>
                    <a:pt x="945" y="241"/>
                    <a:pt x="931" y="240"/>
                    <a:pt x="922" y="231"/>
                  </a:cubicBezTo>
                  <a:lnTo>
                    <a:pt x="860" y="163"/>
                  </a:lnTo>
                  <a:cubicBezTo>
                    <a:pt x="851" y="153"/>
                    <a:pt x="852" y="139"/>
                    <a:pt x="861" y="130"/>
                  </a:cubicBezTo>
                  <a:cubicBezTo>
                    <a:pt x="870" y="122"/>
                    <a:pt x="885" y="122"/>
                    <a:pt x="894" y="132"/>
                  </a:cubicBezTo>
                  <a:close/>
                  <a:moveTo>
                    <a:pt x="1050" y="301"/>
                  </a:moveTo>
                  <a:lnTo>
                    <a:pt x="1069" y="322"/>
                  </a:lnTo>
                  <a:cubicBezTo>
                    <a:pt x="1078" y="331"/>
                    <a:pt x="1077" y="346"/>
                    <a:pt x="1068" y="355"/>
                  </a:cubicBezTo>
                  <a:cubicBezTo>
                    <a:pt x="1058" y="363"/>
                    <a:pt x="1044" y="363"/>
                    <a:pt x="1035" y="353"/>
                  </a:cubicBezTo>
                  <a:lnTo>
                    <a:pt x="1016" y="332"/>
                  </a:lnTo>
                  <a:cubicBezTo>
                    <a:pt x="1007" y="323"/>
                    <a:pt x="1008" y="308"/>
                    <a:pt x="1017" y="300"/>
                  </a:cubicBezTo>
                  <a:cubicBezTo>
                    <a:pt x="1026" y="291"/>
                    <a:pt x="1041" y="292"/>
                    <a:pt x="1050" y="301"/>
                  </a:cubicBezTo>
                  <a:close/>
                  <a:moveTo>
                    <a:pt x="1060" y="316"/>
                  </a:moveTo>
                  <a:lnTo>
                    <a:pt x="1120" y="339"/>
                  </a:lnTo>
                  <a:cubicBezTo>
                    <a:pt x="1132" y="344"/>
                    <a:pt x="1137" y="357"/>
                    <a:pt x="1133" y="369"/>
                  </a:cubicBezTo>
                  <a:cubicBezTo>
                    <a:pt x="1128" y="381"/>
                    <a:pt x="1115" y="387"/>
                    <a:pt x="1103" y="382"/>
                  </a:cubicBezTo>
                  <a:lnTo>
                    <a:pt x="1044" y="359"/>
                  </a:lnTo>
                  <a:cubicBezTo>
                    <a:pt x="1032" y="354"/>
                    <a:pt x="1026" y="341"/>
                    <a:pt x="1030" y="329"/>
                  </a:cubicBezTo>
                  <a:cubicBezTo>
                    <a:pt x="1035" y="317"/>
                    <a:pt x="1049" y="312"/>
                    <a:pt x="1060" y="316"/>
                  </a:cubicBezTo>
                  <a:close/>
                  <a:moveTo>
                    <a:pt x="1243" y="416"/>
                  </a:moveTo>
                  <a:lnTo>
                    <a:pt x="1308" y="480"/>
                  </a:lnTo>
                  <a:cubicBezTo>
                    <a:pt x="1318" y="489"/>
                    <a:pt x="1318" y="504"/>
                    <a:pt x="1309" y="513"/>
                  </a:cubicBezTo>
                  <a:cubicBezTo>
                    <a:pt x="1300" y="522"/>
                    <a:pt x="1285" y="522"/>
                    <a:pt x="1276" y="513"/>
                  </a:cubicBezTo>
                  <a:lnTo>
                    <a:pt x="1210" y="449"/>
                  </a:lnTo>
                  <a:cubicBezTo>
                    <a:pt x="1201" y="440"/>
                    <a:pt x="1201" y="425"/>
                    <a:pt x="1210" y="416"/>
                  </a:cubicBezTo>
                  <a:cubicBezTo>
                    <a:pt x="1219" y="407"/>
                    <a:pt x="1234" y="407"/>
                    <a:pt x="1243" y="416"/>
                  </a:cubicBezTo>
                  <a:close/>
                  <a:moveTo>
                    <a:pt x="1379" y="607"/>
                  </a:moveTo>
                  <a:lnTo>
                    <a:pt x="1415" y="692"/>
                  </a:lnTo>
                  <a:cubicBezTo>
                    <a:pt x="1420" y="704"/>
                    <a:pt x="1415" y="717"/>
                    <a:pt x="1403" y="722"/>
                  </a:cubicBezTo>
                  <a:cubicBezTo>
                    <a:pt x="1392" y="727"/>
                    <a:pt x="1378" y="722"/>
                    <a:pt x="1373" y="710"/>
                  </a:cubicBezTo>
                  <a:lnTo>
                    <a:pt x="1336" y="626"/>
                  </a:lnTo>
                  <a:cubicBezTo>
                    <a:pt x="1331" y="614"/>
                    <a:pt x="1337" y="600"/>
                    <a:pt x="1348" y="595"/>
                  </a:cubicBezTo>
                  <a:cubicBezTo>
                    <a:pt x="1360" y="590"/>
                    <a:pt x="1374" y="596"/>
                    <a:pt x="1379" y="607"/>
                  </a:cubicBezTo>
                  <a:close/>
                  <a:moveTo>
                    <a:pt x="1470" y="820"/>
                  </a:moveTo>
                  <a:lnTo>
                    <a:pt x="1502" y="906"/>
                  </a:lnTo>
                  <a:cubicBezTo>
                    <a:pt x="1507" y="918"/>
                    <a:pt x="1501" y="931"/>
                    <a:pt x="1489" y="936"/>
                  </a:cubicBezTo>
                  <a:cubicBezTo>
                    <a:pt x="1477" y="940"/>
                    <a:pt x="1464" y="934"/>
                    <a:pt x="1459" y="922"/>
                  </a:cubicBezTo>
                  <a:lnTo>
                    <a:pt x="1427" y="836"/>
                  </a:lnTo>
                  <a:cubicBezTo>
                    <a:pt x="1423" y="824"/>
                    <a:pt x="1429" y="811"/>
                    <a:pt x="1441" y="806"/>
                  </a:cubicBezTo>
                  <a:cubicBezTo>
                    <a:pt x="1452" y="802"/>
                    <a:pt x="1466" y="808"/>
                    <a:pt x="1470" y="820"/>
                  </a:cubicBezTo>
                  <a:close/>
                  <a:moveTo>
                    <a:pt x="1551" y="1036"/>
                  </a:moveTo>
                  <a:lnTo>
                    <a:pt x="1583" y="1122"/>
                  </a:lnTo>
                  <a:cubicBezTo>
                    <a:pt x="1588" y="1134"/>
                    <a:pt x="1582" y="1147"/>
                    <a:pt x="1570" y="1152"/>
                  </a:cubicBezTo>
                  <a:cubicBezTo>
                    <a:pt x="1558" y="1156"/>
                    <a:pt x="1545" y="1150"/>
                    <a:pt x="1540" y="1138"/>
                  </a:cubicBezTo>
                  <a:lnTo>
                    <a:pt x="1508" y="1052"/>
                  </a:lnTo>
                  <a:cubicBezTo>
                    <a:pt x="1503" y="1040"/>
                    <a:pt x="1509" y="1027"/>
                    <a:pt x="1521" y="1022"/>
                  </a:cubicBezTo>
                  <a:cubicBezTo>
                    <a:pt x="1533" y="1018"/>
                    <a:pt x="1546" y="1024"/>
                    <a:pt x="1551" y="1036"/>
                  </a:cubicBezTo>
                  <a:close/>
                  <a:moveTo>
                    <a:pt x="1624" y="1257"/>
                  </a:moveTo>
                  <a:lnTo>
                    <a:pt x="1647" y="1346"/>
                  </a:lnTo>
                  <a:cubicBezTo>
                    <a:pt x="1650" y="1358"/>
                    <a:pt x="1643" y="1371"/>
                    <a:pt x="1630" y="1374"/>
                  </a:cubicBezTo>
                  <a:cubicBezTo>
                    <a:pt x="1618" y="1377"/>
                    <a:pt x="1606" y="1370"/>
                    <a:pt x="1602" y="1357"/>
                  </a:cubicBezTo>
                  <a:lnTo>
                    <a:pt x="1579" y="1268"/>
                  </a:lnTo>
                  <a:cubicBezTo>
                    <a:pt x="1576" y="1256"/>
                    <a:pt x="1583" y="1243"/>
                    <a:pt x="1596" y="1240"/>
                  </a:cubicBezTo>
                  <a:cubicBezTo>
                    <a:pt x="1608" y="1237"/>
                    <a:pt x="1621" y="1244"/>
                    <a:pt x="1624" y="1257"/>
                  </a:cubicBezTo>
                  <a:close/>
                  <a:moveTo>
                    <a:pt x="1682" y="1480"/>
                  </a:moveTo>
                  <a:lnTo>
                    <a:pt x="1705" y="1569"/>
                  </a:lnTo>
                  <a:cubicBezTo>
                    <a:pt x="1708" y="1581"/>
                    <a:pt x="1701" y="1594"/>
                    <a:pt x="1688" y="1597"/>
                  </a:cubicBezTo>
                  <a:cubicBezTo>
                    <a:pt x="1676" y="1600"/>
                    <a:pt x="1664" y="1593"/>
                    <a:pt x="1660" y="1580"/>
                  </a:cubicBezTo>
                  <a:lnTo>
                    <a:pt x="1637" y="1491"/>
                  </a:lnTo>
                  <a:cubicBezTo>
                    <a:pt x="1634" y="1479"/>
                    <a:pt x="1641" y="1466"/>
                    <a:pt x="1654" y="1463"/>
                  </a:cubicBezTo>
                  <a:cubicBezTo>
                    <a:pt x="1666" y="1460"/>
                    <a:pt x="1679" y="1467"/>
                    <a:pt x="1682" y="1480"/>
                  </a:cubicBezTo>
                  <a:close/>
                  <a:moveTo>
                    <a:pt x="1742" y="1699"/>
                  </a:moveTo>
                  <a:lnTo>
                    <a:pt x="1777" y="1784"/>
                  </a:lnTo>
                  <a:cubicBezTo>
                    <a:pt x="1781" y="1796"/>
                    <a:pt x="1776" y="1809"/>
                    <a:pt x="1764" y="1814"/>
                  </a:cubicBezTo>
                  <a:cubicBezTo>
                    <a:pt x="1752" y="1819"/>
                    <a:pt x="1739" y="1813"/>
                    <a:pt x="1734" y="1801"/>
                  </a:cubicBezTo>
                  <a:lnTo>
                    <a:pt x="1700" y="1716"/>
                  </a:lnTo>
                  <a:cubicBezTo>
                    <a:pt x="1695" y="1704"/>
                    <a:pt x="1701" y="1690"/>
                    <a:pt x="1713" y="1686"/>
                  </a:cubicBezTo>
                  <a:cubicBezTo>
                    <a:pt x="1724" y="1681"/>
                    <a:pt x="1738" y="1687"/>
                    <a:pt x="1742" y="1699"/>
                  </a:cubicBezTo>
                  <a:close/>
                  <a:moveTo>
                    <a:pt x="1828" y="1912"/>
                  </a:moveTo>
                  <a:lnTo>
                    <a:pt x="1862" y="1998"/>
                  </a:lnTo>
                  <a:cubicBezTo>
                    <a:pt x="1867" y="2010"/>
                    <a:pt x="1861" y="2023"/>
                    <a:pt x="1849" y="2028"/>
                  </a:cubicBezTo>
                  <a:cubicBezTo>
                    <a:pt x="1838" y="2033"/>
                    <a:pt x="1824" y="2027"/>
                    <a:pt x="1819" y="2015"/>
                  </a:cubicBezTo>
                  <a:lnTo>
                    <a:pt x="1785" y="1930"/>
                  </a:lnTo>
                  <a:cubicBezTo>
                    <a:pt x="1781" y="1918"/>
                    <a:pt x="1786" y="1904"/>
                    <a:pt x="1798" y="1900"/>
                  </a:cubicBezTo>
                  <a:cubicBezTo>
                    <a:pt x="1810" y="1895"/>
                    <a:pt x="1823" y="1901"/>
                    <a:pt x="1828" y="1912"/>
                  </a:cubicBezTo>
                  <a:close/>
                  <a:moveTo>
                    <a:pt x="1958" y="2081"/>
                  </a:moveTo>
                  <a:lnTo>
                    <a:pt x="1989" y="2107"/>
                  </a:lnTo>
                  <a:cubicBezTo>
                    <a:pt x="1998" y="2115"/>
                    <a:pt x="1999" y="2130"/>
                    <a:pt x="1991" y="2140"/>
                  </a:cubicBezTo>
                  <a:cubicBezTo>
                    <a:pt x="1983" y="2149"/>
                    <a:pt x="1968" y="2150"/>
                    <a:pt x="1958" y="2142"/>
                  </a:cubicBezTo>
                  <a:lnTo>
                    <a:pt x="1928" y="2116"/>
                  </a:lnTo>
                  <a:cubicBezTo>
                    <a:pt x="1919" y="2108"/>
                    <a:pt x="1918" y="2093"/>
                    <a:pt x="1926" y="2083"/>
                  </a:cubicBezTo>
                  <a:cubicBezTo>
                    <a:pt x="1934" y="2074"/>
                    <a:pt x="1949" y="2073"/>
                    <a:pt x="1958" y="2081"/>
                  </a:cubicBezTo>
                  <a:close/>
                  <a:moveTo>
                    <a:pt x="1994" y="2114"/>
                  </a:moveTo>
                  <a:lnTo>
                    <a:pt x="2018" y="2160"/>
                  </a:lnTo>
                  <a:cubicBezTo>
                    <a:pt x="2024" y="2172"/>
                    <a:pt x="2020" y="2185"/>
                    <a:pt x="2008" y="2191"/>
                  </a:cubicBezTo>
                  <a:cubicBezTo>
                    <a:pt x="1997" y="2197"/>
                    <a:pt x="1983" y="2193"/>
                    <a:pt x="1977" y="2182"/>
                  </a:cubicBezTo>
                  <a:lnTo>
                    <a:pt x="1953" y="2135"/>
                  </a:lnTo>
                  <a:cubicBezTo>
                    <a:pt x="1947" y="2124"/>
                    <a:pt x="1952" y="2110"/>
                    <a:pt x="1963" y="2104"/>
                  </a:cubicBezTo>
                  <a:cubicBezTo>
                    <a:pt x="1974" y="2098"/>
                    <a:pt x="1988" y="2103"/>
                    <a:pt x="1994" y="2114"/>
                  </a:cubicBezTo>
                  <a:close/>
                  <a:moveTo>
                    <a:pt x="2082" y="2283"/>
                  </a:moveTo>
                  <a:lnTo>
                    <a:pt x="2124" y="2365"/>
                  </a:lnTo>
                  <a:cubicBezTo>
                    <a:pt x="2130" y="2376"/>
                    <a:pt x="2126" y="2390"/>
                    <a:pt x="2115" y="2396"/>
                  </a:cubicBezTo>
                  <a:cubicBezTo>
                    <a:pt x="2103" y="2402"/>
                    <a:pt x="2089" y="2397"/>
                    <a:pt x="2084" y="2386"/>
                  </a:cubicBezTo>
                  <a:lnTo>
                    <a:pt x="2041" y="2304"/>
                  </a:lnTo>
                  <a:cubicBezTo>
                    <a:pt x="2035" y="2293"/>
                    <a:pt x="2040" y="2279"/>
                    <a:pt x="2051" y="2273"/>
                  </a:cubicBezTo>
                  <a:cubicBezTo>
                    <a:pt x="2062" y="2267"/>
                    <a:pt x="2076" y="2272"/>
                    <a:pt x="2082" y="2283"/>
                  </a:cubicBezTo>
                  <a:close/>
                  <a:moveTo>
                    <a:pt x="2208" y="2469"/>
                  </a:moveTo>
                  <a:lnTo>
                    <a:pt x="2255" y="2527"/>
                  </a:lnTo>
                  <a:cubicBezTo>
                    <a:pt x="2263" y="2537"/>
                    <a:pt x="2262" y="2552"/>
                    <a:pt x="2252" y="2560"/>
                  </a:cubicBezTo>
                  <a:cubicBezTo>
                    <a:pt x="2242" y="2568"/>
                    <a:pt x="2227" y="2566"/>
                    <a:pt x="2219" y="2556"/>
                  </a:cubicBezTo>
                  <a:lnTo>
                    <a:pt x="2172" y="2498"/>
                  </a:lnTo>
                  <a:cubicBezTo>
                    <a:pt x="2164" y="2488"/>
                    <a:pt x="2166" y="2473"/>
                    <a:pt x="2176" y="2465"/>
                  </a:cubicBezTo>
                  <a:cubicBezTo>
                    <a:pt x="2186" y="2457"/>
                    <a:pt x="2200" y="2459"/>
                    <a:pt x="2208" y="2469"/>
                  </a:cubicBezTo>
                  <a:close/>
                  <a:moveTo>
                    <a:pt x="2254" y="2526"/>
                  </a:moveTo>
                  <a:lnTo>
                    <a:pt x="2266" y="2538"/>
                  </a:lnTo>
                  <a:cubicBezTo>
                    <a:pt x="2274" y="2548"/>
                    <a:pt x="2274" y="2562"/>
                    <a:pt x="2265" y="2571"/>
                  </a:cubicBezTo>
                  <a:cubicBezTo>
                    <a:pt x="2256" y="2580"/>
                    <a:pt x="2241" y="2579"/>
                    <a:pt x="2232" y="2570"/>
                  </a:cubicBezTo>
                  <a:lnTo>
                    <a:pt x="2220" y="2558"/>
                  </a:lnTo>
                  <a:cubicBezTo>
                    <a:pt x="2212" y="2548"/>
                    <a:pt x="2212" y="2534"/>
                    <a:pt x="2221" y="2525"/>
                  </a:cubicBezTo>
                  <a:cubicBezTo>
                    <a:pt x="2231" y="2516"/>
                    <a:pt x="2245" y="2517"/>
                    <a:pt x="2254" y="2526"/>
                  </a:cubicBezTo>
                  <a:close/>
                  <a:moveTo>
                    <a:pt x="2361" y="2639"/>
                  </a:moveTo>
                  <a:lnTo>
                    <a:pt x="2385" y="2664"/>
                  </a:lnTo>
                  <a:cubicBezTo>
                    <a:pt x="2393" y="2673"/>
                    <a:pt x="2393" y="2688"/>
                    <a:pt x="2384" y="2697"/>
                  </a:cubicBezTo>
                  <a:cubicBezTo>
                    <a:pt x="2374" y="2706"/>
                    <a:pt x="2360" y="2705"/>
                    <a:pt x="2351" y="2696"/>
                  </a:cubicBezTo>
                  <a:lnTo>
                    <a:pt x="2327" y="2671"/>
                  </a:lnTo>
                  <a:cubicBezTo>
                    <a:pt x="2318" y="2661"/>
                    <a:pt x="2319" y="2647"/>
                    <a:pt x="2328" y="2638"/>
                  </a:cubicBezTo>
                  <a:cubicBezTo>
                    <a:pt x="2337" y="2629"/>
                    <a:pt x="2352" y="2630"/>
                    <a:pt x="2361" y="2639"/>
                  </a:cubicBezTo>
                  <a:close/>
                  <a:moveTo>
                    <a:pt x="2387" y="2667"/>
                  </a:moveTo>
                  <a:lnTo>
                    <a:pt x="2419" y="2715"/>
                  </a:lnTo>
                  <a:cubicBezTo>
                    <a:pt x="2426" y="2725"/>
                    <a:pt x="2423" y="2740"/>
                    <a:pt x="2413" y="2747"/>
                  </a:cubicBezTo>
                  <a:cubicBezTo>
                    <a:pt x="2402" y="2754"/>
                    <a:pt x="2388" y="2751"/>
                    <a:pt x="2381" y="2741"/>
                  </a:cubicBezTo>
                  <a:lnTo>
                    <a:pt x="2349" y="2693"/>
                  </a:lnTo>
                  <a:cubicBezTo>
                    <a:pt x="2342" y="2682"/>
                    <a:pt x="2344" y="2668"/>
                    <a:pt x="2355" y="2661"/>
                  </a:cubicBezTo>
                  <a:cubicBezTo>
                    <a:pt x="2365" y="2654"/>
                    <a:pt x="2380" y="2657"/>
                    <a:pt x="2387" y="2667"/>
                  </a:cubicBezTo>
                  <a:close/>
                  <a:moveTo>
                    <a:pt x="2496" y="2829"/>
                  </a:moveTo>
                  <a:lnTo>
                    <a:pt x="2520" y="2864"/>
                  </a:lnTo>
                  <a:cubicBezTo>
                    <a:pt x="2527" y="2875"/>
                    <a:pt x="2524" y="2889"/>
                    <a:pt x="2514" y="2896"/>
                  </a:cubicBezTo>
                  <a:cubicBezTo>
                    <a:pt x="2503" y="2903"/>
                    <a:pt x="2489" y="2901"/>
                    <a:pt x="2482" y="2890"/>
                  </a:cubicBezTo>
                  <a:lnTo>
                    <a:pt x="2458" y="2855"/>
                  </a:lnTo>
                  <a:cubicBezTo>
                    <a:pt x="2451" y="2845"/>
                    <a:pt x="2454" y="2830"/>
                    <a:pt x="2464" y="2823"/>
                  </a:cubicBezTo>
                  <a:cubicBezTo>
                    <a:pt x="2475" y="2816"/>
                    <a:pt x="2489" y="2819"/>
                    <a:pt x="2496" y="2829"/>
                  </a:cubicBezTo>
                  <a:close/>
                  <a:moveTo>
                    <a:pt x="2518" y="2861"/>
                  </a:moveTo>
                  <a:lnTo>
                    <a:pt x="2552" y="2898"/>
                  </a:lnTo>
                  <a:cubicBezTo>
                    <a:pt x="2561" y="2907"/>
                    <a:pt x="2560" y="2922"/>
                    <a:pt x="2551" y="2930"/>
                  </a:cubicBezTo>
                  <a:cubicBezTo>
                    <a:pt x="2542" y="2939"/>
                    <a:pt x="2527" y="2939"/>
                    <a:pt x="2518" y="2929"/>
                  </a:cubicBezTo>
                  <a:lnTo>
                    <a:pt x="2484" y="2893"/>
                  </a:lnTo>
                  <a:cubicBezTo>
                    <a:pt x="2475" y="2884"/>
                    <a:pt x="2476" y="2869"/>
                    <a:pt x="2485" y="2860"/>
                  </a:cubicBezTo>
                  <a:cubicBezTo>
                    <a:pt x="2494" y="2852"/>
                    <a:pt x="2509" y="2852"/>
                    <a:pt x="2518" y="2861"/>
                  </a:cubicBezTo>
                  <a:close/>
                  <a:moveTo>
                    <a:pt x="2647" y="2998"/>
                  </a:moveTo>
                  <a:lnTo>
                    <a:pt x="2648" y="3000"/>
                  </a:lnTo>
                  <a:cubicBezTo>
                    <a:pt x="2657" y="3009"/>
                    <a:pt x="2657" y="3023"/>
                    <a:pt x="2647" y="3032"/>
                  </a:cubicBezTo>
                  <a:cubicBezTo>
                    <a:pt x="2638" y="3041"/>
                    <a:pt x="2623" y="3040"/>
                    <a:pt x="2615" y="3031"/>
                  </a:cubicBezTo>
                  <a:lnTo>
                    <a:pt x="2613" y="3030"/>
                  </a:lnTo>
                  <a:cubicBezTo>
                    <a:pt x="2605" y="3021"/>
                    <a:pt x="2605" y="3006"/>
                    <a:pt x="2614" y="2997"/>
                  </a:cubicBezTo>
                  <a:cubicBezTo>
                    <a:pt x="2624" y="2989"/>
                    <a:pt x="2638" y="2989"/>
                    <a:pt x="2647" y="2998"/>
                  </a:cubicBezTo>
                  <a:close/>
                  <a:moveTo>
                    <a:pt x="2636" y="2993"/>
                  </a:moveTo>
                  <a:lnTo>
                    <a:pt x="2724" y="3012"/>
                  </a:lnTo>
                  <a:cubicBezTo>
                    <a:pt x="2737" y="3014"/>
                    <a:pt x="2745" y="3026"/>
                    <a:pt x="2742" y="3039"/>
                  </a:cubicBezTo>
                  <a:cubicBezTo>
                    <a:pt x="2740" y="3051"/>
                    <a:pt x="2727" y="3059"/>
                    <a:pt x="2715" y="3057"/>
                  </a:cubicBezTo>
                  <a:lnTo>
                    <a:pt x="2627" y="3038"/>
                  </a:lnTo>
                  <a:cubicBezTo>
                    <a:pt x="2614" y="3035"/>
                    <a:pt x="2606" y="3023"/>
                    <a:pt x="2609" y="3011"/>
                  </a:cubicBezTo>
                  <a:cubicBezTo>
                    <a:pt x="2612" y="2998"/>
                    <a:pt x="2624" y="2990"/>
                    <a:pt x="2636" y="2993"/>
                  </a:cubicBezTo>
                  <a:close/>
                  <a:moveTo>
                    <a:pt x="2859" y="3031"/>
                  </a:moveTo>
                  <a:lnTo>
                    <a:pt x="2951" y="3040"/>
                  </a:lnTo>
                  <a:cubicBezTo>
                    <a:pt x="2963" y="3042"/>
                    <a:pt x="2972" y="3053"/>
                    <a:pt x="2971" y="3066"/>
                  </a:cubicBezTo>
                  <a:cubicBezTo>
                    <a:pt x="2970" y="3078"/>
                    <a:pt x="2958" y="3088"/>
                    <a:pt x="2946" y="3086"/>
                  </a:cubicBezTo>
                  <a:lnTo>
                    <a:pt x="2854" y="3076"/>
                  </a:lnTo>
                  <a:cubicBezTo>
                    <a:pt x="2841" y="3075"/>
                    <a:pt x="2832" y="3064"/>
                    <a:pt x="2834" y="3051"/>
                  </a:cubicBezTo>
                  <a:cubicBezTo>
                    <a:pt x="2835" y="3038"/>
                    <a:pt x="2846" y="3029"/>
                    <a:pt x="2859" y="3031"/>
                  </a:cubicBezTo>
                  <a:close/>
                  <a:moveTo>
                    <a:pt x="3089" y="3060"/>
                  </a:moveTo>
                  <a:lnTo>
                    <a:pt x="3163" y="3075"/>
                  </a:lnTo>
                  <a:lnTo>
                    <a:pt x="3154" y="3120"/>
                  </a:lnTo>
                  <a:lnTo>
                    <a:pt x="3080" y="3106"/>
                  </a:lnTo>
                  <a:cubicBezTo>
                    <a:pt x="3068" y="3103"/>
                    <a:pt x="3060" y="3091"/>
                    <a:pt x="3062" y="3079"/>
                  </a:cubicBezTo>
                  <a:cubicBezTo>
                    <a:pt x="3065" y="3066"/>
                    <a:pt x="3077" y="3058"/>
                    <a:pt x="3089" y="3060"/>
                  </a:cubicBez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239" name="Rectangle 214"/>
            <p:cNvSpPr>
              <a:spLocks noChangeArrowheads="1"/>
            </p:cNvSpPr>
            <p:nvPr/>
          </p:nvSpPr>
          <p:spPr bwMode="auto">
            <a:xfrm>
              <a:off x="4097338" y="2955925"/>
              <a:ext cx="1636713" cy="1746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10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ild</a:t>
              </a:r>
              <a:r>
                <a:rPr kumimoji="0" lang="el-GR" altLang="el-G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el-GR" altLang="el-GR" sz="10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iron</a:t>
              </a:r>
              <a:r>
                <a:rPr kumimoji="0" lang="el-GR" altLang="el-G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el-GR" altLang="el-GR" sz="10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supplementation</a:t>
              </a:r>
              <a:endParaRPr kumimoji="0" lang="el-GR" altLang="el-G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0" name="Rectangle 215"/>
            <p:cNvSpPr>
              <a:spLocks noChangeArrowheads="1"/>
            </p:cNvSpPr>
            <p:nvPr/>
          </p:nvSpPr>
          <p:spPr bwMode="auto">
            <a:xfrm>
              <a:off x="4410075" y="4748213"/>
              <a:ext cx="1136530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11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Days</a:t>
              </a:r>
              <a:r>
                <a:rPr kumimoji="0" lang="el-GR" altLang="el-GR" sz="11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of </a:t>
              </a:r>
              <a:r>
                <a:rPr kumimoji="0" lang="el-GR" altLang="el-GR" sz="11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adulthood</a:t>
              </a:r>
              <a:endParaRPr kumimoji="0" lang="el-GR" altLang="el-GR" sz="32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7" name="Rectangle 232"/>
            <p:cNvSpPr>
              <a:spLocks noChangeArrowheads="1"/>
            </p:cNvSpPr>
            <p:nvPr/>
          </p:nvSpPr>
          <p:spPr bwMode="auto">
            <a:xfrm>
              <a:off x="5233988" y="3249612"/>
              <a:ext cx="798295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N2+10mM FAC</a:t>
              </a:r>
              <a:endParaRPr kumimoji="0" lang="el-GR" altLang="el-GR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8" name="Freeform 233"/>
            <p:cNvSpPr>
              <a:spLocks noEditPoints="1"/>
            </p:cNvSpPr>
            <p:nvPr/>
          </p:nvSpPr>
          <p:spPr bwMode="auto">
            <a:xfrm>
              <a:off x="5022851" y="3297237"/>
              <a:ext cx="134938" cy="19050"/>
            </a:xfrm>
            <a:custGeom>
              <a:avLst/>
              <a:gdLst>
                <a:gd name="T0" fmla="*/ 0 w 322"/>
                <a:gd name="T1" fmla="*/ 0 h 46"/>
                <a:gd name="T2" fmla="*/ 92 w 322"/>
                <a:gd name="T3" fmla="*/ 0 h 46"/>
                <a:gd name="T4" fmla="*/ 115 w 322"/>
                <a:gd name="T5" fmla="*/ 23 h 46"/>
                <a:gd name="T6" fmla="*/ 92 w 322"/>
                <a:gd name="T7" fmla="*/ 46 h 46"/>
                <a:gd name="T8" fmla="*/ 0 w 322"/>
                <a:gd name="T9" fmla="*/ 46 h 46"/>
                <a:gd name="T10" fmla="*/ 0 w 322"/>
                <a:gd name="T11" fmla="*/ 0 h 46"/>
                <a:gd name="T12" fmla="*/ 230 w 322"/>
                <a:gd name="T13" fmla="*/ 0 h 46"/>
                <a:gd name="T14" fmla="*/ 322 w 322"/>
                <a:gd name="T15" fmla="*/ 0 h 46"/>
                <a:gd name="T16" fmla="*/ 322 w 322"/>
                <a:gd name="T17" fmla="*/ 46 h 46"/>
                <a:gd name="T18" fmla="*/ 230 w 322"/>
                <a:gd name="T19" fmla="*/ 46 h 46"/>
                <a:gd name="T20" fmla="*/ 207 w 322"/>
                <a:gd name="T21" fmla="*/ 23 h 46"/>
                <a:gd name="T22" fmla="*/ 230 w 322"/>
                <a:gd name="T23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322" h="46">
                  <a:moveTo>
                    <a:pt x="0" y="0"/>
                  </a:moveTo>
                  <a:lnTo>
                    <a:pt x="92" y="0"/>
                  </a:lnTo>
                  <a:cubicBezTo>
                    <a:pt x="104" y="0"/>
                    <a:pt x="115" y="10"/>
                    <a:pt x="115" y="23"/>
                  </a:cubicBezTo>
                  <a:cubicBezTo>
                    <a:pt x="115" y="35"/>
                    <a:pt x="104" y="46"/>
                    <a:pt x="92" y="46"/>
                  </a:cubicBezTo>
                  <a:lnTo>
                    <a:pt x="0" y="46"/>
                  </a:lnTo>
                  <a:lnTo>
                    <a:pt x="0" y="0"/>
                  </a:lnTo>
                  <a:close/>
                  <a:moveTo>
                    <a:pt x="230" y="0"/>
                  </a:moveTo>
                  <a:lnTo>
                    <a:pt x="322" y="0"/>
                  </a:lnTo>
                  <a:lnTo>
                    <a:pt x="322" y="46"/>
                  </a:lnTo>
                  <a:lnTo>
                    <a:pt x="230" y="46"/>
                  </a:lnTo>
                  <a:cubicBezTo>
                    <a:pt x="217" y="46"/>
                    <a:pt x="207" y="35"/>
                    <a:pt x="207" y="23"/>
                  </a:cubicBezTo>
                  <a:cubicBezTo>
                    <a:pt x="207" y="10"/>
                    <a:pt x="217" y="0"/>
                    <a:pt x="230" y="0"/>
                  </a:cubicBez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259" name="Rectangle 234"/>
            <p:cNvSpPr>
              <a:spLocks noChangeArrowheads="1"/>
            </p:cNvSpPr>
            <p:nvPr/>
          </p:nvSpPr>
          <p:spPr bwMode="auto">
            <a:xfrm>
              <a:off x="5233988" y="3424237"/>
              <a:ext cx="90088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N2</a:t>
              </a:r>
              <a:r>
                <a:rPr kumimoji="0" lang="en-US" altLang="el-GR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;</a:t>
              </a:r>
              <a:r>
                <a:rPr kumimoji="0" lang="el-GR" altLang="el-GR" sz="9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cisd-1(RNAi)</a:t>
              </a:r>
              <a:r>
                <a:rPr kumimoji="0" lang="en-US" altLang="el-GR" sz="9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+</a:t>
              </a:r>
              <a:endParaRPr kumimoji="0" lang="en-US" altLang="el-GR" sz="900" b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l-GR" sz="900" dirty="0" smtClean="0">
                  <a:solidFill>
                    <a:srgbClr val="000000"/>
                  </a:solidFill>
                </a:rPr>
                <a:t>10mM FAC</a:t>
              </a:r>
              <a:endParaRPr kumimoji="0" lang="el-GR" altLang="el-GR" sz="20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61" name="Freeform 236"/>
            <p:cNvSpPr>
              <a:spLocks noEditPoints="1"/>
            </p:cNvSpPr>
            <p:nvPr/>
          </p:nvSpPr>
          <p:spPr bwMode="auto">
            <a:xfrm>
              <a:off x="5022851" y="3530600"/>
              <a:ext cx="134938" cy="19050"/>
            </a:xfrm>
            <a:custGeom>
              <a:avLst/>
              <a:gdLst>
                <a:gd name="T0" fmla="*/ 0 w 322"/>
                <a:gd name="T1" fmla="*/ 0 h 46"/>
                <a:gd name="T2" fmla="*/ 92 w 322"/>
                <a:gd name="T3" fmla="*/ 0 h 46"/>
                <a:gd name="T4" fmla="*/ 115 w 322"/>
                <a:gd name="T5" fmla="*/ 23 h 46"/>
                <a:gd name="T6" fmla="*/ 92 w 322"/>
                <a:gd name="T7" fmla="*/ 46 h 46"/>
                <a:gd name="T8" fmla="*/ 0 w 322"/>
                <a:gd name="T9" fmla="*/ 46 h 46"/>
                <a:gd name="T10" fmla="*/ 0 w 322"/>
                <a:gd name="T11" fmla="*/ 0 h 46"/>
                <a:gd name="T12" fmla="*/ 230 w 322"/>
                <a:gd name="T13" fmla="*/ 0 h 46"/>
                <a:gd name="T14" fmla="*/ 322 w 322"/>
                <a:gd name="T15" fmla="*/ 0 h 46"/>
                <a:gd name="T16" fmla="*/ 322 w 322"/>
                <a:gd name="T17" fmla="*/ 46 h 46"/>
                <a:gd name="T18" fmla="*/ 230 w 322"/>
                <a:gd name="T19" fmla="*/ 46 h 46"/>
                <a:gd name="T20" fmla="*/ 207 w 322"/>
                <a:gd name="T21" fmla="*/ 23 h 46"/>
                <a:gd name="T22" fmla="*/ 230 w 322"/>
                <a:gd name="T23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322" h="46">
                  <a:moveTo>
                    <a:pt x="0" y="0"/>
                  </a:moveTo>
                  <a:lnTo>
                    <a:pt x="92" y="0"/>
                  </a:lnTo>
                  <a:cubicBezTo>
                    <a:pt x="104" y="0"/>
                    <a:pt x="115" y="11"/>
                    <a:pt x="115" y="23"/>
                  </a:cubicBezTo>
                  <a:cubicBezTo>
                    <a:pt x="115" y="36"/>
                    <a:pt x="104" y="46"/>
                    <a:pt x="92" y="46"/>
                  </a:cubicBezTo>
                  <a:lnTo>
                    <a:pt x="0" y="46"/>
                  </a:lnTo>
                  <a:lnTo>
                    <a:pt x="0" y="0"/>
                  </a:lnTo>
                  <a:close/>
                  <a:moveTo>
                    <a:pt x="230" y="0"/>
                  </a:moveTo>
                  <a:lnTo>
                    <a:pt x="322" y="0"/>
                  </a:lnTo>
                  <a:lnTo>
                    <a:pt x="322" y="46"/>
                  </a:lnTo>
                  <a:lnTo>
                    <a:pt x="230" y="46"/>
                  </a:lnTo>
                  <a:cubicBezTo>
                    <a:pt x="217" y="46"/>
                    <a:pt x="207" y="36"/>
                    <a:pt x="207" y="23"/>
                  </a:cubicBezTo>
                  <a:cubicBezTo>
                    <a:pt x="207" y="11"/>
                    <a:pt x="217" y="0"/>
                    <a:pt x="230" y="0"/>
                  </a:cubicBezTo>
                  <a:close/>
                </a:path>
              </a:pathLst>
            </a:custGeom>
            <a:solidFill>
              <a:srgbClr val="A00000"/>
            </a:solidFill>
            <a:ln w="1588" cap="flat">
              <a:solidFill>
                <a:srgbClr val="A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262" name="Rectangle 237"/>
            <p:cNvSpPr>
              <a:spLocks noChangeArrowheads="1"/>
            </p:cNvSpPr>
            <p:nvPr/>
          </p:nvSpPr>
          <p:spPr bwMode="auto">
            <a:xfrm>
              <a:off x="5233988" y="3717925"/>
              <a:ext cx="881652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N2</a:t>
              </a:r>
              <a:r>
                <a:rPr kumimoji="0" lang="en-US" altLang="el-GR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;</a:t>
              </a:r>
              <a:r>
                <a:rPr kumimoji="0" lang="el-GR" altLang="el-GR" sz="9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ced-9(RNAi)</a:t>
              </a:r>
              <a:r>
                <a:rPr kumimoji="0" lang="en-US" altLang="el-GR" sz="9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+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l-GR" sz="900" dirty="0" smtClean="0">
                  <a:solidFill>
                    <a:srgbClr val="000000"/>
                  </a:solidFill>
                </a:rPr>
                <a:t>10mM FAC</a:t>
              </a:r>
              <a:endParaRPr kumimoji="0" lang="el-GR" altLang="el-GR" sz="20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64" name="Freeform 239"/>
            <p:cNvSpPr>
              <a:spLocks noEditPoints="1"/>
            </p:cNvSpPr>
            <p:nvPr/>
          </p:nvSpPr>
          <p:spPr bwMode="auto">
            <a:xfrm>
              <a:off x="5022851" y="3825875"/>
              <a:ext cx="134938" cy="19050"/>
            </a:xfrm>
            <a:custGeom>
              <a:avLst/>
              <a:gdLst>
                <a:gd name="T0" fmla="*/ 0 w 322"/>
                <a:gd name="T1" fmla="*/ 0 h 46"/>
                <a:gd name="T2" fmla="*/ 92 w 322"/>
                <a:gd name="T3" fmla="*/ 0 h 46"/>
                <a:gd name="T4" fmla="*/ 115 w 322"/>
                <a:gd name="T5" fmla="*/ 23 h 46"/>
                <a:gd name="T6" fmla="*/ 92 w 322"/>
                <a:gd name="T7" fmla="*/ 46 h 46"/>
                <a:gd name="T8" fmla="*/ 0 w 322"/>
                <a:gd name="T9" fmla="*/ 46 h 46"/>
                <a:gd name="T10" fmla="*/ 0 w 322"/>
                <a:gd name="T11" fmla="*/ 0 h 46"/>
                <a:gd name="T12" fmla="*/ 230 w 322"/>
                <a:gd name="T13" fmla="*/ 0 h 46"/>
                <a:gd name="T14" fmla="*/ 322 w 322"/>
                <a:gd name="T15" fmla="*/ 0 h 46"/>
                <a:gd name="T16" fmla="*/ 322 w 322"/>
                <a:gd name="T17" fmla="*/ 46 h 46"/>
                <a:gd name="T18" fmla="*/ 230 w 322"/>
                <a:gd name="T19" fmla="*/ 46 h 46"/>
                <a:gd name="T20" fmla="*/ 207 w 322"/>
                <a:gd name="T21" fmla="*/ 23 h 46"/>
                <a:gd name="T22" fmla="*/ 230 w 322"/>
                <a:gd name="T23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322" h="46">
                  <a:moveTo>
                    <a:pt x="0" y="0"/>
                  </a:moveTo>
                  <a:lnTo>
                    <a:pt x="92" y="0"/>
                  </a:lnTo>
                  <a:cubicBezTo>
                    <a:pt x="104" y="0"/>
                    <a:pt x="115" y="10"/>
                    <a:pt x="115" y="23"/>
                  </a:cubicBezTo>
                  <a:cubicBezTo>
                    <a:pt x="115" y="36"/>
                    <a:pt x="104" y="46"/>
                    <a:pt x="92" y="46"/>
                  </a:cubicBezTo>
                  <a:lnTo>
                    <a:pt x="0" y="46"/>
                  </a:lnTo>
                  <a:lnTo>
                    <a:pt x="0" y="0"/>
                  </a:lnTo>
                  <a:close/>
                  <a:moveTo>
                    <a:pt x="230" y="0"/>
                  </a:moveTo>
                  <a:lnTo>
                    <a:pt x="322" y="0"/>
                  </a:lnTo>
                  <a:lnTo>
                    <a:pt x="322" y="46"/>
                  </a:lnTo>
                  <a:lnTo>
                    <a:pt x="230" y="46"/>
                  </a:lnTo>
                  <a:cubicBezTo>
                    <a:pt x="217" y="46"/>
                    <a:pt x="207" y="36"/>
                    <a:pt x="207" y="23"/>
                  </a:cubicBezTo>
                  <a:cubicBezTo>
                    <a:pt x="207" y="10"/>
                    <a:pt x="217" y="0"/>
                    <a:pt x="230" y="0"/>
                  </a:cubicBezTo>
                  <a:close/>
                </a:path>
              </a:pathLst>
            </a:custGeom>
            <a:solidFill>
              <a:srgbClr val="0000C0"/>
            </a:solidFill>
            <a:ln w="1588" cap="flat">
              <a:solidFill>
                <a:srgbClr val="0000C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265" name="Rectangle 240"/>
            <p:cNvSpPr>
              <a:spLocks noChangeArrowheads="1"/>
            </p:cNvSpPr>
            <p:nvPr/>
          </p:nvSpPr>
          <p:spPr bwMode="auto">
            <a:xfrm>
              <a:off x="5233988" y="4013200"/>
              <a:ext cx="122148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N2</a:t>
              </a:r>
              <a:r>
                <a:rPr kumimoji="0" lang="en-US" altLang="el-GR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;</a:t>
              </a:r>
              <a:r>
                <a:rPr kumimoji="0" lang="el-GR" altLang="el-GR" sz="9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ced-9</a:t>
              </a:r>
              <a:r>
                <a:rPr kumimoji="0" lang="en-US" altLang="el-GR" sz="9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;</a:t>
              </a:r>
              <a:r>
                <a:rPr kumimoji="0" lang="el-GR" altLang="el-GR" sz="9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cisd-1(RNAi)</a:t>
              </a:r>
              <a:r>
                <a:rPr kumimoji="0" lang="el-GR" altLang="el-GR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+</a:t>
              </a:r>
              <a:endParaRPr kumimoji="0" lang="en-US" altLang="el-G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l-GR" sz="900" dirty="0" smtClean="0">
                  <a:solidFill>
                    <a:srgbClr val="000000"/>
                  </a:solidFill>
                </a:rPr>
                <a:t>10mM FAC</a:t>
              </a:r>
              <a:endParaRPr kumimoji="0" lang="el-GR" altLang="el-GR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7" name="Freeform 242"/>
            <p:cNvSpPr>
              <a:spLocks noEditPoints="1"/>
            </p:cNvSpPr>
            <p:nvPr/>
          </p:nvSpPr>
          <p:spPr bwMode="auto">
            <a:xfrm>
              <a:off x="5022851" y="4121150"/>
              <a:ext cx="134938" cy="19050"/>
            </a:xfrm>
            <a:custGeom>
              <a:avLst/>
              <a:gdLst>
                <a:gd name="T0" fmla="*/ 0 w 322"/>
                <a:gd name="T1" fmla="*/ 0 h 46"/>
                <a:gd name="T2" fmla="*/ 92 w 322"/>
                <a:gd name="T3" fmla="*/ 0 h 46"/>
                <a:gd name="T4" fmla="*/ 115 w 322"/>
                <a:gd name="T5" fmla="*/ 23 h 46"/>
                <a:gd name="T6" fmla="*/ 92 w 322"/>
                <a:gd name="T7" fmla="*/ 46 h 46"/>
                <a:gd name="T8" fmla="*/ 0 w 322"/>
                <a:gd name="T9" fmla="*/ 46 h 46"/>
                <a:gd name="T10" fmla="*/ 0 w 322"/>
                <a:gd name="T11" fmla="*/ 0 h 46"/>
                <a:gd name="T12" fmla="*/ 230 w 322"/>
                <a:gd name="T13" fmla="*/ 0 h 46"/>
                <a:gd name="T14" fmla="*/ 322 w 322"/>
                <a:gd name="T15" fmla="*/ 0 h 46"/>
                <a:gd name="T16" fmla="*/ 322 w 322"/>
                <a:gd name="T17" fmla="*/ 46 h 46"/>
                <a:gd name="T18" fmla="*/ 230 w 322"/>
                <a:gd name="T19" fmla="*/ 46 h 46"/>
                <a:gd name="T20" fmla="*/ 207 w 322"/>
                <a:gd name="T21" fmla="*/ 23 h 46"/>
                <a:gd name="T22" fmla="*/ 230 w 322"/>
                <a:gd name="T23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322" h="46">
                  <a:moveTo>
                    <a:pt x="0" y="0"/>
                  </a:moveTo>
                  <a:lnTo>
                    <a:pt x="92" y="0"/>
                  </a:lnTo>
                  <a:cubicBezTo>
                    <a:pt x="104" y="0"/>
                    <a:pt x="115" y="11"/>
                    <a:pt x="115" y="23"/>
                  </a:cubicBezTo>
                  <a:cubicBezTo>
                    <a:pt x="115" y="36"/>
                    <a:pt x="104" y="46"/>
                    <a:pt x="92" y="46"/>
                  </a:cubicBezTo>
                  <a:lnTo>
                    <a:pt x="0" y="46"/>
                  </a:lnTo>
                  <a:lnTo>
                    <a:pt x="0" y="0"/>
                  </a:lnTo>
                  <a:close/>
                  <a:moveTo>
                    <a:pt x="230" y="0"/>
                  </a:moveTo>
                  <a:lnTo>
                    <a:pt x="322" y="0"/>
                  </a:lnTo>
                  <a:lnTo>
                    <a:pt x="322" y="46"/>
                  </a:lnTo>
                  <a:lnTo>
                    <a:pt x="230" y="46"/>
                  </a:lnTo>
                  <a:cubicBezTo>
                    <a:pt x="217" y="46"/>
                    <a:pt x="207" y="36"/>
                    <a:pt x="207" y="23"/>
                  </a:cubicBezTo>
                  <a:cubicBezTo>
                    <a:pt x="207" y="11"/>
                    <a:pt x="217" y="0"/>
                    <a:pt x="230" y="0"/>
                  </a:cubicBezTo>
                  <a:close/>
                </a:path>
              </a:pathLst>
            </a:custGeom>
            <a:solidFill>
              <a:srgbClr val="00C000"/>
            </a:solidFill>
            <a:ln w="1588" cap="flat">
              <a:solidFill>
                <a:srgbClr val="00C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268" name="TextBox 267"/>
            <p:cNvSpPr txBox="1"/>
            <p:nvPr/>
          </p:nvSpPr>
          <p:spPr>
            <a:xfrm rot="16200000">
              <a:off x="2947010" y="3736345"/>
              <a:ext cx="118814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ercent survival</a:t>
              </a:r>
              <a:endParaRPr lang="el-GR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9" name="Δεξιά αγκύλη 268"/>
            <p:cNvSpPr/>
            <p:nvPr/>
          </p:nvSpPr>
          <p:spPr>
            <a:xfrm>
              <a:off x="2707393" y="1008344"/>
              <a:ext cx="45719" cy="258276"/>
            </a:xfrm>
            <a:prstGeom prst="righ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l-GR"/>
            </a:p>
          </p:txBody>
        </p:sp>
        <p:sp>
          <p:nvSpPr>
            <p:cNvPr id="270" name="Rectangle 498"/>
            <p:cNvSpPr>
              <a:spLocks noChangeArrowheads="1"/>
            </p:cNvSpPr>
            <p:nvPr/>
          </p:nvSpPr>
          <p:spPr bwMode="auto">
            <a:xfrm>
              <a:off x="2803529" y="1067672"/>
              <a:ext cx="14106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l-GR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**</a:t>
              </a:r>
              <a:endParaRPr kumimoji="0" lang="el-GR" altLang="el-GR" sz="4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71" name="Δεξιά αγκύλη 270"/>
            <p:cNvSpPr/>
            <p:nvPr/>
          </p:nvSpPr>
          <p:spPr>
            <a:xfrm>
              <a:off x="6131085" y="852502"/>
              <a:ext cx="45719" cy="396000"/>
            </a:xfrm>
            <a:prstGeom prst="righ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l-GR"/>
            </a:p>
          </p:txBody>
        </p:sp>
        <p:sp>
          <p:nvSpPr>
            <p:cNvPr id="272" name="Rectangle 498"/>
            <p:cNvSpPr>
              <a:spLocks noChangeArrowheads="1"/>
            </p:cNvSpPr>
            <p:nvPr/>
          </p:nvSpPr>
          <p:spPr bwMode="auto">
            <a:xfrm rot="5400000">
              <a:off x="6174865" y="947401"/>
              <a:ext cx="7053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l-GR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*</a:t>
              </a:r>
              <a:endParaRPr kumimoji="0" lang="el-GR" altLang="el-GR" sz="4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73" name="Δεξιά αγκύλη 272"/>
            <p:cNvSpPr/>
            <p:nvPr/>
          </p:nvSpPr>
          <p:spPr>
            <a:xfrm>
              <a:off x="6156882" y="3299822"/>
              <a:ext cx="45719" cy="252000"/>
            </a:xfrm>
            <a:prstGeom prst="righ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l-GR"/>
            </a:p>
          </p:txBody>
        </p:sp>
        <p:sp>
          <p:nvSpPr>
            <p:cNvPr id="274" name="Rectangle 498"/>
            <p:cNvSpPr>
              <a:spLocks noChangeArrowheads="1"/>
            </p:cNvSpPr>
            <p:nvPr/>
          </p:nvSpPr>
          <p:spPr bwMode="auto">
            <a:xfrm rot="5400000">
              <a:off x="6094864" y="3318521"/>
              <a:ext cx="28212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l-GR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****</a:t>
              </a:r>
              <a:endParaRPr kumimoji="0" lang="el-GR" altLang="el-GR" sz="4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75" name="Δεξιά αγκύλη 274"/>
            <p:cNvSpPr/>
            <p:nvPr/>
          </p:nvSpPr>
          <p:spPr>
            <a:xfrm>
              <a:off x="6511596" y="3505752"/>
              <a:ext cx="45719" cy="612000"/>
            </a:xfrm>
            <a:prstGeom prst="righ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l-GR"/>
            </a:p>
          </p:txBody>
        </p:sp>
        <p:sp>
          <p:nvSpPr>
            <p:cNvPr id="277" name="TextBox 276"/>
            <p:cNvSpPr txBox="1"/>
            <p:nvPr/>
          </p:nvSpPr>
          <p:spPr>
            <a:xfrm>
              <a:off x="6522667" y="3691265"/>
              <a:ext cx="30649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  <a:endParaRPr lang="el-G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" name="TextBox 1"/>
            <p:cNvSpPr txBox="1"/>
            <p:nvPr/>
          </p:nvSpPr>
          <p:spPr>
            <a:xfrm>
              <a:off x="84759" y="358617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A</a:t>
              </a:r>
              <a:endParaRPr lang="el-GR" dirty="0"/>
            </a:p>
          </p:txBody>
        </p:sp>
        <p:sp>
          <p:nvSpPr>
            <p:cNvPr id="175" name="TextBox 174"/>
            <p:cNvSpPr txBox="1"/>
            <p:nvPr/>
          </p:nvSpPr>
          <p:spPr>
            <a:xfrm>
              <a:off x="84759" y="2711626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B</a:t>
              </a:r>
              <a:endParaRPr lang="el-GR" dirty="0"/>
            </a:p>
          </p:txBody>
        </p:sp>
        <p:sp>
          <p:nvSpPr>
            <p:cNvPr id="176" name="TextBox 175"/>
            <p:cNvSpPr txBox="1"/>
            <p:nvPr/>
          </p:nvSpPr>
          <p:spPr>
            <a:xfrm>
              <a:off x="84759" y="5263437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C</a:t>
              </a:r>
              <a:endParaRPr lang="el-GR" dirty="0"/>
            </a:p>
          </p:txBody>
        </p:sp>
        <p:sp>
          <p:nvSpPr>
            <p:cNvPr id="177" name="TextBox 176"/>
            <p:cNvSpPr txBox="1"/>
            <p:nvPr/>
          </p:nvSpPr>
          <p:spPr>
            <a:xfrm>
              <a:off x="3469216" y="358617"/>
              <a:ext cx="3273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D</a:t>
              </a:r>
              <a:endParaRPr lang="el-GR" dirty="0"/>
            </a:p>
          </p:txBody>
        </p:sp>
        <p:sp>
          <p:nvSpPr>
            <p:cNvPr id="178" name="TextBox 177"/>
            <p:cNvSpPr txBox="1"/>
            <p:nvPr/>
          </p:nvSpPr>
          <p:spPr>
            <a:xfrm>
              <a:off x="3499674" y="2711626"/>
              <a:ext cx="2968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E</a:t>
              </a:r>
              <a:endParaRPr lang="el-GR" dirty="0"/>
            </a:p>
          </p:txBody>
        </p:sp>
      </p:grpSp>
    </p:spTree>
    <p:extLst>
      <p:ext uri="{BB962C8B-B14F-4D97-AF65-F5344CB8AC3E}">
        <p14:creationId xmlns:p14="http://schemas.microsoft.com/office/powerpoint/2010/main" val="3927344739"/>
      </p:ext>
    </p:extLst>
  </p:cSld>
  <p:clrMapOvr>
    <a:masterClrMapping/>
  </p:clrMapOvr>
</p:sld>
</file>

<file path=ppt/theme/theme1.xml><?xml version="1.0" encoding="utf-8"?>
<a:theme xmlns:a="http://schemas.openxmlformats.org/drawingml/2006/main" name="Θέμα του Office">
  <a:themeElements>
    <a:clrScheme name="Θέμα του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Θέμα του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Θέμα του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88</TotalTime>
  <Words>179</Words>
  <Application>Microsoft Office PowerPoint</Application>
  <PresentationFormat>Χαρτί Α4 (210x297 χιλ.)</PresentationFormat>
  <Paragraphs>119</Paragraphs>
  <Slides>1</Slides>
  <Notes>0</Notes>
  <HiddenSlides>0</HiddenSlides>
  <MMClips>0</MMClips>
  <ScaleCrop>false</ScaleCrop>
  <HeadingPairs>
    <vt:vector size="6" baseType="variant">
      <vt:variant>
        <vt:lpstr>Γραμματοσειρές που χρησιμοποιούνται</vt:lpstr>
      </vt:variant>
      <vt:variant>
        <vt:i4>3</vt:i4>
      </vt:variant>
      <vt:variant>
        <vt:lpstr>Θέμα</vt:lpstr>
      </vt:variant>
      <vt:variant>
        <vt:i4>1</vt:i4>
      </vt:variant>
      <vt:variant>
        <vt:lpstr>Τίτλοι διαφανειών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Θέμα του Office</vt:lpstr>
      <vt:lpstr>Παρουσίαση του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Παρουσίαση του PowerPoint</dc:title>
  <dc:creator>Christina Ploumi</dc:creator>
  <cp:lastModifiedBy>christina ploumi</cp:lastModifiedBy>
  <cp:revision>13</cp:revision>
  <dcterms:created xsi:type="dcterms:W3CDTF">2022-11-24T14:48:28Z</dcterms:created>
  <dcterms:modified xsi:type="dcterms:W3CDTF">2022-12-13T13:54:17Z</dcterms:modified>
</cp:coreProperties>
</file>